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6"/>
  </p:notesMasterIdLst>
  <p:sldIdLst>
    <p:sldId id="257" r:id="rId2"/>
    <p:sldId id="258" r:id="rId3"/>
    <p:sldId id="274" r:id="rId4"/>
    <p:sldId id="259" r:id="rId5"/>
    <p:sldId id="260" r:id="rId6"/>
    <p:sldId id="276" r:id="rId7"/>
    <p:sldId id="277" r:id="rId8"/>
    <p:sldId id="286" r:id="rId9"/>
    <p:sldId id="287" r:id="rId10"/>
    <p:sldId id="275" r:id="rId11"/>
    <p:sldId id="285" r:id="rId12"/>
    <p:sldId id="261" r:id="rId13"/>
    <p:sldId id="262" r:id="rId14"/>
    <p:sldId id="263" r:id="rId15"/>
    <p:sldId id="264" r:id="rId16"/>
    <p:sldId id="265" r:id="rId17"/>
    <p:sldId id="288" r:id="rId18"/>
    <p:sldId id="289" r:id="rId19"/>
    <p:sldId id="290" r:id="rId20"/>
    <p:sldId id="266" r:id="rId21"/>
    <p:sldId id="267" r:id="rId22"/>
    <p:sldId id="278" r:id="rId23"/>
    <p:sldId id="268" r:id="rId24"/>
    <p:sldId id="269" r:id="rId25"/>
    <p:sldId id="270" r:id="rId26"/>
    <p:sldId id="291" r:id="rId27"/>
    <p:sldId id="292" r:id="rId28"/>
    <p:sldId id="271" r:id="rId29"/>
    <p:sldId id="279" r:id="rId30"/>
    <p:sldId id="293" r:id="rId31"/>
    <p:sldId id="294" r:id="rId32"/>
    <p:sldId id="295" r:id="rId33"/>
    <p:sldId id="299" r:id="rId34"/>
    <p:sldId id="298" r:id="rId35"/>
    <p:sldId id="297" r:id="rId36"/>
    <p:sldId id="296" r:id="rId37"/>
    <p:sldId id="280" r:id="rId38"/>
    <p:sldId id="300" r:id="rId39"/>
    <p:sldId id="284" r:id="rId40"/>
    <p:sldId id="272" r:id="rId41"/>
    <p:sldId id="282" r:id="rId42"/>
    <p:sldId id="273" r:id="rId43"/>
    <p:sldId id="283" r:id="rId44"/>
    <p:sldId id="301" r:id="rId4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r Ahmed Elshazly" initials="DAE" lastIdx="1" clrIdx="0">
    <p:extLst>
      <p:ext uri="{19B8F6BF-5375-455C-9EA6-DF929625EA0E}">
        <p15:presenceInfo xmlns:p15="http://schemas.microsoft.com/office/powerpoint/2012/main" userId="Dr Ahmed Elshazly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E53B24A-F309-4E6A-823A-1B281AAAC729}" v="123" dt="2026-02-28T22:16:44.7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010" autoAdjust="0"/>
  </p:normalViewPr>
  <p:slideViewPr>
    <p:cSldViewPr snapToGrid="0">
      <p:cViewPr varScale="1">
        <p:scale>
          <a:sx n="102" d="100"/>
          <a:sy n="102" d="100"/>
        </p:scale>
        <p:origin x="91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commentAuthors" Target="commentAuthors.xml"/><Relationship Id="rId50" Type="http://schemas.openxmlformats.org/officeDocument/2006/relationships/theme" Target="theme/theme1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presProps" Target="presProps.xml"/><Relationship Id="rId8" Type="http://schemas.openxmlformats.org/officeDocument/2006/relationships/slide" Target="slides/slide7.xml"/><Relationship Id="rId51" Type="http://schemas.openxmlformats.org/officeDocument/2006/relationships/tableStyles" Target="tableStyle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notesMaster" Target="notesMasters/notesMaster1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r Ahmed Elshazly" userId="92faafa7-b1de-4194-ac20-c5423e5d0806" providerId="ADAL" clId="{591B1513-E534-4A55-B858-A57CE2E401C3}"/>
    <pc:docChg chg="undo custSel addSld delSld modSld sldOrd">
      <pc:chgData name="Dr Ahmed Elshazly" userId="92faafa7-b1de-4194-ac20-c5423e5d0806" providerId="ADAL" clId="{591B1513-E534-4A55-B858-A57CE2E401C3}" dt="2026-03-01T12:38:48.106" v="1177" actId="20577"/>
      <pc:docMkLst>
        <pc:docMk/>
      </pc:docMkLst>
      <pc:sldChg chg="modSp mod">
        <pc:chgData name="Dr Ahmed Elshazly" userId="92faafa7-b1de-4194-ac20-c5423e5d0806" providerId="ADAL" clId="{591B1513-E534-4A55-B858-A57CE2E401C3}" dt="2026-02-28T21:17:08.866" v="2" actId="20577"/>
        <pc:sldMkLst>
          <pc:docMk/>
          <pc:sldMk cId="2938494494" sldId="257"/>
        </pc:sldMkLst>
        <pc:spChg chg="mod">
          <ac:chgData name="Dr Ahmed Elshazly" userId="92faafa7-b1de-4194-ac20-c5423e5d0806" providerId="ADAL" clId="{591B1513-E534-4A55-B858-A57CE2E401C3}" dt="2026-02-28T21:17:08.866" v="2" actId="20577"/>
          <ac:spMkLst>
            <pc:docMk/>
            <pc:sldMk cId="2938494494" sldId="257"/>
            <ac:spMk id="4" creationId="{6EEFB7D9-5E24-A2FB-DE83-4E67EB17F65C}"/>
          </ac:spMkLst>
        </pc:spChg>
      </pc:sldChg>
      <pc:sldChg chg="modSp mod">
        <pc:chgData name="Dr Ahmed Elshazly" userId="92faafa7-b1de-4194-ac20-c5423e5d0806" providerId="ADAL" clId="{591B1513-E534-4A55-B858-A57CE2E401C3}" dt="2026-02-28T21:17:25.170" v="3" actId="20577"/>
        <pc:sldMkLst>
          <pc:docMk/>
          <pc:sldMk cId="3987004051" sldId="258"/>
        </pc:sldMkLst>
        <pc:spChg chg="mod">
          <ac:chgData name="Dr Ahmed Elshazly" userId="92faafa7-b1de-4194-ac20-c5423e5d0806" providerId="ADAL" clId="{591B1513-E534-4A55-B858-A57CE2E401C3}" dt="2026-02-28T21:17:25.170" v="3" actId="20577"/>
          <ac:spMkLst>
            <pc:docMk/>
            <pc:sldMk cId="3987004051" sldId="258"/>
            <ac:spMk id="4" creationId="{44C27FEB-0F6A-C4CE-5BCD-231B2C6FD814}"/>
          </ac:spMkLst>
        </pc:spChg>
      </pc:sldChg>
      <pc:sldChg chg="modSp mod">
        <pc:chgData name="Dr Ahmed Elshazly" userId="92faafa7-b1de-4194-ac20-c5423e5d0806" providerId="ADAL" clId="{591B1513-E534-4A55-B858-A57CE2E401C3}" dt="2026-02-28T21:34:07.725" v="339" actId="20577"/>
        <pc:sldMkLst>
          <pc:docMk/>
          <pc:sldMk cId="2439343383" sldId="266"/>
        </pc:sldMkLst>
        <pc:spChg chg="mod">
          <ac:chgData name="Dr Ahmed Elshazly" userId="92faafa7-b1de-4194-ac20-c5423e5d0806" providerId="ADAL" clId="{591B1513-E534-4A55-B858-A57CE2E401C3}" dt="2026-02-28T21:34:07.725" v="339" actId="20577"/>
          <ac:spMkLst>
            <pc:docMk/>
            <pc:sldMk cId="2439343383" sldId="266"/>
            <ac:spMk id="4" creationId="{A05C9A1D-B717-B5E0-7197-7556E3EF6C82}"/>
          </ac:spMkLst>
        </pc:spChg>
      </pc:sldChg>
      <pc:sldChg chg="modSp mod">
        <pc:chgData name="Dr Ahmed Elshazly" userId="92faafa7-b1de-4194-ac20-c5423e5d0806" providerId="ADAL" clId="{591B1513-E534-4A55-B858-A57CE2E401C3}" dt="2026-02-28T21:34:27.878" v="342" actId="20577"/>
        <pc:sldMkLst>
          <pc:docMk/>
          <pc:sldMk cId="692132382" sldId="267"/>
        </pc:sldMkLst>
        <pc:spChg chg="mod">
          <ac:chgData name="Dr Ahmed Elshazly" userId="92faafa7-b1de-4194-ac20-c5423e5d0806" providerId="ADAL" clId="{591B1513-E534-4A55-B858-A57CE2E401C3}" dt="2026-02-28T21:34:27.878" v="342" actId="20577"/>
          <ac:spMkLst>
            <pc:docMk/>
            <pc:sldMk cId="692132382" sldId="267"/>
            <ac:spMk id="4" creationId="{121AC795-A604-8D99-EA67-D84239264619}"/>
          </ac:spMkLst>
        </pc:spChg>
      </pc:sldChg>
      <pc:sldChg chg="modSp mod">
        <pc:chgData name="Dr Ahmed Elshazly" userId="92faafa7-b1de-4194-ac20-c5423e5d0806" providerId="ADAL" clId="{591B1513-E534-4A55-B858-A57CE2E401C3}" dt="2026-03-01T12:38:48.106" v="1177" actId="20577"/>
        <pc:sldMkLst>
          <pc:docMk/>
          <pc:sldMk cId="105824139" sldId="271"/>
        </pc:sldMkLst>
        <pc:spChg chg="mod">
          <ac:chgData name="Dr Ahmed Elshazly" userId="92faafa7-b1de-4194-ac20-c5423e5d0806" providerId="ADAL" clId="{591B1513-E534-4A55-B858-A57CE2E401C3}" dt="2026-03-01T12:38:48.106" v="1177" actId="20577"/>
          <ac:spMkLst>
            <pc:docMk/>
            <pc:sldMk cId="105824139" sldId="271"/>
            <ac:spMk id="4" creationId="{F379C730-6F35-EC4D-9691-0AF63F442856}"/>
          </ac:spMkLst>
        </pc:spChg>
      </pc:sldChg>
      <pc:sldChg chg="modSp mod">
        <pc:chgData name="Dr Ahmed Elshazly" userId="92faafa7-b1de-4194-ac20-c5423e5d0806" providerId="ADAL" clId="{591B1513-E534-4A55-B858-A57CE2E401C3}" dt="2026-02-28T22:13:46.867" v="1108" actId="20577"/>
        <pc:sldMkLst>
          <pc:docMk/>
          <pc:sldMk cId="2521586895" sldId="272"/>
        </pc:sldMkLst>
        <pc:spChg chg="mod">
          <ac:chgData name="Dr Ahmed Elshazly" userId="92faafa7-b1de-4194-ac20-c5423e5d0806" providerId="ADAL" clId="{591B1513-E534-4A55-B858-A57CE2E401C3}" dt="2026-02-28T22:13:46.867" v="1108" actId="20577"/>
          <ac:spMkLst>
            <pc:docMk/>
            <pc:sldMk cId="2521586895" sldId="272"/>
            <ac:spMk id="4" creationId="{7F76B107-46E2-5CE4-D8A8-D969DBEFBBD6}"/>
          </ac:spMkLst>
        </pc:spChg>
      </pc:sldChg>
      <pc:sldChg chg="modSp mod">
        <pc:chgData name="Dr Ahmed Elshazly" userId="92faafa7-b1de-4194-ac20-c5423e5d0806" providerId="ADAL" clId="{591B1513-E534-4A55-B858-A57CE2E401C3}" dt="2026-02-28T22:14:20.805" v="1113" actId="20577"/>
        <pc:sldMkLst>
          <pc:docMk/>
          <pc:sldMk cId="286445929" sldId="273"/>
        </pc:sldMkLst>
        <pc:spChg chg="mod">
          <ac:chgData name="Dr Ahmed Elshazly" userId="92faafa7-b1de-4194-ac20-c5423e5d0806" providerId="ADAL" clId="{591B1513-E534-4A55-B858-A57CE2E401C3}" dt="2026-02-28T22:14:20.805" v="1113" actId="20577"/>
          <ac:spMkLst>
            <pc:docMk/>
            <pc:sldMk cId="286445929" sldId="273"/>
            <ac:spMk id="4" creationId="{31AF3732-197F-30FF-54BD-ABF9B4B6C684}"/>
          </ac:spMkLst>
        </pc:spChg>
      </pc:sldChg>
      <pc:sldChg chg="addSp delSp modSp mod">
        <pc:chgData name="Dr Ahmed Elshazly" userId="92faafa7-b1de-4194-ac20-c5423e5d0806" providerId="ADAL" clId="{591B1513-E534-4A55-B858-A57CE2E401C3}" dt="2026-02-28T21:18:44.592" v="28" actId="1076"/>
        <pc:sldMkLst>
          <pc:docMk/>
          <pc:sldMk cId="3121231152" sldId="274"/>
        </pc:sldMkLst>
        <pc:spChg chg="mod">
          <ac:chgData name="Dr Ahmed Elshazly" userId="92faafa7-b1de-4194-ac20-c5423e5d0806" providerId="ADAL" clId="{591B1513-E534-4A55-B858-A57CE2E401C3}" dt="2026-02-28T21:17:36.201" v="4" actId="20577"/>
          <ac:spMkLst>
            <pc:docMk/>
            <pc:sldMk cId="3121231152" sldId="274"/>
            <ac:spMk id="4" creationId="{49DC026A-EAF5-FFF6-483E-FBD06F136558}"/>
          </ac:spMkLst>
        </pc:spChg>
        <pc:spChg chg="mod">
          <ac:chgData name="Dr Ahmed Elshazly" userId="92faafa7-b1de-4194-ac20-c5423e5d0806" providerId="ADAL" clId="{591B1513-E534-4A55-B858-A57CE2E401C3}" dt="2026-02-28T21:18:41.900" v="27" actId="1076"/>
          <ac:spMkLst>
            <pc:docMk/>
            <pc:sldMk cId="3121231152" sldId="274"/>
            <ac:spMk id="7" creationId="{87905D77-5CD6-7EB7-FEC7-915E27B30B0B}"/>
          </ac:spMkLst>
        </pc:spChg>
        <pc:spChg chg="mod">
          <ac:chgData name="Dr Ahmed Elshazly" userId="92faafa7-b1de-4194-ac20-c5423e5d0806" providerId="ADAL" clId="{591B1513-E534-4A55-B858-A57CE2E401C3}" dt="2026-02-28T21:18:14.580" v="17" actId="1076"/>
          <ac:spMkLst>
            <pc:docMk/>
            <pc:sldMk cId="3121231152" sldId="274"/>
            <ac:spMk id="14" creationId="{F5B249CB-6F88-D16F-A1FE-AA9EE00933D8}"/>
          </ac:spMkLst>
        </pc:spChg>
        <pc:spChg chg="mod">
          <ac:chgData name="Dr Ahmed Elshazly" userId="92faafa7-b1de-4194-ac20-c5423e5d0806" providerId="ADAL" clId="{591B1513-E534-4A55-B858-A57CE2E401C3}" dt="2026-02-28T21:18:44.592" v="28" actId="1076"/>
          <ac:spMkLst>
            <pc:docMk/>
            <pc:sldMk cId="3121231152" sldId="274"/>
            <ac:spMk id="15" creationId="{17244EAB-028D-0ECC-6C6D-89A55AEA9611}"/>
          </ac:spMkLst>
        </pc:spChg>
        <pc:picChg chg="add mod ord modCrop">
          <ac:chgData name="Dr Ahmed Elshazly" userId="92faafa7-b1de-4194-ac20-c5423e5d0806" providerId="ADAL" clId="{591B1513-E534-4A55-B858-A57CE2E401C3}" dt="2026-02-28T21:18:44.592" v="28" actId="1076"/>
          <ac:picMkLst>
            <pc:docMk/>
            <pc:sldMk cId="3121231152" sldId="274"/>
            <ac:picMk id="2" creationId="{0C1E4B79-8F31-D4A2-4719-42BA6894AE01}"/>
          </ac:picMkLst>
        </pc:picChg>
        <pc:picChg chg="add mod ord modCrop">
          <ac:chgData name="Dr Ahmed Elshazly" userId="92faafa7-b1de-4194-ac20-c5423e5d0806" providerId="ADAL" clId="{591B1513-E534-4A55-B858-A57CE2E401C3}" dt="2026-02-28T21:18:11.708" v="16" actId="1076"/>
          <ac:picMkLst>
            <pc:docMk/>
            <pc:sldMk cId="3121231152" sldId="274"/>
            <ac:picMk id="3" creationId="{6157680A-AF87-FBC9-AAB4-44DCCE0C69DB}"/>
          </ac:picMkLst>
        </pc:picChg>
        <pc:picChg chg="del">
          <ac:chgData name="Dr Ahmed Elshazly" userId="92faafa7-b1de-4194-ac20-c5423e5d0806" providerId="ADAL" clId="{591B1513-E534-4A55-B858-A57CE2E401C3}" dt="2026-02-28T21:17:38.262" v="6" actId="478"/>
          <ac:picMkLst>
            <pc:docMk/>
            <pc:sldMk cId="3121231152" sldId="274"/>
            <ac:picMk id="5" creationId="{23578E75-5A48-D0BB-B24C-DF046A455BBB}"/>
          </ac:picMkLst>
        </pc:picChg>
        <pc:picChg chg="del">
          <ac:chgData name="Dr Ahmed Elshazly" userId="92faafa7-b1de-4194-ac20-c5423e5d0806" providerId="ADAL" clId="{591B1513-E534-4A55-B858-A57CE2E401C3}" dt="2026-02-28T21:17:37.740" v="5" actId="478"/>
          <ac:picMkLst>
            <pc:docMk/>
            <pc:sldMk cId="3121231152" sldId="274"/>
            <ac:picMk id="6" creationId="{FAD1EC89-9D26-2456-2CE4-E483A885C96F}"/>
          </ac:picMkLst>
        </pc:picChg>
      </pc:sldChg>
      <pc:sldChg chg="addSp delSp modSp mod">
        <pc:chgData name="Dr Ahmed Elshazly" userId="92faafa7-b1de-4194-ac20-c5423e5d0806" providerId="ADAL" clId="{591B1513-E534-4A55-B858-A57CE2E401C3}" dt="2026-02-28T21:32:26.984" v="331" actId="478"/>
        <pc:sldMkLst>
          <pc:docMk/>
          <pc:sldMk cId="1677802666" sldId="275"/>
        </pc:sldMkLst>
        <pc:spChg chg="mod">
          <ac:chgData name="Dr Ahmed Elshazly" userId="92faafa7-b1de-4194-ac20-c5423e5d0806" providerId="ADAL" clId="{591B1513-E534-4A55-B858-A57CE2E401C3}" dt="2026-02-28T21:28:41.341" v="241" actId="20577"/>
          <ac:spMkLst>
            <pc:docMk/>
            <pc:sldMk cId="1677802666" sldId="275"/>
            <ac:spMk id="4" creationId="{1AE21C9C-ACAF-1BAC-E3D0-6213E70D30E6}"/>
          </ac:spMkLst>
        </pc:spChg>
        <pc:spChg chg="del">
          <ac:chgData name="Dr Ahmed Elshazly" userId="92faafa7-b1de-4194-ac20-c5423e5d0806" providerId="ADAL" clId="{591B1513-E534-4A55-B858-A57CE2E401C3}" dt="2026-02-28T21:29:19.583" v="253" actId="478"/>
          <ac:spMkLst>
            <pc:docMk/>
            <pc:sldMk cId="1677802666" sldId="275"/>
            <ac:spMk id="6" creationId="{1E1D6552-1CDA-6F77-8A72-D19900EF8E14}"/>
          </ac:spMkLst>
        </pc:spChg>
        <pc:spChg chg="del">
          <ac:chgData name="Dr Ahmed Elshazly" userId="92faafa7-b1de-4194-ac20-c5423e5d0806" providerId="ADAL" clId="{591B1513-E534-4A55-B858-A57CE2E401C3}" dt="2026-02-28T21:29:18.697" v="252" actId="478"/>
          <ac:spMkLst>
            <pc:docMk/>
            <pc:sldMk cId="1677802666" sldId="275"/>
            <ac:spMk id="11" creationId="{25F756DD-378F-8106-A5E1-F508458A6A8A}"/>
          </ac:spMkLst>
        </pc:spChg>
        <pc:spChg chg="del">
          <ac:chgData name="Dr Ahmed Elshazly" userId="92faafa7-b1de-4194-ac20-c5423e5d0806" providerId="ADAL" clId="{591B1513-E534-4A55-B858-A57CE2E401C3}" dt="2026-02-28T21:29:17.251" v="251" actId="478"/>
          <ac:spMkLst>
            <pc:docMk/>
            <pc:sldMk cId="1677802666" sldId="275"/>
            <ac:spMk id="12" creationId="{FA9B1136-46F5-37D9-41DE-50DB3F7A73B3}"/>
          </ac:spMkLst>
        </pc:spChg>
        <pc:spChg chg="del mod">
          <ac:chgData name="Dr Ahmed Elshazly" userId="92faafa7-b1de-4194-ac20-c5423e5d0806" providerId="ADAL" clId="{591B1513-E534-4A55-B858-A57CE2E401C3}" dt="2026-02-28T21:29:15.310" v="249" actId="478"/>
          <ac:spMkLst>
            <pc:docMk/>
            <pc:sldMk cId="1677802666" sldId="275"/>
            <ac:spMk id="13" creationId="{BA4BC118-5861-8ECF-2AAE-85697C5E37AE}"/>
          </ac:spMkLst>
        </pc:spChg>
        <pc:spChg chg="mod">
          <ac:chgData name="Dr Ahmed Elshazly" userId="92faafa7-b1de-4194-ac20-c5423e5d0806" providerId="ADAL" clId="{591B1513-E534-4A55-B858-A57CE2E401C3}" dt="2026-02-28T21:31:39.825" v="313" actId="1076"/>
          <ac:spMkLst>
            <pc:docMk/>
            <pc:sldMk cId="1677802666" sldId="275"/>
            <ac:spMk id="14" creationId="{013CD53A-7AD2-5338-82D5-D84F0F127153}"/>
          </ac:spMkLst>
        </pc:spChg>
        <pc:spChg chg="del">
          <ac:chgData name="Dr Ahmed Elshazly" userId="92faafa7-b1de-4194-ac20-c5423e5d0806" providerId="ADAL" clId="{591B1513-E534-4A55-B858-A57CE2E401C3}" dt="2026-02-28T21:29:17.251" v="251" actId="478"/>
          <ac:spMkLst>
            <pc:docMk/>
            <pc:sldMk cId="1677802666" sldId="275"/>
            <ac:spMk id="15" creationId="{4B8E738C-8CEE-303F-640E-4D47266124FA}"/>
          </ac:spMkLst>
        </pc:spChg>
        <pc:spChg chg="del mod">
          <ac:chgData name="Dr Ahmed Elshazly" userId="92faafa7-b1de-4194-ac20-c5423e5d0806" providerId="ADAL" clId="{591B1513-E534-4A55-B858-A57CE2E401C3}" dt="2026-02-28T21:29:16.253" v="250" actId="478"/>
          <ac:spMkLst>
            <pc:docMk/>
            <pc:sldMk cId="1677802666" sldId="275"/>
            <ac:spMk id="16" creationId="{DABCC12D-FCF7-5577-17B6-BC67D5989FB6}"/>
          </ac:spMkLst>
        </pc:spChg>
        <pc:spChg chg="del">
          <ac:chgData name="Dr Ahmed Elshazly" userId="92faafa7-b1de-4194-ac20-c5423e5d0806" providerId="ADAL" clId="{591B1513-E534-4A55-B858-A57CE2E401C3}" dt="2026-02-28T21:29:18.697" v="252" actId="478"/>
          <ac:spMkLst>
            <pc:docMk/>
            <pc:sldMk cId="1677802666" sldId="275"/>
            <ac:spMk id="17" creationId="{41A12D83-AF6F-52D6-BBF7-A1B02A0297E6}"/>
          </ac:spMkLst>
        </pc:spChg>
        <pc:spChg chg="add mod">
          <ac:chgData name="Dr Ahmed Elshazly" userId="92faafa7-b1de-4194-ac20-c5423e5d0806" providerId="ADAL" clId="{591B1513-E534-4A55-B858-A57CE2E401C3}" dt="2026-02-28T21:31:42.864" v="314" actId="1076"/>
          <ac:spMkLst>
            <pc:docMk/>
            <pc:sldMk cId="1677802666" sldId="275"/>
            <ac:spMk id="20" creationId="{ECDA7C0C-598A-05F8-ED11-3EAC052D711B}"/>
          </ac:spMkLst>
        </pc:spChg>
        <pc:spChg chg="add del mod">
          <ac:chgData name="Dr Ahmed Elshazly" userId="92faafa7-b1de-4194-ac20-c5423e5d0806" providerId="ADAL" clId="{591B1513-E534-4A55-B858-A57CE2E401C3}" dt="2026-02-28T21:32:26.984" v="331" actId="478"/>
          <ac:spMkLst>
            <pc:docMk/>
            <pc:sldMk cId="1677802666" sldId="275"/>
            <ac:spMk id="21" creationId="{8F11DD95-0F3B-EA2D-7E9B-6E0F21725163}"/>
          </ac:spMkLst>
        </pc:spChg>
        <pc:spChg chg="add mod">
          <ac:chgData name="Dr Ahmed Elshazly" userId="92faafa7-b1de-4194-ac20-c5423e5d0806" providerId="ADAL" clId="{591B1513-E534-4A55-B858-A57CE2E401C3}" dt="2026-02-28T21:32:16.051" v="326" actId="1076"/>
          <ac:spMkLst>
            <pc:docMk/>
            <pc:sldMk cId="1677802666" sldId="275"/>
            <ac:spMk id="22" creationId="{693ABBF9-A3EF-E434-91E9-80D9B761DB74}"/>
          </ac:spMkLst>
        </pc:spChg>
        <pc:spChg chg="add mod">
          <ac:chgData name="Dr Ahmed Elshazly" userId="92faafa7-b1de-4194-ac20-c5423e5d0806" providerId="ADAL" clId="{591B1513-E534-4A55-B858-A57CE2E401C3}" dt="2026-02-28T21:31:39.825" v="313" actId="1076"/>
          <ac:spMkLst>
            <pc:docMk/>
            <pc:sldMk cId="1677802666" sldId="275"/>
            <ac:spMk id="23" creationId="{07F70132-DD64-7C63-BF50-AB3DE2D70078}"/>
          </ac:spMkLst>
        </pc:spChg>
        <pc:spChg chg="add mod">
          <ac:chgData name="Dr Ahmed Elshazly" userId="92faafa7-b1de-4194-ac20-c5423e5d0806" providerId="ADAL" clId="{591B1513-E534-4A55-B858-A57CE2E401C3}" dt="2026-02-28T21:32:10.793" v="324" actId="1076"/>
          <ac:spMkLst>
            <pc:docMk/>
            <pc:sldMk cId="1677802666" sldId="275"/>
            <ac:spMk id="24" creationId="{66E5677D-44E3-B427-3ED5-BB89CB3C5980}"/>
          </ac:spMkLst>
        </pc:spChg>
        <pc:spChg chg="add mod">
          <ac:chgData name="Dr Ahmed Elshazly" userId="92faafa7-b1de-4194-ac20-c5423e5d0806" providerId="ADAL" clId="{591B1513-E534-4A55-B858-A57CE2E401C3}" dt="2026-02-28T21:32:13.612" v="325" actId="1076"/>
          <ac:spMkLst>
            <pc:docMk/>
            <pc:sldMk cId="1677802666" sldId="275"/>
            <ac:spMk id="25" creationId="{E1488FE0-8299-A8CA-EA35-8AF0154B239E}"/>
          </ac:spMkLst>
        </pc:spChg>
        <pc:spChg chg="add mod">
          <ac:chgData name="Dr Ahmed Elshazly" userId="92faafa7-b1de-4194-ac20-c5423e5d0806" providerId="ADAL" clId="{591B1513-E534-4A55-B858-A57CE2E401C3}" dt="2026-02-28T21:31:42.864" v="314" actId="1076"/>
          <ac:spMkLst>
            <pc:docMk/>
            <pc:sldMk cId="1677802666" sldId="275"/>
            <ac:spMk id="27" creationId="{D854CA7E-2A4C-F57F-A82D-2DE106897A7B}"/>
          </ac:spMkLst>
        </pc:spChg>
        <pc:spChg chg="add mod">
          <ac:chgData name="Dr Ahmed Elshazly" userId="92faafa7-b1de-4194-ac20-c5423e5d0806" providerId="ADAL" clId="{591B1513-E534-4A55-B858-A57CE2E401C3}" dt="2026-02-28T21:31:17.330" v="304" actId="14100"/>
          <ac:spMkLst>
            <pc:docMk/>
            <pc:sldMk cId="1677802666" sldId="275"/>
            <ac:spMk id="28" creationId="{9EA0F444-9AE8-FE07-72B0-8A27AEF3177F}"/>
          </ac:spMkLst>
        </pc:spChg>
        <pc:spChg chg="add mod">
          <ac:chgData name="Dr Ahmed Elshazly" userId="92faafa7-b1de-4194-ac20-c5423e5d0806" providerId="ADAL" clId="{591B1513-E534-4A55-B858-A57CE2E401C3}" dt="2026-02-28T21:31:20.478" v="305" actId="1076"/>
          <ac:spMkLst>
            <pc:docMk/>
            <pc:sldMk cId="1677802666" sldId="275"/>
            <ac:spMk id="29" creationId="{1387F313-AFD8-BAA5-AF7F-97C2EAF00A40}"/>
          </ac:spMkLst>
        </pc:spChg>
        <pc:spChg chg="add mod">
          <ac:chgData name="Dr Ahmed Elshazly" userId="92faafa7-b1de-4194-ac20-c5423e5d0806" providerId="ADAL" clId="{591B1513-E534-4A55-B858-A57CE2E401C3}" dt="2026-02-28T21:32:04.411" v="323" actId="1076"/>
          <ac:spMkLst>
            <pc:docMk/>
            <pc:sldMk cId="1677802666" sldId="275"/>
            <ac:spMk id="30" creationId="{CF48EA4B-0D61-282D-F2A1-3ADD2CE79B14}"/>
          </ac:spMkLst>
        </pc:spChg>
        <pc:picChg chg="mod ord modCrop">
          <ac:chgData name="Dr Ahmed Elshazly" userId="92faafa7-b1de-4194-ac20-c5423e5d0806" providerId="ADAL" clId="{591B1513-E534-4A55-B858-A57CE2E401C3}" dt="2026-02-28T21:31:39.825" v="313" actId="1076"/>
          <ac:picMkLst>
            <pc:docMk/>
            <pc:sldMk cId="1677802666" sldId="275"/>
            <ac:picMk id="2" creationId="{BAC75292-C2B0-3D80-888F-246981DEF610}"/>
          </ac:picMkLst>
        </pc:picChg>
        <pc:picChg chg="add mod modCrop">
          <ac:chgData name="Dr Ahmed Elshazly" userId="92faafa7-b1de-4194-ac20-c5423e5d0806" providerId="ADAL" clId="{591B1513-E534-4A55-B858-A57CE2E401C3}" dt="2026-02-28T21:31:42.864" v="314" actId="1076"/>
          <ac:picMkLst>
            <pc:docMk/>
            <pc:sldMk cId="1677802666" sldId="275"/>
            <ac:picMk id="3" creationId="{3663C03C-2589-AC64-B4F3-CEE1A1AED88F}"/>
          </ac:picMkLst>
        </pc:picChg>
        <pc:picChg chg="del">
          <ac:chgData name="Dr Ahmed Elshazly" userId="92faafa7-b1de-4194-ac20-c5423e5d0806" providerId="ADAL" clId="{591B1513-E534-4A55-B858-A57CE2E401C3}" dt="2026-02-28T21:28:48.238" v="242" actId="478"/>
          <ac:picMkLst>
            <pc:docMk/>
            <pc:sldMk cId="1677802666" sldId="275"/>
            <ac:picMk id="5" creationId="{915E9194-9E39-0282-1A75-A0F3A84DF49B}"/>
          </ac:picMkLst>
        </pc:picChg>
        <pc:picChg chg="del">
          <ac:chgData name="Dr Ahmed Elshazly" userId="92faafa7-b1de-4194-ac20-c5423e5d0806" providerId="ADAL" clId="{591B1513-E534-4A55-B858-A57CE2E401C3}" dt="2026-02-28T21:28:52.194" v="245" actId="478"/>
          <ac:picMkLst>
            <pc:docMk/>
            <pc:sldMk cId="1677802666" sldId="275"/>
            <ac:picMk id="7" creationId="{6727B876-DCB2-B298-9D21-ED97621006AE}"/>
          </ac:picMkLst>
        </pc:picChg>
        <pc:picChg chg="del">
          <ac:chgData name="Dr Ahmed Elshazly" userId="92faafa7-b1de-4194-ac20-c5423e5d0806" providerId="ADAL" clId="{591B1513-E534-4A55-B858-A57CE2E401C3}" dt="2026-02-28T21:28:51.459" v="244" actId="478"/>
          <ac:picMkLst>
            <pc:docMk/>
            <pc:sldMk cId="1677802666" sldId="275"/>
            <ac:picMk id="8" creationId="{9B180D05-6E54-DCC5-8C6D-80327D9B99C2}"/>
          </ac:picMkLst>
        </pc:picChg>
        <pc:picChg chg="del">
          <ac:chgData name="Dr Ahmed Elshazly" userId="92faafa7-b1de-4194-ac20-c5423e5d0806" providerId="ADAL" clId="{591B1513-E534-4A55-B858-A57CE2E401C3}" dt="2026-02-28T21:28:50.641" v="243" actId="478"/>
          <ac:picMkLst>
            <pc:docMk/>
            <pc:sldMk cId="1677802666" sldId="275"/>
            <ac:picMk id="9" creationId="{69FADE87-0708-1578-7881-CD8009A42D5C}"/>
          </ac:picMkLst>
        </pc:picChg>
        <pc:picChg chg="add mod modCrop">
          <ac:chgData name="Dr Ahmed Elshazly" userId="92faafa7-b1de-4194-ac20-c5423e5d0806" providerId="ADAL" clId="{591B1513-E534-4A55-B858-A57CE2E401C3}" dt="2026-02-28T21:31:20.478" v="305" actId="1076"/>
          <ac:picMkLst>
            <pc:docMk/>
            <pc:sldMk cId="1677802666" sldId="275"/>
            <ac:picMk id="10" creationId="{DCC2AB0C-DEA5-F767-773B-0D80789FF79F}"/>
          </ac:picMkLst>
        </pc:picChg>
        <pc:picChg chg="add mod modCrop">
          <ac:chgData name="Dr Ahmed Elshazly" userId="92faafa7-b1de-4194-ac20-c5423e5d0806" providerId="ADAL" clId="{591B1513-E534-4A55-B858-A57CE2E401C3}" dt="2026-02-28T21:31:59.961" v="321" actId="1076"/>
          <ac:picMkLst>
            <pc:docMk/>
            <pc:sldMk cId="1677802666" sldId="275"/>
            <ac:picMk id="18" creationId="{8A848FED-D93F-9CC1-A3AC-866A7F5C3481}"/>
          </ac:picMkLst>
        </pc:picChg>
        <pc:picChg chg="mod modCrop">
          <ac:chgData name="Dr Ahmed Elshazly" userId="92faafa7-b1de-4194-ac20-c5423e5d0806" providerId="ADAL" clId="{591B1513-E534-4A55-B858-A57CE2E401C3}" dt="2026-02-28T21:31:09.446" v="302" actId="1076"/>
          <ac:picMkLst>
            <pc:docMk/>
            <pc:sldMk cId="1677802666" sldId="275"/>
            <ac:picMk id="19" creationId="{CB9F5814-6FF9-F46F-985A-B0A352AA9A40}"/>
          </ac:picMkLst>
        </pc:picChg>
        <pc:picChg chg="add del mod modCrop">
          <ac:chgData name="Dr Ahmed Elshazly" userId="92faafa7-b1de-4194-ac20-c5423e5d0806" providerId="ADAL" clId="{591B1513-E534-4A55-B858-A57CE2E401C3}" dt="2026-02-28T21:32:25.950" v="330" actId="478"/>
          <ac:picMkLst>
            <pc:docMk/>
            <pc:sldMk cId="1677802666" sldId="275"/>
            <ac:picMk id="26" creationId="{A125B5B7-87E4-4407-4C29-A8D8A98EEF59}"/>
          </ac:picMkLst>
        </pc:picChg>
      </pc:sldChg>
      <pc:sldChg chg="modSp mod ord">
        <pc:chgData name="Dr Ahmed Elshazly" userId="92faafa7-b1de-4194-ac20-c5423e5d0806" providerId="ADAL" clId="{591B1513-E534-4A55-B858-A57CE2E401C3}" dt="2026-02-28T21:20:04.057" v="42"/>
        <pc:sldMkLst>
          <pc:docMk/>
          <pc:sldMk cId="3285137656" sldId="276"/>
        </pc:sldMkLst>
        <pc:spChg chg="mod">
          <ac:chgData name="Dr Ahmed Elshazly" userId="92faafa7-b1de-4194-ac20-c5423e5d0806" providerId="ADAL" clId="{591B1513-E534-4A55-B858-A57CE2E401C3}" dt="2026-02-28T21:19:29.209" v="38" actId="20577"/>
          <ac:spMkLst>
            <pc:docMk/>
            <pc:sldMk cId="3285137656" sldId="276"/>
            <ac:spMk id="4" creationId="{7D0E917E-48DF-86D5-3310-496858CDBE09}"/>
          </ac:spMkLst>
        </pc:spChg>
      </pc:sldChg>
      <pc:sldChg chg="modSp mod ord">
        <pc:chgData name="Dr Ahmed Elshazly" userId="92faafa7-b1de-4194-ac20-c5423e5d0806" providerId="ADAL" clId="{591B1513-E534-4A55-B858-A57CE2E401C3}" dt="2026-02-28T21:20:27.387" v="48" actId="1076"/>
        <pc:sldMkLst>
          <pc:docMk/>
          <pc:sldMk cId="3450603217" sldId="277"/>
        </pc:sldMkLst>
        <pc:spChg chg="mod">
          <ac:chgData name="Dr Ahmed Elshazly" userId="92faafa7-b1de-4194-ac20-c5423e5d0806" providerId="ADAL" clId="{591B1513-E534-4A55-B858-A57CE2E401C3}" dt="2026-02-28T21:20:27.387" v="48" actId="1076"/>
          <ac:spMkLst>
            <pc:docMk/>
            <pc:sldMk cId="3450603217" sldId="277"/>
            <ac:spMk id="4" creationId="{751DE470-3F4E-0C56-A278-9B3A6AAB7A70}"/>
          </ac:spMkLst>
        </pc:spChg>
      </pc:sldChg>
      <pc:sldChg chg="modSp mod">
        <pc:chgData name="Dr Ahmed Elshazly" userId="92faafa7-b1de-4194-ac20-c5423e5d0806" providerId="ADAL" clId="{591B1513-E534-4A55-B858-A57CE2E401C3}" dt="2026-02-28T21:34:34.074" v="343" actId="20577"/>
        <pc:sldMkLst>
          <pc:docMk/>
          <pc:sldMk cId="1637957765" sldId="278"/>
        </pc:sldMkLst>
        <pc:spChg chg="mod">
          <ac:chgData name="Dr Ahmed Elshazly" userId="92faafa7-b1de-4194-ac20-c5423e5d0806" providerId="ADAL" clId="{591B1513-E534-4A55-B858-A57CE2E401C3}" dt="2026-02-28T21:34:34.074" v="343" actId="20577"/>
          <ac:spMkLst>
            <pc:docMk/>
            <pc:sldMk cId="1637957765" sldId="278"/>
            <ac:spMk id="4" creationId="{510BE27C-7456-C3FF-2775-6951EB23F2AD}"/>
          </ac:spMkLst>
        </pc:spChg>
      </pc:sldChg>
      <pc:sldChg chg="modSp mod ord">
        <pc:chgData name="Dr Ahmed Elshazly" userId="92faafa7-b1de-4194-ac20-c5423e5d0806" providerId="ADAL" clId="{591B1513-E534-4A55-B858-A57CE2E401C3}" dt="2026-02-28T21:51:40.776" v="658" actId="20577"/>
        <pc:sldMkLst>
          <pc:docMk/>
          <pc:sldMk cId="3546048745" sldId="279"/>
        </pc:sldMkLst>
        <pc:spChg chg="mod">
          <ac:chgData name="Dr Ahmed Elshazly" userId="92faafa7-b1de-4194-ac20-c5423e5d0806" providerId="ADAL" clId="{591B1513-E534-4A55-B858-A57CE2E401C3}" dt="2026-02-28T21:51:40.776" v="658" actId="20577"/>
          <ac:spMkLst>
            <pc:docMk/>
            <pc:sldMk cId="3546048745" sldId="279"/>
            <ac:spMk id="4" creationId="{17AEE205-5CD2-5B50-433A-3C2D74C63446}"/>
          </ac:spMkLst>
        </pc:spChg>
      </pc:sldChg>
      <pc:sldChg chg="modSp mod">
        <pc:chgData name="Dr Ahmed Elshazly" userId="92faafa7-b1de-4194-ac20-c5423e5d0806" providerId="ADAL" clId="{591B1513-E534-4A55-B858-A57CE2E401C3}" dt="2026-02-28T22:11:29.754" v="1061" actId="20577"/>
        <pc:sldMkLst>
          <pc:docMk/>
          <pc:sldMk cId="2875477353" sldId="280"/>
        </pc:sldMkLst>
        <pc:spChg chg="mod">
          <ac:chgData name="Dr Ahmed Elshazly" userId="92faafa7-b1de-4194-ac20-c5423e5d0806" providerId="ADAL" clId="{591B1513-E534-4A55-B858-A57CE2E401C3}" dt="2026-02-28T22:11:29.754" v="1061" actId="20577"/>
          <ac:spMkLst>
            <pc:docMk/>
            <pc:sldMk cId="2875477353" sldId="280"/>
            <ac:spMk id="4" creationId="{8A91F96A-634D-1F54-578D-F54221AB22C2}"/>
          </ac:spMkLst>
        </pc:spChg>
      </pc:sldChg>
      <pc:sldChg chg="del">
        <pc:chgData name="Dr Ahmed Elshazly" userId="92faafa7-b1de-4194-ac20-c5423e5d0806" providerId="ADAL" clId="{591B1513-E534-4A55-B858-A57CE2E401C3}" dt="2026-02-28T21:51:16.317" v="655" actId="47"/>
        <pc:sldMkLst>
          <pc:docMk/>
          <pc:sldMk cId="279313396" sldId="281"/>
        </pc:sldMkLst>
      </pc:sldChg>
      <pc:sldChg chg="modSp mod">
        <pc:chgData name="Dr Ahmed Elshazly" userId="92faafa7-b1de-4194-ac20-c5423e5d0806" providerId="ADAL" clId="{591B1513-E534-4A55-B858-A57CE2E401C3}" dt="2026-02-28T22:14:14.346" v="1112" actId="20577"/>
        <pc:sldMkLst>
          <pc:docMk/>
          <pc:sldMk cId="1836456833" sldId="282"/>
        </pc:sldMkLst>
        <pc:spChg chg="mod">
          <ac:chgData name="Dr Ahmed Elshazly" userId="92faafa7-b1de-4194-ac20-c5423e5d0806" providerId="ADAL" clId="{591B1513-E534-4A55-B858-A57CE2E401C3}" dt="2026-02-28T22:14:14.346" v="1112" actId="20577"/>
          <ac:spMkLst>
            <pc:docMk/>
            <pc:sldMk cId="1836456833" sldId="282"/>
            <ac:spMk id="4" creationId="{0F6D7D40-EE01-524C-FBE1-1B7CE8AD5C4F}"/>
          </ac:spMkLst>
        </pc:spChg>
      </pc:sldChg>
      <pc:sldChg chg="modSp mod">
        <pc:chgData name="Dr Ahmed Elshazly" userId="92faafa7-b1de-4194-ac20-c5423e5d0806" providerId="ADAL" clId="{591B1513-E534-4A55-B858-A57CE2E401C3}" dt="2026-02-28T22:14:27.382" v="1114" actId="20577"/>
        <pc:sldMkLst>
          <pc:docMk/>
          <pc:sldMk cId="2031762361" sldId="283"/>
        </pc:sldMkLst>
        <pc:spChg chg="mod">
          <ac:chgData name="Dr Ahmed Elshazly" userId="92faafa7-b1de-4194-ac20-c5423e5d0806" providerId="ADAL" clId="{591B1513-E534-4A55-B858-A57CE2E401C3}" dt="2026-02-28T22:14:27.382" v="1114" actId="20577"/>
          <ac:spMkLst>
            <pc:docMk/>
            <pc:sldMk cId="2031762361" sldId="283"/>
            <ac:spMk id="4" creationId="{2147C4FB-1948-E83F-BEFB-60639EDDFEDD}"/>
          </ac:spMkLst>
        </pc:spChg>
      </pc:sldChg>
      <pc:sldChg chg="addSp delSp modSp mod ord">
        <pc:chgData name="Dr Ahmed Elshazly" userId="92faafa7-b1de-4194-ac20-c5423e5d0806" providerId="ADAL" clId="{591B1513-E534-4A55-B858-A57CE2E401C3}" dt="2026-02-28T22:13:37.062" v="1106" actId="20577"/>
        <pc:sldMkLst>
          <pc:docMk/>
          <pc:sldMk cId="2271389516" sldId="284"/>
        </pc:sldMkLst>
        <pc:spChg chg="add mod">
          <ac:chgData name="Dr Ahmed Elshazly" userId="92faafa7-b1de-4194-ac20-c5423e5d0806" providerId="ADAL" clId="{591B1513-E534-4A55-B858-A57CE2E401C3}" dt="2026-02-28T22:13:37.062" v="1106" actId="20577"/>
          <ac:spMkLst>
            <pc:docMk/>
            <pc:sldMk cId="2271389516" sldId="284"/>
            <ac:spMk id="2" creationId="{DE5FD534-AB9D-6D22-0248-A161D1FD7C3C}"/>
          </ac:spMkLst>
        </pc:spChg>
        <pc:spChg chg="del">
          <ac:chgData name="Dr Ahmed Elshazly" userId="92faafa7-b1de-4194-ac20-c5423e5d0806" providerId="ADAL" clId="{591B1513-E534-4A55-B858-A57CE2E401C3}" dt="2026-02-28T22:13:30.251" v="1104" actId="478"/>
          <ac:spMkLst>
            <pc:docMk/>
            <pc:sldMk cId="2271389516" sldId="284"/>
            <ac:spMk id="4" creationId="{5B008ECF-4857-4C46-8D07-C29509A46ABE}"/>
          </ac:spMkLst>
        </pc:spChg>
      </pc:sldChg>
      <pc:sldChg chg="addSp modSp mod">
        <pc:chgData name="Dr Ahmed Elshazly" userId="92faafa7-b1de-4194-ac20-c5423e5d0806" providerId="ADAL" clId="{591B1513-E534-4A55-B858-A57CE2E401C3}" dt="2026-02-28T21:33:28.368" v="336" actId="20577"/>
        <pc:sldMkLst>
          <pc:docMk/>
          <pc:sldMk cId="521303939" sldId="285"/>
        </pc:sldMkLst>
        <pc:spChg chg="add mod">
          <ac:chgData name="Dr Ahmed Elshazly" userId="92faafa7-b1de-4194-ac20-c5423e5d0806" providerId="ADAL" clId="{591B1513-E534-4A55-B858-A57CE2E401C3}" dt="2026-02-28T21:33:28.368" v="336" actId="20577"/>
          <ac:spMkLst>
            <pc:docMk/>
            <pc:sldMk cId="521303939" sldId="285"/>
            <ac:spMk id="2" creationId="{F437EBAA-58E9-FC34-0A3B-EC9B0966D3F6}"/>
          </ac:spMkLst>
        </pc:spChg>
      </pc:sldChg>
      <pc:sldChg chg="addSp delSp modSp new mod">
        <pc:chgData name="Dr Ahmed Elshazly" userId="92faafa7-b1de-4194-ac20-c5423e5d0806" providerId="ADAL" clId="{591B1513-E534-4A55-B858-A57CE2E401C3}" dt="2026-02-28T21:23:26.084" v="121" actId="14100"/>
        <pc:sldMkLst>
          <pc:docMk/>
          <pc:sldMk cId="1908728088" sldId="286"/>
        </pc:sldMkLst>
        <pc:spChg chg="del">
          <ac:chgData name="Dr Ahmed Elshazly" userId="92faafa7-b1de-4194-ac20-c5423e5d0806" providerId="ADAL" clId="{591B1513-E534-4A55-B858-A57CE2E401C3}" dt="2026-02-28T21:20:34.118" v="49" actId="478"/>
          <ac:spMkLst>
            <pc:docMk/>
            <pc:sldMk cId="1908728088" sldId="286"/>
            <ac:spMk id="2" creationId="{211BE344-4D28-62BF-6BCC-3524EB7D380C}"/>
          </ac:spMkLst>
        </pc:spChg>
        <pc:spChg chg="del">
          <ac:chgData name="Dr Ahmed Elshazly" userId="92faafa7-b1de-4194-ac20-c5423e5d0806" providerId="ADAL" clId="{591B1513-E534-4A55-B858-A57CE2E401C3}" dt="2026-02-28T21:20:37.013" v="50" actId="478"/>
          <ac:spMkLst>
            <pc:docMk/>
            <pc:sldMk cId="1908728088" sldId="286"/>
            <ac:spMk id="3" creationId="{1B776B28-DE27-DB6C-6357-D4C26ECDBEE8}"/>
          </ac:spMkLst>
        </pc:spChg>
        <pc:spChg chg="add mod">
          <ac:chgData name="Dr Ahmed Elshazly" userId="92faafa7-b1de-4194-ac20-c5423e5d0806" providerId="ADAL" clId="{591B1513-E534-4A55-B858-A57CE2E401C3}" dt="2026-02-28T21:20:44.407" v="52" actId="20577"/>
          <ac:spMkLst>
            <pc:docMk/>
            <pc:sldMk cId="1908728088" sldId="286"/>
            <ac:spMk id="4" creationId="{434F1EC3-1931-B4D8-1621-F314FAC5AFC2}"/>
          </ac:spMkLst>
        </pc:spChg>
        <pc:spChg chg="add mod">
          <ac:chgData name="Dr Ahmed Elshazly" userId="92faafa7-b1de-4194-ac20-c5423e5d0806" providerId="ADAL" clId="{591B1513-E534-4A55-B858-A57CE2E401C3}" dt="2026-02-28T21:22:39.815" v="103" actId="1076"/>
          <ac:spMkLst>
            <pc:docMk/>
            <pc:sldMk cId="1908728088" sldId="286"/>
            <ac:spMk id="7" creationId="{FB4AE9F9-B7E0-1E08-04A1-B83665CB9341}"/>
          </ac:spMkLst>
        </pc:spChg>
        <pc:spChg chg="add mod">
          <ac:chgData name="Dr Ahmed Elshazly" userId="92faafa7-b1de-4194-ac20-c5423e5d0806" providerId="ADAL" clId="{591B1513-E534-4A55-B858-A57CE2E401C3}" dt="2026-02-28T21:22:18.670" v="96" actId="1076"/>
          <ac:spMkLst>
            <pc:docMk/>
            <pc:sldMk cId="1908728088" sldId="286"/>
            <ac:spMk id="8" creationId="{A395F5A1-E78C-1D35-4A59-A4299D4D76E6}"/>
          </ac:spMkLst>
        </pc:spChg>
        <pc:spChg chg="add mod">
          <ac:chgData name="Dr Ahmed Elshazly" userId="92faafa7-b1de-4194-ac20-c5423e5d0806" providerId="ADAL" clId="{591B1513-E534-4A55-B858-A57CE2E401C3}" dt="2026-02-28T21:21:58.701" v="85" actId="1076"/>
          <ac:spMkLst>
            <pc:docMk/>
            <pc:sldMk cId="1908728088" sldId="286"/>
            <ac:spMk id="9" creationId="{0E4FE86F-A1EE-52E1-1B3E-E99A5FFB3C36}"/>
          </ac:spMkLst>
        </pc:spChg>
        <pc:spChg chg="add mod">
          <ac:chgData name="Dr Ahmed Elshazly" userId="92faafa7-b1de-4194-ac20-c5423e5d0806" providerId="ADAL" clId="{591B1513-E534-4A55-B858-A57CE2E401C3}" dt="2026-02-28T21:22:23.411" v="97" actId="1076"/>
          <ac:spMkLst>
            <pc:docMk/>
            <pc:sldMk cId="1908728088" sldId="286"/>
            <ac:spMk id="13" creationId="{0B5B68B4-5328-2DE2-2402-C17B29118EA2}"/>
          </ac:spMkLst>
        </pc:spChg>
        <pc:spChg chg="add mod">
          <ac:chgData name="Dr Ahmed Elshazly" userId="92faafa7-b1de-4194-ac20-c5423e5d0806" providerId="ADAL" clId="{591B1513-E534-4A55-B858-A57CE2E401C3}" dt="2026-02-28T21:22:23.411" v="97" actId="1076"/>
          <ac:spMkLst>
            <pc:docMk/>
            <pc:sldMk cId="1908728088" sldId="286"/>
            <ac:spMk id="14" creationId="{D547C473-86E0-E96D-E7CA-D6319F924B4A}"/>
          </ac:spMkLst>
        </pc:spChg>
        <pc:spChg chg="add mod">
          <ac:chgData name="Dr Ahmed Elshazly" userId="92faafa7-b1de-4194-ac20-c5423e5d0806" providerId="ADAL" clId="{591B1513-E534-4A55-B858-A57CE2E401C3}" dt="2026-02-28T21:22:39.815" v="103" actId="1076"/>
          <ac:spMkLst>
            <pc:docMk/>
            <pc:sldMk cId="1908728088" sldId="286"/>
            <ac:spMk id="15" creationId="{30713F33-3D88-65EC-F46B-64463D63A2EC}"/>
          </ac:spMkLst>
        </pc:spChg>
        <pc:spChg chg="add mod">
          <ac:chgData name="Dr Ahmed Elshazly" userId="92faafa7-b1de-4194-ac20-c5423e5d0806" providerId="ADAL" clId="{591B1513-E534-4A55-B858-A57CE2E401C3}" dt="2026-02-28T21:21:55.527" v="84" actId="1076"/>
          <ac:spMkLst>
            <pc:docMk/>
            <pc:sldMk cId="1908728088" sldId="286"/>
            <ac:spMk id="16" creationId="{7056A1DA-6B41-9802-FC1B-993948EA9E1C}"/>
          </ac:spMkLst>
        </pc:spChg>
        <pc:spChg chg="add mod">
          <ac:chgData name="Dr Ahmed Elshazly" userId="92faafa7-b1de-4194-ac20-c5423e5d0806" providerId="ADAL" clId="{591B1513-E534-4A55-B858-A57CE2E401C3}" dt="2026-02-28T21:22:18.670" v="96" actId="1076"/>
          <ac:spMkLst>
            <pc:docMk/>
            <pc:sldMk cId="1908728088" sldId="286"/>
            <ac:spMk id="18" creationId="{608BC473-1D93-BB92-16CC-A0F26052CE8A}"/>
          </ac:spMkLst>
        </pc:spChg>
        <pc:spChg chg="add mod">
          <ac:chgData name="Dr Ahmed Elshazly" userId="92faafa7-b1de-4194-ac20-c5423e5d0806" providerId="ADAL" clId="{591B1513-E534-4A55-B858-A57CE2E401C3}" dt="2026-02-28T21:22:27.276" v="99" actId="1076"/>
          <ac:spMkLst>
            <pc:docMk/>
            <pc:sldMk cId="1908728088" sldId="286"/>
            <ac:spMk id="19" creationId="{4F57B460-6DEA-C531-65DD-13EEE4685EE1}"/>
          </ac:spMkLst>
        </pc:spChg>
        <pc:spChg chg="add mod">
          <ac:chgData name="Dr Ahmed Elshazly" userId="92faafa7-b1de-4194-ac20-c5423e5d0806" providerId="ADAL" clId="{591B1513-E534-4A55-B858-A57CE2E401C3}" dt="2026-02-28T21:22:27.276" v="99" actId="1076"/>
          <ac:spMkLst>
            <pc:docMk/>
            <pc:sldMk cId="1908728088" sldId="286"/>
            <ac:spMk id="20" creationId="{0E71773F-907B-99AA-3962-09A874AE5034}"/>
          </ac:spMkLst>
        </pc:spChg>
        <pc:spChg chg="add mod">
          <ac:chgData name="Dr Ahmed Elshazly" userId="92faafa7-b1de-4194-ac20-c5423e5d0806" providerId="ADAL" clId="{591B1513-E534-4A55-B858-A57CE2E401C3}" dt="2026-02-28T21:22:53.610" v="106" actId="14100"/>
          <ac:spMkLst>
            <pc:docMk/>
            <pc:sldMk cId="1908728088" sldId="286"/>
            <ac:spMk id="21" creationId="{7D4EA3CC-8470-A04A-8D2E-6979514BFF8C}"/>
          </ac:spMkLst>
        </pc:spChg>
        <pc:spChg chg="add mod">
          <ac:chgData name="Dr Ahmed Elshazly" userId="92faafa7-b1de-4194-ac20-c5423e5d0806" providerId="ADAL" clId="{591B1513-E534-4A55-B858-A57CE2E401C3}" dt="2026-02-28T21:23:00.659" v="108" actId="1076"/>
          <ac:spMkLst>
            <pc:docMk/>
            <pc:sldMk cId="1908728088" sldId="286"/>
            <ac:spMk id="22" creationId="{1E5696D0-F3D7-97E6-1965-7B7ABE46B1FD}"/>
          </ac:spMkLst>
        </pc:spChg>
        <pc:spChg chg="add mod">
          <ac:chgData name="Dr Ahmed Elshazly" userId="92faafa7-b1de-4194-ac20-c5423e5d0806" providerId="ADAL" clId="{591B1513-E534-4A55-B858-A57CE2E401C3}" dt="2026-02-28T21:23:08.095" v="112" actId="14100"/>
          <ac:spMkLst>
            <pc:docMk/>
            <pc:sldMk cId="1908728088" sldId="286"/>
            <ac:spMk id="23" creationId="{DA5B47D4-C01E-10E1-67FE-27B11B0E9C0D}"/>
          </ac:spMkLst>
        </pc:spChg>
        <pc:spChg chg="add mod">
          <ac:chgData name="Dr Ahmed Elshazly" userId="92faafa7-b1de-4194-ac20-c5423e5d0806" providerId="ADAL" clId="{591B1513-E534-4A55-B858-A57CE2E401C3}" dt="2026-02-28T21:23:19.001" v="117" actId="1076"/>
          <ac:spMkLst>
            <pc:docMk/>
            <pc:sldMk cId="1908728088" sldId="286"/>
            <ac:spMk id="24" creationId="{34C9BAAD-1188-9598-3EA0-087B8BDA5352}"/>
          </ac:spMkLst>
        </pc:spChg>
        <pc:spChg chg="add mod">
          <ac:chgData name="Dr Ahmed Elshazly" userId="92faafa7-b1de-4194-ac20-c5423e5d0806" providerId="ADAL" clId="{591B1513-E534-4A55-B858-A57CE2E401C3}" dt="2026-02-28T21:23:26.084" v="121" actId="14100"/>
          <ac:spMkLst>
            <pc:docMk/>
            <pc:sldMk cId="1908728088" sldId="286"/>
            <ac:spMk id="25" creationId="{8EDD6F2E-BB95-CEC6-E3AC-CC06E174267D}"/>
          </ac:spMkLst>
        </pc:spChg>
        <pc:picChg chg="add mod modCrop">
          <ac:chgData name="Dr Ahmed Elshazly" userId="92faafa7-b1de-4194-ac20-c5423e5d0806" providerId="ADAL" clId="{591B1513-E534-4A55-B858-A57CE2E401C3}" dt="2026-02-28T21:22:28.787" v="100" actId="1076"/>
          <ac:picMkLst>
            <pc:docMk/>
            <pc:sldMk cId="1908728088" sldId="286"/>
            <ac:picMk id="5" creationId="{55C10614-D134-7398-EF37-A088FB53F171}"/>
          </ac:picMkLst>
        </pc:picChg>
        <pc:picChg chg="add mod ord modCrop">
          <ac:chgData name="Dr Ahmed Elshazly" userId="92faafa7-b1de-4194-ac20-c5423e5d0806" providerId="ADAL" clId="{591B1513-E534-4A55-B858-A57CE2E401C3}" dt="2026-02-28T21:22:35.927" v="102" actId="1076"/>
          <ac:picMkLst>
            <pc:docMk/>
            <pc:sldMk cId="1908728088" sldId="286"/>
            <ac:picMk id="6" creationId="{F1222D8B-372B-A82F-4F8D-EFDE1DA07133}"/>
          </ac:picMkLst>
        </pc:picChg>
        <pc:picChg chg="mod modCrop">
          <ac:chgData name="Dr Ahmed Elshazly" userId="92faafa7-b1de-4194-ac20-c5423e5d0806" providerId="ADAL" clId="{591B1513-E534-4A55-B858-A57CE2E401C3}" dt="2026-02-28T21:22:13.929" v="95" actId="1076"/>
          <ac:picMkLst>
            <pc:docMk/>
            <pc:sldMk cId="1908728088" sldId="286"/>
            <ac:picMk id="10" creationId="{6E568E85-FA71-7BE4-F553-F1988EE1B28D}"/>
          </ac:picMkLst>
        </pc:picChg>
        <pc:picChg chg="mod modCrop">
          <ac:chgData name="Dr Ahmed Elshazly" userId="92faafa7-b1de-4194-ac20-c5423e5d0806" providerId="ADAL" clId="{591B1513-E534-4A55-B858-A57CE2E401C3}" dt="2026-02-28T21:21:17.395" v="65" actId="1076"/>
          <ac:picMkLst>
            <pc:docMk/>
            <pc:sldMk cId="1908728088" sldId="286"/>
            <ac:picMk id="11" creationId="{5C8A2C7A-60D2-7499-4B3F-EB3DBB1E8791}"/>
          </ac:picMkLst>
        </pc:picChg>
        <pc:picChg chg="mod modCrop">
          <ac:chgData name="Dr Ahmed Elshazly" userId="92faafa7-b1de-4194-ac20-c5423e5d0806" providerId="ADAL" clId="{591B1513-E534-4A55-B858-A57CE2E401C3}" dt="2026-02-28T21:21:04.342" v="58" actId="1076"/>
          <ac:picMkLst>
            <pc:docMk/>
            <pc:sldMk cId="1908728088" sldId="286"/>
            <ac:picMk id="12" creationId="{31711474-0C45-E615-18CC-29F1CEBC0C1A}"/>
          </ac:picMkLst>
        </pc:picChg>
        <pc:cxnChg chg="del">
          <ac:chgData name="Dr Ahmed Elshazly" userId="92faafa7-b1de-4194-ac20-c5423e5d0806" providerId="ADAL" clId="{591B1513-E534-4A55-B858-A57CE2E401C3}" dt="2026-02-28T21:22:05.061" v="87" actId="478"/>
          <ac:cxnSpMkLst>
            <pc:docMk/>
            <pc:sldMk cId="1908728088" sldId="286"/>
            <ac:cxnSpMk id="17" creationId="{623F6F6C-0C2A-217E-2809-BAECC26928A8}"/>
          </ac:cxnSpMkLst>
        </pc:cxnChg>
      </pc:sldChg>
      <pc:sldChg chg="addSp delSp modSp new mod">
        <pc:chgData name="Dr Ahmed Elshazly" userId="92faafa7-b1de-4194-ac20-c5423e5d0806" providerId="ADAL" clId="{591B1513-E534-4A55-B858-A57CE2E401C3}" dt="2026-02-28T21:28:30.612" v="240" actId="1076"/>
        <pc:sldMkLst>
          <pc:docMk/>
          <pc:sldMk cId="3092309862" sldId="287"/>
        </pc:sldMkLst>
        <pc:spChg chg="del">
          <ac:chgData name="Dr Ahmed Elshazly" userId="92faafa7-b1de-4194-ac20-c5423e5d0806" providerId="ADAL" clId="{591B1513-E534-4A55-B858-A57CE2E401C3}" dt="2026-02-28T21:23:46.240" v="123" actId="478"/>
          <ac:spMkLst>
            <pc:docMk/>
            <pc:sldMk cId="3092309862" sldId="287"/>
            <ac:spMk id="2" creationId="{7F0B8446-60E5-4212-0FE6-6A2400B54920}"/>
          </ac:spMkLst>
        </pc:spChg>
        <pc:spChg chg="del">
          <ac:chgData name="Dr Ahmed Elshazly" userId="92faafa7-b1de-4194-ac20-c5423e5d0806" providerId="ADAL" clId="{591B1513-E534-4A55-B858-A57CE2E401C3}" dt="2026-02-28T21:23:46.240" v="123" actId="478"/>
          <ac:spMkLst>
            <pc:docMk/>
            <pc:sldMk cId="3092309862" sldId="287"/>
            <ac:spMk id="3" creationId="{344240A6-B3A6-712D-3B95-32CF881A36CC}"/>
          </ac:spMkLst>
        </pc:spChg>
        <pc:spChg chg="add mod">
          <ac:chgData name="Dr Ahmed Elshazly" userId="92faafa7-b1de-4194-ac20-c5423e5d0806" providerId="ADAL" clId="{591B1513-E534-4A55-B858-A57CE2E401C3}" dt="2026-02-28T21:23:54.439" v="125" actId="20577"/>
          <ac:spMkLst>
            <pc:docMk/>
            <pc:sldMk cId="3092309862" sldId="287"/>
            <ac:spMk id="4" creationId="{9E9CE927-C36F-1CA7-36F3-0E72F7FCC265}"/>
          </ac:spMkLst>
        </pc:spChg>
        <pc:spChg chg="add mod">
          <ac:chgData name="Dr Ahmed Elshazly" userId="92faafa7-b1de-4194-ac20-c5423e5d0806" providerId="ADAL" clId="{591B1513-E534-4A55-B858-A57CE2E401C3}" dt="2026-02-28T21:24:21.910" v="133" actId="1076"/>
          <ac:spMkLst>
            <pc:docMk/>
            <pc:sldMk cId="3092309862" sldId="287"/>
            <ac:spMk id="7" creationId="{DFE460BA-B0A4-69C4-F582-5498D8B40395}"/>
          </ac:spMkLst>
        </pc:spChg>
        <pc:spChg chg="mod">
          <ac:chgData name="Dr Ahmed Elshazly" userId="92faafa7-b1de-4194-ac20-c5423e5d0806" providerId="ADAL" clId="{591B1513-E534-4A55-B858-A57CE2E401C3}" dt="2026-02-28T21:27:16.149" v="211" actId="1076"/>
          <ac:spMkLst>
            <pc:docMk/>
            <pc:sldMk cId="3092309862" sldId="287"/>
            <ac:spMk id="10" creationId="{E5CD1878-C5E1-D64F-9BDE-27548B8545F7}"/>
          </ac:spMkLst>
        </pc:spChg>
        <pc:spChg chg="add mod">
          <ac:chgData name="Dr Ahmed Elshazly" userId="92faafa7-b1de-4194-ac20-c5423e5d0806" providerId="ADAL" clId="{591B1513-E534-4A55-B858-A57CE2E401C3}" dt="2026-02-28T21:26:32.145" v="195" actId="1037"/>
          <ac:spMkLst>
            <pc:docMk/>
            <pc:sldMk cId="3092309862" sldId="287"/>
            <ac:spMk id="11" creationId="{BF6BD2D1-DC9C-87D2-D050-E854953EE54D}"/>
          </ac:spMkLst>
        </pc:spChg>
        <pc:spChg chg="add mod">
          <ac:chgData name="Dr Ahmed Elshazly" userId="92faafa7-b1de-4194-ac20-c5423e5d0806" providerId="ADAL" clId="{591B1513-E534-4A55-B858-A57CE2E401C3}" dt="2026-02-28T21:24:18.807" v="132" actId="1076"/>
          <ac:spMkLst>
            <pc:docMk/>
            <pc:sldMk cId="3092309862" sldId="287"/>
            <ac:spMk id="12" creationId="{D2E197FB-B5CE-2ABA-A70C-FF1D4C318A2B}"/>
          </ac:spMkLst>
        </pc:spChg>
        <pc:spChg chg="add mod">
          <ac:chgData name="Dr Ahmed Elshazly" userId="92faafa7-b1de-4194-ac20-c5423e5d0806" providerId="ADAL" clId="{591B1513-E534-4A55-B858-A57CE2E401C3}" dt="2026-02-28T21:26:32.145" v="195" actId="1037"/>
          <ac:spMkLst>
            <pc:docMk/>
            <pc:sldMk cId="3092309862" sldId="287"/>
            <ac:spMk id="13" creationId="{7790BB83-AFA9-8B64-390A-E6ED495D7BF2}"/>
          </ac:spMkLst>
        </pc:spChg>
        <pc:spChg chg="add mod">
          <ac:chgData name="Dr Ahmed Elshazly" userId="92faafa7-b1de-4194-ac20-c5423e5d0806" providerId="ADAL" clId="{591B1513-E534-4A55-B858-A57CE2E401C3}" dt="2026-02-28T21:27:16.149" v="211" actId="1076"/>
          <ac:spMkLst>
            <pc:docMk/>
            <pc:sldMk cId="3092309862" sldId="287"/>
            <ac:spMk id="14" creationId="{658B9C70-DB90-5E31-2320-6CA8693DD48C}"/>
          </ac:spMkLst>
        </pc:spChg>
        <pc:spChg chg="add mod">
          <ac:chgData name="Dr Ahmed Elshazly" userId="92faafa7-b1de-4194-ac20-c5423e5d0806" providerId="ADAL" clId="{591B1513-E534-4A55-B858-A57CE2E401C3}" dt="2026-02-28T21:26:01.812" v="170" actId="1076"/>
          <ac:spMkLst>
            <pc:docMk/>
            <pc:sldMk cId="3092309862" sldId="287"/>
            <ac:spMk id="15" creationId="{FAF75855-FE54-1EC4-A112-7A970A28ECDA}"/>
          </ac:spMkLst>
        </pc:spChg>
        <pc:spChg chg="mod">
          <ac:chgData name="Dr Ahmed Elshazly" userId="92faafa7-b1de-4194-ac20-c5423e5d0806" providerId="ADAL" clId="{591B1513-E534-4A55-B858-A57CE2E401C3}" dt="2026-02-28T21:26:47.932" v="199" actId="1076"/>
          <ac:spMkLst>
            <pc:docMk/>
            <pc:sldMk cId="3092309862" sldId="287"/>
            <ac:spMk id="16" creationId="{FC92E3D3-B49E-24E1-971C-50D79A309041}"/>
          </ac:spMkLst>
        </pc:spChg>
        <pc:spChg chg="add mod">
          <ac:chgData name="Dr Ahmed Elshazly" userId="92faafa7-b1de-4194-ac20-c5423e5d0806" providerId="ADAL" clId="{591B1513-E534-4A55-B858-A57CE2E401C3}" dt="2026-02-28T21:27:31.396" v="217" actId="1076"/>
          <ac:spMkLst>
            <pc:docMk/>
            <pc:sldMk cId="3092309862" sldId="287"/>
            <ac:spMk id="17" creationId="{FF1887F5-2B59-2F28-1ACC-C97D8B45F24C}"/>
          </ac:spMkLst>
        </pc:spChg>
        <pc:spChg chg="add mod">
          <ac:chgData name="Dr Ahmed Elshazly" userId="92faafa7-b1de-4194-ac20-c5423e5d0806" providerId="ADAL" clId="{591B1513-E534-4A55-B858-A57CE2E401C3}" dt="2026-02-28T21:26:01.812" v="170" actId="1076"/>
          <ac:spMkLst>
            <pc:docMk/>
            <pc:sldMk cId="3092309862" sldId="287"/>
            <ac:spMk id="18" creationId="{2E42B576-B72A-97A2-A0D4-F02D3E247FE9}"/>
          </ac:spMkLst>
        </pc:spChg>
        <pc:spChg chg="add mod">
          <ac:chgData name="Dr Ahmed Elshazly" userId="92faafa7-b1de-4194-ac20-c5423e5d0806" providerId="ADAL" clId="{591B1513-E534-4A55-B858-A57CE2E401C3}" dt="2026-02-28T21:26:47.932" v="199" actId="1076"/>
          <ac:spMkLst>
            <pc:docMk/>
            <pc:sldMk cId="3092309862" sldId="287"/>
            <ac:spMk id="19" creationId="{94B180A6-1FB3-26A6-0DB9-188A3F3CBA26}"/>
          </ac:spMkLst>
        </pc:spChg>
        <pc:spChg chg="add mod">
          <ac:chgData name="Dr Ahmed Elshazly" userId="92faafa7-b1de-4194-ac20-c5423e5d0806" providerId="ADAL" clId="{591B1513-E534-4A55-B858-A57CE2E401C3}" dt="2026-02-28T21:27:31.396" v="217" actId="1076"/>
          <ac:spMkLst>
            <pc:docMk/>
            <pc:sldMk cId="3092309862" sldId="287"/>
            <ac:spMk id="20" creationId="{8974F6D6-E59F-4ECE-D215-8988971C3AFC}"/>
          </ac:spMkLst>
        </pc:spChg>
        <pc:spChg chg="add mod">
          <ac:chgData name="Dr Ahmed Elshazly" userId="92faafa7-b1de-4194-ac20-c5423e5d0806" providerId="ADAL" clId="{591B1513-E534-4A55-B858-A57CE2E401C3}" dt="2026-02-28T21:27:47.910" v="221" actId="14100"/>
          <ac:spMkLst>
            <pc:docMk/>
            <pc:sldMk cId="3092309862" sldId="287"/>
            <ac:spMk id="23" creationId="{8B866568-6BCB-00F2-BF20-28C57E9DB604}"/>
          </ac:spMkLst>
        </pc:spChg>
        <pc:spChg chg="add mod">
          <ac:chgData name="Dr Ahmed Elshazly" userId="92faafa7-b1de-4194-ac20-c5423e5d0806" providerId="ADAL" clId="{591B1513-E534-4A55-B858-A57CE2E401C3}" dt="2026-02-28T21:27:56.330" v="224" actId="1076"/>
          <ac:spMkLst>
            <pc:docMk/>
            <pc:sldMk cId="3092309862" sldId="287"/>
            <ac:spMk id="24" creationId="{4E4AF0C3-42C4-0A1A-EFFE-8C64B5532720}"/>
          </ac:spMkLst>
        </pc:spChg>
        <pc:spChg chg="add mod">
          <ac:chgData name="Dr Ahmed Elshazly" userId="92faafa7-b1de-4194-ac20-c5423e5d0806" providerId="ADAL" clId="{591B1513-E534-4A55-B858-A57CE2E401C3}" dt="2026-02-28T21:28:02.932" v="227" actId="14100"/>
          <ac:spMkLst>
            <pc:docMk/>
            <pc:sldMk cId="3092309862" sldId="287"/>
            <ac:spMk id="25" creationId="{208DD37F-5EAF-D5C6-7BD8-AB89D89DD780}"/>
          </ac:spMkLst>
        </pc:spChg>
        <pc:spChg chg="add mod">
          <ac:chgData name="Dr Ahmed Elshazly" userId="92faafa7-b1de-4194-ac20-c5423e5d0806" providerId="ADAL" clId="{591B1513-E534-4A55-B858-A57CE2E401C3}" dt="2026-02-28T21:28:09.382" v="231" actId="1076"/>
          <ac:spMkLst>
            <pc:docMk/>
            <pc:sldMk cId="3092309862" sldId="287"/>
            <ac:spMk id="26" creationId="{49A6398C-AD42-37CE-4134-4C3DDD375DDB}"/>
          </ac:spMkLst>
        </pc:spChg>
        <pc:spChg chg="add del mod">
          <ac:chgData name="Dr Ahmed Elshazly" userId="92faafa7-b1de-4194-ac20-c5423e5d0806" providerId="ADAL" clId="{591B1513-E534-4A55-B858-A57CE2E401C3}" dt="2026-02-28T21:28:25.733" v="239" actId="478"/>
          <ac:spMkLst>
            <pc:docMk/>
            <pc:sldMk cId="3092309862" sldId="287"/>
            <ac:spMk id="27" creationId="{382C5D4A-34B0-3B82-0FE7-38DC418DCB0F}"/>
          </ac:spMkLst>
        </pc:spChg>
        <pc:spChg chg="add mod">
          <ac:chgData name="Dr Ahmed Elshazly" userId="92faafa7-b1de-4194-ac20-c5423e5d0806" providerId="ADAL" clId="{591B1513-E534-4A55-B858-A57CE2E401C3}" dt="2026-02-28T21:28:19.292" v="236" actId="14100"/>
          <ac:spMkLst>
            <pc:docMk/>
            <pc:sldMk cId="3092309862" sldId="287"/>
            <ac:spMk id="28" creationId="{326E91C8-735D-76AA-1771-683969C72C45}"/>
          </ac:spMkLst>
        </pc:spChg>
        <pc:spChg chg="add mod">
          <ac:chgData name="Dr Ahmed Elshazly" userId="92faafa7-b1de-4194-ac20-c5423e5d0806" providerId="ADAL" clId="{591B1513-E534-4A55-B858-A57CE2E401C3}" dt="2026-02-28T21:28:30.612" v="240" actId="1076"/>
          <ac:spMkLst>
            <pc:docMk/>
            <pc:sldMk cId="3092309862" sldId="287"/>
            <ac:spMk id="29" creationId="{5CE1ED30-4A91-6408-DDCB-B5522575E436}"/>
          </ac:spMkLst>
        </pc:spChg>
        <pc:picChg chg="mod modCrop">
          <ac:chgData name="Dr Ahmed Elshazly" userId="92faafa7-b1de-4194-ac20-c5423e5d0806" providerId="ADAL" clId="{591B1513-E534-4A55-B858-A57CE2E401C3}" dt="2026-02-28T21:25:58.516" v="169" actId="1076"/>
          <ac:picMkLst>
            <pc:docMk/>
            <pc:sldMk cId="3092309862" sldId="287"/>
            <ac:picMk id="5" creationId="{6890A84E-607F-D31F-7DF2-B4FB3124DF89}"/>
          </ac:picMkLst>
        </pc:picChg>
        <pc:picChg chg="mod modCrop">
          <ac:chgData name="Dr Ahmed Elshazly" userId="92faafa7-b1de-4194-ac20-c5423e5d0806" providerId="ADAL" clId="{591B1513-E534-4A55-B858-A57CE2E401C3}" dt="2026-02-28T21:26:07.018" v="172" actId="1076"/>
          <ac:picMkLst>
            <pc:docMk/>
            <pc:sldMk cId="3092309862" sldId="287"/>
            <ac:picMk id="6" creationId="{F76F661C-37CD-5016-4014-6A53736E61C8}"/>
          </ac:picMkLst>
        </pc:picChg>
        <pc:picChg chg="mod modCrop">
          <ac:chgData name="Dr Ahmed Elshazly" userId="92faafa7-b1de-4194-ac20-c5423e5d0806" providerId="ADAL" clId="{591B1513-E534-4A55-B858-A57CE2E401C3}" dt="2026-02-28T21:27:08.790" v="209" actId="1076"/>
          <ac:picMkLst>
            <pc:docMk/>
            <pc:sldMk cId="3092309862" sldId="287"/>
            <ac:picMk id="8" creationId="{AE7DF765-510B-8BE2-041B-D56B4ACD5B0B}"/>
          </ac:picMkLst>
        </pc:picChg>
        <pc:picChg chg="mod modCrop">
          <ac:chgData name="Dr Ahmed Elshazly" userId="92faafa7-b1de-4194-ac20-c5423e5d0806" providerId="ADAL" clId="{591B1513-E534-4A55-B858-A57CE2E401C3}" dt="2026-02-28T21:27:28.864" v="216" actId="1076"/>
          <ac:picMkLst>
            <pc:docMk/>
            <pc:sldMk cId="3092309862" sldId="287"/>
            <ac:picMk id="9" creationId="{80587543-ACE9-650E-C266-5A27FD88FDBB}"/>
          </ac:picMkLst>
        </pc:picChg>
        <pc:picChg chg="mod modCrop">
          <ac:chgData name="Dr Ahmed Elshazly" userId="92faafa7-b1de-4194-ac20-c5423e5d0806" providerId="ADAL" clId="{591B1513-E534-4A55-B858-A57CE2E401C3}" dt="2026-02-28T21:26:32.145" v="195" actId="1037"/>
          <ac:picMkLst>
            <pc:docMk/>
            <pc:sldMk cId="3092309862" sldId="287"/>
            <ac:picMk id="21" creationId="{8C43B7C7-BD3D-12B2-064A-CCC459634A72}"/>
          </ac:picMkLst>
        </pc:picChg>
        <pc:picChg chg="mod modCrop">
          <ac:chgData name="Dr Ahmed Elshazly" userId="92faafa7-b1de-4194-ac20-c5423e5d0806" providerId="ADAL" clId="{591B1513-E534-4A55-B858-A57CE2E401C3}" dt="2026-02-28T21:27:32.619" v="218" actId="1076"/>
          <ac:picMkLst>
            <pc:docMk/>
            <pc:sldMk cId="3092309862" sldId="287"/>
            <ac:picMk id="22" creationId="{E80B042B-6F1C-42C6-AD61-70ADCBD116DD}"/>
          </ac:picMkLst>
        </pc:picChg>
      </pc:sldChg>
      <pc:sldChg chg="addSp delSp modSp new mod">
        <pc:chgData name="Dr Ahmed Elshazly" userId="92faafa7-b1de-4194-ac20-c5423e5d0806" providerId="ADAL" clId="{591B1513-E534-4A55-B858-A57CE2E401C3}" dt="2026-02-28T21:38:16.392" v="420" actId="1076"/>
        <pc:sldMkLst>
          <pc:docMk/>
          <pc:sldMk cId="436452245" sldId="288"/>
        </pc:sldMkLst>
        <pc:spChg chg="del">
          <ac:chgData name="Dr Ahmed Elshazly" userId="92faafa7-b1de-4194-ac20-c5423e5d0806" providerId="ADAL" clId="{591B1513-E534-4A55-B858-A57CE2E401C3}" dt="2026-02-28T21:35:07.727" v="349" actId="478"/>
          <ac:spMkLst>
            <pc:docMk/>
            <pc:sldMk cId="436452245" sldId="288"/>
            <ac:spMk id="2" creationId="{56A44101-7270-705D-0274-A26C3B3FF9DE}"/>
          </ac:spMkLst>
        </pc:spChg>
        <pc:spChg chg="del">
          <ac:chgData name="Dr Ahmed Elshazly" userId="92faafa7-b1de-4194-ac20-c5423e5d0806" providerId="ADAL" clId="{591B1513-E534-4A55-B858-A57CE2E401C3}" dt="2026-02-28T21:35:07.727" v="349" actId="478"/>
          <ac:spMkLst>
            <pc:docMk/>
            <pc:sldMk cId="436452245" sldId="288"/>
            <ac:spMk id="3" creationId="{E9565B26-6D7E-BEEA-BBB9-D1245139959C}"/>
          </ac:spMkLst>
        </pc:spChg>
        <pc:spChg chg="add mod">
          <ac:chgData name="Dr Ahmed Elshazly" userId="92faafa7-b1de-4194-ac20-c5423e5d0806" providerId="ADAL" clId="{591B1513-E534-4A55-B858-A57CE2E401C3}" dt="2026-02-28T21:35:17.074" v="353" actId="20577"/>
          <ac:spMkLst>
            <pc:docMk/>
            <pc:sldMk cId="436452245" sldId="288"/>
            <ac:spMk id="4" creationId="{C869F44E-8507-241A-6ED0-BFD5B7BF5FC9}"/>
          </ac:spMkLst>
        </pc:spChg>
        <pc:spChg chg="add mod">
          <ac:chgData name="Dr Ahmed Elshazly" userId="92faafa7-b1de-4194-ac20-c5423e5d0806" providerId="ADAL" clId="{591B1513-E534-4A55-B858-A57CE2E401C3}" dt="2026-02-28T21:35:39.188" v="361" actId="1076"/>
          <ac:spMkLst>
            <pc:docMk/>
            <pc:sldMk cId="436452245" sldId="288"/>
            <ac:spMk id="9" creationId="{E9903C06-FD90-23A8-5ACA-D0E780441F1B}"/>
          </ac:spMkLst>
        </pc:spChg>
        <pc:spChg chg="add mod ord">
          <ac:chgData name="Dr Ahmed Elshazly" userId="92faafa7-b1de-4194-ac20-c5423e5d0806" providerId="ADAL" clId="{591B1513-E534-4A55-B858-A57CE2E401C3}" dt="2026-02-28T21:37:35.911" v="404" actId="167"/>
          <ac:spMkLst>
            <pc:docMk/>
            <pc:sldMk cId="436452245" sldId="288"/>
            <ac:spMk id="10" creationId="{E1C5793C-D844-AEE1-65A2-39F74415F1C8}"/>
          </ac:spMkLst>
        </pc:spChg>
        <pc:spChg chg="add mod ord">
          <ac:chgData name="Dr Ahmed Elshazly" userId="92faafa7-b1de-4194-ac20-c5423e5d0806" providerId="ADAL" clId="{591B1513-E534-4A55-B858-A57CE2E401C3}" dt="2026-02-28T21:37:35.911" v="404" actId="167"/>
          <ac:spMkLst>
            <pc:docMk/>
            <pc:sldMk cId="436452245" sldId="288"/>
            <ac:spMk id="13" creationId="{4295D1E1-467A-60BC-E033-D0FD1CC0FE1A}"/>
          </ac:spMkLst>
        </pc:spChg>
        <pc:spChg chg="add mod ord">
          <ac:chgData name="Dr Ahmed Elshazly" userId="92faafa7-b1de-4194-ac20-c5423e5d0806" providerId="ADAL" clId="{591B1513-E534-4A55-B858-A57CE2E401C3}" dt="2026-02-28T21:37:35.911" v="404" actId="167"/>
          <ac:spMkLst>
            <pc:docMk/>
            <pc:sldMk cId="436452245" sldId="288"/>
            <ac:spMk id="14" creationId="{9E6C571A-78CB-CC05-C47C-B192C93CAD9C}"/>
          </ac:spMkLst>
        </pc:spChg>
        <pc:spChg chg="add mod ord">
          <ac:chgData name="Dr Ahmed Elshazly" userId="92faafa7-b1de-4194-ac20-c5423e5d0806" providerId="ADAL" clId="{591B1513-E534-4A55-B858-A57CE2E401C3}" dt="2026-02-28T21:37:35.911" v="404" actId="167"/>
          <ac:spMkLst>
            <pc:docMk/>
            <pc:sldMk cId="436452245" sldId="288"/>
            <ac:spMk id="15" creationId="{6023BD89-F431-B7D0-8BEB-C9C075DF61B4}"/>
          </ac:spMkLst>
        </pc:spChg>
        <pc:spChg chg="add mod ord">
          <ac:chgData name="Dr Ahmed Elshazly" userId="92faafa7-b1de-4194-ac20-c5423e5d0806" providerId="ADAL" clId="{591B1513-E534-4A55-B858-A57CE2E401C3}" dt="2026-02-28T21:37:35.911" v="404" actId="167"/>
          <ac:spMkLst>
            <pc:docMk/>
            <pc:sldMk cId="436452245" sldId="288"/>
            <ac:spMk id="16" creationId="{DEF4A73F-5BD6-EF1E-A65A-39002A6ED602}"/>
          </ac:spMkLst>
        </pc:spChg>
        <pc:spChg chg="add mod">
          <ac:chgData name="Dr Ahmed Elshazly" userId="92faafa7-b1de-4194-ac20-c5423e5d0806" providerId="ADAL" clId="{591B1513-E534-4A55-B858-A57CE2E401C3}" dt="2026-02-28T21:37:42.808" v="407" actId="14100"/>
          <ac:spMkLst>
            <pc:docMk/>
            <pc:sldMk cId="436452245" sldId="288"/>
            <ac:spMk id="17" creationId="{30D067BA-7688-AF68-10E4-5C7B9F6CB8FB}"/>
          </ac:spMkLst>
        </pc:spChg>
        <pc:spChg chg="add mod">
          <ac:chgData name="Dr Ahmed Elshazly" userId="92faafa7-b1de-4194-ac20-c5423e5d0806" providerId="ADAL" clId="{591B1513-E534-4A55-B858-A57CE2E401C3}" dt="2026-02-28T21:37:48.222" v="409" actId="1076"/>
          <ac:spMkLst>
            <pc:docMk/>
            <pc:sldMk cId="436452245" sldId="288"/>
            <ac:spMk id="18" creationId="{238A276D-10BF-30E9-9F27-FD9896C3476A}"/>
          </ac:spMkLst>
        </pc:spChg>
        <pc:spChg chg="add mod">
          <ac:chgData name="Dr Ahmed Elshazly" userId="92faafa7-b1de-4194-ac20-c5423e5d0806" providerId="ADAL" clId="{591B1513-E534-4A55-B858-A57CE2E401C3}" dt="2026-02-28T21:37:58.826" v="411" actId="1076"/>
          <ac:spMkLst>
            <pc:docMk/>
            <pc:sldMk cId="436452245" sldId="288"/>
            <ac:spMk id="19" creationId="{1C33B9E9-178F-2D1E-8D5B-A6B04D33C69F}"/>
          </ac:spMkLst>
        </pc:spChg>
        <pc:spChg chg="add mod">
          <ac:chgData name="Dr Ahmed Elshazly" userId="92faafa7-b1de-4194-ac20-c5423e5d0806" providerId="ADAL" clId="{591B1513-E534-4A55-B858-A57CE2E401C3}" dt="2026-02-28T21:38:02.538" v="413" actId="1076"/>
          <ac:spMkLst>
            <pc:docMk/>
            <pc:sldMk cId="436452245" sldId="288"/>
            <ac:spMk id="20" creationId="{D4785676-5001-5671-1483-71405E18DE17}"/>
          </ac:spMkLst>
        </pc:spChg>
        <pc:spChg chg="add mod">
          <ac:chgData name="Dr Ahmed Elshazly" userId="92faafa7-b1de-4194-ac20-c5423e5d0806" providerId="ADAL" clId="{591B1513-E534-4A55-B858-A57CE2E401C3}" dt="2026-02-28T21:38:08.235" v="415" actId="1076"/>
          <ac:spMkLst>
            <pc:docMk/>
            <pc:sldMk cId="436452245" sldId="288"/>
            <ac:spMk id="21" creationId="{3DCC0A48-059F-E45C-EC6E-DA6FB9D7D9B4}"/>
          </ac:spMkLst>
        </pc:spChg>
        <pc:spChg chg="add mod">
          <ac:chgData name="Dr Ahmed Elshazly" userId="92faafa7-b1de-4194-ac20-c5423e5d0806" providerId="ADAL" clId="{591B1513-E534-4A55-B858-A57CE2E401C3}" dt="2026-02-28T21:38:16.392" v="420" actId="1076"/>
          <ac:spMkLst>
            <pc:docMk/>
            <pc:sldMk cId="436452245" sldId="288"/>
            <ac:spMk id="22" creationId="{3FD1556E-93FC-2212-C7F7-A4398DBB09D7}"/>
          </ac:spMkLst>
        </pc:spChg>
        <pc:picChg chg="add mod ord modCrop">
          <ac:chgData name="Dr Ahmed Elshazly" userId="92faafa7-b1de-4194-ac20-c5423e5d0806" providerId="ADAL" clId="{591B1513-E534-4A55-B858-A57CE2E401C3}" dt="2026-02-28T21:37:35.911" v="404" actId="167"/>
          <ac:picMkLst>
            <pc:docMk/>
            <pc:sldMk cId="436452245" sldId="288"/>
            <ac:picMk id="5" creationId="{2493CADB-EE4B-9DF8-228B-27F8A791C4C7}"/>
          </ac:picMkLst>
        </pc:picChg>
        <pc:picChg chg="mod ord modCrop">
          <ac:chgData name="Dr Ahmed Elshazly" userId="92faafa7-b1de-4194-ac20-c5423e5d0806" providerId="ADAL" clId="{591B1513-E534-4A55-B858-A57CE2E401C3}" dt="2026-02-28T21:37:35.911" v="404" actId="167"/>
          <ac:picMkLst>
            <pc:docMk/>
            <pc:sldMk cId="436452245" sldId="288"/>
            <ac:picMk id="6" creationId="{EB629703-7B78-86FE-BF10-6FA139959C3B}"/>
          </ac:picMkLst>
        </pc:picChg>
        <pc:picChg chg="add mod ord modCrop">
          <ac:chgData name="Dr Ahmed Elshazly" userId="92faafa7-b1de-4194-ac20-c5423e5d0806" providerId="ADAL" clId="{591B1513-E534-4A55-B858-A57CE2E401C3}" dt="2026-02-28T21:37:35.911" v="404" actId="167"/>
          <ac:picMkLst>
            <pc:docMk/>
            <pc:sldMk cId="436452245" sldId="288"/>
            <ac:picMk id="7" creationId="{AA2F2770-DCD7-7429-B09B-95A15E5E14E9}"/>
          </ac:picMkLst>
        </pc:picChg>
        <pc:picChg chg="add mod ord modCrop">
          <ac:chgData name="Dr Ahmed Elshazly" userId="92faafa7-b1de-4194-ac20-c5423e5d0806" providerId="ADAL" clId="{591B1513-E534-4A55-B858-A57CE2E401C3}" dt="2026-02-28T21:37:35.911" v="404" actId="167"/>
          <ac:picMkLst>
            <pc:docMk/>
            <pc:sldMk cId="436452245" sldId="288"/>
            <ac:picMk id="8" creationId="{98CEEE5A-1101-0A29-932B-DEE46A003A73}"/>
          </ac:picMkLst>
        </pc:picChg>
        <pc:picChg chg="add mod ord modCrop">
          <ac:chgData name="Dr Ahmed Elshazly" userId="92faafa7-b1de-4194-ac20-c5423e5d0806" providerId="ADAL" clId="{591B1513-E534-4A55-B858-A57CE2E401C3}" dt="2026-02-28T21:37:35.911" v="404" actId="167"/>
          <ac:picMkLst>
            <pc:docMk/>
            <pc:sldMk cId="436452245" sldId="288"/>
            <ac:picMk id="11" creationId="{7A22D374-5B7C-AD3D-8B01-4080152FEC0C}"/>
          </ac:picMkLst>
        </pc:picChg>
        <pc:picChg chg="mod modCrop">
          <ac:chgData name="Dr Ahmed Elshazly" userId="92faafa7-b1de-4194-ac20-c5423e5d0806" providerId="ADAL" clId="{591B1513-E534-4A55-B858-A57CE2E401C3}" dt="2026-02-28T21:37:13.230" v="401" actId="1076"/>
          <ac:picMkLst>
            <pc:docMk/>
            <pc:sldMk cId="436452245" sldId="288"/>
            <ac:picMk id="12" creationId="{A2E724B1-183B-6D32-F80C-DDC4A1FDF729}"/>
          </ac:picMkLst>
        </pc:picChg>
      </pc:sldChg>
      <pc:sldChg chg="addSp delSp modSp new mod">
        <pc:chgData name="Dr Ahmed Elshazly" userId="92faafa7-b1de-4194-ac20-c5423e5d0806" providerId="ADAL" clId="{591B1513-E534-4A55-B858-A57CE2E401C3}" dt="2026-02-28T21:43:03.757" v="510" actId="20577"/>
        <pc:sldMkLst>
          <pc:docMk/>
          <pc:sldMk cId="2284307970" sldId="289"/>
        </pc:sldMkLst>
        <pc:spChg chg="del">
          <ac:chgData name="Dr Ahmed Elshazly" userId="92faafa7-b1de-4194-ac20-c5423e5d0806" providerId="ADAL" clId="{591B1513-E534-4A55-B858-A57CE2E401C3}" dt="2026-02-28T21:35:05.047" v="348" actId="478"/>
          <ac:spMkLst>
            <pc:docMk/>
            <pc:sldMk cId="2284307970" sldId="289"/>
            <ac:spMk id="2" creationId="{6947A6F1-2619-2B5A-0EB8-C7B656D201CC}"/>
          </ac:spMkLst>
        </pc:spChg>
        <pc:spChg chg="del">
          <ac:chgData name="Dr Ahmed Elshazly" userId="92faafa7-b1de-4194-ac20-c5423e5d0806" providerId="ADAL" clId="{591B1513-E534-4A55-B858-A57CE2E401C3}" dt="2026-02-28T21:35:05.047" v="348" actId="478"/>
          <ac:spMkLst>
            <pc:docMk/>
            <pc:sldMk cId="2284307970" sldId="289"/>
            <ac:spMk id="3" creationId="{691963A6-1F7B-2A8E-8CAE-AA030B406E58}"/>
          </ac:spMkLst>
        </pc:spChg>
        <pc:spChg chg="add mod">
          <ac:chgData name="Dr Ahmed Elshazly" userId="92faafa7-b1de-4194-ac20-c5423e5d0806" providerId="ADAL" clId="{591B1513-E534-4A55-B858-A57CE2E401C3}" dt="2026-02-28T21:43:03.757" v="510" actId="20577"/>
          <ac:spMkLst>
            <pc:docMk/>
            <pc:sldMk cId="2284307970" sldId="289"/>
            <ac:spMk id="4" creationId="{37EA8CB3-9B20-22E0-F967-69836D1F98A4}"/>
          </ac:spMkLst>
        </pc:spChg>
        <pc:spChg chg="add mod">
          <ac:chgData name="Dr Ahmed Elshazly" userId="92faafa7-b1de-4194-ac20-c5423e5d0806" providerId="ADAL" clId="{591B1513-E534-4A55-B858-A57CE2E401C3}" dt="2026-02-28T21:41:36.408" v="478" actId="1076"/>
          <ac:spMkLst>
            <pc:docMk/>
            <pc:sldMk cId="2284307970" sldId="289"/>
            <ac:spMk id="11" creationId="{04E7E7B7-7718-4A04-0639-7B817493919A}"/>
          </ac:spMkLst>
        </pc:spChg>
        <pc:spChg chg="add mod">
          <ac:chgData name="Dr Ahmed Elshazly" userId="92faafa7-b1de-4194-ac20-c5423e5d0806" providerId="ADAL" clId="{591B1513-E534-4A55-B858-A57CE2E401C3}" dt="2026-02-28T21:39:41.678" v="432" actId="1076"/>
          <ac:spMkLst>
            <pc:docMk/>
            <pc:sldMk cId="2284307970" sldId="289"/>
            <ac:spMk id="12" creationId="{52074563-9C5C-1A5A-3708-796CF748007F}"/>
          </ac:spMkLst>
        </pc:spChg>
        <pc:spChg chg="add mod">
          <ac:chgData name="Dr Ahmed Elshazly" userId="92faafa7-b1de-4194-ac20-c5423e5d0806" providerId="ADAL" clId="{591B1513-E534-4A55-B858-A57CE2E401C3}" dt="2026-02-28T21:40:08.851" v="446" actId="1076"/>
          <ac:spMkLst>
            <pc:docMk/>
            <pc:sldMk cId="2284307970" sldId="289"/>
            <ac:spMk id="13" creationId="{73A65B35-0AA1-7126-C823-62EFE17B6D6F}"/>
          </ac:spMkLst>
        </pc:spChg>
        <pc:spChg chg="add mod">
          <ac:chgData name="Dr Ahmed Elshazly" userId="92faafa7-b1de-4194-ac20-c5423e5d0806" providerId="ADAL" clId="{591B1513-E534-4A55-B858-A57CE2E401C3}" dt="2026-02-28T21:40:11.916" v="447" actId="1076"/>
          <ac:spMkLst>
            <pc:docMk/>
            <pc:sldMk cId="2284307970" sldId="289"/>
            <ac:spMk id="14" creationId="{6E9EDE7B-823B-983B-500F-9164AE514000}"/>
          </ac:spMkLst>
        </pc:spChg>
        <pc:spChg chg="add mod">
          <ac:chgData name="Dr Ahmed Elshazly" userId="92faafa7-b1de-4194-ac20-c5423e5d0806" providerId="ADAL" clId="{591B1513-E534-4A55-B858-A57CE2E401C3}" dt="2026-02-28T21:41:43.140" v="479" actId="1076"/>
          <ac:spMkLst>
            <pc:docMk/>
            <pc:sldMk cId="2284307970" sldId="289"/>
            <ac:spMk id="15" creationId="{73DF1E45-2A99-CB3C-ED90-1F10ECFB92C4}"/>
          </ac:spMkLst>
        </pc:spChg>
        <pc:spChg chg="add mod">
          <ac:chgData name="Dr Ahmed Elshazly" userId="92faafa7-b1de-4194-ac20-c5423e5d0806" providerId="ADAL" clId="{591B1513-E534-4A55-B858-A57CE2E401C3}" dt="2026-02-28T21:40:55.163" v="465" actId="1076"/>
          <ac:spMkLst>
            <pc:docMk/>
            <pc:sldMk cId="2284307970" sldId="289"/>
            <ac:spMk id="16" creationId="{1EA8FD2C-AE87-3604-6ED7-E6E1A52A0121}"/>
          </ac:spMkLst>
        </pc:spChg>
        <pc:spChg chg="add mod">
          <ac:chgData name="Dr Ahmed Elshazly" userId="92faafa7-b1de-4194-ac20-c5423e5d0806" providerId="ADAL" clId="{591B1513-E534-4A55-B858-A57CE2E401C3}" dt="2026-02-28T21:41:59.308" v="485" actId="1036"/>
          <ac:spMkLst>
            <pc:docMk/>
            <pc:sldMk cId="2284307970" sldId="289"/>
            <ac:spMk id="17" creationId="{87F5E0BE-6AD4-39B1-A517-44A36002E87B}"/>
          </ac:spMkLst>
        </pc:spChg>
        <pc:spChg chg="add mod">
          <ac:chgData name="Dr Ahmed Elshazly" userId="92faafa7-b1de-4194-ac20-c5423e5d0806" providerId="ADAL" clId="{591B1513-E534-4A55-B858-A57CE2E401C3}" dt="2026-02-28T21:42:08.555" v="489" actId="14100"/>
          <ac:spMkLst>
            <pc:docMk/>
            <pc:sldMk cId="2284307970" sldId="289"/>
            <ac:spMk id="18" creationId="{88C9249D-A824-8F2A-AAFD-7BE36DE40C91}"/>
          </ac:spMkLst>
        </pc:spChg>
        <pc:spChg chg="add mod">
          <ac:chgData name="Dr Ahmed Elshazly" userId="92faafa7-b1de-4194-ac20-c5423e5d0806" providerId="ADAL" clId="{591B1513-E534-4A55-B858-A57CE2E401C3}" dt="2026-02-28T21:42:17.426" v="491" actId="1076"/>
          <ac:spMkLst>
            <pc:docMk/>
            <pc:sldMk cId="2284307970" sldId="289"/>
            <ac:spMk id="19" creationId="{28767790-E20C-B5FA-792F-7C5C3CFC981C}"/>
          </ac:spMkLst>
        </pc:spChg>
        <pc:spChg chg="add mod">
          <ac:chgData name="Dr Ahmed Elshazly" userId="92faafa7-b1de-4194-ac20-c5423e5d0806" providerId="ADAL" clId="{591B1513-E534-4A55-B858-A57CE2E401C3}" dt="2026-02-28T21:42:23.136" v="498" actId="1036"/>
          <ac:spMkLst>
            <pc:docMk/>
            <pc:sldMk cId="2284307970" sldId="289"/>
            <ac:spMk id="20" creationId="{34C719A2-7146-DC8E-B845-70DA85499054}"/>
          </ac:spMkLst>
        </pc:spChg>
        <pc:spChg chg="add mod">
          <ac:chgData name="Dr Ahmed Elshazly" userId="92faafa7-b1de-4194-ac20-c5423e5d0806" providerId="ADAL" clId="{591B1513-E534-4A55-B858-A57CE2E401C3}" dt="2026-02-28T21:42:27.932" v="503" actId="1035"/>
          <ac:spMkLst>
            <pc:docMk/>
            <pc:sldMk cId="2284307970" sldId="289"/>
            <ac:spMk id="21" creationId="{D3957C63-F073-186D-6FC2-CDD536D0D5BA}"/>
          </ac:spMkLst>
        </pc:spChg>
        <pc:spChg chg="add mod">
          <ac:chgData name="Dr Ahmed Elshazly" userId="92faafa7-b1de-4194-ac20-c5423e5d0806" providerId="ADAL" clId="{591B1513-E534-4A55-B858-A57CE2E401C3}" dt="2026-02-28T21:42:38.461" v="508" actId="1037"/>
          <ac:spMkLst>
            <pc:docMk/>
            <pc:sldMk cId="2284307970" sldId="289"/>
            <ac:spMk id="22" creationId="{F056D49D-99D7-CFB3-94FF-370EE293C36F}"/>
          </ac:spMkLst>
        </pc:spChg>
        <pc:picChg chg="add mod modCrop">
          <ac:chgData name="Dr Ahmed Elshazly" userId="92faafa7-b1de-4194-ac20-c5423e5d0806" providerId="ADAL" clId="{591B1513-E534-4A55-B858-A57CE2E401C3}" dt="2026-02-28T21:40:27.166" v="455" actId="1076"/>
          <ac:picMkLst>
            <pc:docMk/>
            <pc:sldMk cId="2284307970" sldId="289"/>
            <ac:picMk id="5" creationId="{1F20A107-7175-F064-0707-5750A235D68B}"/>
          </ac:picMkLst>
        </pc:picChg>
        <pc:picChg chg="add mod modCrop">
          <ac:chgData name="Dr Ahmed Elshazly" userId="92faafa7-b1de-4194-ac20-c5423e5d0806" providerId="ADAL" clId="{591B1513-E534-4A55-B858-A57CE2E401C3}" dt="2026-02-28T21:40:03.968" v="445" actId="1076"/>
          <ac:picMkLst>
            <pc:docMk/>
            <pc:sldMk cId="2284307970" sldId="289"/>
            <ac:picMk id="6" creationId="{18E7D514-FAF3-9E69-47B5-0D2F12DCA41F}"/>
          </ac:picMkLst>
        </pc:picChg>
        <pc:picChg chg="add mod modCrop">
          <ac:chgData name="Dr Ahmed Elshazly" userId="92faafa7-b1de-4194-ac20-c5423e5d0806" providerId="ADAL" clId="{591B1513-E534-4A55-B858-A57CE2E401C3}" dt="2026-02-28T21:40:52.375" v="464" actId="1076"/>
          <ac:picMkLst>
            <pc:docMk/>
            <pc:sldMk cId="2284307970" sldId="289"/>
            <ac:picMk id="7" creationId="{4CA30EF8-4D2D-C4A5-6CC0-EB0147063239}"/>
          </ac:picMkLst>
        </pc:picChg>
        <pc:picChg chg="mod modCrop">
          <ac:chgData name="Dr Ahmed Elshazly" userId="92faafa7-b1de-4194-ac20-c5423e5d0806" providerId="ADAL" clId="{591B1513-E534-4A55-B858-A57CE2E401C3}" dt="2026-02-28T21:39:39.516" v="431" actId="1076"/>
          <ac:picMkLst>
            <pc:docMk/>
            <pc:sldMk cId="2284307970" sldId="289"/>
            <ac:picMk id="8" creationId="{CED60EA7-5D25-295A-00DA-58A40D67ECAB}"/>
          </ac:picMkLst>
        </pc:picChg>
        <pc:picChg chg="add mod modCrop">
          <ac:chgData name="Dr Ahmed Elshazly" userId="92faafa7-b1de-4194-ac20-c5423e5d0806" providerId="ADAL" clId="{591B1513-E534-4A55-B858-A57CE2E401C3}" dt="2026-02-28T21:39:51.297" v="438" actId="1076"/>
          <ac:picMkLst>
            <pc:docMk/>
            <pc:sldMk cId="2284307970" sldId="289"/>
            <ac:picMk id="9" creationId="{5EA09BCA-5DFB-89B4-0454-B6D54D3DC4CC}"/>
          </ac:picMkLst>
        </pc:picChg>
        <pc:picChg chg="mod modCrop">
          <ac:chgData name="Dr Ahmed Elshazly" userId="92faafa7-b1de-4194-ac20-c5423e5d0806" providerId="ADAL" clId="{591B1513-E534-4A55-B858-A57CE2E401C3}" dt="2026-02-28T21:41:34.476" v="477" actId="1076"/>
          <ac:picMkLst>
            <pc:docMk/>
            <pc:sldMk cId="2284307970" sldId="289"/>
            <ac:picMk id="10" creationId="{0FD686F2-6105-776C-E7C0-3BD79C7F5EF7}"/>
          </ac:picMkLst>
        </pc:picChg>
      </pc:sldChg>
      <pc:sldChg chg="addSp delSp modSp new mod">
        <pc:chgData name="Dr Ahmed Elshazly" userId="92faafa7-b1de-4194-ac20-c5423e5d0806" providerId="ADAL" clId="{591B1513-E534-4A55-B858-A57CE2E401C3}" dt="2026-02-28T21:45:27.274" v="556" actId="1076"/>
        <pc:sldMkLst>
          <pc:docMk/>
          <pc:sldMk cId="63235985" sldId="290"/>
        </pc:sldMkLst>
        <pc:spChg chg="del">
          <ac:chgData name="Dr Ahmed Elshazly" userId="92faafa7-b1de-4194-ac20-c5423e5d0806" providerId="ADAL" clId="{591B1513-E534-4A55-B858-A57CE2E401C3}" dt="2026-02-28T21:35:02.464" v="347" actId="478"/>
          <ac:spMkLst>
            <pc:docMk/>
            <pc:sldMk cId="63235985" sldId="290"/>
            <ac:spMk id="2" creationId="{E8A883D5-9318-95E2-FF8A-D212C025CDE8}"/>
          </ac:spMkLst>
        </pc:spChg>
        <pc:spChg chg="del">
          <ac:chgData name="Dr Ahmed Elshazly" userId="92faafa7-b1de-4194-ac20-c5423e5d0806" providerId="ADAL" clId="{591B1513-E534-4A55-B858-A57CE2E401C3}" dt="2026-02-28T21:35:02.464" v="347" actId="478"/>
          <ac:spMkLst>
            <pc:docMk/>
            <pc:sldMk cId="63235985" sldId="290"/>
            <ac:spMk id="3" creationId="{4CF158E5-2809-61C4-080F-C90A8EAD2943}"/>
          </ac:spMkLst>
        </pc:spChg>
        <pc:spChg chg="add mod">
          <ac:chgData name="Dr Ahmed Elshazly" userId="92faafa7-b1de-4194-ac20-c5423e5d0806" providerId="ADAL" clId="{591B1513-E534-4A55-B858-A57CE2E401C3}" dt="2026-02-28T21:44:43.648" v="541" actId="1076"/>
          <ac:spMkLst>
            <pc:docMk/>
            <pc:sldMk cId="63235985" sldId="290"/>
            <ac:spMk id="4" creationId="{51BB91CF-DDD9-3B83-52F0-B34437F4B582}"/>
          </ac:spMkLst>
        </pc:spChg>
        <pc:spChg chg="add mod">
          <ac:chgData name="Dr Ahmed Elshazly" userId="92faafa7-b1de-4194-ac20-c5423e5d0806" providerId="ADAL" clId="{591B1513-E534-4A55-B858-A57CE2E401C3}" dt="2026-02-28T21:44:50.712" v="543" actId="1076"/>
          <ac:spMkLst>
            <pc:docMk/>
            <pc:sldMk cId="63235985" sldId="290"/>
            <ac:spMk id="9" creationId="{D4F08AC6-BAB7-F4A6-FC64-624D8D416BEB}"/>
          </ac:spMkLst>
        </pc:spChg>
        <pc:spChg chg="add mod">
          <ac:chgData name="Dr Ahmed Elshazly" userId="92faafa7-b1de-4194-ac20-c5423e5d0806" providerId="ADAL" clId="{591B1513-E534-4A55-B858-A57CE2E401C3}" dt="2026-02-28T21:44:53.714" v="544" actId="1076"/>
          <ac:spMkLst>
            <pc:docMk/>
            <pc:sldMk cId="63235985" sldId="290"/>
            <ac:spMk id="10" creationId="{E10265D3-21A3-FC0C-025A-781B92A83B6D}"/>
          </ac:spMkLst>
        </pc:spChg>
        <pc:spChg chg="add mod">
          <ac:chgData name="Dr Ahmed Elshazly" userId="92faafa7-b1de-4194-ac20-c5423e5d0806" providerId="ADAL" clId="{591B1513-E534-4A55-B858-A57CE2E401C3}" dt="2026-02-28T21:44:40.996" v="540" actId="1076"/>
          <ac:spMkLst>
            <pc:docMk/>
            <pc:sldMk cId="63235985" sldId="290"/>
            <ac:spMk id="11" creationId="{27AF41F3-6FA8-340A-B518-3EC7AAE3E511}"/>
          </ac:spMkLst>
        </pc:spChg>
        <pc:spChg chg="add mod">
          <ac:chgData name="Dr Ahmed Elshazly" userId="92faafa7-b1de-4194-ac20-c5423e5d0806" providerId="ADAL" clId="{591B1513-E534-4A55-B858-A57CE2E401C3}" dt="2026-02-28T21:44:47.958" v="542" actId="1076"/>
          <ac:spMkLst>
            <pc:docMk/>
            <pc:sldMk cId="63235985" sldId="290"/>
            <ac:spMk id="12" creationId="{4E8FC3A3-E1C5-B91F-170F-47945E3E66F4}"/>
          </ac:spMkLst>
        </pc:spChg>
        <pc:spChg chg="add mod">
          <ac:chgData name="Dr Ahmed Elshazly" userId="92faafa7-b1de-4194-ac20-c5423e5d0806" providerId="ADAL" clId="{591B1513-E534-4A55-B858-A57CE2E401C3}" dt="2026-02-28T21:44:40.996" v="540" actId="1076"/>
          <ac:spMkLst>
            <pc:docMk/>
            <pc:sldMk cId="63235985" sldId="290"/>
            <ac:spMk id="13" creationId="{3E810855-0EE4-AE90-ED20-AA1AE08A0038}"/>
          </ac:spMkLst>
        </pc:spChg>
        <pc:spChg chg="add mod">
          <ac:chgData name="Dr Ahmed Elshazly" userId="92faafa7-b1de-4194-ac20-c5423e5d0806" providerId="ADAL" clId="{591B1513-E534-4A55-B858-A57CE2E401C3}" dt="2026-02-28T21:44:47.958" v="542" actId="1076"/>
          <ac:spMkLst>
            <pc:docMk/>
            <pc:sldMk cId="63235985" sldId="290"/>
            <ac:spMk id="14" creationId="{4BEA1DB7-0878-9F4A-14E3-7B3A4FB7E72A}"/>
          </ac:spMkLst>
        </pc:spChg>
        <pc:spChg chg="add mod">
          <ac:chgData name="Dr Ahmed Elshazly" userId="92faafa7-b1de-4194-ac20-c5423e5d0806" providerId="ADAL" clId="{591B1513-E534-4A55-B858-A57CE2E401C3}" dt="2026-02-28T21:45:06.753" v="548" actId="14100"/>
          <ac:spMkLst>
            <pc:docMk/>
            <pc:sldMk cId="63235985" sldId="290"/>
            <ac:spMk id="15" creationId="{1936BEE5-02AA-C347-894E-EE388DF4DA41}"/>
          </ac:spMkLst>
        </pc:spChg>
        <pc:spChg chg="add mod">
          <ac:chgData name="Dr Ahmed Elshazly" userId="92faafa7-b1de-4194-ac20-c5423e5d0806" providerId="ADAL" clId="{591B1513-E534-4A55-B858-A57CE2E401C3}" dt="2026-02-28T21:45:11.650" v="550" actId="1076"/>
          <ac:spMkLst>
            <pc:docMk/>
            <pc:sldMk cId="63235985" sldId="290"/>
            <ac:spMk id="16" creationId="{DFC260F2-2163-A934-005A-968C1AA59EED}"/>
          </ac:spMkLst>
        </pc:spChg>
        <pc:spChg chg="add mod">
          <ac:chgData name="Dr Ahmed Elshazly" userId="92faafa7-b1de-4194-ac20-c5423e5d0806" providerId="ADAL" clId="{591B1513-E534-4A55-B858-A57CE2E401C3}" dt="2026-02-28T21:45:17.383" v="552" actId="1076"/>
          <ac:spMkLst>
            <pc:docMk/>
            <pc:sldMk cId="63235985" sldId="290"/>
            <ac:spMk id="17" creationId="{F5994402-0616-3B98-7685-3C4677379145}"/>
          </ac:spMkLst>
        </pc:spChg>
        <pc:spChg chg="add mod">
          <ac:chgData name="Dr Ahmed Elshazly" userId="92faafa7-b1de-4194-ac20-c5423e5d0806" providerId="ADAL" clId="{591B1513-E534-4A55-B858-A57CE2E401C3}" dt="2026-02-28T21:45:27.274" v="556" actId="1076"/>
          <ac:spMkLst>
            <pc:docMk/>
            <pc:sldMk cId="63235985" sldId="290"/>
            <ac:spMk id="18" creationId="{095CCE03-0C83-9338-B028-EF0FE4607ED6}"/>
          </ac:spMkLst>
        </pc:spChg>
        <pc:picChg chg="add mod modCrop">
          <ac:chgData name="Dr Ahmed Elshazly" userId="92faafa7-b1de-4194-ac20-c5423e5d0806" providerId="ADAL" clId="{591B1513-E534-4A55-B858-A57CE2E401C3}" dt="2026-02-28T21:44:31.120" v="536" actId="1076"/>
          <ac:picMkLst>
            <pc:docMk/>
            <pc:sldMk cId="63235985" sldId="290"/>
            <ac:picMk id="5" creationId="{5AB972C4-66AC-8986-B029-4E681970C323}"/>
          </ac:picMkLst>
        </pc:picChg>
        <pc:picChg chg="add mod modCrop">
          <ac:chgData name="Dr Ahmed Elshazly" userId="92faafa7-b1de-4194-ac20-c5423e5d0806" providerId="ADAL" clId="{591B1513-E534-4A55-B858-A57CE2E401C3}" dt="2026-02-28T21:44:34.720" v="539" actId="1076"/>
          <ac:picMkLst>
            <pc:docMk/>
            <pc:sldMk cId="63235985" sldId="290"/>
            <ac:picMk id="6" creationId="{81032A54-BBF7-A036-539C-2B1FB20A2942}"/>
          </ac:picMkLst>
        </pc:picChg>
        <pc:picChg chg="add mod modCrop">
          <ac:chgData name="Dr Ahmed Elshazly" userId="92faafa7-b1de-4194-ac20-c5423e5d0806" providerId="ADAL" clId="{591B1513-E534-4A55-B858-A57CE2E401C3}" dt="2026-02-28T21:44:15.827" v="529" actId="1076"/>
          <ac:picMkLst>
            <pc:docMk/>
            <pc:sldMk cId="63235985" sldId="290"/>
            <ac:picMk id="7" creationId="{6C4B32D6-2147-CF8A-43FC-A419478EC30E}"/>
          </ac:picMkLst>
        </pc:picChg>
        <pc:picChg chg="add mod modCrop">
          <ac:chgData name="Dr Ahmed Elshazly" userId="92faafa7-b1de-4194-ac20-c5423e5d0806" providerId="ADAL" clId="{591B1513-E534-4A55-B858-A57CE2E401C3}" dt="2026-02-28T21:44:53.714" v="544" actId="1076"/>
          <ac:picMkLst>
            <pc:docMk/>
            <pc:sldMk cId="63235985" sldId="290"/>
            <ac:picMk id="8" creationId="{9A12B18D-0D3E-B8B4-AB77-AD551094F1E2}"/>
          </ac:picMkLst>
        </pc:picChg>
      </pc:sldChg>
      <pc:sldChg chg="addSp delSp modSp new mod">
        <pc:chgData name="Dr Ahmed Elshazly" userId="92faafa7-b1de-4194-ac20-c5423e5d0806" providerId="ADAL" clId="{591B1513-E534-4A55-B858-A57CE2E401C3}" dt="2026-02-28T21:49:57.870" v="639" actId="14100"/>
        <pc:sldMkLst>
          <pc:docMk/>
          <pc:sldMk cId="1675306941" sldId="291"/>
        </pc:sldMkLst>
        <pc:spChg chg="del">
          <ac:chgData name="Dr Ahmed Elshazly" userId="92faafa7-b1de-4194-ac20-c5423e5d0806" providerId="ADAL" clId="{591B1513-E534-4A55-B858-A57CE2E401C3}" dt="2026-02-28T21:46:10.269" v="558" actId="478"/>
          <ac:spMkLst>
            <pc:docMk/>
            <pc:sldMk cId="1675306941" sldId="291"/>
            <ac:spMk id="2" creationId="{7A372E33-3F33-0953-9D97-3F9EAC9F3D91}"/>
          </ac:spMkLst>
        </pc:spChg>
        <pc:spChg chg="del">
          <ac:chgData name="Dr Ahmed Elshazly" userId="92faafa7-b1de-4194-ac20-c5423e5d0806" providerId="ADAL" clId="{591B1513-E534-4A55-B858-A57CE2E401C3}" dt="2026-02-28T21:46:10.269" v="558" actId="478"/>
          <ac:spMkLst>
            <pc:docMk/>
            <pc:sldMk cId="1675306941" sldId="291"/>
            <ac:spMk id="3" creationId="{B531877C-1C22-D2ED-260F-A46D32C99432}"/>
          </ac:spMkLst>
        </pc:spChg>
        <pc:spChg chg="add del mod">
          <ac:chgData name="Dr Ahmed Elshazly" userId="92faafa7-b1de-4194-ac20-c5423e5d0806" providerId="ADAL" clId="{591B1513-E534-4A55-B858-A57CE2E401C3}" dt="2026-02-28T21:47:48.558" v="591" actId="21"/>
          <ac:spMkLst>
            <pc:docMk/>
            <pc:sldMk cId="1675306941" sldId="291"/>
            <ac:spMk id="11" creationId="{EE326994-E632-DE54-B49D-FCE9F6B65464}"/>
          </ac:spMkLst>
        </pc:spChg>
        <pc:spChg chg="add del mod">
          <ac:chgData name="Dr Ahmed Elshazly" userId="92faafa7-b1de-4194-ac20-c5423e5d0806" providerId="ADAL" clId="{591B1513-E534-4A55-B858-A57CE2E401C3}" dt="2026-02-28T21:47:48.558" v="591" actId="21"/>
          <ac:spMkLst>
            <pc:docMk/>
            <pc:sldMk cId="1675306941" sldId="291"/>
            <ac:spMk id="12" creationId="{7AF85C9C-A101-3950-834F-7E7C9A2FD69C}"/>
          </ac:spMkLst>
        </pc:spChg>
        <pc:spChg chg="add mod">
          <ac:chgData name="Dr Ahmed Elshazly" userId="92faafa7-b1de-4194-ac20-c5423e5d0806" providerId="ADAL" clId="{591B1513-E534-4A55-B858-A57CE2E401C3}" dt="2026-02-28T21:49:01.925" v="620" actId="1076"/>
          <ac:spMkLst>
            <pc:docMk/>
            <pc:sldMk cId="1675306941" sldId="291"/>
            <ac:spMk id="13" creationId="{A02487AA-4C25-1298-486A-C5EC6608F6D0}"/>
          </ac:spMkLst>
        </pc:spChg>
        <pc:spChg chg="add mod">
          <ac:chgData name="Dr Ahmed Elshazly" userId="92faafa7-b1de-4194-ac20-c5423e5d0806" providerId="ADAL" clId="{591B1513-E534-4A55-B858-A57CE2E401C3}" dt="2026-02-28T21:49:11.948" v="624" actId="1076"/>
          <ac:spMkLst>
            <pc:docMk/>
            <pc:sldMk cId="1675306941" sldId="291"/>
            <ac:spMk id="14" creationId="{878DAE42-7AAC-40ED-B008-2FA45E9AEE9F}"/>
          </ac:spMkLst>
        </pc:spChg>
        <pc:spChg chg="add mod">
          <ac:chgData name="Dr Ahmed Elshazly" userId="92faafa7-b1de-4194-ac20-c5423e5d0806" providerId="ADAL" clId="{591B1513-E534-4A55-B858-A57CE2E401C3}" dt="2026-02-28T21:49:00.100" v="619" actId="1076"/>
          <ac:spMkLst>
            <pc:docMk/>
            <pc:sldMk cId="1675306941" sldId="291"/>
            <ac:spMk id="15" creationId="{1CA5AED4-246A-6DC0-E2DC-16B383C3EDB8}"/>
          </ac:spMkLst>
        </pc:spChg>
        <pc:spChg chg="add mod">
          <ac:chgData name="Dr Ahmed Elshazly" userId="92faafa7-b1de-4194-ac20-c5423e5d0806" providerId="ADAL" clId="{591B1513-E534-4A55-B858-A57CE2E401C3}" dt="2026-02-28T21:48:57.461" v="618" actId="1076"/>
          <ac:spMkLst>
            <pc:docMk/>
            <pc:sldMk cId="1675306941" sldId="291"/>
            <ac:spMk id="16" creationId="{1357C8E9-EB20-18FD-1304-11849DF18526}"/>
          </ac:spMkLst>
        </pc:spChg>
        <pc:spChg chg="add mod">
          <ac:chgData name="Dr Ahmed Elshazly" userId="92faafa7-b1de-4194-ac20-c5423e5d0806" providerId="ADAL" clId="{591B1513-E534-4A55-B858-A57CE2E401C3}" dt="2026-02-28T21:48:50.174" v="616" actId="1076"/>
          <ac:spMkLst>
            <pc:docMk/>
            <pc:sldMk cId="1675306941" sldId="291"/>
            <ac:spMk id="17" creationId="{22403F88-9D6F-1445-E683-C158ACDB01CD}"/>
          </ac:spMkLst>
        </pc:spChg>
        <pc:spChg chg="add del mod">
          <ac:chgData name="Dr Ahmed Elshazly" userId="92faafa7-b1de-4194-ac20-c5423e5d0806" providerId="ADAL" clId="{591B1513-E534-4A55-B858-A57CE2E401C3}" dt="2026-02-28T21:47:48.558" v="591" actId="21"/>
          <ac:spMkLst>
            <pc:docMk/>
            <pc:sldMk cId="1675306941" sldId="291"/>
            <ac:spMk id="18" creationId="{48312F67-5921-C64A-3D81-3B50F711D1AD}"/>
          </ac:spMkLst>
        </pc:spChg>
        <pc:spChg chg="add del mod">
          <ac:chgData name="Dr Ahmed Elshazly" userId="92faafa7-b1de-4194-ac20-c5423e5d0806" providerId="ADAL" clId="{591B1513-E534-4A55-B858-A57CE2E401C3}" dt="2026-02-28T21:47:22.448" v="579" actId="478"/>
          <ac:spMkLst>
            <pc:docMk/>
            <pc:sldMk cId="1675306941" sldId="291"/>
            <ac:spMk id="19" creationId="{0ADD5875-D2FA-00F7-335C-93D41992F0C2}"/>
          </ac:spMkLst>
        </pc:spChg>
        <pc:spChg chg="add mod">
          <ac:chgData name="Dr Ahmed Elshazly" userId="92faafa7-b1de-4194-ac20-c5423e5d0806" providerId="ADAL" clId="{591B1513-E534-4A55-B858-A57CE2E401C3}" dt="2026-02-28T21:49:08.282" v="623" actId="1076"/>
          <ac:spMkLst>
            <pc:docMk/>
            <pc:sldMk cId="1675306941" sldId="291"/>
            <ac:spMk id="20" creationId="{99B59920-C555-C3D2-5891-9B0D609AD33B}"/>
          </ac:spMkLst>
        </pc:spChg>
        <pc:spChg chg="add mod">
          <ac:chgData name="Dr Ahmed Elshazly" userId="92faafa7-b1de-4194-ac20-c5423e5d0806" providerId="ADAL" clId="{591B1513-E534-4A55-B858-A57CE2E401C3}" dt="2026-02-28T21:49:33.117" v="627" actId="14100"/>
          <ac:spMkLst>
            <pc:docMk/>
            <pc:sldMk cId="1675306941" sldId="291"/>
            <ac:spMk id="21" creationId="{1E5C1FB4-68DE-AE7B-2F25-911858A12579}"/>
          </ac:spMkLst>
        </pc:spChg>
        <pc:spChg chg="add mod">
          <ac:chgData name="Dr Ahmed Elshazly" userId="92faafa7-b1de-4194-ac20-c5423e5d0806" providerId="ADAL" clId="{591B1513-E534-4A55-B858-A57CE2E401C3}" dt="2026-02-28T21:49:36.565" v="629" actId="1076"/>
          <ac:spMkLst>
            <pc:docMk/>
            <pc:sldMk cId="1675306941" sldId="291"/>
            <ac:spMk id="22" creationId="{E601FF9F-ED45-EE7B-2762-9CE7D88785E3}"/>
          </ac:spMkLst>
        </pc:spChg>
        <pc:spChg chg="add mod">
          <ac:chgData name="Dr Ahmed Elshazly" userId="92faafa7-b1de-4194-ac20-c5423e5d0806" providerId="ADAL" clId="{591B1513-E534-4A55-B858-A57CE2E401C3}" dt="2026-02-28T21:49:42.394" v="632" actId="14100"/>
          <ac:spMkLst>
            <pc:docMk/>
            <pc:sldMk cId="1675306941" sldId="291"/>
            <ac:spMk id="23" creationId="{2E995230-4038-77E4-AEB8-6E65AB3E892C}"/>
          </ac:spMkLst>
        </pc:spChg>
        <pc:spChg chg="add mod">
          <ac:chgData name="Dr Ahmed Elshazly" userId="92faafa7-b1de-4194-ac20-c5423e5d0806" providerId="ADAL" clId="{591B1513-E534-4A55-B858-A57CE2E401C3}" dt="2026-02-28T21:49:52.651" v="636" actId="1076"/>
          <ac:spMkLst>
            <pc:docMk/>
            <pc:sldMk cId="1675306941" sldId="291"/>
            <ac:spMk id="24" creationId="{A5382E8C-4305-0FD6-E41D-3D249C357736}"/>
          </ac:spMkLst>
        </pc:spChg>
        <pc:spChg chg="add mod">
          <ac:chgData name="Dr Ahmed Elshazly" userId="92faafa7-b1de-4194-ac20-c5423e5d0806" providerId="ADAL" clId="{591B1513-E534-4A55-B858-A57CE2E401C3}" dt="2026-02-28T21:49:57.870" v="639" actId="14100"/>
          <ac:spMkLst>
            <pc:docMk/>
            <pc:sldMk cId="1675306941" sldId="291"/>
            <ac:spMk id="25" creationId="{26BE0D76-D1A8-50ED-F248-4AFCC169607F}"/>
          </ac:spMkLst>
        </pc:spChg>
        <pc:picChg chg="mod modCrop">
          <ac:chgData name="Dr Ahmed Elshazly" userId="92faafa7-b1de-4194-ac20-c5423e5d0806" providerId="ADAL" clId="{591B1513-E534-4A55-B858-A57CE2E401C3}" dt="2026-02-28T21:49:06.467" v="622" actId="1076"/>
          <ac:picMkLst>
            <pc:docMk/>
            <pc:sldMk cId="1675306941" sldId="291"/>
            <ac:picMk id="4" creationId="{B04AB4DD-EB69-42BE-F958-7F1417F6CDB1}"/>
          </ac:picMkLst>
        </pc:picChg>
        <pc:picChg chg="mod modCrop">
          <ac:chgData name="Dr Ahmed Elshazly" userId="92faafa7-b1de-4194-ac20-c5423e5d0806" providerId="ADAL" clId="{591B1513-E534-4A55-B858-A57CE2E401C3}" dt="2026-02-28T21:47:45.603" v="590" actId="1076"/>
          <ac:picMkLst>
            <pc:docMk/>
            <pc:sldMk cId="1675306941" sldId="291"/>
            <ac:picMk id="5" creationId="{5CB4A406-9977-863B-6490-768D6A3DE040}"/>
          </ac:picMkLst>
        </pc:picChg>
        <pc:picChg chg="mod modCrop">
          <ac:chgData name="Dr Ahmed Elshazly" userId="92faafa7-b1de-4194-ac20-c5423e5d0806" providerId="ADAL" clId="{591B1513-E534-4A55-B858-A57CE2E401C3}" dt="2026-02-28T21:48:47.811" v="615" actId="1076"/>
          <ac:picMkLst>
            <pc:docMk/>
            <pc:sldMk cId="1675306941" sldId="291"/>
            <ac:picMk id="6" creationId="{02BAAF0E-FC90-289D-A51B-386432259E3E}"/>
          </ac:picMkLst>
        </pc:picChg>
        <pc:picChg chg="add mod modCrop">
          <ac:chgData name="Dr Ahmed Elshazly" userId="92faafa7-b1de-4194-ac20-c5423e5d0806" providerId="ADAL" clId="{591B1513-E534-4A55-B858-A57CE2E401C3}" dt="2026-02-28T21:47:10.688" v="573" actId="1076"/>
          <ac:picMkLst>
            <pc:docMk/>
            <pc:sldMk cId="1675306941" sldId="291"/>
            <ac:picMk id="7" creationId="{C83FCF6C-4516-76B9-5A4C-7A68CAA21DE1}"/>
          </ac:picMkLst>
        </pc:picChg>
        <pc:picChg chg="del mod">
          <ac:chgData name="Dr Ahmed Elshazly" userId="92faafa7-b1de-4194-ac20-c5423e5d0806" providerId="ADAL" clId="{591B1513-E534-4A55-B858-A57CE2E401C3}" dt="2026-02-28T21:47:48.558" v="591" actId="21"/>
          <ac:picMkLst>
            <pc:docMk/>
            <pc:sldMk cId="1675306941" sldId="291"/>
            <ac:picMk id="8" creationId="{BED4E30B-220C-8505-C740-023FFF2369B4}"/>
          </ac:picMkLst>
        </pc:picChg>
        <pc:picChg chg="mod modCrop">
          <ac:chgData name="Dr Ahmed Elshazly" userId="92faafa7-b1de-4194-ac20-c5423e5d0806" providerId="ADAL" clId="{591B1513-E534-4A55-B858-A57CE2E401C3}" dt="2026-02-28T21:48:51.460" v="617" actId="1076"/>
          <ac:picMkLst>
            <pc:docMk/>
            <pc:sldMk cId="1675306941" sldId="291"/>
            <ac:picMk id="9" creationId="{F97DB034-4E67-5B5C-D235-EB11C2382A1C}"/>
          </ac:picMkLst>
        </pc:picChg>
        <pc:picChg chg="del mod">
          <ac:chgData name="Dr Ahmed Elshazly" userId="92faafa7-b1de-4194-ac20-c5423e5d0806" providerId="ADAL" clId="{591B1513-E534-4A55-B858-A57CE2E401C3}" dt="2026-02-28T21:47:48.558" v="591" actId="21"/>
          <ac:picMkLst>
            <pc:docMk/>
            <pc:sldMk cId="1675306941" sldId="291"/>
            <ac:picMk id="10" creationId="{025F625C-5AC1-6028-0985-AB6868891C01}"/>
          </ac:picMkLst>
        </pc:picChg>
      </pc:sldChg>
      <pc:sldChg chg="addSp delSp modSp new mod">
        <pc:chgData name="Dr Ahmed Elshazly" userId="92faafa7-b1de-4194-ac20-c5423e5d0806" providerId="ADAL" clId="{591B1513-E534-4A55-B858-A57CE2E401C3}" dt="2026-02-28T21:50:31.697" v="653" actId="1076"/>
        <pc:sldMkLst>
          <pc:docMk/>
          <pc:sldMk cId="1195008141" sldId="292"/>
        </pc:sldMkLst>
        <pc:spChg chg="del">
          <ac:chgData name="Dr Ahmed Elshazly" userId="92faafa7-b1de-4194-ac20-c5423e5d0806" providerId="ADAL" clId="{591B1513-E534-4A55-B858-A57CE2E401C3}" dt="2026-02-28T21:47:52.311" v="593" actId="478"/>
          <ac:spMkLst>
            <pc:docMk/>
            <pc:sldMk cId="1195008141" sldId="292"/>
            <ac:spMk id="2" creationId="{F5E69F92-B7CE-528A-E3B9-63C2A6D5A660}"/>
          </ac:spMkLst>
        </pc:spChg>
        <pc:spChg chg="del">
          <ac:chgData name="Dr Ahmed Elshazly" userId="92faafa7-b1de-4194-ac20-c5423e5d0806" providerId="ADAL" clId="{591B1513-E534-4A55-B858-A57CE2E401C3}" dt="2026-02-28T21:47:52.311" v="593" actId="478"/>
          <ac:spMkLst>
            <pc:docMk/>
            <pc:sldMk cId="1195008141" sldId="292"/>
            <ac:spMk id="3" creationId="{938517E1-757B-99C2-6EA9-6E824B91F3CD}"/>
          </ac:spMkLst>
        </pc:spChg>
        <pc:spChg chg="add mod">
          <ac:chgData name="Dr Ahmed Elshazly" userId="92faafa7-b1de-4194-ac20-c5423e5d0806" providerId="ADAL" clId="{591B1513-E534-4A55-B858-A57CE2E401C3}" dt="2026-02-28T21:47:56.374" v="595"/>
          <ac:spMkLst>
            <pc:docMk/>
            <pc:sldMk cId="1195008141" sldId="292"/>
            <ac:spMk id="4" creationId="{76BD543E-02BF-94E3-504B-AEE2374F261B}"/>
          </ac:spMkLst>
        </pc:spChg>
        <pc:spChg chg="add mod">
          <ac:chgData name="Dr Ahmed Elshazly" userId="92faafa7-b1de-4194-ac20-c5423e5d0806" providerId="ADAL" clId="{591B1513-E534-4A55-B858-A57CE2E401C3}" dt="2026-02-28T21:50:19.645" v="648" actId="14100"/>
          <ac:spMkLst>
            <pc:docMk/>
            <pc:sldMk cId="1195008141" sldId="292"/>
            <ac:spMk id="5" creationId="{9D5AC4B4-1225-CB77-6F95-F1F55707F730}"/>
          </ac:spMkLst>
        </pc:spChg>
        <pc:spChg chg="add mod">
          <ac:chgData name="Dr Ahmed Elshazly" userId="92faafa7-b1de-4194-ac20-c5423e5d0806" providerId="ADAL" clId="{591B1513-E534-4A55-B858-A57CE2E401C3}" dt="2026-02-28T21:50:31.697" v="653" actId="1076"/>
          <ac:spMkLst>
            <pc:docMk/>
            <pc:sldMk cId="1195008141" sldId="292"/>
            <ac:spMk id="6" creationId="{A56D6053-6821-D464-7900-5B7A6C7120D3}"/>
          </ac:spMkLst>
        </pc:spChg>
        <pc:spChg chg="add mod">
          <ac:chgData name="Dr Ahmed Elshazly" userId="92faafa7-b1de-4194-ac20-c5423e5d0806" providerId="ADAL" clId="{591B1513-E534-4A55-B858-A57CE2E401C3}" dt="2026-02-28T21:48:34.103" v="612" actId="1076"/>
          <ac:spMkLst>
            <pc:docMk/>
            <pc:sldMk cId="1195008141" sldId="292"/>
            <ac:spMk id="11" creationId="{EE326994-E632-DE54-B49D-FCE9F6B65464}"/>
          </ac:spMkLst>
        </pc:spChg>
        <pc:spChg chg="add mod">
          <ac:chgData name="Dr Ahmed Elshazly" userId="92faafa7-b1de-4194-ac20-c5423e5d0806" providerId="ADAL" clId="{591B1513-E534-4A55-B858-A57CE2E401C3}" dt="2026-02-28T21:48:09.876" v="602" actId="1076"/>
          <ac:spMkLst>
            <pc:docMk/>
            <pc:sldMk cId="1195008141" sldId="292"/>
            <ac:spMk id="12" creationId="{7AF85C9C-A101-3950-834F-7E7C9A2FD69C}"/>
          </ac:spMkLst>
        </pc:spChg>
        <pc:spChg chg="add del mod">
          <ac:chgData name="Dr Ahmed Elshazly" userId="92faafa7-b1de-4194-ac20-c5423e5d0806" providerId="ADAL" clId="{591B1513-E534-4A55-B858-A57CE2E401C3}" dt="2026-02-28T21:48:35.460" v="613" actId="478"/>
          <ac:spMkLst>
            <pc:docMk/>
            <pc:sldMk cId="1195008141" sldId="292"/>
            <ac:spMk id="18" creationId="{48312F67-5921-C64A-3D81-3B50F711D1AD}"/>
          </ac:spMkLst>
        </pc:spChg>
        <pc:picChg chg="add mod ord modCrop">
          <ac:chgData name="Dr Ahmed Elshazly" userId="92faafa7-b1de-4194-ac20-c5423e5d0806" providerId="ADAL" clId="{591B1513-E534-4A55-B858-A57CE2E401C3}" dt="2026-02-28T21:50:13.360" v="644" actId="167"/>
          <ac:picMkLst>
            <pc:docMk/>
            <pc:sldMk cId="1195008141" sldId="292"/>
            <ac:picMk id="8" creationId="{BED4E30B-220C-8505-C740-023FFF2369B4}"/>
          </ac:picMkLst>
        </pc:picChg>
        <pc:picChg chg="add mod ord modCrop">
          <ac:chgData name="Dr Ahmed Elshazly" userId="92faafa7-b1de-4194-ac20-c5423e5d0806" providerId="ADAL" clId="{591B1513-E534-4A55-B858-A57CE2E401C3}" dt="2026-02-28T21:50:10.966" v="643" actId="167"/>
          <ac:picMkLst>
            <pc:docMk/>
            <pc:sldMk cId="1195008141" sldId="292"/>
            <ac:picMk id="10" creationId="{025F625C-5AC1-6028-0985-AB6868891C01}"/>
          </ac:picMkLst>
        </pc:picChg>
      </pc:sldChg>
      <pc:sldChg chg="addSp delSp modSp new mod">
        <pc:chgData name="Dr Ahmed Elshazly" userId="92faafa7-b1de-4194-ac20-c5423e5d0806" providerId="ADAL" clId="{591B1513-E534-4A55-B858-A57CE2E401C3}" dt="2026-02-28T21:59:05.750" v="816" actId="21"/>
        <pc:sldMkLst>
          <pc:docMk/>
          <pc:sldMk cId="604023247" sldId="293"/>
        </pc:sldMkLst>
        <pc:spChg chg="del">
          <ac:chgData name="Dr Ahmed Elshazly" userId="92faafa7-b1de-4194-ac20-c5423e5d0806" providerId="ADAL" clId="{591B1513-E534-4A55-B858-A57CE2E401C3}" dt="2026-02-28T21:51:54.120" v="660" actId="478"/>
          <ac:spMkLst>
            <pc:docMk/>
            <pc:sldMk cId="604023247" sldId="293"/>
            <ac:spMk id="2" creationId="{AA8E5EF3-E157-E04D-ED1C-495C8CDB20FB}"/>
          </ac:spMkLst>
        </pc:spChg>
        <pc:spChg chg="del">
          <ac:chgData name="Dr Ahmed Elshazly" userId="92faafa7-b1de-4194-ac20-c5423e5d0806" providerId="ADAL" clId="{591B1513-E534-4A55-B858-A57CE2E401C3}" dt="2026-02-28T21:51:55.204" v="661" actId="478"/>
          <ac:spMkLst>
            <pc:docMk/>
            <pc:sldMk cId="604023247" sldId="293"/>
            <ac:spMk id="3" creationId="{E1EEAF64-B021-7D92-F368-9BEC27156CF7}"/>
          </ac:spMkLst>
        </pc:spChg>
        <pc:spChg chg="add mod">
          <ac:chgData name="Dr Ahmed Elshazly" userId="92faafa7-b1de-4194-ac20-c5423e5d0806" providerId="ADAL" clId="{591B1513-E534-4A55-B858-A57CE2E401C3}" dt="2026-02-28T21:56:03.977" v="756" actId="20577"/>
          <ac:spMkLst>
            <pc:docMk/>
            <pc:sldMk cId="604023247" sldId="293"/>
            <ac:spMk id="4" creationId="{0E4EAAAB-6F2E-D697-6109-34FE0EC64699}"/>
          </ac:spMkLst>
        </pc:spChg>
        <pc:spChg chg="add mod">
          <ac:chgData name="Dr Ahmed Elshazly" userId="92faafa7-b1de-4194-ac20-c5423e5d0806" providerId="ADAL" clId="{591B1513-E534-4A55-B858-A57CE2E401C3}" dt="2026-02-28T21:55:33.363" v="749" actId="1076"/>
          <ac:spMkLst>
            <pc:docMk/>
            <pc:sldMk cId="604023247" sldId="293"/>
            <ac:spMk id="12" creationId="{306F6E86-DD88-D03A-266A-D129DD0AA5CA}"/>
          </ac:spMkLst>
        </pc:spChg>
        <pc:spChg chg="add mod">
          <ac:chgData name="Dr Ahmed Elshazly" userId="92faafa7-b1de-4194-ac20-c5423e5d0806" providerId="ADAL" clId="{591B1513-E534-4A55-B858-A57CE2E401C3}" dt="2026-02-28T21:54:18.182" v="716" actId="1076"/>
          <ac:spMkLst>
            <pc:docMk/>
            <pc:sldMk cId="604023247" sldId="293"/>
            <ac:spMk id="13" creationId="{5599CCFC-DBD5-9F2B-7B74-9C153C4EEC3F}"/>
          </ac:spMkLst>
        </pc:spChg>
        <pc:spChg chg="add mod">
          <ac:chgData name="Dr Ahmed Elshazly" userId="92faafa7-b1de-4194-ac20-c5423e5d0806" providerId="ADAL" clId="{591B1513-E534-4A55-B858-A57CE2E401C3}" dt="2026-02-28T21:55:26.532" v="745" actId="1076"/>
          <ac:spMkLst>
            <pc:docMk/>
            <pc:sldMk cId="604023247" sldId="293"/>
            <ac:spMk id="14" creationId="{F7286B46-E0D6-12DA-5B77-432369B0F39C}"/>
          </ac:spMkLst>
        </pc:spChg>
        <pc:spChg chg="add mod">
          <ac:chgData name="Dr Ahmed Elshazly" userId="92faafa7-b1de-4194-ac20-c5423e5d0806" providerId="ADAL" clId="{591B1513-E534-4A55-B858-A57CE2E401C3}" dt="2026-02-28T21:55:26.532" v="745" actId="1076"/>
          <ac:spMkLst>
            <pc:docMk/>
            <pc:sldMk cId="604023247" sldId="293"/>
            <ac:spMk id="15" creationId="{AED5F401-D808-C717-6276-1A24A87E25F5}"/>
          </ac:spMkLst>
        </pc:spChg>
        <pc:spChg chg="add mod">
          <ac:chgData name="Dr Ahmed Elshazly" userId="92faafa7-b1de-4194-ac20-c5423e5d0806" providerId="ADAL" clId="{591B1513-E534-4A55-B858-A57CE2E401C3}" dt="2026-02-28T21:55:26.532" v="745" actId="1076"/>
          <ac:spMkLst>
            <pc:docMk/>
            <pc:sldMk cId="604023247" sldId="293"/>
            <ac:spMk id="16" creationId="{0771FA1A-5825-0F31-B41B-28FE2855A3E2}"/>
          </ac:spMkLst>
        </pc:spChg>
        <pc:spChg chg="add mod">
          <ac:chgData name="Dr Ahmed Elshazly" userId="92faafa7-b1de-4194-ac20-c5423e5d0806" providerId="ADAL" clId="{591B1513-E534-4A55-B858-A57CE2E401C3}" dt="2026-02-28T21:54:30.327" v="722" actId="1076"/>
          <ac:spMkLst>
            <pc:docMk/>
            <pc:sldMk cId="604023247" sldId="293"/>
            <ac:spMk id="17" creationId="{7B60C067-8AAF-8F26-A77A-8E8B7B1EBD7A}"/>
          </ac:spMkLst>
        </pc:spChg>
        <pc:spChg chg="add mod">
          <ac:chgData name="Dr Ahmed Elshazly" userId="92faafa7-b1de-4194-ac20-c5423e5d0806" providerId="ADAL" clId="{591B1513-E534-4A55-B858-A57CE2E401C3}" dt="2026-02-28T21:54:21.075" v="717" actId="1076"/>
          <ac:spMkLst>
            <pc:docMk/>
            <pc:sldMk cId="604023247" sldId="293"/>
            <ac:spMk id="18" creationId="{49E5DA15-46F0-6FF8-9FE4-10864C4381BA}"/>
          </ac:spMkLst>
        </pc:spChg>
        <pc:spChg chg="add mod">
          <ac:chgData name="Dr Ahmed Elshazly" userId="92faafa7-b1de-4194-ac20-c5423e5d0806" providerId="ADAL" clId="{591B1513-E534-4A55-B858-A57CE2E401C3}" dt="2026-02-28T21:54:35.076" v="724" actId="1076"/>
          <ac:spMkLst>
            <pc:docMk/>
            <pc:sldMk cId="604023247" sldId="293"/>
            <ac:spMk id="26" creationId="{295F8C06-1C8D-DDD9-4884-10AECD21386C}"/>
          </ac:spMkLst>
        </pc:spChg>
        <pc:spChg chg="add mod">
          <ac:chgData name="Dr Ahmed Elshazly" userId="92faafa7-b1de-4194-ac20-c5423e5d0806" providerId="ADAL" clId="{591B1513-E534-4A55-B858-A57CE2E401C3}" dt="2026-02-28T21:56:10.130" v="758" actId="14100"/>
          <ac:spMkLst>
            <pc:docMk/>
            <pc:sldMk cId="604023247" sldId="293"/>
            <ac:spMk id="27" creationId="{2AAE9866-A7D0-6B1C-6CEA-CD0F3081A9E0}"/>
          </ac:spMkLst>
        </pc:spChg>
        <pc:spChg chg="add mod">
          <ac:chgData name="Dr Ahmed Elshazly" userId="92faafa7-b1de-4194-ac20-c5423e5d0806" providerId="ADAL" clId="{591B1513-E534-4A55-B858-A57CE2E401C3}" dt="2026-02-28T21:56:23.734" v="762" actId="1076"/>
          <ac:spMkLst>
            <pc:docMk/>
            <pc:sldMk cId="604023247" sldId="293"/>
            <ac:spMk id="28" creationId="{2BE228E0-0035-8FB1-593A-D2FCFB7CB63A}"/>
          </ac:spMkLst>
        </pc:spChg>
        <pc:spChg chg="add mod">
          <ac:chgData name="Dr Ahmed Elshazly" userId="92faafa7-b1de-4194-ac20-c5423e5d0806" providerId="ADAL" clId="{591B1513-E534-4A55-B858-A57CE2E401C3}" dt="2026-02-28T21:56:32.724" v="764" actId="1076"/>
          <ac:spMkLst>
            <pc:docMk/>
            <pc:sldMk cId="604023247" sldId="293"/>
            <ac:spMk id="29" creationId="{136A3989-115E-63A4-0C8C-C4AC8EA7BA42}"/>
          </ac:spMkLst>
        </pc:spChg>
        <pc:spChg chg="add del mod">
          <ac:chgData name="Dr Ahmed Elshazly" userId="92faafa7-b1de-4194-ac20-c5423e5d0806" providerId="ADAL" clId="{591B1513-E534-4A55-B858-A57CE2E401C3}" dt="2026-02-28T21:59:05.750" v="816" actId="21"/>
          <ac:spMkLst>
            <pc:docMk/>
            <pc:sldMk cId="604023247" sldId="293"/>
            <ac:spMk id="30" creationId="{4C4EC87B-DCCF-A619-E189-38FE45AB0247}"/>
          </ac:spMkLst>
        </pc:spChg>
        <pc:spChg chg="add mod">
          <ac:chgData name="Dr Ahmed Elshazly" userId="92faafa7-b1de-4194-ac20-c5423e5d0806" providerId="ADAL" clId="{591B1513-E534-4A55-B858-A57CE2E401C3}" dt="2026-02-28T21:56:36.694" v="766" actId="571"/>
          <ac:spMkLst>
            <pc:docMk/>
            <pc:sldMk cId="604023247" sldId="293"/>
            <ac:spMk id="31" creationId="{EB462A36-2421-2D12-1EDF-E9172A3FC1F9}"/>
          </ac:spMkLst>
        </pc:spChg>
        <pc:spChg chg="add mod">
          <ac:chgData name="Dr Ahmed Elshazly" userId="92faafa7-b1de-4194-ac20-c5423e5d0806" providerId="ADAL" clId="{591B1513-E534-4A55-B858-A57CE2E401C3}" dt="2026-02-28T21:56:43.327" v="778" actId="1038"/>
          <ac:spMkLst>
            <pc:docMk/>
            <pc:sldMk cId="604023247" sldId="293"/>
            <ac:spMk id="32" creationId="{284FECF8-5009-1A99-2A56-3E6078E4255E}"/>
          </ac:spMkLst>
        </pc:spChg>
        <pc:spChg chg="add mod">
          <ac:chgData name="Dr Ahmed Elshazly" userId="92faafa7-b1de-4194-ac20-c5423e5d0806" providerId="ADAL" clId="{591B1513-E534-4A55-B858-A57CE2E401C3}" dt="2026-02-28T21:56:49.243" v="780" actId="1076"/>
          <ac:spMkLst>
            <pc:docMk/>
            <pc:sldMk cId="604023247" sldId="293"/>
            <ac:spMk id="33" creationId="{5C42154E-7F1A-F7A6-664F-4DE4C439D85E}"/>
          </ac:spMkLst>
        </pc:spChg>
        <pc:spChg chg="add mod">
          <ac:chgData name="Dr Ahmed Elshazly" userId="92faafa7-b1de-4194-ac20-c5423e5d0806" providerId="ADAL" clId="{591B1513-E534-4A55-B858-A57CE2E401C3}" dt="2026-02-28T21:56:52.851" v="782" actId="1076"/>
          <ac:spMkLst>
            <pc:docMk/>
            <pc:sldMk cId="604023247" sldId="293"/>
            <ac:spMk id="34" creationId="{A2171631-1052-7957-FF9A-64E7A7D90966}"/>
          </ac:spMkLst>
        </pc:spChg>
        <pc:spChg chg="add mod">
          <ac:chgData name="Dr Ahmed Elshazly" userId="92faafa7-b1de-4194-ac20-c5423e5d0806" providerId="ADAL" clId="{591B1513-E534-4A55-B858-A57CE2E401C3}" dt="2026-02-28T21:56:57.943" v="784" actId="1076"/>
          <ac:spMkLst>
            <pc:docMk/>
            <pc:sldMk cId="604023247" sldId="293"/>
            <ac:spMk id="35" creationId="{3C804381-ACC6-95B9-E611-73E6BC3E5D13}"/>
          </ac:spMkLst>
        </pc:spChg>
        <pc:graphicFrameChg chg="del">
          <ac:chgData name="Dr Ahmed Elshazly" userId="92faafa7-b1de-4194-ac20-c5423e5d0806" providerId="ADAL" clId="{591B1513-E534-4A55-B858-A57CE2E401C3}" dt="2026-02-28T21:52:17.971" v="665" actId="478"/>
          <ac:graphicFrameMkLst>
            <pc:docMk/>
            <pc:sldMk cId="604023247" sldId="293"/>
            <ac:graphicFrameMk id="19" creationId="{181CC343-DBC3-3A35-F6D0-2A569F386679}"/>
          </ac:graphicFrameMkLst>
        </pc:graphicFrameChg>
        <pc:graphicFrameChg chg="del">
          <ac:chgData name="Dr Ahmed Elshazly" userId="92faafa7-b1de-4194-ac20-c5423e5d0806" providerId="ADAL" clId="{591B1513-E534-4A55-B858-A57CE2E401C3}" dt="2026-02-28T21:52:19.226" v="666" actId="478"/>
          <ac:graphicFrameMkLst>
            <pc:docMk/>
            <pc:sldMk cId="604023247" sldId="293"/>
            <ac:graphicFrameMk id="20" creationId="{CD8CB598-83A3-B5A3-3E8C-AD1ECDA1A3F9}"/>
          </ac:graphicFrameMkLst>
        </pc:graphicFrameChg>
        <pc:graphicFrameChg chg="del">
          <ac:chgData name="Dr Ahmed Elshazly" userId="92faafa7-b1de-4194-ac20-c5423e5d0806" providerId="ADAL" clId="{591B1513-E534-4A55-B858-A57CE2E401C3}" dt="2026-02-28T21:52:20.352" v="667" actId="478"/>
          <ac:graphicFrameMkLst>
            <pc:docMk/>
            <pc:sldMk cId="604023247" sldId="293"/>
            <ac:graphicFrameMk id="21" creationId="{90E8E53E-DA67-E978-F05B-F0F29B8ED6F7}"/>
          </ac:graphicFrameMkLst>
        </pc:graphicFrameChg>
        <pc:graphicFrameChg chg="del">
          <ac:chgData name="Dr Ahmed Elshazly" userId="92faafa7-b1de-4194-ac20-c5423e5d0806" providerId="ADAL" clId="{591B1513-E534-4A55-B858-A57CE2E401C3}" dt="2026-02-28T21:52:22.376" v="668" actId="478"/>
          <ac:graphicFrameMkLst>
            <pc:docMk/>
            <pc:sldMk cId="604023247" sldId="293"/>
            <ac:graphicFrameMk id="22" creationId="{5E901A9B-B922-9871-2245-209C82FEDB30}"/>
          </ac:graphicFrameMkLst>
        </pc:graphicFrameChg>
        <pc:graphicFrameChg chg="del">
          <ac:chgData name="Dr Ahmed Elshazly" userId="92faafa7-b1de-4194-ac20-c5423e5d0806" providerId="ADAL" clId="{591B1513-E534-4A55-B858-A57CE2E401C3}" dt="2026-02-28T21:52:23.504" v="669" actId="478"/>
          <ac:graphicFrameMkLst>
            <pc:docMk/>
            <pc:sldMk cId="604023247" sldId="293"/>
            <ac:graphicFrameMk id="23" creationId="{2A41E626-AF44-0019-69B6-795122B4D9DE}"/>
          </ac:graphicFrameMkLst>
        </pc:graphicFrameChg>
        <pc:graphicFrameChg chg="del">
          <ac:chgData name="Dr Ahmed Elshazly" userId="92faafa7-b1de-4194-ac20-c5423e5d0806" providerId="ADAL" clId="{591B1513-E534-4A55-B858-A57CE2E401C3}" dt="2026-02-28T21:52:27.888" v="670" actId="478"/>
          <ac:graphicFrameMkLst>
            <pc:docMk/>
            <pc:sldMk cId="604023247" sldId="293"/>
            <ac:graphicFrameMk id="24" creationId="{B3EB5018-6E46-D420-2BF2-B9034C06C922}"/>
          </ac:graphicFrameMkLst>
        </pc:graphicFrameChg>
        <pc:picChg chg="mod modCrop">
          <ac:chgData name="Dr Ahmed Elshazly" userId="92faafa7-b1de-4194-ac20-c5423e5d0806" providerId="ADAL" clId="{591B1513-E534-4A55-B858-A57CE2E401C3}" dt="2026-02-28T21:54:21.075" v="717" actId="1076"/>
          <ac:picMkLst>
            <pc:docMk/>
            <pc:sldMk cId="604023247" sldId="293"/>
            <ac:picMk id="5" creationId="{90744CC5-0AC3-9B63-4DA5-5F8DA11D7EC3}"/>
          </ac:picMkLst>
        </pc:picChg>
        <pc:picChg chg="mod modCrop">
          <ac:chgData name="Dr Ahmed Elshazly" userId="92faafa7-b1de-4194-ac20-c5423e5d0806" providerId="ADAL" clId="{591B1513-E534-4A55-B858-A57CE2E401C3}" dt="2026-02-28T21:54:25.810" v="720" actId="1076"/>
          <ac:picMkLst>
            <pc:docMk/>
            <pc:sldMk cId="604023247" sldId="293"/>
            <ac:picMk id="6" creationId="{150F15F1-F7E3-723C-7FDD-AC1D77072400}"/>
          </ac:picMkLst>
        </pc:picChg>
        <pc:picChg chg="mod modCrop">
          <ac:chgData name="Dr Ahmed Elshazly" userId="92faafa7-b1de-4194-ac20-c5423e5d0806" providerId="ADAL" clId="{591B1513-E534-4A55-B858-A57CE2E401C3}" dt="2026-02-28T21:55:26.532" v="745" actId="1076"/>
          <ac:picMkLst>
            <pc:docMk/>
            <pc:sldMk cId="604023247" sldId="293"/>
            <ac:picMk id="7" creationId="{4756F771-DB07-785C-7098-D7EB8EA4A773}"/>
          </ac:picMkLst>
        </pc:picChg>
        <pc:picChg chg="add mod modCrop">
          <ac:chgData name="Dr Ahmed Elshazly" userId="92faafa7-b1de-4194-ac20-c5423e5d0806" providerId="ADAL" clId="{591B1513-E534-4A55-B858-A57CE2E401C3}" dt="2026-02-28T21:55:26.532" v="745" actId="1076"/>
          <ac:picMkLst>
            <pc:docMk/>
            <pc:sldMk cId="604023247" sldId="293"/>
            <ac:picMk id="8" creationId="{078E5705-9747-76EF-2D5E-4D1853284B7A}"/>
          </ac:picMkLst>
        </pc:picChg>
        <pc:picChg chg="mod modCrop">
          <ac:chgData name="Dr Ahmed Elshazly" userId="92faafa7-b1de-4194-ac20-c5423e5d0806" providerId="ADAL" clId="{591B1513-E534-4A55-B858-A57CE2E401C3}" dt="2026-02-28T21:55:26.532" v="745" actId="1076"/>
          <ac:picMkLst>
            <pc:docMk/>
            <pc:sldMk cId="604023247" sldId="293"/>
            <ac:picMk id="9" creationId="{9A8FA2C9-BAF2-089D-2F65-4ECBC44B2863}"/>
          </ac:picMkLst>
        </pc:picChg>
        <pc:picChg chg="mod modCrop">
          <ac:chgData name="Dr Ahmed Elshazly" userId="92faafa7-b1de-4194-ac20-c5423e5d0806" providerId="ADAL" clId="{591B1513-E534-4A55-B858-A57CE2E401C3}" dt="2026-02-28T21:55:34.339" v="750" actId="1076"/>
          <ac:picMkLst>
            <pc:docMk/>
            <pc:sldMk cId="604023247" sldId="293"/>
            <ac:picMk id="10" creationId="{8D82DBE9-2C4F-6FB3-5566-949C61938F51}"/>
          </ac:picMkLst>
        </pc:picChg>
        <pc:picChg chg="add mod modCrop">
          <ac:chgData name="Dr Ahmed Elshazly" userId="92faafa7-b1de-4194-ac20-c5423e5d0806" providerId="ADAL" clId="{591B1513-E534-4A55-B858-A57CE2E401C3}" dt="2026-02-28T21:52:45.049" v="679" actId="1076"/>
          <ac:picMkLst>
            <pc:docMk/>
            <pc:sldMk cId="604023247" sldId="293"/>
            <ac:picMk id="11" creationId="{683BEC4B-4F4B-1EB1-D179-7D0A2EADE844}"/>
          </ac:picMkLst>
        </pc:picChg>
        <pc:picChg chg="mod modCrop">
          <ac:chgData name="Dr Ahmed Elshazly" userId="92faafa7-b1de-4194-ac20-c5423e5d0806" providerId="ADAL" clId="{591B1513-E534-4A55-B858-A57CE2E401C3}" dt="2026-02-28T21:54:32.448" v="723" actId="1076"/>
          <ac:picMkLst>
            <pc:docMk/>
            <pc:sldMk cId="604023247" sldId="293"/>
            <ac:picMk id="25" creationId="{A0A32453-F24D-3155-7DEC-52FA132D44A9}"/>
          </ac:picMkLst>
        </pc:picChg>
      </pc:sldChg>
      <pc:sldChg chg="addSp delSp modSp new mod">
        <pc:chgData name="Dr Ahmed Elshazly" userId="92faafa7-b1de-4194-ac20-c5423e5d0806" providerId="ADAL" clId="{591B1513-E534-4A55-B858-A57CE2E401C3}" dt="2026-02-28T21:59:27.144" v="824" actId="1076"/>
        <pc:sldMkLst>
          <pc:docMk/>
          <pc:sldMk cId="1140519584" sldId="294"/>
        </pc:sldMkLst>
        <pc:spChg chg="del">
          <ac:chgData name="Dr Ahmed Elshazly" userId="92faafa7-b1de-4194-ac20-c5423e5d0806" providerId="ADAL" clId="{591B1513-E534-4A55-B858-A57CE2E401C3}" dt="2026-02-28T21:57:14.772" v="786" actId="478"/>
          <ac:spMkLst>
            <pc:docMk/>
            <pc:sldMk cId="1140519584" sldId="294"/>
            <ac:spMk id="2" creationId="{B684877B-5B06-89F5-18E4-04E5AB8E96BB}"/>
          </ac:spMkLst>
        </pc:spChg>
        <pc:spChg chg="del">
          <ac:chgData name="Dr Ahmed Elshazly" userId="92faafa7-b1de-4194-ac20-c5423e5d0806" providerId="ADAL" clId="{591B1513-E534-4A55-B858-A57CE2E401C3}" dt="2026-02-28T21:57:14.772" v="786" actId="478"/>
          <ac:spMkLst>
            <pc:docMk/>
            <pc:sldMk cId="1140519584" sldId="294"/>
            <ac:spMk id="3" creationId="{DB15F418-4833-908C-CAC4-DD1AD5C66DB8}"/>
          </ac:spMkLst>
        </pc:spChg>
        <pc:spChg chg="add mod">
          <ac:chgData name="Dr Ahmed Elshazly" userId="92faafa7-b1de-4194-ac20-c5423e5d0806" providerId="ADAL" clId="{591B1513-E534-4A55-B858-A57CE2E401C3}" dt="2026-02-28T21:57:56.071" v="793" actId="20577"/>
          <ac:spMkLst>
            <pc:docMk/>
            <pc:sldMk cId="1140519584" sldId="294"/>
            <ac:spMk id="4" creationId="{59C2CEC9-0CED-4D1C-B60E-F57B6E4F800B}"/>
          </ac:spMkLst>
        </pc:spChg>
        <pc:spChg chg="add mod">
          <ac:chgData name="Dr Ahmed Elshazly" userId="92faafa7-b1de-4194-ac20-c5423e5d0806" providerId="ADAL" clId="{591B1513-E534-4A55-B858-A57CE2E401C3}" dt="2026-02-28T21:59:01.626" v="815" actId="1076"/>
          <ac:spMkLst>
            <pc:docMk/>
            <pc:sldMk cId="1140519584" sldId="294"/>
            <ac:spMk id="8" creationId="{D8407516-3989-D5BF-1F07-469F471F4E59}"/>
          </ac:spMkLst>
        </pc:spChg>
        <pc:spChg chg="add mod">
          <ac:chgData name="Dr Ahmed Elshazly" userId="92faafa7-b1de-4194-ac20-c5423e5d0806" providerId="ADAL" clId="{591B1513-E534-4A55-B858-A57CE2E401C3}" dt="2026-02-28T21:58:58.860" v="814" actId="1076"/>
          <ac:spMkLst>
            <pc:docMk/>
            <pc:sldMk cId="1140519584" sldId="294"/>
            <ac:spMk id="9" creationId="{7D239E51-727F-BC67-0275-1045D8413A95}"/>
          </ac:spMkLst>
        </pc:spChg>
        <pc:spChg chg="add mod">
          <ac:chgData name="Dr Ahmed Elshazly" userId="92faafa7-b1de-4194-ac20-c5423e5d0806" providerId="ADAL" clId="{591B1513-E534-4A55-B858-A57CE2E401C3}" dt="2026-02-28T21:58:56.377" v="813" actId="1076"/>
          <ac:spMkLst>
            <pc:docMk/>
            <pc:sldMk cId="1140519584" sldId="294"/>
            <ac:spMk id="10" creationId="{DB9072FA-2305-462F-A73E-99E3731A8869}"/>
          </ac:spMkLst>
        </pc:spChg>
        <pc:spChg chg="add mod">
          <ac:chgData name="Dr Ahmed Elshazly" userId="92faafa7-b1de-4194-ac20-c5423e5d0806" providerId="ADAL" clId="{591B1513-E534-4A55-B858-A57CE2E401C3}" dt="2026-02-28T21:59:21.278" v="822" actId="1076"/>
          <ac:spMkLst>
            <pc:docMk/>
            <pc:sldMk cId="1140519584" sldId="294"/>
            <ac:spMk id="12" creationId="{A7B60D4E-9B17-FD00-EFA7-B20C7B702EE8}"/>
          </ac:spMkLst>
        </pc:spChg>
        <pc:spChg chg="add mod">
          <ac:chgData name="Dr Ahmed Elshazly" userId="92faafa7-b1de-4194-ac20-c5423e5d0806" providerId="ADAL" clId="{591B1513-E534-4A55-B858-A57CE2E401C3}" dt="2026-02-28T21:59:27.144" v="824" actId="1076"/>
          <ac:spMkLst>
            <pc:docMk/>
            <pc:sldMk cId="1140519584" sldId="294"/>
            <ac:spMk id="13" creationId="{A1F7F3D8-E46D-62DE-210A-5627545146E0}"/>
          </ac:spMkLst>
        </pc:spChg>
        <pc:spChg chg="add mod">
          <ac:chgData name="Dr Ahmed Elshazly" userId="92faafa7-b1de-4194-ac20-c5423e5d0806" providerId="ADAL" clId="{591B1513-E534-4A55-B858-A57CE2E401C3}" dt="2026-02-28T21:59:14.665" v="820" actId="1076"/>
          <ac:spMkLst>
            <pc:docMk/>
            <pc:sldMk cId="1140519584" sldId="294"/>
            <ac:spMk id="30" creationId="{4C4EC87B-DCCF-A619-E189-38FE45AB0247}"/>
          </ac:spMkLst>
        </pc:spChg>
        <pc:graphicFrameChg chg="add del mod">
          <ac:chgData name="Dr Ahmed Elshazly" userId="92faafa7-b1de-4194-ac20-c5423e5d0806" providerId="ADAL" clId="{591B1513-E534-4A55-B858-A57CE2E401C3}" dt="2026-02-28T21:58:20.308" v="795" actId="478"/>
          <ac:graphicFrameMkLst>
            <pc:docMk/>
            <pc:sldMk cId="1140519584" sldId="294"/>
            <ac:graphicFrameMk id="11" creationId="{F3C77FDD-4C38-BA1C-7D69-3A193C15FCFB}"/>
          </ac:graphicFrameMkLst>
        </pc:graphicFrameChg>
        <pc:picChg chg="add mod modCrop">
          <ac:chgData name="Dr Ahmed Elshazly" userId="92faafa7-b1de-4194-ac20-c5423e5d0806" providerId="ADAL" clId="{591B1513-E534-4A55-B858-A57CE2E401C3}" dt="2026-02-28T21:58:29.648" v="799" actId="1076"/>
          <ac:picMkLst>
            <pc:docMk/>
            <pc:sldMk cId="1140519584" sldId="294"/>
            <ac:picMk id="5" creationId="{8D3A0D30-68ED-C4F6-E0DC-5453BAC5B9DC}"/>
          </ac:picMkLst>
        </pc:picChg>
        <pc:picChg chg="add mod modCrop">
          <ac:chgData name="Dr Ahmed Elshazly" userId="92faafa7-b1de-4194-ac20-c5423e5d0806" providerId="ADAL" clId="{591B1513-E534-4A55-B858-A57CE2E401C3}" dt="2026-02-28T21:58:38.581" v="804" actId="1076"/>
          <ac:picMkLst>
            <pc:docMk/>
            <pc:sldMk cId="1140519584" sldId="294"/>
            <ac:picMk id="6" creationId="{88D37B77-097E-193D-3A03-6DD351D3B359}"/>
          </ac:picMkLst>
        </pc:picChg>
        <pc:picChg chg="add mod modCrop">
          <ac:chgData name="Dr Ahmed Elshazly" userId="92faafa7-b1de-4194-ac20-c5423e5d0806" providerId="ADAL" clId="{591B1513-E534-4A55-B858-A57CE2E401C3}" dt="2026-02-28T21:58:53.472" v="812" actId="1076"/>
          <ac:picMkLst>
            <pc:docMk/>
            <pc:sldMk cId="1140519584" sldId="294"/>
            <ac:picMk id="7" creationId="{4FD8F87F-8121-51B3-DF31-D960C10CCEFC}"/>
          </ac:picMkLst>
        </pc:picChg>
      </pc:sldChg>
      <pc:sldChg chg="addSp modSp add mod">
        <pc:chgData name="Dr Ahmed Elshazly" userId="92faafa7-b1de-4194-ac20-c5423e5d0806" providerId="ADAL" clId="{591B1513-E534-4A55-B858-A57CE2E401C3}" dt="2026-02-28T22:01:05.261" v="856" actId="1076"/>
        <pc:sldMkLst>
          <pc:docMk/>
          <pc:sldMk cId="969025427" sldId="295"/>
        </pc:sldMkLst>
        <pc:spChg chg="add mod">
          <ac:chgData name="Dr Ahmed Elshazly" userId="92faafa7-b1de-4194-ac20-c5423e5d0806" providerId="ADAL" clId="{591B1513-E534-4A55-B858-A57CE2E401C3}" dt="2026-02-28T21:59:34.502" v="826" actId="20577"/>
          <ac:spMkLst>
            <pc:docMk/>
            <pc:sldMk cId="969025427" sldId="295"/>
            <ac:spMk id="2" creationId="{BE991B86-F5F8-1BF5-F4AB-C445757D6670}"/>
          </ac:spMkLst>
        </pc:spChg>
        <pc:spChg chg="add mod">
          <ac:chgData name="Dr Ahmed Elshazly" userId="92faafa7-b1de-4194-ac20-c5423e5d0806" providerId="ADAL" clId="{591B1513-E534-4A55-B858-A57CE2E401C3}" dt="2026-02-28T22:00:29.273" v="847" actId="1076"/>
          <ac:spMkLst>
            <pc:docMk/>
            <pc:sldMk cId="969025427" sldId="295"/>
            <ac:spMk id="6" creationId="{667C72E9-7AD6-56D5-E631-0F780AB74452}"/>
          </ac:spMkLst>
        </pc:spChg>
        <pc:spChg chg="add mod">
          <ac:chgData name="Dr Ahmed Elshazly" userId="92faafa7-b1de-4194-ac20-c5423e5d0806" providerId="ADAL" clId="{591B1513-E534-4A55-B858-A57CE2E401C3}" dt="2026-02-28T22:00:31.085" v="848" actId="1076"/>
          <ac:spMkLst>
            <pc:docMk/>
            <pc:sldMk cId="969025427" sldId="295"/>
            <ac:spMk id="7" creationId="{351A9D61-C95B-B908-85FA-75D34C6E8B83}"/>
          </ac:spMkLst>
        </pc:spChg>
        <pc:spChg chg="add mod">
          <ac:chgData name="Dr Ahmed Elshazly" userId="92faafa7-b1de-4194-ac20-c5423e5d0806" providerId="ADAL" clId="{591B1513-E534-4A55-B858-A57CE2E401C3}" dt="2026-02-28T21:59:59.651" v="834" actId="1076"/>
          <ac:spMkLst>
            <pc:docMk/>
            <pc:sldMk cId="969025427" sldId="295"/>
            <ac:spMk id="8" creationId="{935EB04E-9258-783C-2686-FA3BDB11FA55}"/>
          </ac:spMkLst>
        </pc:spChg>
        <pc:spChg chg="add mod">
          <ac:chgData name="Dr Ahmed Elshazly" userId="92faafa7-b1de-4194-ac20-c5423e5d0806" providerId="ADAL" clId="{591B1513-E534-4A55-B858-A57CE2E401C3}" dt="2026-02-28T22:00:50.761" v="852" actId="14100"/>
          <ac:spMkLst>
            <pc:docMk/>
            <pc:sldMk cId="969025427" sldId="295"/>
            <ac:spMk id="9" creationId="{F55A86A9-423E-9FE4-BF79-9A1633453B7D}"/>
          </ac:spMkLst>
        </pc:spChg>
        <pc:spChg chg="add mod">
          <ac:chgData name="Dr Ahmed Elshazly" userId="92faafa7-b1de-4194-ac20-c5423e5d0806" providerId="ADAL" clId="{591B1513-E534-4A55-B858-A57CE2E401C3}" dt="2026-02-28T22:00:55.959" v="854" actId="1076"/>
          <ac:spMkLst>
            <pc:docMk/>
            <pc:sldMk cId="969025427" sldId="295"/>
            <ac:spMk id="10" creationId="{117ED522-2EAF-5472-9ECE-B23FD0E16707}"/>
          </ac:spMkLst>
        </pc:spChg>
        <pc:spChg chg="add mod">
          <ac:chgData name="Dr Ahmed Elshazly" userId="92faafa7-b1de-4194-ac20-c5423e5d0806" providerId="ADAL" clId="{591B1513-E534-4A55-B858-A57CE2E401C3}" dt="2026-02-28T22:01:05.261" v="856" actId="1076"/>
          <ac:spMkLst>
            <pc:docMk/>
            <pc:sldMk cId="969025427" sldId="295"/>
            <ac:spMk id="11" creationId="{5B00D035-83F1-DFA7-9AC6-33CEEE5E77AC}"/>
          </ac:spMkLst>
        </pc:spChg>
        <pc:picChg chg="add mod modCrop">
          <ac:chgData name="Dr Ahmed Elshazly" userId="92faafa7-b1de-4194-ac20-c5423e5d0806" providerId="ADAL" clId="{591B1513-E534-4A55-B858-A57CE2E401C3}" dt="2026-02-28T22:00:32.654" v="849" actId="1076"/>
          <ac:picMkLst>
            <pc:docMk/>
            <pc:sldMk cId="969025427" sldId="295"/>
            <ac:picMk id="3" creationId="{19FA164E-8A28-3F80-4036-856B3E158A7D}"/>
          </ac:picMkLst>
        </pc:picChg>
        <pc:picChg chg="add mod modCrop">
          <ac:chgData name="Dr Ahmed Elshazly" userId="92faafa7-b1de-4194-ac20-c5423e5d0806" providerId="ADAL" clId="{591B1513-E534-4A55-B858-A57CE2E401C3}" dt="2026-02-28T21:59:57.319" v="833" actId="1076"/>
          <ac:picMkLst>
            <pc:docMk/>
            <pc:sldMk cId="969025427" sldId="295"/>
            <ac:picMk id="4" creationId="{97187A08-3376-E42F-9BD6-F3B6155F739E}"/>
          </ac:picMkLst>
        </pc:picChg>
        <pc:picChg chg="add mod modCrop">
          <ac:chgData name="Dr Ahmed Elshazly" userId="92faafa7-b1de-4194-ac20-c5423e5d0806" providerId="ADAL" clId="{591B1513-E534-4A55-B858-A57CE2E401C3}" dt="2026-02-28T22:00:25.877" v="846" actId="1076"/>
          <ac:picMkLst>
            <pc:docMk/>
            <pc:sldMk cId="969025427" sldId="295"/>
            <ac:picMk id="5" creationId="{7C26056E-4A5F-E55C-E051-23B07916E9D6}"/>
          </ac:picMkLst>
        </pc:picChg>
      </pc:sldChg>
      <pc:sldChg chg="addSp delSp modSp add mod">
        <pc:chgData name="Dr Ahmed Elshazly" userId="92faafa7-b1de-4194-ac20-c5423e5d0806" providerId="ADAL" clId="{591B1513-E534-4A55-B858-A57CE2E401C3}" dt="2026-02-28T22:11:17.353" v="1059" actId="1076"/>
        <pc:sldMkLst>
          <pc:docMk/>
          <pc:sldMk cId="1114644223" sldId="296"/>
        </pc:sldMkLst>
        <pc:spChg chg="add mod">
          <ac:chgData name="Dr Ahmed Elshazly" userId="92faafa7-b1de-4194-ac20-c5423e5d0806" providerId="ADAL" clId="{591B1513-E534-4A55-B858-A57CE2E401C3}" dt="2026-02-28T22:08:35.198" v="1002" actId="20577"/>
          <ac:spMkLst>
            <pc:docMk/>
            <pc:sldMk cId="1114644223" sldId="296"/>
            <ac:spMk id="2" creationId="{DAA8CEE7-EAF8-3F3D-22E8-229C5B427BF7}"/>
          </ac:spMkLst>
        </pc:spChg>
        <pc:spChg chg="add mod">
          <ac:chgData name="Dr Ahmed Elshazly" userId="92faafa7-b1de-4194-ac20-c5423e5d0806" providerId="ADAL" clId="{591B1513-E534-4A55-B858-A57CE2E401C3}" dt="2026-02-28T22:09:46.376" v="1018" actId="1076"/>
          <ac:spMkLst>
            <pc:docMk/>
            <pc:sldMk cId="1114644223" sldId="296"/>
            <ac:spMk id="5" creationId="{C5657BF8-DEE4-E050-5A3D-1CBD749E3DE4}"/>
          </ac:spMkLst>
        </pc:spChg>
        <pc:spChg chg="add mod">
          <ac:chgData name="Dr Ahmed Elshazly" userId="92faafa7-b1de-4194-ac20-c5423e5d0806" providerId="ADAL" clId="{591B1513-E534-4A55-B858-A57CE2E401C3}" dt="2026-02-28T22:09:48.239" v="1019" actId="1076"/>
          <ac:spMkLst>
            <pc:docMk/>
            <pc:sldMk cId="1114644223" sldId="296"/>
            <ac:spMk id="6" creationId="{5E4A1C9F-B34B-EADD-5D2E-8E3DCCEBC8E6}"/>
          </ac:spMkLst>
        </pc:spChg>
        <pc:spChg chg="add mod">
          <ac:chgData name="Dr Ahmed Elshazly" userId="92faafa7-b1de-4194-ac20-c5423e5d0806" providerId="ADAL" clId="{591B1513-E534-4A55-B858-A57CE2E401C3}" dt="2026-02-28T22:10:44.288" v="1042" actId="1076"/>
          <ac:spMkLst>
            <pc:docMk/>
            <pc:sldMk cId="1114644223" sldId="296"/>
            <ac:spMk id="7" creationId="{98C5D71D-305E-5035-8072-B77B41C9A126}"/>
          </ac:spMkLst>
        </pc:spChg>
        <pc:spChg chg="add mod">
          <ac:chgData name="Dr Ahmed Elshazly" userId="92faafa7-b1de-4194-ac20-c5423e5d0806" providerId="ADAL" clId="{591B1513-E534-4A55-B858-A57CE2E401C3}" dt="2026-02-28T22:10:40.396" v="1041" actId="1076"/>
          <ac:spMkLst>
            <pc:docMk/>
            <pc:sldMk cId="1114644223" sldId="296"/>
            <ac:spMk id="8" creationId="{AF089FD8-84AC-DEF0-38FB-D8F1D24EA135}"/>
          </ac:spMkLst>
        </pc:spChg>
        <pc:spChg chg="add del mod">
          <ac:chgData name="Dr Ahmed Elshazly" userId="92faafa7-b1de-4194-ac20-c5423e5d0806" providerId="ADAL" clId="{591B1513-E534-4A55-B858-A57CE2E401C3}" dt="2026-02-28T22:10:45.574" v="1043" actId="478"/>
          <ac:spMkLst>
            <pc:docMk/>
            <pc:sldMk cId="1114644223" sldId="296"/>
            <ac:spMk id="9" creationId="{5214875F-A01E-1BE8-0104-E3839FC2A487}"/>
          </ac:spMkLst>
        </pc:spChg>
        <pc:spChg chg="add mod">
          <ac:chgData name="Dr Ahmed Elshazly" userId="92faafa7-b1de-4194-ac20-c5423e5d0806" providerId="ADAL" clId="{591B1513-E534-4A55-B858-A57CE2E401C3}" dt="2026-02-28T22:10:56.507" v="1047" actId="1076"/>
          <ac:spMkLst>
            <pc:docMk/>
            <pc:sldMk cId="1114644223" sldId="296"/>
            <ac:spMk id="13" creationId="{E00AA5B1-F5DE-E489-5A45-2CD8DAFF09FB}"/>
          </ac:spMkLst>
        </pc:spChg>
        <pc:spChg chg="add mod">
          <ac:chgData name="Dr Ahmed Elshazly" userId="92faafa7-b1de-4194-ac20-c5423e5d0806" providerId="ADAL" clId="{591B1513-E534-4A55-B858-A57CE2E401C3}" dt="2026-02-28T22:10:59.407" v="1049" actId="1076"/>
          <ac:spMkLst>
            <pc:docMk/>
            <pc:sldMk cId="1114644223" sldId="296"/>
            <ac:spMk id="14" creationId="{AB35AA89-E830-CD43-6DB3-A2EEA1928E5E}"/>
          </ac:spMkLst>
        </pc:spChg>
        <pc:spChg chg="add mod">
          <ac:chgData name="Dr Ahmed Elshazly" userId="92faafa7-b1de-4194-ac20-c5423e5d0806" providerId="ADAL" clId="{591B1513-E534-4A55-B858-A57CE2E401C3}" dt="2026-02-28T22:11:06.199" v="1053" actId="1076"/>
          <ac:spMkLst>
            <pc:docMk/>
            <pc:sldMk cId="1114644223" sldId="296"/>
            <ac:spMk id="15" creationId="{CF7C1C37-6F3C-2328-2B4C-7DA6B3869491}"/>
          </ac:spMkLst>
        </pc:spChg>
        <pc:spChg chg="add mod">
          <ac:chgData name="Dr Ahmed Elshazly" userId="92faafa7-b1de-4194-ac20-c5423e5d0806" providerId="ADAL" clId="{591B1513-E534-4A55-B858-A57CE2E401C3}" dt="2026-02-28T22:11:10.273" v="1055" actId="1076"/>
          <ac:spMkLst>
            <pc:docMk/>
            <pc:sldMk cId="1114644223" sldId="296"/>
            <ac:spMk id="16" creationId="{52F288CD-B5D5-16E9-E00A-84D5566487A7}"/>
          </ac:spMkLst>
        </pc:spChg>
        <pc:spChg chg="add mod">
          <ac:chgData name="Dr Ahmed Elshazly" userId="92faafa7-b1de-4194-ac20-c5423e5d0806" providerId="ADAL" clId="{591B1513-E534-4A55-B858-A57CE2E401C3}" dt="2026-02-28T22:11:17.353" v="1059" actId="1076"/>
          <ac:spMkLst>
            <pc:docMk/>
            <pc:sldMk cId="1114644223" sldId="296"/>
            <ac:spMk id="17" creationId="{22498CEC-2810-FFFB-0CAA-118141D53710}"/>
          </ac:spMkLst>
        </pc:spChg>
        <pc:picChg chg="add mod modCrop">
          <ac:chgData name="Dr Ahmed Elshazly" userId="92faafa7-b1de-4194-ac20-c5423e5d0806" providerId="ADAL" clId="{591B1513-E534-4A55-B858-A57CE2E401C3}" dt="2026-02-28T22:09:43.999" v="1017" actId="1076"/>
          <ac:picMkLst>
            <pc:docMk/>
            <pc:sldMk cId="1114644223" sldId="296"/>
            <ac:picMk id="3" creationId="{955E0101-BE48-F7DD-C761-641516AB1972}"/>
          </ac:picMkLst>
        </pc:picChg>
        <pc:picChg chg="add mod modCrop">
          <ac:chgData name="Dr Ahmed Elshazly" userId="92faafa7-b1de-4194-ac20-c5423e5d0806" providerId="ADAL" clId="{591B1513-E534-4A55-B858-A57CE2E401C3}" dt="2026-02-28T22:09:42.565" v="1016" actId="1076"/>
          <ac:picMkLst>
            <pc:docMk/>
            <pc:sldMk cId="1114644223" sldId="296"/>
            <ac:picMk id="4" creationId="{71DC6829-ADD5-76C6-ACF6-92924424289E}"/>
          </ac:picMkLst>
        </pc:picChg>
        <pc:picChg chg="add mod modCrop">
          <ac:chgData name="Dr Ahmed Elshazly" userId="92faafa7-b1de-4194-ac20-c5423e5d0806" providerId="ADAL" clId="{591B1513-E534-4A55-B858-A57CE2E401C3}" dt="2026-02-28T22:10:37.681" v="1040" actId="1076"/>
          <ac:picMkLst>
            <pc:docMk/>
            <pc:sldMk cId="1114644223" sldId="296"/>
            <ac:picMk id="10" creationId="{C3AE773D-9DCF-F8BF-CCD3-5B209C745DA5}"/>
          </ac:picMkLst>
        </pc:picChg>
        <pc:picChg chg="add mod modCrop">
          <ac:chgData name="Dr Ahmed Elshazly" userId="92faafa7-b1de-4194-ac20-c5423e5d0806" providerId="ADAL" clId="{591B1513-E534-4A55-B858-A57CE2E401C3}" dt="2026-02-28T22:10:36.136" v="1039" actId="1076"/>
          <ac:picMkLst>
            <pc:docMk/>
            <pc:sldMk cId="1114644223" sldId="296"/>
            <ac:picMk id="11" creationId="{8AF6CA4B-988C-6B73-B84D-3E8005A8A197}"/>
          </ac:picMkLst>
        </pc:picChg>
        <pc:picChg chg="add mod modCrop">
          <ac:chgData name="Dr Ahmed Elshazly" userId="92faafa7-b1de-4194-ac20-c5423e5d0806" providerId="ADAL" clId="{591B1513-E534-4A55-B858-A57CE2E401C3}" dt="2026-02-28T22:10:19.695" v="1032" actId="1076"/>
          <ac:picMkLst>
            <pc:docMk/>
            <pc:sldMk cId="1114644223" sldId="296"/>
            <ac:picMk id="12" creationId="{CCED8EAB-3DCF-ED06-D541-5168F5F5670E}"/>
          </ac:picMkLst>
        </pc:picChg>
      </pc:sldChg>
      <pc:sldChg chg="addSp delSp modSp add mod">
        <pc:chgData name="Dr Ahmed Elshazly" userId="92faafa7-b1de-4194-ac20-c5423e5d0806" providerId="ADAL" clId="{591B1513-E534-4A55-B858-A57CE2E401C3}" dt="2026-02-28T22:08:16.134" v="1000" actId="14100"/>
        <pc:sldMkLst>
          <pc:docMk/>
          <pc:sldMk cId="1605307987" sldId="297"/>
        </pc:sldMkLst>
        <pc:spChg chg="add mod">
          <ac:chgData name="Dr Ahmed Elshazly" userId="92faafa7-b1de-4194-ac20-c5423e5d0806" providerId="ADAL" clId="{591B1513-E534-4A55-B858-A57CE2E401C3}" dt="2026-02-28T22:05:56.641" v="969" actId="20577"/>
          <ac:spMkLst>
            <pc:docMk/>
            <pc:sldMk cId="1605307987" sldId="297"/>
            <ac:spMk id="2" creationId="{B8B5CC43-60DF-DBAA-CAE9-9BCD477EFD44}"/>
          </ac:spMkLst>
        </pc:spChg>
        <pc:spChg chg="add mod">
          <ac:chgData name="Dr Ahmed Elshazly" userId="92faafa7-b1de-4194-ac20-c5423e5d0806" providerId="ADAL" clId="{591B1513-E534-4A55-B858-A57CE2E401C3}" dt="2026-02-28T22:07:52.436" v="991" actId="1076"/>
          <ac:spMkLst>
            <pc:docMk/>
            <pc:sldMk cId="1605307987" sldId="297"/>
            <ac:spMk id="6" creationId="{FEBABE0F-D062-7417-F615-32BCB2541D03}"/>
          </ac:spMkLst>
        </pc:spChg>
        <pc:spChg chg="add mod">
          <ac:chgData name="Dr Ahmed Elshazly" userId="92faafa7-b1de-4194-ac20-c5423e5d0806" providerId="ADAL" clId="{591B1513-E534-4A55-B858-A57CE2E401C3}" dt="2026-02-28T22:07:55.170" v="993" actId="1076"/>
          <ac:spMkLst>
            <pc:docMk/>
            <pc:sldMk cId="1605307987" sldId="297"/>
            <ac:spMk id="7" creationId="{0FB1A788-5E2C-D708-42C8-8A9B7DBF9FC3}"/>
          </ac:spMkLst>
        </pc:spChg>
        <pc:spChg chg="add mod">
          <ac:chgData name="Dr Ahmed Elshazly" userId="92faafa7-b1de-4194-ac20-c5423e5d0806" providerId="ADAL" clId="{591B1513-E534-4A55-B858-A57CE2E401C3}" dt="2026-02-28T22:08:11.386" v="997" actId="1076"/>
          <ac:spMkLst>
            <pc:docMk/>
            <pc:sldMk cId="1605307987" sldId="297"/>
            <ac:spMk id="8" creationId="{45182486-2C7D-0355-65FB-8567012F9917}"/>
          </ac:spMkLst>
        </pc:spChg>
        <pc:spChg chg="add mod">
          <ac:chgData name="Dr Ahmed Elshazly" userId="92faafa7-b1de-4194-ac20-c5423e5d0806" providerId="ADAL" clId="{591B1513-E534-4A55-B858-A57CE2E401C3}" dt="2026-02-28T22:08:16.134" v="1000" actId="14100"/>
          <ac:spMkLst>
            <pc:docMk/>
            <pc:sldMk cId="1605307987" sldId="297"/>
            <ac:spMk id="9" creationId="{CABF8690-81D3-9584-5D73-3356D631F90D}"/>
          </ac:spMkLst>
        </pc:spChg>
        <pc:picChg chg="add del mod modCrop">
          <ac:chgData name="Dr Ahmed Elshazly" userId="92faafa7-b1de-4194-ac20-c5423e5d0806" providerId="ADAL" clId="{591B1513-E534-4A55-B858-A57CE2E401C3}" dt="2026-02-28T22:07:27.802" v="978" actId="478"/>
          <ac:picMkLst>
            <pc:docMk/>
            <pc:sldMk cId="1605307987" sldId="297"/>
            <ac:picMk id="3" creationId="{A6302CE6-02D9-C99D-C6B6-576A44E02BF7}"/>
          </ac:picMkLst>
        </pc:picChg>
        <pc:picChg chg="add mod modCrop">
          <ac:chgData name="Dr Ahmed Elshazly" userId="92faafa7-b1de-4194-ac20-c5423e5d0806" providerId="ADAL" clId="{591B1513-E534-4A55-B858-A57CE2E401C3}" dt="2026-02-28T22:07:48.458" v="989" actId="1076"/>
          <ac:picMkLst>
            <pc:docMk/>
            <pc:sldMk cId="1605307987" sldId="297"/>
            <ac:picMk id="4" creationId="{D2BE3B3B-E841-C046-3F23-50985BAAF959}"/>
          </ac:picMkLst>
        </pc:picChg>
        <pc:picChg chg="add mod modCrop">
          <ac:chgData name="Dr Ahmed Elshazly" userId="92faafa7-b1de-4194-ac20-c5423e5d0806" providerId="ADAL" clId="{591B1513-E534-4A55-B858-A57CE2E401C3}" dt="2026-02-28T22:07:56.207" v="994" actId="1076"/>
          <ac:picMkLst>
            <pc:docMk/>
            <pc:sldMk cId="1605307987" sldId="297"/>
            <ac:picMk id="5" creationId="{B0D01CD6-72AD-5CCB-57B3-11E3C6C42827}"/>
          </ac:picMkLst>
        </pc:picChg>
      </pc:sldChg>
      <pc:sldChg chg="addSp modSp add mod">
        <pc:chgData name="Dr Ahmed Elshazly" userId="92faafa7-b1de-4194-ac20-c5423e5d0806" providerId="ADAL" clId="{591B1513-E534-4A55-B858-A57CE2E401C3}" dt="2026-02-28T22:05:44.280" v="966" actId="14100"/>
        <pc:sldMkLst>
          <pc:docMk/>
          <pc:sldMk cId="3477231905" sldId="298"/>
        </pc:sldMkLst>
        <pc:spChg chg="add mod">
          <ac:chgData name="Dr Ahmed Elshazly" userId="92faafa7-b1de-4194-ac20-c5423e5d0806" providerId="ADAL" clId="{591B1513-E534-4A55-B858-A57CE2E401C3}" dt="2026-02-28T22:04:16.449" v="930" actId="20577"/>
          <ac:spMkLst>
            <pc:docMk/>
            <pc:sldMk cId="3477231905" sldId="298"/>
            <ac:spMk id="2" creationId="{807E76F5-2E2F-F466-3838-11B715D439F9}"/>
          </ac:spMkLst>
        </pc:spChg>
        <pc:spChg chg="add mod">
          <ac:chgData name="Dr Ahmed Elshazly" userId="92faafa7-b1de-4194-ac20-c5423e5d0806" providerId="ADAL" clId="{591B1513-E534-4A55-B858-A57CE2E401C3}" dt="2026-02-28T22:05:20.826" v="955" actId="1076"/>
          <ac:spMkLst>
            <pc:docMk/>
            <pc:sldMk cId="3477231905" sldId="298"/>
            <ac:spMk id="6" creationId="{285FA515-3304-8CD3-7C35-15965127F559}"/>
          </ac:spMkLst>
        </pc:spChg>
        <pc:spChg chg="add mod">
          <ac:chgData name="Dr Ahmed Elshazly" userId="92faafa7-b1de-4194-ac20-c5423e5d0806" providerId="ADAL" clId="{591B1513-E534-4A55-B858-A57CE2E401C3}" dt="2026-02-28T22:05:07.581" v="949" actId="1076"/>
          <ac:spMkLst>
            <pc:docMk/>
            <pc:sldMk cId="3477231905" sldId="298"/>
            <ac:spMk id="7" creationId="{C41AB2CD-18D1-E634-29E5-CEF98B77CD63}"/>
          </ac:spMkLst>
        </pc:spChg>
        <pc:spChg chg="add mod">
          <ac:chgData name="Dr Ahmed Elshazly" userId="92faafa7-b1de-4194-ac20-c5423e5d0806" providerId="ADAL" clId="{591B1513-E534-4A55-B858-A57CE2E401C3}" dt="2026-02-28T22:04:51.284" v="941" actId="1076"/>
          <ac:spMkLst>
            <pc:docMk/>
            <pc:sldMk cId="3477231905" sldId="298"/>
            <ac:spMk id="8" creationId="{07F9D825-BCFB-56C4-178E-62DE8B7B3E41}"/>
          </ac:spMkLst>
        </pc:spChg>
        <pc:spChg chg="add mod">
          <ac:chgData name="Dr Ahmed Elshazly" userId="92faafa7-b1de-4194-ac20-c5423e5d0806" providerId="ADAL" clId="{591B1513-E534-4A55-B858-A57CE2E401C3}" dt="2026-02-28T22:05:37.600" v="963" actId="14100"/>
          <ac:spMkLst>
            <pc:docMk/>
            <pc:sldMk cId="3477231905" sldId="298"/>
            <ac:spMk id="9" creationId="{2E97C5B4-7D22-CE85-5E5C-35D4A2E8CDD7}"/>
          </ac:spMkLst>
        </pc:spChg>
        <pc:spChg chg="add mod">
          <ac:chgData name="Dr Ahmed Elshazly" userId="92faafa7-b1de-4194-ac20-c5423e5d0806" providerId="ADAL" clId="{591B1513-E534-4A55-B858-A57CE2E401C3}" dt="2026-02-28T22:05:44.280" v="966" actId="14100"/>
          <ac:spMkLst>
            <pc:docMk/>
            <pc:sldMk cId="3477231905" sldId="298"/>
            <ac:spMk id="10" creationId="{ED3FEAF2-E787-CA3D-30AA-C53AEF983AAA}"/>
          </ac:spMkLst>
        </pc:spChg>
        <pc:spChg chg="add mod">
          <ac:chgData name="Dr Ahmed Elshazly" userId="92faafa7-b1de-4194-ac20-c5423e5d0806" providerId="ADAL" clId="{591B1513-E534-4A55-B858-A57CE2E401C3}" dt="2026-02-28T22:05:31.259" v="959" actId="14100"/>
          <ac:spMkLst>
            <pc:docMk/>
            <pc:sldMk cId="3477231905" sldId="298"/>
            <ac:spMk id="19" creationId="{D00CECAF-408E-955B-ADDC-A6B4BD00ADBA}"/>
          </ac:spMkLst>
        </pc:spChg>
        <pc:picChg chg="add mod modCrop">
          <ac:chgData name="Dr Ahmed Elshazly" userId="92faafa7-b1de-4194-ac20-c5423e5d0806" providerId="ADAL" clId="{591B1513-E534-4A55-B858-A57CE2E401C3}" dt="2026-02-28T22:05:18.274" v="954" actId="1076"/>
          <ac:picMkLst>
            <pc:docMk/>
            <pc:sldMk cId="3477231905" sldId="298"/>
            <ac:picMk id="3" creationId="{C035B927-0087-4D5B-FFCA-B80D828C0087}"/>
          </ac:picMkLst>
        </pc:picChg>
        <pc:picChg chg="add mod modCrop">
          <ac:chgData name="Dr Ahmed Elshazly" userId="92faafa7-b1de-4194-ac20-c5423e5d0806" providerId="ADAL" clId="{591B1513-E534-4A55-B858-A57CE2E401C3}" dt="2026-02-28T22:04:48.673" v="940" actId="1076"/>
          <ac:picMkLst>
            <pc:docMk/>
            <pc:sldMk cId="3477231905" sldId="298"/>
            <ac:picMk id="4" creationId="{FCC6265C-DD44-A4DF-E0AB-BDCE97930BDB}"/>
          </ac:picMkLst>
        </pc:picChg>
        <pc:picChg chg="add mod modCrop">
          <ac:chgData name="Dr Ahmed Elshazly" userId="92faafa7-b1de-4194-ac20-c5423e5d0806" providerId="ADAL" clId="{591B1513-E534-4A55-B858-A57CE2E401C3}" dt="2026-02-28T22:05:03.779" v="948" actId="1076"/>
          <ac:picMkLst>
            <pc:docMk/>
            <pc:sldMk cId="3477231905" sldId="298"/>
            <ac:picMk id="5" creationId="{6A54DE07-13AA-E60A-A904-58689897723D}"/>
          </ac:picMkLst>
        </pc:picChg>
      </pc:sldChg>
      <pc:sldChg chg="addSp delSp modSp add mod">
        <pc:chgData name="Dr Ahmed Elshazly" userId="92faafa7-b1de-4194-ac20-c5423e5d0806" providerId="ADAL" clId="{591B1513-E534-4A55-B858-A57CE2E401C3}" dt="2026-02-28T22:05:24.162" v="956" actId="21"/>
        <pc:sldMkLst>
          <pc:docMk/>
          <pc:sldMk cId="1303127191" sldId="299"/>
        </pc:sldMkLst>
        <pc:spChg chg="add mod">
          <ac:chgData name="Dr Ahmed Elshazly" userId="92faafa7-b1de-4194-ac20-c5423e5d0806" providerId="ADAL" clId="{591B1513-E534-4A55-B858-A57CE2E401C3}" dt="2026-02-28T22:01:23.736" v="858" actId="20577"/>
          <ac:spMkLst>
            <pc:docMk/>
            <pc:sldMk cId="1303127191" sldId="299"/>
            <ac:spMk id="2" creationId="{4194AD6C-1B69-D45D-E9CB-0353A4A68913}"/>
          </ac:spMkLst>
        </pc:spChg>
        <pc:spChg chg="add mod">
          <ac:chgData name="Dr Ahmed Elshazly" userId="92faafa7-b1de-4194-ac20-c5423e5d0806" providerId="ADAL" clId="{591B1513-E534-4A55-B858-A57CE2E401C3}" dt="2026-02-28T22:03:07.256" v="902" actId="1076"/>
          <ac:spMkLst>
            <pc:docMk/>
            <pc:sldMk cId="1303127191" sldId="299"/>
            <ac:spMk id="9" creationId="{791ECE12-8A18-3A05-4C2F-BBC7D6623F69}"/>
          </ac:spMkLst>
        </pc:spChg>
        <pc:spChg chg="add mod">
          <ac:chgData name="Dr Ahmed Elshazly" userId="92faafa7-b1de-4194-ac20-c5423e5d0806" providerId="ADAL" clId="{591B1513-E534-4A55-B858-A57CE2E401C3}" dt="2026-02-28T22:02:51.523" v="894" actId="1076"/>
          <ac:spMkLst>
            <pc:docMk/>
            <pc:sldMk cId="1303127191" sldId="299"/>
            <ac:spMk id="10" creationId="{2D2AD958-1BBA-DBBC-98E1-A70DCF803B04}"/>
          </ac:spMkLst>
        </pc:spChg>
        <pc:spChg chg="add mod">
          <ac:chgData name="Dr Ahmed Elshazly" userId="92faafa7-b1de-4194-ac20-c5423e5d0806" providerId="ADAL" clId="{591B1513-E534-4A55-B858-A57CE2E401C3}" dt="2026-02-28T22:02:36.904" v="887" actId="1076"/>
          <ac:spMkLst>
            <pc:docMk/>
            <pc:sldMk cId="1303127191" sldId="299"/>
            <ac:spMk id="11" creationId="{943E244F-151C-5623-6D1D-A9F993D328DA}"/>
          </ac:spMkLst>
        </pc:spChg>
        <pc:spChg chg="add mod">
          <ac:chgData name="Dr Ahmed Elshazly" userId="92faafa7-b1de-4194-ac20-c5423e5d0806" providerId="ADAL" clId="{591B1513-E534-4A55-B858-A57CE2E401C3}" dt="2026-02-28T22:02:20.594" v="880" actId="1076"/>
          <ac:spMkLst>
            <pc:docMk/>
            <pc:sldMk cId="1303127191" sldId="299"/>
            <ac:spMk id="12" creationId="{FD12A9B2-8260-D1E3-0D88-6F35CEE7CCE6}"/>
          </ac:spMkLst>
        </pc:spChg>
        <pc:spChg chg="add mod">
          <ac:chgData name="Dr Ahmed Elshazly" userId="92faafa7-b1de-4194-ac20-c5423e5d0806" providerId="ADAL" clId="{591B1513-E534-4A55-B858-A57CE2E401C3}" dt="2026-02-28T22:01:49.828" v="866" actId="1076"/>
          <ac:spMkLst>
            <pc:docMk/>
            <pc:sldMk cId="1303127191" sldId="299"/>
            <ac:spMk id="13" creationId="{56FC23EB-3A42-BB69-5D1D-410F000C1E0F}"/>
          </ac:spMkLst>
        </pc:spChg>
        <pc:spChg chg="add mod">
          <ac:chgData name="Dr Ahmed Elshazly" userId="92faafa7-b1de-4194-ac20-c5423e5d0806" providerId="ADAL" clId="{591B1513-E534-4A55-B858-A57CE2E401C3}" dt="2026-02-28T22:02:03.632" v="872" actId="1076"/>
          <ac:spMkLst>
            <pc:docMk/>
            <pc:sldMk cId="1303127191" sldId="299"/>
            <ac:spMk id="14" creationId="{35500DEE-57A5-1D1B-2A2C-554389B768F0}"/>
          </ac:spMkLst>
        </pc:spChg>
        <pc:spChg chg="add mod">
          <ac:chgData name="Dr Ahmed Elshazly" userId="92faafa7-b1de-4194-ac20-c5423e5d0806" providerId="ADAL" clId="{591B1513-E534-4A55-B858-A57CE2E401C3}" dt="2026-02-28T22:03:21.082" v="905" actId="14100"/>
          <ac:spMkLst>
            <pc:docMk/>
            <pc:sldMk cId="1303127191" sldId="299"/>
            <ac:spMk id="16" creationId="{557FB062-685F-4731-235F-D8DBDA5757E9}"/>
          </ac:spMkLst>
        </pc:spChg>
        <pc:spChg chg="add mod">
          <ac:chgData name="Dr Ahmed Elshazly" userId="92faafa7-b1de-4194-ac20-c5423e5d0806" providerId="ADAL" clId="{591B1513-E534-4A55-B858-A57CE2E401C3}" dt="2026-02-28T22:03:27.595" v="912" actId="1038"/>
          <ac:spMkLst>
            <pc:docMk/>
            <pc:sldMk cId="1303127191" sldId="299"/>
            <ac:spMk id="17" creationId="{1C0D706A-C9C6-77A7-7DD8-6215A740E5FC}"/>
          </ac:spMkLst>
        </pc:spChg>
        <pc:spChg chg="add mod">
          <ac:chgData name="Dr Ahmed Elshazly" userId="92faafa7-b1de-4194-ac20-c5423e5d0806" providerId="ADAL" clId="{591B1513-E534-4A55-B858-A57CE2E401C3}" dt="2026-02-28T22:03:32.122" v="914" actId="1076"/>
          <ac:spMkLst>
            <pc:docMk/>
            <pc:sldMk cId="1303127191" sldId="299"/>
            <ac:spMk id="18" creationId="{3A99DF73-8293-9C77-CF37-EF889D36B51B}"/>
          </ac:spMkLst>
        </pc:spChg>
        <pc:spChg chg="add del mod">
          <ac:chgData name="Dr Ahmed Elshazly" userId="92faafa7-b1de-4194-ac20-c5423e5d0806" providerId="ADAL" clId="{591B1513-E534-4A55-B858-A57CE2E401C3}" dt="2026-02-28T22:05:24.162" v="956" actId="21"/>
          <ac:spMkLst>
            <pc:docMk/>
            <pc:sldMk cId="1303127191" sldId="299"/>
            <ac:spMk id="19" creationId="{D00CECAF-408E-955B-ADDC-A6B4BD00ADBA}"/>
          </ac:spMkLst>
        </pc:spChg>
        <pc:spChg chg="add mod">
          <ac:chgData name="Dr Ahmed Elshazly" userId="92faafa7-b1de-4194-ac20-c5423e5d0806" providerId="ADAL" clId="{591B1513-E534-4A55-B858-A57CE2E401C3}" dt="2026-02-28T22:03:37.040" v="916" actId="571"/>
          <ac:spMkLst>
            <pc:docMk/>
            <pc:sldMk cId="1303127191" sldId="299"/>
            <ac:spMk id="20" creationId="{48520F47-C34F-E1C9-2E68-1A01EFD36949}"/>
          </ac:spMkLst>
        </pc:spChg>
        <pc:spChg chg="add mod">
          <ac:chgData name="Dr Ahmed Elshazly" userId="92faafa7-b1de-4194-ac20-c5423e5d0806" providerId="ADAL" clId="{591B1513-E534-4A55-B858-A57CE2E401C3}" dt="2026-02-28T22:03:37.672" v="917"/>
          <ac:spMkLst>
            <pc:docMk/>
            <pc:sldMk cId="1303127191" sldId="299"/>
            <ac:spMk id="21" creationId="{6FB0A757-5290-2E76-8BEF-E694B0FBA2CB}"/>
          </ac:spMkLst>
        </pc:spChg>
        <pc:spChg chg="add mod">
          <ac:chgData name="Dr Ahmed Elshazly" userId="92faafa7-b1de-4194-ac20-c5423e5d0806" providerId="ADAL" clId="{591B1513-E534-4A55-B858-A57CE2E401C3}" dt="2026-02-28T22:03:40.792" v="918" actId="571"/>
          <ac:spMkLst>
            <pc:docMk/>
            <pc:sldMk cId="1303127191" sldId="299"/>
            <ac:spMk id="22" creationId="{0A2B76D4-6381-F3CB-87C2-EEC446F09268}"/>
          </ac:spMkLst>
        </pc:spChg>
        <pc:spChg chg="add mod">
          <ac:chgData name="Dr Ahmed Elshazly" userId="92faafa7-b1de-4194-ac20-c5423e5d0806" providerId="ADAL" clId="{591B1513-E534-4A55-B858-A57CE2E401C3}" dt="2026-02-28T22:04:00.229" v="927" actId="1038"/>
          <ac:spMkLst>
            <pc:docMk/>
            <pc:sldMk cId="1303127191" sldId="299"/>
            <ac:spMk id="23" creationId="{0E874323-2EAC-AEE0-84E1-C646A445A179}"/>
          </ac:spMkLst>
        </pc:spChg>
        <pc:graphicFrameChg chg="del">
          <ac:chgData name="Dr Ahmed Elshazly" userId="92faafa7-b1de-4194-ac20-c5423e5d0806" providerId="ADAL" clId="{591B1513-E534-4A55-B858-A57CE2E401C3}" dt="2026-02-28T22:02:53.783" v="896" actId="478"/>
          <ac:graphicFrameMkLst>
            <pc:docMk/>
            <pc:sldMk cId="1303127191" sldId="299"/>
            <ac:graphicFrameMk id="15" creationId="{A9540C95-0CA3-71EC-249A-012DA980CC97}"/>
          </ac:graphicFrameMkLst>
        </pc:graphicFrameChg>
        <pc:picChg chg="add mod modCrop">
          <ac:chgData name="Dr Ahmed Elshazly" userId="92faafa7-b1de-4194-ac20-c5423e5d0806" providerId="ADAL" clId="{591B1513-E534-4A55-B858-A57CE2E401C3}" dt="2026-02-28T22:02:01.677" v="871" actId="1076"/>
          <ac:picMkLst>
            <pc:docMk/>
            <pc:sldMk cId="1303127191" sldId="299"/>
            <ac:picMk id="3" creationId="{88320307-16E2-05DD-99AF-BEC69FAEC698}"/>
          </ac:picMkLst>
        </pc:picChg>
        <pc:picChg chg="add mod modCrop">
          <ac:chgData name="Dr Ahmed Elshazly" userId="92faafa7-b1de-4194-ac20-c5423e5d0806" providerId="ADAL" clId="{591B1513-E534-4A55-B858-A57CE2E401C3}" dt="2026-02-28T22:02:34.004" v="886" actId="1076"/>
          <ac:picMkLst>
            <pc:docMk/>
            <pc:sldMk cId="1303127191" sldId="299"/>
            <ac:picMk id="4" creationId="{2BC55C5A-F1B1-29B4-C108-84B86B4D642D}"/>
          </ac:picMkLst>
        </pc:picChg>
        <pc:picChg chg="add mod modCrop">
          <ac:chgData name="Dr Ahmed Elshazly" userId="92faafa7-b1de-4194-ac20-c5423e5d0806" providerId="ADAL" clId="{591B1513-E534-4A55-B858-A57CE2E401C3}" dt="2026-02-28T22:01:47.376" v="865" actId="1076"/>
          <ac:picMkLst>
            <pc:docMk/>
            <pc:sldMk cId="1303127191" sldId="299"/>
            <ac:picMk id="5" creationId="{EBD545A8-1DFA-A62D-7D88-0A01A5D4017A}"/>
          </ac:picMkLst>
        </pc:picChg>
        <pc:picChg chg="mod modCrop">
          <ac:chgData name="Dr Ahmed Elshazly" userId="92faafa7-b1de-4194-ac20-c5423e5d0806" providerId="ADAL" clId="{591B1513-E534-4A55-B858-A57CE2E401C3}" dt="2026-02-28T22:02:17.645" v="879" actId="1076"/>
          <ac:picMkLst>
            <pc:docMk/>
            <pc:sldMk cId="1303127191" sldId="299"/>
            <ac:picMk id="6" creationId="{B6997919-AB68-461B-3607-337D7EF5C6F0}"/>
          </ac:picMkLst>
        </pc:picChg>
        <pc:picChg chg="add mod modCrop">
          <ac:chgData name="Dr Ahmed Elshazly" userId="92faafa7-b1de-4194-ac20-c5423e5d0806" providerId="ADAL" clId="{591B1513-E534-4A55-B858-A57CE2E401C3}" dt="2026-02-28T22:03:04.279" v="901" actId="1076"/>
          <ac:picMkLst>
            <pc:docMk/>
            <pc:sldMk cId="1303127191" sldId="299"/>
            <ac:picMk id="7" creationId="{14879C39-ED72-81FD-8228-28679CFC37AB}"/>
          </ac:picMkLst>
        </pc:picChg>
        <pc:picChg chg="mod modCrop">
          <ac:chgData name="Dr Ahmed Elshazly" userId="92faafa7-b1de-4194-ac20-c5423e5d0806" providerId="ADAL" clId="{591B1513-E534-4A55-B858-A57CE2E401C3}" dt="2026-02-28T22:02:48.480" v="893" actId="1076"/>
          <ac:picMkLst>
            <pc:docMk/>
            <pc:sldMk cId="1303127191" sldId="299"/>
            <ac:picMk id="8" creationId="{3FE149D4-CB86-8ADA-E785-E273965CAA21}"/>
          </ac:picMkLst>
        </pc:picChg>
      </pc:sldChg>
      <pc:sldChg chg="addSp delSp modSp new mod">
        <pc:chgData name="Dr Ahmed Elshazly" userId="92faafa7-b1de-4194-ac20-c5423e5d0806" providerId="ADAL" clId="{591B1513-E534-4A55-B858-A57CE2E401C3}" dt="2026-02-28T22:13:09.625" v="1100" actId="1076"/>
        <pc:sldMkLst>
          <pc:docMk/>
          <pc:sldMk cId="2891402879" sldId="300"/>
        </pc:sldMkLst>
        <pc:spChg chg="del">
          <ac:chgData name="Dr Ahmed Elshazly" userId="92faafa7-b1de-4194-ac20-c5423e5d0806" providerId="ADAL" clId="{591B1513-E534-4A55-B858-A57CE2E401C3}" dt="2026-02-28T22:11:44.798" v="1063" actId="478"/>
          <ac:spMkLst>
            <pc:docMk/>
            <pc:sldMk cId="2891402879" sldId="300"/>
            <ac:spMk id="2" creationId="{56DFEFF2-CCC0-4C22-D10E-B109DF51E160}"/>
          </ac:spMkLst>
        </pc:spChg>
        <pc:spChg chg="del">
          <ac:chgData name="Dr Ahmed Elshazly" userId="92faafa7-b1de-4194-ac20-c5423e5d0806" providerId="ADAL" clId="{591B1513-E534-4A55-B858-A57CE2E401C3}" dt="2026-02-28T22:11:44.798" v="1063" actId="478"/>
          <ac:spMkLst>
            <pc:docMk/>
            <pc:sldMk cId="2891402879" sldId="300"/>
            <ac:spMk id="3" creationId="{42875851-DB99-E95C-7ACD-2DE8AEF9A009}"/>
          </ac:spMkLst>
        </pc:spChg>
        <pc:spChg chg="add mod">
          <ac:chgData name="Dr Ahmed Elshazly" userId="92faafa7-b1de-4194-ac20-c5423e5d0806" providerId="ADAL" clId="{591B1513-E534-4A55-B858-A57CE2E401C3}" dt="2026-02-28T22:11:53.264" v="1065" actId="20577"/>
          <ac:spMkLst>
            <pc:docMk/>
            <pc:sldMk cId="2891402879" sldId="300"/>
            <ac:spMk id="4" creationId="{3E17470B-5C04-021B-7E53-E4A8649819E6}"/>
          </ac:spMkLst>
        </pc:spChg>
        <pc:spChg chg="add mod">
          <ac:chgData name="Dr Ahmed Elshazly" userId="92faafa7-b1de-4194-ac20-c5423e5d0806" providerId="ADAL" clId="{591B1513-E534-4A55-B858-A57CE2E401C3}" dt="2026-02-28T22:12:40.705" v="1086" actId="1076"/>
          <ac:spMkLst>
            <pc:docMk/>
            <pc:sldMk cId="2891402879" sldId="300"/>
            <ac:spMk id="8" creationId="{90D6D58B-DAB3-E0B2-C27F-966EC21F9EDE}"/>
          </ac:spMkLst>
        </pc:spChg>
        <pc:spChg chg="add mod">
          <ac:chgData name="Dr Ahmed Elshazly" userId="92faafa7-b1de-4194-ac20-c5423e5d0806" providerId="ADAL" clId="{591B1513-E534-4A55-B858-A57CE2E401C3}" dt="2026-02-28T22:12:42.947" v="1087" actId="1076"/>
          <ac:spMkLst>
            <pc:docMk/>
            <pc:sldMk cId="2891402879" sldId="300"/>
            <ac:spMk id="9" creationId="{C5B8C768-D837-833A-0AA9-486A8E47117C}"/>
          </ac:spMkLst>
        </pc:spChg>
        <pc:spChg chg="add mod">
          <ac:chgData name="Dr Ahmed Elshazly" userId="92faafa7-b1de-4194-ac20-c5423e5d0806" providerId="ADAL" clId="{591B1513-E534-4A55-B858-A57CE2E401C3}" dt="2026-02-28T22:12:46.012" v="1088" actId="1076"/>
          <ac:spMkLst>
            <pc:docMk/>
            <pc:sldMk cId="2891402879" sldId="300"/>
            <ac:spMk id="11" creationId="{BED4C7A1-B7B0-D102-A61B-4C27B0BA1453}"/>
          </ac:spMkLst>
        </pc:spChg>
        <pc:spChg chg="add mod">
          <ac:chgData name="Dr Ahmed Elshazly" userId="92faafa7-b1de-4194-ac20-c5423e5d0806" providerId="ADAL" clId="{591B1513-E534-4A55-B858-A57CE2E401C3}" dt="2026-02-28T22:12:55.291" v="1091" actId="14100"/>
          <ac:spMkLst>
            <pc:docMk/>
            <pc:sldMk cId="2891402879" sldId="300"/>
            <ac:spMk id="12" creationId="{1574286C-F8B4-BD85-C44E-2EC0218393FD}"/>
          </ac:spMkLst>
        </pc:spChg>
        <pc:spChg chg="add mod">
          <ac:chgData name="Dr Ahmed Elshazly" userId="92faafa7-b1de-4194-ac20-c5423e5d0806" providerId="ADAL" clId="{591B1513-E534-4A55-B858-A57CE2E401C3}" dt="2026-02-28T22:13:01.417" v="1095" actId="14100"/>
          <ac:spMkLst>
            <pc:docMk/>
            <pc:sldMk cId="2891402879" sldId="300"/>
            <ac:spMk id="13" creationId="{6275004B-1CC1-E387-9CF8-5704C11C41CC}"/>
          </ac:spMkLst>
        </pc:spChg>
        <pc:spChg chg="add mod">
          <ac:chgData name="Dr Ahmed Elshazly" userId="92faafa7-b1de-4194-ac20-c5423e5d0806" providerId="ADAL" clId="{591B1513-E534-4A55-B858-A57CE2E401C3}" dt="2026-02-28T22:13:09.625" v="1100" actId="1076"/>
          <ac:spMkLst>
            <pc:docMk/>
            <pc:sldMk cId="2891402879" sldId="300"/>
            <ac:spMk id="14" creationId="{2E36453C-9E04-AD07-FDDC-48E8AE4D7039}"/>
          </ac:spMkLst>
        </pc:spChg>
        <pc:graphicFrameChg chg="add del mod">
          <ac:chgData name="Dr Ahmed Elshazly" userId="92faafa7-b1de-4194-ac20-c5423e5d0806" providerId="ADAL" clId="{591B1513-E534-4A55-B858-A57CE2E401C3}" dt="2026-02-28T22:12:01.618" v="1067" actId="478"/>
          <ac:graphicFrameMkLst>
            <pc:docMk/>
            <pc:sldMk cId="2891402879" sldId="300"/>
            <ac:graphicFrameMk id="7" creationId="{9B4F7C37-E917-EA15-01C0-72949534E3F5}"/>
          </ac:graphicFrameMkLst>
        </pc:graphicFrameChg>
        <pc:picChg chg="add mod modCrop">
          <ac:chgData name="Dr Ahmed Elshazly" userId="92faafa7-b1de-4194-ac20-c5423e5d0806" providerId="ADAL" clId="{591B1513-E534-4A55-B858-A57CE2E401C3}" dt="2026-02-28T22:12:21.595" v="1078" actId="1076"/>
          <ac:picMkLst>
            <pc:docMk/>
            <pc:sldMk cId="2891402879" sldId="300"/>
            <ac:picMk id="5" creationId="{E646106B-352A-9AC1-6300-41DA3D56E431}"/>
          </ac:picMkLst>
        </pc:picChg>
        <pc:picChg chg="add mod modCrop">
          <ac:chgData name="Dr Ahmed Elshazly" userId="92faafa7-b1de-4194-ac20-c5423e5d0806" providerId="ADAL" clId="{591B1513-E534-4A55-B858-A57CE2E401C3}" dt="2026-02-28T22:12:37.644" v="1085" actId="1076"/>
          <ac:picMkLst>
            <pc:docMk/>
            <pc:sldMk cId="2891402879" sldId="300"/>
            <ac:picMk id="6" creationId="{C5880883-3EF0-871E-CBD7-FFD73CC38BB2}"/>
          </ac:picMkLst>
        </pc:picChg>
        <pc:picChg chg="add mod modCrop">
          <ac:chgData name="Dr Ahmed Elshazly" userId="92faafa7-b1de-4194-ac20-c5423e5d0806" providerId="ADAL" clId="{591B1513-E534-4A55-B858-A57CE2E401C3}" dt="2026-02-28T22:12:12.377" v="1073" actId="1076"/>
          <ac:picMkLst>
            <pc:docMk/>
            <pc:sldMk cId="2891402879" sldId="300"/>
            <ac:picMk id="10" creationId="{402F35AC-E7F6-1D74-A774-B728478C66C6}"/>
          </ac:picMkLst>
        </pc:picChg>
      </pc:sldChg>
      <pc:sldChg chg="addSp delSp modSp new mod">
        <pc:chgData name="Dr Ahmed Elshazly" userId="92faafa7-b1de-4194-ac20-c5423e5d0806" providerId="ADAL" clId="{591B1513-E534-4A55-B858-A57CE2E401C3}" dt="2026-02-28T22:16:49.353" v="1175" actId="14100"/>
        <pc:sldMkLst>
          <pc:docMk/>
          <pc:sldMk cId="2153483527" sldId="301"/>
        </pc:sldMkLst>
        <pc:spChg chg="del">
          <ac:chgData name="Dr Ahmed Elshazly" userId="92faafa7-b1de-4194-ac20-c5423e5d0806" providerId="ADAL" clId="{591B1513-E534-4A55-B858-A57CE2E401C3}" dt="2026-02-28T22:14:38.918" v="1116" actId="478"/>
          <ac:spMkLst>
            <pc:docMk/>
            <pc:sldMk cId="2153483527" sldId="301"/>
            <ac:spMk id="2" creationId="{6690B8D3-0267-E5D1-C7C3-E83B81627CA0}"/>
          </ac:spMkLst>
        </pc:spChg>
        <pc:spChg chg="del">
          <ac:chgData name="Dr Ahmed Elshazly" userId="92faafa7-b1de-4194-ac20-c5423e5d0806" providerId="ADAL" clId="{591B1513-E534-4A55-B858-A57CE2E401C3}" dt="2026-02-28T22:14:38.918" v="1116" actId="478"/>
          <ac:spMkLst>
            <pc:docMk/>
            <pc:sldMk cId="2153483527" sldId="301"/>
            <ac:spMk id="3" creationId="{345BDA56-5A47-3787-56A7-197D6A560C52}"/>
          </ac:spMkLst>
        </pc:spChg>
        <pc:spChg chg="add mod">
          <ac:chgData name="Dr Ahmed Elshazly" userId="92faafa7-b1de-4194-ac20-c5423e5d0806" providerId="ADAL" clId="{591B1513-E534-4A55-B858-A57CE2E401C3}" dt="2026-02-28T22:14:47.294" v="1118" actId="20577"/>
          <ac:spMkLst>
            <pc:docMk/>
            <pc:sldMk cId="2153483527" sldId="301"/>
            <ac:spMk id="4" creationId="{8D6F0867-B448-1E0B-FA2C-F3FA888183D4}"/>
          </ac:spMkLst>
        </pc:spChg>
        <pc:spChg chg="add mod">
          <ac:chgData name="Dr Ahmed Elshazly" userId="92faafa7-b1de-4194-ac20-c5423e5d0806" providerId="ADAL" clId="{591B1513-E534-4A55-B858-A57CE2E401C3}" dt="2026-02-28T22:15:09.472" v="1126" actId="1076"/>
          <ac:spMkLst>
            <pc:docMk/>
            <pc:sldMk cId="2153483527" sldId="301"/>
            <ac:spMk id="11" creationId="{3E7E4C5A-7311-8CF5-DE3C-D968FF44D640}"/>
          </ac:spMkLst>
        </pc:spChg>
        <pc:spChg chg="add mod">
          <ac:chgData name="Dr Ahmed Elshazly" userId="92faafa7-b1de-4194-ac20-c5423e5d0806" providerId="ADAL" clId="{591B1513-E534-4A55-B858-A57CE2E401C3}" dt="2026-02-28T22:16:13.078" v="1160" actId="1076"/>
          <ac:spMkLst>
            <pc:docMk/>
            <pc:sldMk cId="2153483527" sldId="301"/>
            <ac:spMk id="12" creationId="{48749843-9714-4ACF-56CD-5D2D92B7DBBA}"/>
          </ac:spMkLst>
        </pc:spChg>
        <pc:spChg chg="add mod">
          <ac:chgData name="Dr Ahmed Elshazly" userId="92faafa7-b1de-4194-ac20-c5423e5d0806" providerId="ADAL" clId="{591B1513-E534-4A55-B858-A57CE2E401C3}" dt="2026-02-28T22:16:15.682" v="1161" actId="1076"/>
          <ac:spMkLst>
            <pc:docMk/>
            <pc:sldMk cId="2153483527" sldId="301"/>
            <ac:spMk id="13" creationId="{A44A8502-EE0D-FC9C-95F4-CFC7C988526F}"/>
          </ac:spMkLst>
        </pc:spChg>
        <pc:spChg chg="add mod">
          <ac:chgData name="Dr Ahmed Elshazly" userId="92faafa7-b1de-4194-ac20-c5423e5d0806" providerId="ADAL" clId="{591B1513-E534-4A55-B858-A57CE2E401C3}" dt="2026-02-28T22:15:43.668" v="1145" actId="1076"/>
          <ac:spMkLst>
            <pc:docMk/>
            <pc:sldMk cId="2153483527" sldId="301"/>
            <ac:spMk id="14" creationId="{FBE620C5-13A1-E3D1-5D54-7D51D389EE17}"/>
          </ac:spMkLst>
        </pc:spChg>
        <pc:spChg chg="add mod">
          <ac:chgData name="Dr Ahmed Elshazly" userId="92faafa7-b1de-4194-ac20-c5423e5d0806" providerId="ADAL" clId="{591B1513-E534-4A55-B858-A57CE2E401C3}" dt="2026-02-28T22:15:57.694" v="1153" actId="1076"/>
          <ac:spMkLst>
            <pc:docMk/>
            <pc:sldMk cId="2153483527" sldId="301"/>
            <ac:spMk id="15" creationId="{5E6854F8-03E3-06D2-98CC-2BE5A5C45FD4}"/>
          </ac:spMkLst>
        </pc:spChg>
        <pc:spChg chg="add mod">
          <ac:chgData name="Dr Ahmed Elshazly" userId="92faafa7-b1de-4194-ac20-c5423e5d0806" providerId="ADAL" clId="{591B1513-E534-4A55-B858-A57CE2E401C3}" dt="2026-02-28T22:16:26.845" v="1165" actId="14100"/>
          <ac:spMkLst>
            <pc:docMk/>
            <pc:sldMk cId="2153483527" sldId="301"/>
            <ac:spMk id="16" creationId="{35492949-599B-C5C1-50A8-0936EC3A4221}"/>
          </ac:spMkLst>
        </pc:spChg>
        <pc:spChg chg="add mod">
          <ac:chgData name="Dr Ahmed Elshazly" userId="92faafa7-b1de-4194-ac20-c5423e5d0806" providerId="ADAL" clId="{591B1513-E534-4A55-B858-A57CE2E401C3}" dt="2026-02-28T22:16:30.142" v="1167" actId="1076"/>
          <ac:spMkLst>
            <pc:docMk/>
            <pc:sldMk cId="2153483527" sldId="301"/>
            <ac:spMk id="17" creationId="{B839AFCF-EEEC-A8A5-048D-9DFAD3C2E38E}"/>
          </ac:spMkLst>
        </pc:spChg>
        <pc:spChg chg="add mod">
          <ac:chgData name="Dr Ahmed Elshazly" userId="92faafa7-b1de-4194-ac20-c5423e5d0806" providerId="ADAL" clId="{591B1513-E534-4A55-B858-A57CE2E401C3}" dt="2026-02-28T22:16:36.827" v="1170" actId="14100"/>
          <ac:spMkLst>
            <pc:docMk/>
            <pc:sldMk cId="2153483527" sldId="301"/>
            <ac:spMk id="18" creationId="{FAF079F3-E4D6-FCA3-F23E-DBC4E2690752}"/>
          </ac:spMkLst>
        </pc:spChg>
        <pc:spChg chg="add mod">
          <ac:chgData name="Dr Ahmed Elshazly" userId="92faafa7-b1de-4194-ac20-c5423e5d0806" providerId="ADAL" clId="{591B1513-E534-4A55-B858-A57CE2E401C3}" dt="2026-02-28T22:16:43.985" v="1172" actId="1076"/>
          <ac:spMkLst>
            <pc:docMk/>
            <pc:sldMk cId="2153483527" sldId="301"/>
            <ac:spMk id="19" creationId="{FAD5FFD1-9A10-75DD-AE8B-AF90B5BA752F}"/>
          </ac:spMkLst>
        </pc:spChg>
        <pc:spChg chg="add mod">
          <ac:chgData name="Dr Ahmed Elshazly" userId="92faafa7-b1de-4194-ac20-c5423e5d0806" providerId="ADAL" clId="{591B1513-E534-4A55-B858-A57CE2E401C3}" dt="2026-02-28T22:16:49.353" v="1175" actId="14100"/>
          <ac:spMkLst>
            <pc:docMk/>
            <pc:sldMk cId="2153483527" sldId="301"/>
            <ac:spMk id="20" creationId="{A5F25C19-78E6-832E-B9CE-E68BC6BF8A9B}"/>
          </ac:spMkLst>
        </pc:spChg>
        <pc:graphicFrameChg chg="del">
          <ac:chgData name="Dr Ahmed Elshazly" userId="92faafa7-b1de-4194-ac20-c5423e5d0806" providerId="ADAL" clId="{591B1513-E534-4A55-B858-A57CE2E401C3}" dt="2026-02-28T22:14:58.438" v="1120" actId="478"/>
          <ac:graphicFrameMkLst>
            <pc:docMk/>
            <pc:sldMk cId="2153483527" sldId="301"/>
            <ac:graphicFrameMk id="10" creationId="{F803B7F3-C511-535C-989D-49987B053635}"/>
          </ac:graphicFrameMkLst>
        </pc:graphicFrameChg>
        <pc:picChg chg="add mod modCrop">
          <ac:chgData name="Dr Ahmed Elshazly" userId="92faafa7-b1de-4194-ac20-c5423e5d0806" providerId="ADAL" clId="{591B1513-E534-4A55-B858-A57CE2E401C3}" dt="2026-02-28T22:15:53.403" v="1150" actId="1076"/>
          <ac:picMkLst>
            <pc:docMk/>
            <pc:sldMk cId="2153483527" sldId="301"/>
            <ac:picMk id="5" creationId="{1B1DECA9-7A71-CE47-909C-D11923C64079}"/>
          </ac:picMkLst>
        </pc:picChg>
        <pc:picChg chg="add mod modCrop">
          <ac:chgData name="Dr Ahmed Elshazly" userId="92faafa7-b1de-4194-ac20-c5423e5d0806" providerId="ADAL" clId="{591B1513-E534-4A55-B858-A57CE2E401C3}" dt="2026-02-28T22:15:07.188" v="1125" actId="1076"/>
          <ac:picMkLst>
            <pc:docMk/>
            <pc:sldMk cId="2153483527" sldId="301"/>
            <ac:picMk id="6" creationId="{A44E61D6-B0A6-5A12-35EA-BEA7946BD8F5}"/>
          </ac:picMkLst>
        </pc:picChg>
        <pc:picChg chg="add mod modCrop">
          <ac:chgData name="Dr Ahmed Elshazly" userId="92faafa7-b1de-4194-ac20-c5423e5d0806" providerId="ADAL" clId="{591B1513-E534-4A55-B858-A57CE2E401C3}" dt="2026-02-28T22:16:17.170" v="1162" actId="1076"/>
          <ac:picMkLst>
            <pc:docMk/>
            <pc:sldMk cId="2153483527" sldId="301"/>
            <ac:picMk id="7" creationId="{CAB0A232-4C4C-13D3-F52D-A778BE9006A7}"/>
          </ac:picMkLst>
        </pc:picChg>
        <pc:picChg chg="add mod modCrop">
          <ac:chgData name="Dr Ahmed Elshazly" userId="92faafa7-b1de-4194-ac20-c5423e5d0806" providerId="ADAL" clId="{591B1513-E534-4A55-B858-A57CE2E401C3}" dt="2026-02-28T22:16:09.833" v="1159" actId="1076"/>
          <ac:picMkLst>
            <pc:docMk/>
            <pc:sldMk cId="2153483527" sldId="301"/>
            <ac:picMk id="8" creationId="{9B39E9DE-6A58-F900-4849-E69474C117B6}"/>
          </ac:picMkLst>
        </pc:picChg>
        <pc:picChg chg="add mod modCrop">
          <ac:chgData name="Dr Ahmed Elshazly" userId="92faafa7-b1de-4194-ac20-c5423e5d0806" providerId="ADAL" clId="{591B1513-E534-4A55-B858-A57CE2E401C3}" dt="2026-02-28T22:15:26.815" v="1136" actId="1076"/>
          <ac:picMkLst>
            <pc:docMk/>
            <pc:sldMk cId="2153483527" sldId="301"/>
            <ac:picMk id="9" creationId="{54D724B0-6727-A008-EC54-6FF3274937DF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004606-84AF-4174-948B-4CD5BDD15E56}" type="datetimeFigureOut">
              <a:rPr lang="en-US" smtClean="0"/>
              <a:t>3/1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4D7208-E4E9-4579-A477-15F3C8C23A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5379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4D7208-E4E9-4579-A477-15F3C8C23A1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579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745AA9-7776-4BA3-95CE-53B3A1A391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54F147-52C4-4395-B603-7FA803B460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3145466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51829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3" Type="http://schemas.microsoft.com/office/2007/relationships/hdphoto" Target="../media/hdphoto34.wdp"/><Relationship Id="rId7" Type="http://schemas.microsoft.com/office/2007/relationships/hdphoto" Target="../media/hdphoto36.wdp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7.png"/><Relationship Id="rId11" Type="http://schemas.microsoft.com/office/2007/relationships/hdphoto" Target="../media/hdphoto38.wdp"/><Relationship Id="rId5" Type="http://schemas.microsoft.com/office/2007/relationships/hdphoto" Target="../media/hdphoto35.wdp"/><Relationship Id="rId10" Type="http://schemas.openxmlformats.org/officeDocument/2006/relationships/image" Target="../media/image39.png"/><Relationship Id="rId4" Type="http://schemas.openxmlformats.org/officeDocument/2006/relationships/image" Target="../media/image36.png"/><Relationship Id="rId9" Type="http://schemas.microsoft.com/office/2007/relationships/hdphoto" Target="../media/hdphoto37.wdp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microsoft.com/office/2007/relationships/hdphoto" Target="../media/hdphoto44.wdp"/><Relationship Id="rId3" Type="http://schemas.microsoft.com/office/2007/relationships/hdphoto" Target="../media/hdphoto39.wdp"/><Relationship Id="rId7" Type="http://schemas.microsoft.com/office/2007/relationships/hdphoto" Target="../media/hdphoto41.wdp"/><Relationship Id="rId12" Type="http://schemas.openxmlformats.org/officeDocument/2006/relationships/image" Target="../media/image45.png"/><Relationship Id="rId17" Type="http://schemas.microsoft.com/office/2007/relationships/hdphoto" Target="../media/hdphoto46.wdp"/><Relationship Id="rId2" Type="http://schemas.openxmlformats.org/officeDocument/2006/relationships/image" Target="../media/image40.png"/><Relationship Id="rId16" Type="http://schemas.openxmlformats.org/officeDocument/2006/relationships/image" Target="../media/image4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2.png"/><Relationship Id="rId11" Type="http://schemas.microsoft.com/office/2007/relationships/hdphoto" Target="../media/hdphoto43.wdp"/><Relationship Id="rId5" Type="http://schemas.microsoft.com/office/2007/relationships/hdphoto" Target="../media/hdphoto40.wdp"/><Relationship Id="rId15" Type="http://schemas.microsoft.com/office/2007/relationships/hdphoto" Target="../media/hdphoto45.wdp"/><Relationship Id="rId10" Type="http://schemas.openxmlformats.org/officeDocument/2006/relationships/image" Target="../media/image44.png"/><Relationship Id="rId4" Type="http://schemas.openxmlformats.org/officeDocument/2006/relationships/image" Target="../media/image41.png"/><Relationship Id="rId9" Type="http://schemas.microsoft.com/office/2007/relationships/hdphoto" Target="../media/hdphoto42.wdp"/><Relationship Id="rId14" Type="http://schemas.openxmlformats.org/officeDocument/2006/relationships/image" Target="../media/image46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13" Type="http://schemas.microsoft.com/office/2007/relationships/hdphoto" Target="../media/hdphoto52.wdp"/><Relationship Id="rId3" Type="http://schemas.microsoft.com/office/2007/relationships/hdphoto" Target="../media/hdphoto47.wdp"/><Relationship Id="rId7" Type="http://schemas.microsoft.com/office/2007/relationships/hdphoto" Target="../media/hdphoto49.wdp"/><Relationship Id="rId12" Type="http://schemas.openxmlformats.org/officeDocument/2006/relationships/image" Target="../media/image53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0.png"/><Relationship Id="rId11" Type="http://schemas.microsoft.com/office/2007/relationships/hdphoto" Target="../media/hdphoto51.wdp"/><Relationship Id="rId5" Type="http://schemas.microsoft.com/office/2007/relationships/hdphoto" Target="../media/hdphoto48.wdp"/><Relationship Id="rId10" Type="http://schemas.openxmlformats.org/officeDocument/2006/relationships/image" Target="../media/image52.png"/><Relationship Id="rId4" Type="http://schemas.openxmlformats.org/officeDocument/2006/relationships/image" Target="../media/image49.png"/><Relationship Id="rId9" Type="http://schemas.microsoft.com/office/2007/relationships/hdphoto" Target="../media/hdphoto50.wdp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png"/><Relationship Id="rId13" Type="http://schemas.microsoft.com/office/2007/relationships/hdphoto" Target="../media/hdphoto58.wdp"/><Relationship Id="rId3" Type="http://schemas.microsoft.com/office/2007/relationships/hdphoto" Target="../media/hdphoto53.wdp"/><Relationship Id="rId7" Type="http://schemas.microsoft.com/office/2007/relationships/hdphoto" Target="../media/hdphoto55.wdp"/><Relationship Id="rId12" Type="http://schemas.openxmlformats.org/officeDocument/2006/relationships/image" Target="../media/image59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6.png"/><Relationship Id="rId11" Type="http://schemas.microsoft.com/office/2007/relationships/hdphoto" Target="../media/hdphoto57.wdp"/><Relationship Id="rId5" Type="http://schemas.microsoft.com/office/2007/relationships/hdphoto" Target="../media/hdphoto54.wdp"/><Relationship Id="rId10" Type="http://schemas.openxmlformats.org/officeDocument/2006/relationships/image" Target="../media/image58.png"/><Relationship Id="rId4" Type="http://schemas.openxmlformats.org/officeDocument/2006/relationships/image" Target="../media/image55.png"/><Relationship Id="rId9" Type="http://schemas.microsoft.com/office/2007/relationships/hdphoto" Target="../media/hdphoto56.wdp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13" Type="http://schemas.microsoft.com/office/2007/relationships/hdphoto" Target="../media/hdphoto64.wdp"/><Relationship Id="rId3" Type="http://schemas.microsoft.com/office/2007/relationships/hdphoto" Target="../media/hdphoto59.wdp"/><Relationship Id="rId7" Type="http://schemas.microsoft.com/office/2007/relationships/hdphoto" Target="../media/hdphoto61.wdp"/><Relationship Id="rId12" Type="http://schemas.openxmlformats.org/officeDocument/2006/relationships/image" Target="../media/image65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2.png"/><Relationship Id="rId11" Type="http://schemas.microsoft.com/office/2007/relationships/hdphoto" Target="../media/hdphoto63.wdp"/><Relationship Id="rId5" Type="http://schemas.microsoft.com/office/2007/relationships/hdphoto" Target="../media/hdphoto60.wdp"/><Relationship Id="rId10" Type="http://schemas.openxmlformats.org/officeDocument/2006/relationships/image" Target="../media/image64.png"/><Relationship Id="rId4" Type="http://schemas.openxmlformats.org/officeDocument/2006/relationships/image" Target="../media/image61.png"/><Relationship Id="rId9" Type="http://schemas.microsoft.com/office/2007/relationships/hdphoto" Target="../media/hdphoto62.wdp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9.png"/><Relationship Id="rId13" Type="http://schemas.microsoft.com/office/2007/relationships/hdphoto" Target="../media/hdphoto70.wdp"/><Relationship Id="rId3" Type="http://schemas.microsoft.com/office/2007/relationships/hdphoto" Target="../media/hdphoto65.wdp"/><Relationship Id="rId7" Type="http://schemas.microsoft.com/office/2007/relationships/hdphoto" Target="../media/hdphoto67.wdp"/><Relationship Id="rId12" Type="http://schemas.openxmlformats.org/officeDocument/2006/relationships/image" Target="../media/image71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8.png"/><Relationship Id="rId11" Type="http://schemas.microsoft.com/office/2007/relationships/hdphoto" Target="../media/hdphoto69.wdp"/><Relationship Id="rId5" Type="http://schemas.microsoft.com/office/2007/relationships/hdphoto" Target="../media/hdphoto66.wdp"/><Relationship Id="rId10" Type="http://schemas.openxmlformats.org/officeDocument/2006/relationships/image" Target="../media/image70.png"/><Relationship Id="rId4" Type="http://schemas.openxmlformats.org/officeDocument/2006/relationships/image" Target="../media/image67.png"/><Relationship Id="rId9" Type="http://schemas.microsoft.com/office/2007/relationships/hdphoto" Target="../media/hdphoto68.wdp"/></Relationships>
</file>

<file path=ppt/slides/_rels/slide16.xml.rels><?xml version="1.0" encoding="UTF-8" standalone="yes"?>
<Relationships xmlns="http://schemas.openxmlformats.org/package/2006/relationships"><Relationship Id="rId3" Type="http://schemas.microsoft.com/office/2007/relationships/hdphoto" Target="../media/hdphoto71.wdp"/><Relationship Id="rId7" Type="http://schemas.microsoft.com/office/2007/relationships/hdphoto" Target="../media/hdphoto73.wdp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4.png"/><Relationship Id="rId5" Type="http://schemas.microsoft.com/office/2007/relationships/hdphoto" Target="../media/hdphoto72.wdp"/><Relationship Id="rId4" Type="http://schemas.openxmlformats.org/officeDocument/2006/relationships/image" Target="../media/image73.pn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png"/><Relationship Id="rId13" Type="http://schemas.microsoft.com/office/2007/relationships/hdphoto" Target="../media/hdphoto79.wdp"/><Relationship Id="rId3" Type="http://schemas.microsoft.com/office/2007/relationships/hdphoto" Target="../media/hdphoto74.wdp"/><Relationship Id="rId7" Type="http://schemas.microsoft.com/office/2007/relationships/hdphoto" Target="../media/hdphoto76.wdp"/><Relationship Id="rId12" Type="http://schemas.openxmlformats.org/officeDocument/2006/relationships/image" Target="../media/image80.png"/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7.png"/><Relationship Id="rId11" Type="http://schemas.microsoft.com/office/2007/relationships/hdphoto" Target="../media/hdphoto78.wdp"/><Relationship Id="rId5" Type="http://schemas.microsoft.com/office/2007/relationships/hdphoto" Target="../media/hdphoto75.wdp"/><Relationship Id="rId10" Type="http://schemas.openxmlformats.org/officeDocument/2006/relationships/image" Target="../media/image79.png"/><Relationship Id="rId4" Type="http://schemas.openxmlformats.org/officeDocument/2006/relationships/image" Target="../media/image76.png"/><Relationship Id="rId9" Type="http://schemas.microsoft.com/office/2007/relationships/hdphoto" Target="../media/hdphoto77.wdp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4.png"/><Relationship Id="rId13" Type="http://schemas.microsoft.com/office/2007/relationships/hdphoto" Target="../media/hdphoto85.wdp"/><Relationship Id="rId3" Type="http://schemas.microsoft.com/office/2007/relationships/hdphoto" Target="../media/hdphoto80.wdp"/><Relationship Id="rId7" Type="http://schemas.microsoft.com/office/2007/relationships/hdphoto" Target="../media/hdphoto82.wdp"/><Relationship Id="rId12" Type="http://schemas.openxmlformats.org/officeDocument/2006/relationships/image" Target="../media/image86.png"/><Relationship Id="rId2" Type="http://schemas.openxmlformats.org/officeDocument/2006/relationships/image" Target="../media/image8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3.png"/><Relationship Id="rId11" Type="http://schemas.microsoft.com/office/2007/relationships/hdphoto" Target="../media/hdphoto84.wdp"/><Relationship Id="rId5" Type="http://schemas.microsoft.com/office/2007/relationships/hdphoto" Target="../media/hdphoto81.wdp"/><Relationship Id="rId10" Type="http://schemas.openxmlformats.org/officeDocument/2006/relationships/image" Target="../media/image85.png"/><Relationship Id="rId4" Type="http://schemas.openxmlformats.org/officeDocument/2006/relationships/image" Target="../media/image82.png"/><Relationship Id="rId9" Type="http://schemas.microsoft.com/office/2007/relationships/hdphoto" Target="../media/hdphoto83.wdp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90.png"/><Relationship Id="rId3" Type="http://schemas.microsoft.com/office/2007/relationships/hdphoto" Target="../media/hdphoto86.wdp"/><Relationship Id="rId7" Type="http://schemas.microsoft.com/office/2007/relationships/hdphoto" Target="../media/hdphoto88.wdp"/><Relationship Id="rId2" Type="http://schemas.openxmlformats.org/officeDocument/2006/relationships/image" Target="../media/image8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9.png"/><Relationship Id="rId5" Type="http://schemas.microsoft.com/office/2007/relationships/hdphoto" Target="../media/hdphoto87.wdp"/><Relationship Id="rId4" Type="http://schemas.openxmlformats.org/officeDocument/2006/relationships/image" Target="../media/image88.png"/><Relationship Id="rId9" Type="http://schemas.microsoft.com/office/2007/relationships/hdphoto" Target="../media/hdphoto89.wdp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8.wdp"/><Relationship Id="rId3" Type="http://schemas.openxmlformats.org/officeDocument/2006/relationships/image" Target="../media/image6.png"/><Relationship Id="rId7" Type="http://schemas.openxmlformats.org/officeDocument/2006/relationships/image" Target="../media/image8.png"/><Relationship Id="rId12" Type="http://schemas.microsoft.com/office/2007/relationships/hdphoto" Target="../media/hdphoto10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7.wdp"/><Relationship Id="rId11" Type="http://schemas.openxmlformats.org/officeDocument/2006/relationships/image" Target="../media/image10.png"/><Relationship Id="rId5" Type="http://schemas.openxmlformats.org/officeDocument/2006/relationships/image" Target="../media/image7.png"/><Relationship Id="rId10" Type="http://schemas.microsoft.com/office/2007/relationships/hdphoto" Target="../media/hdphoto9.wdp"/><Relationship Id="rId4" Type="http://schemas.microsoft.com/office/2007/relationships/hdphoto" Target="../media/hdphoto6.wdp"/><Relationship Id="rId9" Type="http://schemas.openxmlformats.org/officeDocument/2006/relationships/image" Target="../media/image9.pn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94.png"/><Relationship Id="rId3" Type="http://schemas.microsoft.com/office/2007/relationships/hdphoto" Target="../media/hdphoto90.wdp"/><Relationship Id="rId7" Type="http://schemas.microsoft.com/office/2007/relationships/hdphoto" Target="../media/hdphoto92.wdp"/><Relationship Id="rId2" Type="http://schemas.openxmlformats.org/officeDocument/2006/relationships/image" Target="../media/image9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3.png"/><Relationship Id="rId5" Type="http://schemas.microsoft.com/office/2007/relationships/hdphoto" Target="../media/hdphoto91.wdp"/><Relationship Id="rId4" Type="http://schemas.openxmlformats.org/officeDocument/2006/relationships/image" Target="../media/image92.png"/><Relationship Id="rId9" Type="http://schemas.microsoft.com/office/2007/relationships/hdphoto" Target="../media/hdphoto93.wdp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8.png"/><Relationship Id="rId3" Type="http://schemas.microsoft.com/office/2007/relationships/hdphoto" Target="../media/hdphoto20.wdp"/><Relationship Id="rId7" Type="http://schemas.microsoft.com/office/2007/relationships/hdphoto" Target="../media/hdphoto94.wdp"/><Relationship Id="rId2" Type="http://schemas.openxmlformats.org/officeDocument/2006/relationships/image" Target="../media/image9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7.png"/><Relationship Id="rId5" Type="http://schemas.microsoft.com/office/2007/relationships/hdphoto" Target="../media/hdphoto19.wdp"/><Relationship Id="rId4" Type="http://schemas.openxmlformats.org/officeDocument/2006/relationships/image" Target="../media/image96.png"/><Relationship Id="rId9" Type="http://schemas.microsoft.com/office/2007/relationships/hdphoto" Target="../media/hdphoto95.wdp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1.png"/><Relationship Id="rId3" Type="http://schemas.microsoft.com/office/2007/relationships/hdphoto" Target="../media/hdphoto96.wdp"/><Relationship Id="rId7" Type="http://schemas.microsoft.com/office/2007/relationships/hdphoto" Target="../media/hdphoto97.wdp"/><Relationship Id="rId2" Type="http://schemas.openxmlformats.org/officeDocument/2006/relationships/image" Target="../media/image9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0.png"/><Relationship Id="rId5" Type="http://schemas.microsoft.com/office/2007/relationships/hdphoto" Target="../media/hdphoto22.wdp"/><Relationship Id="rId4" Type="http://schemas.openxmlformats.org/officeDocument/2006/relationships/image" Target="../media/image22.png"/><Relationship Id="rId9" Type="http://schemas.microsoft.com/office/2007/relationships/hdphoto" Target="../media/hdphoto98.wdp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png"/><Relationship Id="rId3" Type="http://schemas.microsoft.com/office/2007/relationships/hdphoto" Target="../media/hdphoto99.wdp"/><Relationship Id="rId7" Type="http://schemas.microsoft.com/office/2007/relationships/hdphoto" Target="../media/hdphoto100.wdp"/><Relationship Id="rId2" Type="http://schemas.openxmlformats.org/officeDocument/2006/relationships/image" Target="../media/image10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4.png"/><Relationship Id="rId5" Type="http://schemas.microsoft.com/office/2007/relationships/hdphoto" Target="../media/hdphoto47.wdp"/><Relationship Id="rId4" Type="http://schemas.openxmlformats.org/officeDocument/2006/relationships/image" Target="../media/image103.png"/><Relationship Id="rId9" Type="http://schemas.microsoft.com/office/2007/relationships/hdphoto" Target="../media/hdphoto52.wdp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8.png"/><Relationship Id="rId3" Type="http://schemas.microsoft.com/office/2007/relationships/hdphoto" Target="../media/hdphoto101.wdp"/><Relationship Id="rId7" Type="http://schemas.microsoft.com/office/2007/relationships/hdphoto" Target="../media/hdphoto103.wdp"/><Relationship Id="rId2" Type="http://schemas.openxmlformats.org/officeDocument/2006/relationships/image" Target="../media/image10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7.png"/><Relationship Id="rId5" Type="http://schemas.microsoft.com/office/2007/relationships/hdphoto" Target="../media/hdphoto102.wdp"/><Relationship Id="rId4" Type="http://schemas.openxmlformats.org/officeDocument/2006/relationships/image" Target="../media/image106.png"/><Relationship Id="rId9" Type="http://schemas.microsoft.com/office/2007/relationships/hdphoto" Target="../media/hdphoto104.wdp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png"/><Relationship Id="rId3" Type="http://schemas.microsoft.com/office/2007/relationships/hdphoto" Target="../media/hdphoto105.wdp"/><Relationship Id="rId7" Type="http://schemas.microsoft.com/office/2007/relationships/hdphoto" Target="../media/hdphoto106.wdp"/><Relationship Id="rId2" Type="http://schemas.openxmlformats.org/officeDocument/2006/relationships/image" Target="../media/image10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0.png"/><Relationship Id="rId5" Type="http://schemas.microsoft.com/office/2007/relationships/hdphoto" Target="../media/hdphoto61.wdp"/><Relationship Id="rId4" Type="http://schemas.openxmlformats.org/officeDocument/2006/relationships/image" Target="../media/image62.png"/><Relationship Id="rId9" Type="http://schemas.microsoft.com/office/2007/relationships/hdphoto" Target="../media/hdphoto64.wdp"/></Relationships>
</file>

<file path=ppt/slides/_rels/slide2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4.png"/><Relationship Id="rId3" Type="http://schemas.microsoft.com/office/2007/relationships/hdphoto" Target="../media/hdphoto107.wdp"/><Relationship Id="rId7" Type="http://schemas.microsoft.com/office/2007/relationships/hdphoto" Target="../media/hdphoto109.wdp"/><Relationship Id="rId2" Type="http://schemas.openxmlformats.org/officeDocument/2006/relationships/image" Target="../media/image1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3.png"/><Relationship Id="rId11" Type="http://schemas.microsoft.com/office/2007/relationships/hdphoto" Target="../media/hdphoto111.wdp"/><Relationship Id="rId5" Type="http://schemas.microsoft.com/office/2007/relationships/hdphoto" Target="../media/hdphoto108.wdp"/><Relationship Id="rId10" Type="http://schemas.openxmlformats.org/officeDocument/2006/relationships/image" Target="../media/image115.png"/><Relationship Id="rId4" Type="http://schemas.openxmlformats.org/officeDocument/2006/relationships/image" Target="../media/image112.png"/><Relationship Id="rId9" Type="http://schemas.microsoft.com/office/2007/relationships/hdphoto" Target="../media/hdphoto110.wdp"/></Relationships>
</file>

<file path=ppt/slides/_rels/slide27.xml.rels><?xml version="1.0" encoding="UTF-8" standalone="yes"?>
<Relationships xmlns="http://schemas.openxmlformats.org/package/2006/relationships"><Relationship Id="rId3" Type="http://schemas.microsoft.com/office/2007/relationships/hdphoto" Target="../media/hdphoto112.wdp"/><Relationship Id="rId2" Type="http://schemas.openxmlformats.org/officeDocument/2006/relationships/image" Target="../media/image116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13.wdp"/><Relationship Id="rId4" Type="http://schemas.openxmlformats.org/officeDocument/2006/relationships/image" Target="../media/image117.png"/></Relationships>
</file>

<file path=ppt/slides/_rels/slide2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3" Type="http://schemas.microsoft.com/office/2007/relationships/hdphoto" Target="../media/hdphoto114.wdp"/><Relationship Id="rId7" Type="http://schemas.microsoft.com/office/2007/relationships/hdphoto" Target="../media/hdphoto115.wdp"/><Relationship Id="rId2" Type="http://schemas.openxmlformats.org/officeDocument/2006/relationships/image" Target="../media/image1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9.png"/><Relationship Id="rId5" Type="http://schemas.microsoft.com/office/2007/relationships/hdphoto" Target="../media/hdphoto67.wdp"/><Relationship Id="rId4" Type="http://schemas.openxmlformats.org/officeDocument/2006/relationships/image" Target="../media/image68.png"/><Relationship Id="rId9" Type="http://schemas.microsoft.com/office/2007/relationships/hdphoto" Target="../media/hdphoto70.wdp"/></Relationships>
</file>

<file path=ppt/slides/_rels/slide29.xml.rels><?xml version="1.0" encoding="UTF-8" standalone="yes"?>
<Relationships xmlns="http://schemas.openxmlformats.org/package/2006/relationships"><Relationship Id="rId3" Type="http://schemas.microsoft.com/office/2007/relationships/hdphoto" Target="../media/hdphoto116.wdp"/><Relationship Id="rId2" Type="http://schemas.openxmlformats.org/officeDocument/2006/relationships/image" Target="../media/image120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17.wdp"/><Relationship Id="rId4" Type="http://schemas.openxmlformats.org/officeDocument/2006/relationships/image" Target="../media/image121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2.wdp"/><Relationship Id="rId4" Type="http://schemas.openxmlformats.org/officeDocument/2006/relationships/image" Target="../media/image12.png"/></Relationships>
</file>

<file path=ppt/slides/_rels/slide3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5.png"/><Relationship Id="rId13" Type="http://schemas.microsoft.com/office/2007/relationships/hdphoto" Target="../media/hdphoto123.wdp"/><Relationship Id="rId3" Type="http://schemas.microsoft.com/office/2007/relationships/hdphoto" Target="../media/hdphoto118.wdp"/><Relationship Id="rId7" Type="http://schemas.microsoft.com/office/2007/relationships/hdphoto" Target="../media/hdphoto120.wdp"/><Relationship Id="rId12" Type="http://schemas.openxmlformats.org/officeDocument/2006/relationships/image" Target="../media/image127.png"/><Relationship Id="rId17" Type="http://schemas.microsoft.com/office/2007/relationships/hdphoto" Target="../media/hdphoto125.wdp"/><Relationship Id="rId2" Type="http://schemas.openxmlformats.org/officeDocument/2006/relationships/image" Target="../media/image122.png"/><Relationship Id="rId16" Type="http://schemas.openxmlformats.org/officeDocument/2006/relationships/image" Target="../media/image12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4.png"/><Relationship Id="rId11" Type="http://schemas.microsoft.com/office/2007/relationships/hdphoto" Target="../media/hdphoto122.wdp"/><Relationship Id="rId5" Type="http://schemas.microsoft.com/office/2007/relationships/hdphoto" Target="../media/hdphoto119.wdp"/><Relationship Id="rId15" Type="http://schemas.microsoft.com/office/2007/relationships/hdphoto" Target="../media/hdphoto124.wdp"/><Relationship Id="rId10" Type="http://schemas.openxmlformats.org/officeDocument/2006/relationships/image" Target="../media/image126.png"/><Relationship Id="rId4" Type="http://schemas.openxmlformats.org/officeDocument/2006/relationships/image" Target="../media/image123.png"/><Relationship Id="rId9" Type="http://schemas.microsoft.com/office/2007/relationships/hdphoto" Target="../media/hdphoto121.wdp"/><Relationship Id="rId14" Type="http://schemas.openxmlformats.org/officeDocument/2006/relationships/image" Target="../media/image128.png"/></Relationships>
</file>

<file path=ppt/slides/_rels/slide31.xml.rels><?xml version="1.0" encoding="UTF-8" standalone="yes"?>
<Relationships xmlns="http://schemas.openxmlformats.org/package/2006/relationships"><Relationship Id="rId3" Type="http://schemas.microsoft.com/office/2007/relationships/hdphoto" Target="../media/hdphoto126.wdp"/><Relationship Id="rId7" Type="http://schemas.microsoft.com/office/2007/relationships/hdphoto" Target="../media/hdphoto128.wdp"/><Relationship Id="rId2" Type="http://schemas.openxmlformats.org/officeDocument/2006/relationships/image" Target="../media/image13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2.png"/><Relationship Id="rId5" Type="http://schemas.microsoft.com/office/2007/relationships/hdphoto" Target="../media/hdphoto127.wdp"/><Relationship Id="rId4" Type="http://schemas.openxmlformats.org/officeDocument/2006/relationships/image" Target="../media/image131.png"/></Relationships>
</file>

<file path=ppt/slides/_rels/slide32.xml.rels><?xml version="1.0" encoding="UTF-8" standalone="yes"?>
<Relationships xmlns="http://schemas.openxmlformats.org/package/2006/relationships"><Relationship Id="rId3" Type="http://schemas.microsoft.com/office/2007/relationships/hdphoto" Target="../media/hdphoto128.wdp"/><Relationship Id="rId7" Type="http://schemas.microsoft.com/office/2007/relationships/hdphoto" Target="../media/hdphoto130.wdp"/><Relationship Id="rId2" Type="http://schemas.openxmlformats.org/officeDocument/2006/relationships/image" Target="../media/image13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4.png"/><Relationship Id="rId5" Type="http://schemas.microsoft.com/office/2007/relationships/hdphoto" Target="../media/hdphoto129.wdp"/><Relationship Id="rId4" Type="http://schemas.openxmlformats.org/officeDocument/2006/relationships/image" Target="../media/image133.png"/></Relationships>
</file>

<file path=ppt/slides/_rels/slide3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8.png"/><Relationship Id="rId3" Type="http://schemas.microsoft.com/office/2007/relationships/hdphoto" Target="../media/hdphoto121.wdp"/><Relationship Id="rId7" Type="http://schemas.microsoft.com/office/2007/relationships/hdphoto" Target="../media/hdphoto132.wdp"/><Relationship Id="rId2" Type="http://schemas.openxmlformats.org/officeDocument/2006/relationships/image" Target="../media/image13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7.png"/><Relationship Id="rId11" Type="http://schemas.microsoft.com/office/2007/relationships/hdphoto" Target="../media/hdphoto124.wdp"/><Relationship Id="rId5" Type="http://schemas.microsoft.com/office/2007/relationships/hdphoto" Target="../media/hdphoto131.wdp"/><Relationship Id="rId10" Type="http://schemas.openxmlformats.org/officeDocument/2006/relationships/image" Target="../media/image128.png"/><Relationship Id="rId4" Type="http://schemas.openxmlformats.org/officeDocument/2006/relationships/image" Target="../media/image136.png"/><Relationship Id="rId9" Type="http://schemas.microsoft.com/office/2007/relationships/hdphoto" Target="../media/hdphoto133.wdp"/></Relationships>
</file>

<file path=ppt/slides/_rels/slide34.xml.rels><?xml version="1.0" encoding="UTF-8" standalone="yes"?>
<Relationships xmlns="http://schemas.openxmlformats.org/package/2006/relationships"><Relationship Id="rId3" Type="http://schemas.microsoft.com/office/2007/relationships/hdphoto" Target="../media/hdphoto128.wdp"/><Relationship Id="rId7" Type="http://schemas.microsoft.com/office/2007/relationships/hdphoto" Target="../media/hdphoto130.wdp"/><Relationship Id="rId2" Type="http://schemas.openxmlformats.org/officeDocument/2006/relationships/image" Target="../media/image13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4.png"/><Relationship Id="rId5" Type="http://schemas.microsoft.com/office/2007/relationships/hdphoto" Target="../media/hdphoto129.wdp"/><Relationship Id="rId4" Type="http://schemas.openxmlformats.org/officeDocument/2006/relationships/image" Target="../media/image133.png"/></Relationships>
</file>

<file path=ppt/slides/_rels/slide35.xml.rels><?xml version="1.0" encoding="UTF-8" standalone="yes"?>
<Relationships xmlns="http://schemas.openxmlformats.org/package/2006/relationships"><Relationship Id="rId3" Type="http://schemas.microsoft.com/office/2007/relationships/hdphoto" Target="../media/hdphoto134.wdp"/><Relationship Id="rId2" Type="http://schemas.openxmlformats.org/officeDocument/2006/relationships/image" Target="../media/image139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35.wdp"/><Relationship Id="rId4" Type="http://schemas.openxmlformats.org/officeDocument/2006/relationships/image" Target="../media/image140.png"/></Relationships>
</file>

<file path=ppt/slides/_rels/slide3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4.png"/><Relationship Id="rId3" Type="http://schemas.microsoft.com/office/2007/relationships/hdphoto" Target="../media/hdphoto136.wdp"/><Relationship Id="rId7" Type="http://schemas.microsoft.com/office/2007/relationships/hdphoto" Target="../media/hdphoto138.wdp"/><Relationship Id="rId2" Type="http://schemas.openxmlformats.org/officeDocument/2006/relationships/image" Target="../media/image14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3.png"/><Relationship Id="rId11" Type="http://schemas.microsoft.com/office/2007/relationships/hdphoto" Target="../media/hdphoto140.wdp"/><Relationship Id="rId5" Type="http://schemas.microsoft.com/office/2007/relationships/hdphoto" Target="../media/hdphoto137.wdp"/><Relationship Id="rId10" Type="http://schemas.openxmlformats.org/officeDocument/2006/relationships/image" Target="../media/image145.png"/><Relationship Id="rId4" Type="http://schemas.openxmlformats.org/officeDocument/2006/relationships/image" Target="../media/image142.png"/><Relationship Id="rId9" Type="http://schemas.microsoft.com/office/2007/relationships/hdphoto" Target="../media/hdphoto139.wdp"/></Relationships>
</file>

<file path=ppt/slides/_rels/slide37.xml.rels><?xml version="1.0" encoding="UTF-8" standalone="yes"?>
<Relationships xmlns="http://schemas.openxmlformats.org/package/2006/relationships"><Relationship Id="rId3" Type="http://schemas.microsoft.com/office/2007/relationships/hdphoto" Target="../media/hdphoto141.wdp"/><Relationship Id="rId2" Type="http://schemas.openxmlformats.org/officeDocument/2006/relationships/image" Target="../media/image146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2.wdp"/><Relationship Id="rId4" Type="http://schemas.openxmlformats.org/officeDocument/2006/relationships/image" Target="../media/image22.png"/></Relationships>
</file>

<file path=ppt/slides/_rels/slide38.xml.rels><?xml version="1.0" encoding="UTF-8" standalone="yes"?>
<Relationships xmlns="http://schemas.openxmlformats.org/package/2006/relationships"><Relationship Id="rId3" Type="http://schemas.microsoft.com/office/2007/relationships/hdphoto" Target="../media/hdphoto142.wdp"/><Relationship Id="rId7" Type="http://schemas.microsoft.com/office/2007/relationships/hdphoto" Target="../media/hdphoto144.wdp"/><Relationship Id="rId2" Type="http://schemas.openxmlformats.org/officeDocument/2006/relationships/image" Target="../media/image14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9.png"/><Relationship Id="rId5" Type="http://schemas.microsoft.com/office/2007/relationships/hdphoto" Target="../media/hdphoto143.wdp"/><Relationship Id="rId4" Type="http://schemas.openxmlformats.org/officeDocument/2006/relationships/image" Target="../media/image148.png"/></Relationships>
</file>

<file path=ppt/slides/_rels/slide39.xml.rels><?xml version="1.0" encoding="UTF-8" standalone="yes"?>
<Relationships xmlns="http://schemas.openxmlformats.org/package/2006/relationships"><Relationship Id="rId3" Type="http://schemas.microsoft.com/office/2007/relationships/hdphoto" Target="../media/hdphoto145.wdp"/><Relationship Id="rId2" Type="http://schemas.openxmlformats.org/officeDocument/2006/relationships/image" Target="../media/image150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46.wdp"/><Relationship Id="rId4" Type="http://schemas.openxmlformats.org/officeDocument/2006/relationships/image" Target="../media/image15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microsoft.com/office/2007/relationships/hdphoto" Target="../media/hdphoto13.wdp"/><Relationship Id="rId7" Type="http://schemas.microsoft.com/office/2007/relationships/hdphoto" Target="../media/hdphoto15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5" Type="http://schemas.microsoft.com/office/2007/relationships/hdphoto" Target="../media/hdphoto14.wdp"/><Relationship Id="rId4" Type="http://schemas.openxmlformats.org/officeDocument/2006/relationships/image" Target="../media/image14.png"/><Relationship Id="rId9" Type="http://schemas.microsoft.com/office/2007/relationships/hdphoto" Target="../media/hdphoto16.wdp"/></Relationships>
</file>

<file path=ppt/slides/_rels/slide4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4.png"/><Relationship Id="rId3" Type="http://schemas.microsoft.com/office/2007/relationships/hdphoto" Target="../media/hdphoto147.wdp"/><Relationship Id="rId7" Type="http://schemas.microsoft.com/office/2007/relationships/hdphoto" Target="../media/hdphoto55.wdp"/><Relationship Id="rId2" Type="http://schemas.openxmlformats.org/officeDocument/2006/relationships/image" Target="../media/image15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6.png"/><Relationship Id="rId5" Type="http://schemas.microsoft.com/office/2007/relationships/hdphoto" Target="../media/hdphoto148.wdp"/><Relationship Id="rId4" Type="http://schemas.openxmlformats.org/officeDocument/2006/relationships/image" Target="../media/image153.png"/><Relationship Id="rId9" Type="http://schemas.microsoft.com/office/2007/relationships/hdphoto" Target="../media/hdphoto149.wdp"/></Relationships>
</file>

<file path=ppt/slides/_rels/slide4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8.png"/><Relationship Id="rId3" Type="http://schemas.microsoft.com/office/2007/relationships/hdphoto" Target="../media/hdphoto150.wdp"/><Relationship Id="rId7" Type="http://schemas.microsoft.com/office/2007/relationships/hdphoto" Target="../media/hdphoto152.wdp"/><Relationship Id="rId2" Type="http://schemas.openxmlformats.org/officeDocument/2006/relationships/image" Target="../media/image15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7.png"/><Relationship Id="rId5" Type="http://schemas.microsoft.com/office/2007/relationships/hdphoto" Target="../media/hdphoto151.wdp"/><Relationship Id="rId4" Type="http://schemas.openxmlformats.org/officeDocument/2006/relationships/image" Target="../media/image156.png"/><Relationship Id="rId9" Type="http://schemas.microsoft.com/office/2007/relationships/hdphoto" Target="../media/hdphoto153.wdp"/></Relationships>
</file>

<file path=ppt/slides/_rels/slide4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2.png"/><Relationship Id="rId13" Type="http://schemas.microsoft.com/office/2007/relationships/hdphoto" Target="../media/hdphoto159.wdp"/><Relationship Id="rId3" Type="http://schemas.microsoft.com/office/2007/relationships/hdphoto" Target="../media/hdphoto154.wdp"/><Relationship Id="rId7" Type="http://schemas.microsoft.com/office/2007/relationships/hdphoto" Target="../media/hdphoto156.wdp"/><Relationship Id="rId12" Type="http://schemas.openxmlformats.org/officeDocument/2006/relationships/image" Target="../media/image164.png"/><Relationship Id="rId2" Type="http://schemas.openxmlformats.org/officeDocument/2006/relationships/image" Target="../media/image15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1.png"/><Relationship Id="rId11" Type="http://schemas.microsoft.com/office/2007/relationships/hdphoto" Target="../media/hdphoto158.wdp"/><Relationship Id="rId5" Type="http://schemas.microsoft.com/office/2007/relationships/hdphoto" Target="../media/hdphoto155.wdp"/><Relationship Id="rId10" Type="http://schemas.openxmlformats.org/officeDocument/2006/relationships/image" Target="../media/image163.png"/><Relationship Id="rId4" Type="http://schemas.openxmlformats.org/officeDocument/2006/relationships/image" Target="../media/image160.png"/><Relationship Id="rId9" Type="http://schemas.microsoft.com/office/2007/relationships/hdphoto" Target="../media/hdphoto157.wdp"/></Relationships>
</file>

<file path=ppt/slides/_rels/slide43.xml.rels><?xml version="1.0" encoding="UTF-8" standalone="yes"?>
<Relationships xmlns="http://schemas.openxmlformats.org/package/2006/relationships"><Relationship Id="rId3" Type="http://schemas.microsoft.com/office/2007/relationships/hdphoto" Target="../media/hdphoto160.wdp"/><Relationship Id="rId7" Type="http://schemas.microsoft.com/office/2007/relationships/hdphoto" Target="../media/hdphoto25.wdp"/><Relationship Id="rId2" Type="http://schemas.openxmlformats.org/officeDocument/2006/relationships/image" Target="../media/image16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png"/><Relationship Id="rId5" Type="http://schemas.microsoft.com/office/2007/relationships/hdphoto" Target="../media/hdphoto161.wdp"/><Relationship Id="rId4" Type="http://schemas.openxmlformats.org/officeDocument/2006/relationships/image" Target="../media/image166.png"/></Relationships>
</file>

<file path=ppt/slides/_rels/slide4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0.png"/><Relationship Id="rId3" Type="http://schemas.microsoft.com/office/2007/relationships/hdphoto" Target="../media/hdphoto162.wdp"/><Relationship Id="rId7" Type="http://schemas.microsoft.com/office/2007/relationships/hdphoto" Target="../media/hdphoto164.wdp"/><Relationship Id="rId2" Type="http://schemas.openxmlformats.org/officeDocument/2006/relationships/image" Target="../media/image16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9.png"/><Relationship Id="rId11" Type="http://schemas.microsoft.com/office/2007/relationships/hdphoto" Target="../media/hdphoto166.wdp"/><Relationship Id="rId5" Type="http://schemas.microsoft.com/office/2007/relationships/hdphoto" Target="../media/hdphoto163.wdp"/><Relationship Id="rId10" Type="http://schemas.openxmlformats.org/officeDocument/2006/relationships/image" Target="../media/image171.png"/><Relationship Id="rId4" Type="http://schemas.openxmlformats.org/officeDocument/2006/relationships/image" Target="../media/image168.png"/><Relationship Id="rId9" Type="http://schemas.microsoft.com/office/2007/relationships/hdphoto" Target="../media/hdphoto165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microsoft.com/office/2007/relationships/hdphoto" Target="../media/hdphoto17.wdp"/><Relationship Id="rId7" Type="http://schemas.microsoft.com/office/2007/relationships/hdphoto" Target="../media/hdphoto19.wdp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microsoft.com/office/2007/relationships/hdphoto" Target="../media/hdphoto18.wdp"/><Relationship Id="rId4" Type="http://schemas.openxmlformats.org/officeDocument/2006/relationships/image" Target="../media/image18.png"/><Relationship Id="rId9" Type="http://schemas.microsoft.com/office/2007/relationships/hdphoto" Target="../media/hdphoto20.wdp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21.wdp"/><Relationship Id="rId7" Type="http://schemas.microsoft.com/office/2007/relationships/hdphoto" Target="../media/hdphoto23.wdp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png"/><Relationship Id="rId5" Type="http://schemas.microsoft.com/office/2007/relationships/hdphoto" Target="../media/hdphoto22.wdp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24.wdp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5.wdp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microsoft.com/office/2007/relationships/hdphoto" Target="../media/hdphoto26.wdp"/><Relationship Id="rId7" Type="http://schemas.microsoft.com/office/2007/relationships/hdphoto" Target="../media/hdphoto28.wdp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8.png"/><Relationship Id="rId11" Type="http://schemas.microsoft.com/office/2007/relationships/hdphoto" Target="../media/hdphoto30.wdp"/><Relationship Id="rId5" Type="http://schemas.microsoft.com/office/2007/relationships/hdphoto" Target="../media/hdphoto27.wdp"/><Relationship Id="rId10" Type="http://schemas.openxmlformats.org/officeDocument/2006/relationships/image" Target="../media/image30.png"/><Relationship Id="rId4" Type="http://schemas.openxmlformats.org/officeDocument/2006/relationships/image" Target="../media/image27.png"/><Relationship Id="rId9" Type="http://schemas.microsoft.com/office/2007/relationships/hdphoto" Target="../media/hdphoto29.wdp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microsoft.com/office/2007/relationships/hdphoto" Target="../media/hdphoto31.wdp"/><Relationship Id="rId7" Type="http://schemas.microsoft.com/office/2007/relationships/hdphoto" Target="../media/hdphoto27.wdp"/><Relationship Id="rId12" Type="http://schemas.openxmlformats.org/officeDocument/2006/relationships/image" Target="../media/image34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7.png"/><Relationship Id="rId11" Type="http://schemas.microsoft.com/office/2007/relationships/hdphoto" Target="../media/hdphoto33.wdp"/><Relationship Id="rId5" Type="http://schemas.microsoft.com/office/2007/relationships/hdphoto" Target="../media/hdphoto32.wdp"/><Relationship Id="rId10" Type="http://schemas.openxmlformats.org/officeDocument/2006/relationships/image" Target="../media/image33.png"/><Relationship Id="rId4" Type="http://schemas.openxmlformats.org/officeDocument/2006/relationships/image" Target="../media/image32.png"/><Relationship Id="rId9" Type="http://schemas.microsoft.com/office/2007/relationships/hdphoto" Target="../media/hdphoto2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EEFB7D9-5E24-A2FB-DE83-4E67EB17F65C}"/>
              </a:ext>
            </a:extLst>
          </p:cNvPr>
          <p:cNvSpPr txBox="1"/>
          <p:nvPr/>
        </p:nvSpPr>
        <p:spPr>
          <a:xfrm>
            <a:off x="0" y="0"/>
            <a:ext cx="21690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1C AUTAC 24h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E6F4C97-6CE7-6C4D-0A98-5CD633341ED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074" t="26928" r="19779" b="41220"/>
          <a:stretch/>
        </p:blipFill>
        <p:spPr>
          <a:xfrm>
            <a:off x="1994593" y="3431575"/>
            <a:ext cx="3117636" cy="16366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4A1B4BC-83BC-D920-1D07-325AA87DE97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832" t="35258" r="13450" b="23620"/>
          <a:stretch/>
        </p:blipFill>
        <p:spPr>
          <a:xfrm>
            <a:off x="8376661" y="467127"/>
            <a:ext cx="3601979" cy="20642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AF0F139-C5E5-C9DB-E00D-D6BD844E4DE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799" t="37443" r="32844" b="32060"/>
          <a:stretch/>
        </p:blipFill>
        <p:spPr>
          <a:xfrm>
            <a:off x="8464296" y="4729710"/>
            <a:ext cx="3514344" cy="18686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EF75869-95E4-59F7-B4B7-8398CD5DAA7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692" t="29364" r="28152" b="40199"/>
          <a:stretch/>
        </p:blipFill>
        <p:spPr>
          <a:xfrm>
            <a:off x="8537371" y="2682583"/>
            <a:ext cx="3441269" cy="18246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AB08B34-0C40-A67F-4C3A-DFC740E2B111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678" t="36900" r="23635" b="27656"/>
          <a:stretch/>
        </p:blipFill>
        <p:spPr>
          <a:xfrm>
            <a:off x="1994593" y="1668183"/>
            <a:ext cx="3151439" cy="16366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771E580-458D-E990-1580-E08155ABDBEB}"/>
              </a:ext>
            </a:extLst>
          </p:cNvPr>
          <p:cNvSpPr txBox="1"/>
          <p:nvPr/>
        </p:nvSpPr>
        <p:spPr>
          <a:xfrm>
            <a:off x="1246472" y="2476217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64B9DDD-9B57-72EA-6FAA-B085A9E93890}"/>
              </a:ext>
            </a:extLst>
          </p:cNvPr>
          <p:cNvSpPr txBox="1"/>
          <p:nvPr/>
        </p:nvSpPr>
        <p:spPr>
          <a:xfrm>
            <a:off x="1249829" y="4107401"/>
            <a:ext cx="4299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Bcl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A695244-9AED-D098-22DA-8ABDA8976846}"/>
              </a:ext>
            </a:extLst>
          </p:cNvPr>
          <p:cNvSpPr txBox="1"/>
          <p:nvPr/>
        </p:nvSpPr>
        <p:spPr>
          <a:xfrm>
            <a:off x="7640654" y="1237621"/>
            <a:ext cx="4571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Bclxl</a:t>
            </a:r>
            <a:endParaRPr lang="en-US" sz="11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68EA0FA-9C30-B183-6ACC-EF3EF0E52796}"/>
              </a:ext>
            </a:extLst>
          </p:cNvPr>
          <p:cNvSpPr txBox="1"/>
          <p:nvPr/>
        </p:nvSpPr>
        <p:spPr>
          <a:xfrm>
            <a:off x="7606528" y="3519610"/>
            <a:ext cx="5950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 I/II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86C7AF-A42D-1807-91E7-D7428F7D0B37}"/>
              </a:ext>
            </a:extLst>
          </p:cNvPr>
          <p:cNvSpPr txBox="1"/>
          <p:nvPr/>
        </p:nvSpPr>
        <p:spPr>
          <a:xfrm>
            <a:off x="7562908" y="5664040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5198E4C-C450-ADCA-3E1E-9358D8148988}"/>
              </a:ext>
            </a:extLst>
          </p:cNvPr>
          <p:cNvSpPr/>
          <p:nvPr/>
        </p:nvSpPr>
        <p:spPr>
          <a:xfrm>
            <a:off x="2664201" y="1989897"/>
            <a:ext cx="1763537" cy="6564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9AE9AA6E-CD0E-9D29-94E5-0F304CC7F5A3}"/>
              </a:ext>
            </a:extLst>
          </p:cNvPr>
          <p:cNvSpPr/>
          <p:nvPr/>
        </p:nvSpPr>
        <p:spPr>
          <a:xfrm>
            <a:off x="2560569" y="3854430"/>
            <a:ext cx="1763537" cy="6564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48F964F-A815-6B79-02DB-DAB2CFB5C1DF}"/>
              </a:ext>
            </a:extLst>
          </p:cNvPr>
          <p:cNvSpPr/>
          <p:nvPr/>
        </p:nvSpPr>
        <p:spPr>
          <a:xfrm>
            <a:off x="9089137" y="5269160"/>
            <a:ext cx="2154390" cy="6564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173B65CB-C449-0F73-A2CF-1148AD3AC1A4}"/>
              </a:ext>
            </a:extLst>
          </p:cNvPr>
          <p:cNvSpPr/>
          <p:nvPr/>
        </p:nvSpPr>
        <p:spPr>
          <a:xfrm>
            <a:off x="9180810" y="3100755"/>
            <a:ext cx="2154390" cy="6564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BBF3B47B-5FD8-F72C-0A83-6011E946B14C}"/>
              </a:ext>
            </a:extLst>
          </p:cNvPr>
          <p:cNvSpPr/>
          <p:nvPr/>
        </p:nvSpPr>
        <p:spPr>
          <a:xfrm>
            <a:off x="8958306" y="1011693"/>
            <a:ext cx="2154390" cy="6564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4944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AC75292-C2B0-3D80-888F-246981DEF610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417" t="30060" r="21343" b="19255"/>
          <a:stretch>
            <a:fillRect/>
          </a:stretch>
        </p:blipFill>
        <p:spPr>
          <a:xfrm>
            <a:off x="611469" y="458587"/>
            <a:ext cx="3287174" cy="23395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AE21C9C-ACAF-1BAC-E3D0-6213E70D30E6}"/>
              </a:ext>
            </a:extLst>
          </p:cNvPr>
          <p:cNvSpPr txBox="1"/>
          <p:nvPr/>
        </p:nvSpPr>
        <p:spPr>
          <a:xfrm>
            <a:off x="0" y="0"/>
            <a:ext cx="1089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D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13CD53A-7AD2-5338-82D5-D84F0F127153}"/>
              </a:ext>
            </a:extLst>
          </p:cNvPr>
          <p:cNvSpPr/>
          <p:nvPr/>
        </p:nvSpPr>
        <p:spPr>
          <a:xfrm>
            <a:off x="1711623" y="2000730"/>
            <a:ext cx="1328924" cy="4324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663C03C-2589-AC64-B4F3-CEE1A1AED88F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553" t="7776" r="10802" b="3267"/>
          <a:stretch>
            <a:fillRect/>
          </a:stretch>
        </p:blipFill>
        <p:spPr>
          <a:xfrm>
            <a:off x="4696055" y="288574"/>
            <a:ext cx="2689781" cy="25095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CC2AB0C-DEA5-F767-773B-0D80789FF79F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051" t="8954" r="7130" b="3358"/>
          <a:stretch>
            <a:fillRect/>
          </a:stretch>
        </p:blipFill>
        <p:spPr>
          <a:xfrm>
            <a:off x="4075391" y="3704718"/>
            <a:ext cx="3125776" cy="27334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A848FED-D93F-9CC1-A3AC-866A7F5C3481}"/>
              </a:ext>
            </a:extLst>
          </p:cNvPr>
          <p:cNvPicPr>
            <a:picLocks noChangeAspect="1"/>
          </p:cNvPicPr>
          <p:nvPr/>
        </p:nvPicPr>
        <p:blipFill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852" t="23589" r="14391" b="13884"/>
          <a:stretch>
            <a:fillRect/>
          </a:stretch>
        </p:blipFill>
        <p:spPr>
          <a:xfrm>
            <a:off x="8700516" y="203023"/>
            <a:ext cx="2817527" cy="26639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CB9F5814-6FF9-F46F-985A-B0A352AA9A40}"/>
              </a:ext>
            </a:extLst>
          </p:cNvPr>
          <p:cNvPicPr>
            <a:picLocks noChangeAspect="1"/>
          </p:cNvPicPr>
          <p:nvPr/>
        </p:nvPicPr>
        <p:blipFill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171" t="7908" r="8273" b="1998"/>
          <a:stretch>
            <a:fillRect/>
          </a:stretch>
        </p:blipFill>
        <p:spPr>
          <a:xfrm>
            <a:off x="676333" y="3639899"/>
            <a:ext cx="2781655" cy="273344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ECDA7C0C-598A-05F8-ED11-3EAC052D711B}"/>
              </a:ext>
            </a:extLst>
          </p:cNvPr>
          <p:cNvSpPr txBox="1"/>
          <p:nvPr/>
        </p:nvSpPr>
        <p:spPr>
          <a:xfrm>
            <a:off x="4140701" y="497336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93ABBF9-A3EF-E434-91E9-80D9B761DB74}"/>
              </a:ext>
            </a:extLst>
          </p:cNvPr>
          <p:cNvSpPr txBox="1"/>
          <p:nvPr/>
        </p:nvSpPr>
        <p:spPr>
          <a:xfrm>
            <a:off x="8092013" y="2433157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7F70132-DD64-7C63-BF50-AB3DE2D70078}"/>
              </a:ext>
            </a:extLst>
          </p:cNvPr>
          <p:cNvSpPr txBox="1"/>
          <p:nvPr/>
        </p:nvSpPr>
        <p:spPr>
          <a:xfrm>
            <a:off x="135693" y="1377030"/>
            <a:ext cx="3946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p6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6E5677D-44E3-B427-3ED5-BB89CB3C5980}"/>
              </a:ext>
            </a:extLst>
          </p:cNvPr>
          <p:cNvSpPr txBox="1"/>
          <p:nvPr/>
        </p:nvSpPr>
        <p:spPr>
          <a:xfrm>
            <a:off x="1380300" y="3378289"/>
            <a:ext cx="9957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PARP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1488FE0-8299-A8CA-EA35-8AF0154B239E}"/>
              </a:ext>
            </a:extLst>
          </p:cNvPr>
          <p:cNvSpPr txBox="1"/>
          <p:nvPr/>
        </p:nvSpPr>
        <p:spPr>
          <a:xfrm>
            <a:off x="4785473" y="3378289"/>
            <a:ext cx="12554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</a:t>
            </a:r>
            <a:r>
              <a:rPr lang="en-US" sz="1100" b="1" dirty="0" err="1"/>
              <a:t>Caspase</a:t>
            </a:r>
            <a:r>
              <a:rPr lang="en-US" sz="1100" b="1" dirty="0"/>
              <a:t> 3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D854CA7E-2A4C-F57F-A82D-2DE106897A7B}"/>
              </a:ext>
            </a:extLst>
          </p:cNvPr>
          <p:cNvSpPr/>
          <p:nvPr/>
        </p:nvSpPr>
        <p:spPr>
          <a:xfrm>
            <a:off x="4919680" y="447457"/>
            <a:ext cx="772087" cy="3431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9EA0F444-9AE8-FE07-72B0-8A27AEF3177F}"/>
              </a:ext>
            </a:extLst>
          </p:cNvPr>
          <p:cNvSpPr/>
          <p:nvPr/>
        </p:nvSpPr>
        <p:spPr>
          <a:xfrm>
            <a:off x="1025086" y="4091232"/>
            <a:ext cx="916836" cy="2819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1387F313-AFD8-BAA5-AF7F-97C2EAF00A40}"/>
              </a:ext>
            </a:extLst>
          </p:cNvPr>
          <p:cNvSpPr/>
          <p:nvPr/>
        </p:nvSpPr>
        <p:spPr>
          <a:xfrm>
            <a:off x="5342728" y="5906012"/>
            <a:ext cx="849771" cy="3957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CF48EA4B-0D61-282D-F2A1-3ADD2CE79B14}"/>
              </a:ext>
            </a:extLst>
          </p:cNvPr>
          <p:cNvSpPr/>
          <p:nvPr/>
        </p:nvSpPr>
        <p:spPr>
          <a:xfrm>
            <a:off x="8727451" y="2454983"/>
            <a:ext cx="772087" cy="3431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80266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A6539C4-7924-47EF-9C59-B4222F63D5EA}"/>
              </a:ext>
            </a:extLst>
          </p:cNvPr>
          <p:cNvSpPr txBox="1"/>
          <p:nvPr/>
        </p:nvSpPr>
        <p:spPr>
          <a:xfrm>
            <a:off x="0" y="0"/>
            <a:ext cx="1055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5AB768D-335C-478D-A1BD-5689BA75414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115" t="19253" r="23860" b="46242"/>
          <a:stretch/>
        </p:blipFill>
        <p:spPr>
          <a:xfrm>
            <a:off x="8854706" y="369332"/>
            <a:ext cx="2843577" cy="18717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FF87D7F-C1AF-4AC2-AE88-DFCE1843507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291" t="19596" r="23748" b="6687"/>
          <a:stretch/>
        </p:blipFill>
        <p:spPr>
          <a:xfrm>
            <a:off x="8854706" y="3518381"/>
            <a:ext cx="3205017" cy="30596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16D760C-BF16-4BFF-A250-2BF4DD4D30D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684" t="7580" r="19832" b="13797"/>
          <a:stretch/>
        </p:blipFill>
        <p:spPr>
          <a:xfrm>
            <a:off x="5801576" y="517168"/>
            <a:ext cx="2267010" cy="24927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B4FE98C-1B1B-43D7-AD1A-863F08D3CA0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066" t="22344" r="25811" b="29730"/>
          <a:stretch/>
        </p:blipFill>
        <p:spPr>
          <a:xfrm>
            <a:off x="6530995" y="3511896"/>
            <a:ext cx="2189037" cy="229288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D7886BA-1D53-47DA-9D2E-E2631E8E9BFE}"/>
              </a:ext>
            </a:extLst>
          </p:cNvPr>
          <p:cNvSpPr txBox="1"/>
          <p:nvPr/>
        </p:nvSpPr>
        <p:spPr>
          <a:xfrm>
            <a:off x="8346868" y="475498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98C7E1B-0FFD-4522-9DC1-20A1DA7B6AD7}"/>
              </a:ext>
            </a:extLst>
          </p:cNvPr>
          <p:cNvSpPr txBox="1"/>
          <p:nvPr/>
        </p:nvSpPr>
        <p:spPr>
          <a:xfrm>
            <a:off x="7232786" y="3205603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5826BBD-A16B-4827-BBE3-F03FEF20C02C}"/>
              </a:ext>
            </a:extLst>
          </p:cNvPr>
          <p:cNvSpPr txBox="1"/>
          <p:nvPr/>
        </p:nvSpPr>
        <p:spPr>
          <a:xfrm>
            <a:off x="6299427" y="231656"/>
            <a:ext cx="95731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Cleaved PAR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F70CC6F-F784-4AAA-87CC-E211AEE6BCF7}"/>
              </a:ext>
            </a:extLst>
          </p:cNvPr>
          <p:cNvSpPr txBox="1"/>
          <p:nvPr/>
        </p:nvSpPr>
        <p:spPr>
          <a:xfrm>
            <a:off x="10457214" y="3198717"/>
            <a:ext cx="5565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UBC13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C3115E24-1A3A-40C7-927D-1960AFE1ECE7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152" t="10428" r="20564" b="36173"/>
          <a:stretch/>
        </p:blipFill>
        <p:spPr>
          <a:xfrm>
            <a:off x="1427154" y="231656"/>
            <a:ext cx="2611016" cy="1956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DF65E04-EC82-4E9C-A97A-FC4FD1D97BE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604" t="59141" r="19916" b="16042"/>
          <a:stretch/>
        </p:blipFill>
        <p:spPr>
          <a:xfrm>
            <a:off x="2774739" y="5030933"/>
            <a:ext cx="2509534" cy="16112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C33F169-D023-4ECA-998D-8F01D217E8EF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550" t="27432" r="20405" b="7443"/>
          <a:stretch/>
        </p:blipFill>
        <p:spPr>
          <a:xfrm>
            <a:off x="406611" y="4538926"/>
            <a:ext cx="2041085" cy="20874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22E843F-48AF-4B40-8E02-24D47B45C14D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582" t="20980" r="19882" b="27170"/>
          <a:stretch/>
        </p:blipFill>
        <p:spPr>
          <a:xfrm>
            <a:off x="1247034" y="2354654"/>
            <a:ext cx="2843577" cy="17869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4D8201D8-6326-49F3-939F-FF4CAFBE49FE}"/>
              </a:ext>
            </a:extLst>
          </p:cNvPr>
          <p:cNvSpPr txBox="1"/>
          <p:nvPr/>
        </p:nvSpPr>
        <p:spPr>
          <a:xfrm>
            <a:off x="750451" y="729414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ABCA385-07A4-4829-B9CB-C1BA913A7BB7}"/>
              </a:ext>
            </a:extLst>
          </p:cNvPr>
          <p:cNvSpPr txBox="1"/>
          <p:nvPr/>
        </p:nvSpPr>
        <p:spPr>
          <a:xfrm>
            <a:off x="3354114" y="4642961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1F757EF-EA32-4FC5-BBA2-DEB17D426CD5}"/>
              </a:ext>
            </a:extLst>
          </p:cNvPr>
          <p:cNvSpPr txBox="1"/>
          <p:nvPr/>
        </p:nvSpPr>
        <p:spPr>
          <a:xfrm>
            <a:off x="1007084" y="4270683"/>
            <a:ext cx="95731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Cleaved PARP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065187F-98ED-4215-96AE-1F2CDA872EFC}"/>
              </a:ext>
            </a:extLst>
          </p:cNvPr>
          <p:cNvSpPr txBox="1"/>
          <p:nvPr/>
        </p:nvSpPr>
        <p:spPr>
          <a:xfrm>
            <a:off x="623168" y="3006979"/>
            <a:ext cx="5405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TRAF6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99A9007-1210-4CBF-BA2D-BB690875B033}"/>
              </a:ext>
            </a:extLst>
          </p:cNvPr>
          <p:cNvSpPr/>
          <p:nvPr/>
        </p:nvSpPr>
        <p:spPr>
          <a:xfrm>
            <a:off x="1585334" y="400759"/>
            <a:ext cx="1158858" cy="4033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F0C7D5A-7E63-4743-ABF2-4FADFC0BDF11}"/>
              </a:ext>
            </a:extLst>
          </p:cNvPr>
          <p:cNvSpPr/>
          <p:nvPr/>
        </p:nvSpPr>
        <p:spPr>
          <a:xfrm>
            <a:off x="1509477" y="2476651"/>
            <a:ext cx="1158858" cy="4033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28B0147-AEC4-4BDF-B75A-593BAE7E623D}"/>
              </a:ext>
            </a:extLst>
          </p:cNvPr>
          <p:cNvSpPr/>
          <p:nvPr/>
        </p:nvSpPr>
        <p:spPr>
          <a:xfrm>
            <a:off x="986911" y="4567580"/>
            <a:ext cx="997661" cy="2863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14537123-E7EB-48F0-A728-86AB51F0C338}"/>
              </a:ext>
            </a:extLst>
          </p:cNvPr>
          <p:cNvSpPr/>
          <p:nvPr/>
        </p:nvSpPr>
        <p:spPr>
          <a:xfrm>
            <a:off x="3071472" y="5207704"/>
            <a:ext cx="997661" cy="2863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785A2A14-AD4B-4368-A4BF-D16953ACCA61}"/>
              </a:ext>
            </a:extLst>
          </p:cNvPr>
          <p:cNvSpPr/>
          <p:nvPr/>
        </p:nvSpPr>
        <p:spPr>
          <a:xfrm>
            <a:off x="3223872" y="5360104"/>
            <a:ext cx="997661" cy="2863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FF3043A-E93B-4934-97DD-74F647326921}"/>
              </a:ext>
            </a:extLst>
          </p:cNvPr>
          <p:cNvSpPr/>
          <p:nvPr/>
        </p:nvSpPr>
        <p:spPr>
          <a:xfrm>
            <a:off x="6609207" y="3655228"/>
            <a:ext cx="997661" cy="2863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C4DC47C-E99F-4824-9E0A-DF03C77ACCDB}"/>
              </a:ext>
            </a:extLst>
          </p:cNvPr>
          <p:cNvSpPr/>
          <p:nvPr/>
        </p:nvSpPr>
        <p:spPr>
          <a:xfrm>
            <a:off x="9459553" y="6107483"/>
            <a:ext cx="997661" cy="2863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A3F658D3-C3C0-4343-A2D2-CB9563593E75}"/>
              </a:ext>
            </a:extLst>
          </p:cNvPr>
          <p:cNvSpPr/>
          <p:nvPr/>
        </p:nvSpPr>
        <p:spPr>
          <a:xfrm>
            <a:off x="6952341" y="602456"/>
            <a:ext cx="769260" cy="2863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72330204-BD44-4619-A911-097680A9912A}"/>
              </a:ext>
            </a:extLst>
          </p:cNvPr>
          <p:cNvSpPr/>
          <p:nvPr/>
        </p:nvSpPr>
        <p:spPr>
          <a:xfrm>
            <a:off x="9666552" y="517168"/>
            <a:ext cx="1175292" cy="2863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437EBAA-58E9-FC34-0A3B-EC9B0966D3F6}"/>
              </a:ext>
            </a:extLst>
          </p:cNvPr>
          <p:cNvSpPr txBox="1"/>
          <p:nvPr/>
        </p:nvSpPr>
        <p:spPr>
          <a:xfrm>
            <a:off x="4824290" y="0"/>
            <a:ext cx="1055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F</a:t>
            </a:r>
          </a:p>
        </p:txBody>
      </p:sp>
    </p:spTree>
    <p:extLst>
      <p:ext uri="{BB962C8B-B14F-4D97-AF65-F5344CB8AC3E}">
        <p14:creationId xmlns:p14="http://schemas.microsoft.com/office/powerpoint/2010/main" val="52130393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87F6C3E-A160-80BF-6821-DC75D122C1E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792" t="24147" r="13652" b="37778"/>
          <a:stretch/>
        </p:blipFill>
        <p:spPr>
          <a:xfrm>
            <a:off x="1377489" y="4223647"/>
            <a:ext cx="3901440" cy="18329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DBCE217-D0E1-2001-88A1-78C87F907C8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761" t="35407" r="11792" b="33795"/>
          <a:stretch/>
        </p:blipFill>
        <p:spPr>
          <a:xfrm>
            <a:off x="1377488" y="2472900"/>
            <a:ext cx="3901441" cy="16019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523F5C8-BC2E-8067-455C-39723EFE7F0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810" t="34472" r="16062" b="35818"/>
          <a:stretch/>
        </p:blipFill>
        <p:spPr>
          <a:xfrm>
            <a:off x="1377489" y="921783"/>
            <a:ext cx="3901440" cy="14603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CA73308-BFC5-9D24-EF53-CD558CD716E4}"/>
              </a:ext>
            </a:extLst>
          </p:cNvPr>
          <p:cNvSpPr txBox="1"/>
          <p:nvPr/>
        </p:nvSpPr>
        <p:spPr>
          <a:xfrm>
            <a:off x="765041" y="1607793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87D8F06-2167-516C-4EDB-C1A44C8C895F}"/>
              </a:ext>
            </a:extLst>
          </p:cNvPr>
          <p:cNvSpPr txBox="1"/>
          <p:nvPr/>
        </p:nvSpPr>
        <p:spPr>
          <a:xfrm>
            <a:off x="584056" y="3012246"/>
            <a:ext cx="5950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 I/II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7169FD9-0BC0-9194-F11C-FF4A43779046}"/>
              </a:ext>
            </a:extLst>
          </p:cNvPr>
          <p:cNvSpPr txBox="1"/>
          <p:nvPr/>
        </p:nvSpPr>
        <p:spPr>
          <a:xfrm>
            <a:off x="627183" y="5049599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BE7169A2-BFC1-705D-3D01-E9728F12541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327" t="31906" r="25813" b="50291"/>
          <a:stretch/>
        </p:blipFill>
        <p:spPr>
          <a:xfrm>
            <a:off x="7199874" y="1019459"/>
            <a:ext cx="3483864" cy="14264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1E5C42C-35C7-183E-5225-A35ECB824A25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798" t="36784" r="6197" b="26755"/>
          <a:stretch/>
        </p:blipFill>
        <p:spPr>
          <a:xfrm>
            <a:off x="7199874" y="2650167"/>
            <a:ext cx="3509794" cy="14264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6B72450-5A46-A832-A3F4-35D0EED6FF30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583" t="24928" r="8055" b="32135"/>
          <a:stretch/>
        </p:blipFill>
        <p:spPr>
          <a:xfrm>
            <a:off x="7199874" y="4280875"/>
            <a:ext cx="3509794" cy="17861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3D6C5438-01D8-4E39-0A82-DE7A739271C0}"/>
              </a:ext>
            </a:extLst>
          </p:cNvPr>
          <p:cNvSpPr/>
          <p:nvPr/>
        </p:nvSpPr>
        <p:spPr>
          <a:xfrm>
            <a:off x="8201143" y="1509899"/>
            <a:ext cx="1305681" cy="348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D9469F1-6678-2876-D7A7-CF6C9DAB98D6}"/>
              </a:ext>
            </a:extLst>
          </p:cNvPr>
          <p:cNvSpPr/>
          <p:nvPr/>
        </p:nvSpPr>
        <p:spPr>
          <a:xfrm>
            <a:off x="8380975" y="3163507"/>
            <a:ext cx="1040891" cy="3421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D185D4B-905F-3DD5-4329-6C3C68037385}"/>
              </a:ext>
            </a:extLst>
          </p:cNvPr>
          <p:cNvSpPr/>
          <p:nvPr/>
        </p:nvSpPr>
        <p:spPr>
          <a:xfrm>
            <a:off x="7417807" y="5071555"/>
            <a:ext cx="1040891" cy="3421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A97DAB76-816B-FE9D-27C1-830FE3B229E8}"/>
              </a:ext>
            </a:extLst>
          </p:cNvPr>
          <p:cNvSpPr/>
          <p:nvPr/>
        </p:nvSpPr>
        <p:spPr>
          <a:xfrm>
            <a:off x="1592741" y="1504551"/>
            <a:ext cx="1040891" cy="3421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EBA03AD1-F2AE-A8E6-53DE-7E4A47B4FD22}"/>
              </a:ext>
            </a:extLst>
          </p:cNvPr>
          <p:cNvSpPr/>
          <p:nvPr/>
        </p:nvSpPr>
        <p:spPr>
          <a:xfrm>
            <a:off x="1452136" y="2988710"/>
            <a:ext cx="1143658" cy="482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82F9E361-8BD5-B312-B6EF-5FE617978009}"/>
              </a:ext>
            </a:extLst>
          </p:cNvPr>
          <p:cNvSpPr/>
          <p:nvPr/>
        </p:nvSpPr>
        <p:spPr>
          <a:xfrm>
            <a:off x="1508262" y="4814562"/>
            <a:ext cx="1143658" cy="482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21C4419-3252-C8FD-BF00-85E2E989FE0B}"/>
              </a:ext>
            </a:extLst>
          </p:cNvPr>
          <p:cNvSpPr txBox="1"/>
          <p:nvPr/>
        </p:nvSpPr>
        <p:spPr>
          <a:xfrm>
            <a:off x="6561133" y="1754330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419C8D6-111A-9655-1779-B3E553A2982C}"/>
              </a:ext>
            </a:extLst>
          </p:cNvPr>
          <p:cNvSpPr txBox="1"/>
          <p:nvPr/>
        </p:nvSpPr>
        <p:spPr>
          <a:xfrm>
            <a:off x="6442556" y="3158783"/>
            <a:ext cx="5950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 I/II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8F323E1-3411-3550-E5A9-FF3C2CDD57E1}"/>
              </a:ext>
            </a:extLst>
          </p:cNvPr>
          <p:cNvSpPr txBox="1"/>
          <p:nvPr/>
        </p:nvSpPr>
        <p:spPr>
          <a:xfrm>
            <a:off x="6423275" y="5196136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EC1FCB0-2B8C-519C-A884-48340DEC30EC}"/>
              </a:ext>
            </a:extLst>
          </p:cNvPr>
          <p:cNvSpPr txBox="1"/>
          <p:nvPr/>
        </p:nvSpPr>
        <p:spPr>
          <a:xfrm>
            <a:off x="2809874" y="154588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U266B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69FE0E7-6C92-CBC4-5CF4-65027212EA38}"/>
              </a:ext>
            </a:extLst>
          </p:cNvPr>
          <p:cNvSpPr txBox="1"/>
          <p:nvPr/>
        </p:nvSpPr>
        <p:spPr>
          <a:xfrm>
            <a:off x="8314566" y="154588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MM.1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6A192E7-74F9-DC47-B852-5F2A5263FE77}"/>
              </a:ext>
            </a:extLst>
          </p:cNvPr>
          <p:cNvSpPr txBox="1"/>
          <p:nvPr/>
        </p:nvSpPr>
        <p:spPr>
          <a:xfrm>
            <a:off x="0" y="0"/>
            <a:ext cx="10829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3A</a:t>
            </a:r>
          </a:p>
        </p:txBody>
      </p:sp>
    </p:spTree>
    <p:extLst>
      <p:ext uri="{BB962C8B-B14F-4D97-AF65-F5344CB8AC3E}">
        <p14:creationId xmlns:p14="http://schemas.microsoft.com/office/powerpoint/2010/main" val="297764972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6415805-EE0D-17A9-BDBA-152D603DDDE5}"/>
              </a:ext>
            </a:extLst>
          </p:cNvPr>
          <p:cNvSpPr txBox="1"/>
          <p:nvPr/>
        </p:nvSpPr>
        <p:spPr>
          <a:xfrm>
            <a:off x="0" y="0"/>
            <a:ext cx="10829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3A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E5124B0-9B07-FF1E-A145-CD741EC398F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923" t="34104" r="11538" b="24955"/>
          <a:stretch/>
        </p:blipFill>
        <p:spPr>
          <a:xfrm>
            <a:off x="1494526" y="513662"/>
            <a:ext cx="3438144" cy="18215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19C8247-3CB9-BDFF-5C14-129B7AF4873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057" t="30138" r="11542" b="25906"/>
          <a:stretch/>
        </p:blipFill>
        <p:spPr>
          <a:xfrm>
            <a:off x="1422901" y="2439439"/>
            <a:ext cx="3509769" cy="18215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D5CCBFA-BBAF-FC0B-F484-071A394B130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808" t="21728" r="14562" b="30497"/>
          <a:stretch/>
        </p:blipFill>
        <p:spPr>
          <a:xfrm>
            <a:off x="1422901" y="4353249"/>
            <a:ext cx="3509768" cy="24143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AB5456F-468D-2C2E-5BA3-41BF9F44C59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812" t="33240" r="14503" b="26198"/>
          <a:stretch/>
        </p:blipFill>
        <p:spPr>
          <a:xfrm>
            <a:off x="6743936" y="513662"/>
            <a:ext cx="3287032" cy="18923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9DC703A-3431-98FB-9ED0-B10348F7B97C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476" t="33381" r="13638" b="25769"/>
          <a:stretch/>
        </p:blipFill>
        <p:spPr>
          <a:xfrm>
            <a:off x="6338533" y="4732966"/>
            <a:ext cx="3287032" cy="20510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5E8271CC-4074-06B6-D98A-66DF67E4F0B4}"/>
              </a:ext>
            </a:extLst>
          </p:cNvPr>
          <p:cNvSpPr/>
          <p:nvPr/>
        </p:nvSpPr>
        <p:spPr>
          <a:xfrm>
            <a:off x="1708168" y="1251350"/>
            <a:ext cx="1143658" cy="482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8269A90-73F8-94A3-0981-FEDB6A65713A}"/>
              </a:ext>
            </a:extLst>
          </p:cNvPr>
          <p:cNvSpPr/>
          <p:nvPr/>
        </p:nvSpPr>
        <p:spPr>
          <a:xfrm>
            <a:off x="3351040" y="2971876"/>
            <a:ext cx="1143658" cy="482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57B531A-22EA-8BD7-4A8D-62BF524BF9C9}"/>
              </a:ext>
            </a:extLst>
          </p:cNvPr>
          <p:cNvSpPr/>
          <p:nvPr/>
        </p:nvSpPr>
        <p:spPr>
          <a:xfrm>
            <a:off x="1749738" y="4678756"/>
            <a:ext cx="1143658" cy="482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5836640-2330-17C3-E6DB-ED8EA97405F1}"/>
              </a:ext>
            </a:extLst>
          </p:cNvPr>
          <p:cNvSpPr/>
          <p:nvPr/>
        </p:nvSpPr>
        <p:spPr>
          <a:xfrm>
            <a:off x="8709424" y="1183168"/>
            <a:ext cx="1143658" cy="482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87CF0B9-61F0-BED3-CFE0-6044B28F8832}"/>
              </a:ext>
            </a:extLst>
          </p:cNvPr>
          <p:cNvSpPr/>
          <p:nvPr/>
        </p:nvSpPr>
        <p:spPr>
          <a:xfrm>
            <a:off x="8275064" y="5382108"/>
            <a:ext cx="1143658" cy="482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088264B-4E61-0FCF-1C5E-6F4DCDC46109}"/>
              </a:ext>
            </a:extLst>
          </p:cNvPr>
          <p:cNvSpPr txBox="1"/>
          <p:nvPr/>
        </p:nvSpPr>
        <p:spPr>
          <a:xfrm>
            <a:off x="741248" y="1361805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87E5B03-257A-8A6B-0017-EBA9631EEF09}"/>
              </a:ext>
            </a:extLst>
          </p:cNvPr>
          <p:cNvSpPr txBox="1"/>
          <p:nvPr/>
        </p:nvSpPr>
        <p:spPr>
          <a:xfrm>
            <a:off x="560263" y="3459527"/>
            <a:ext cx="5950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 I/II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6E52F33-59DA-866A-B5FC-80B9C521666F}"/>
              </a:ext>
            </a:extLst>
          </p:cNvPr>
          <p:cNvSpPr txBox="1"/>
          <p:nvPr/>
        </p:nvSpPr>
        <p:spPr>
          <a:xfrm>
            <a:off x="603390" y="5496880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FEB20F-B1A6-C2DE-08BF-69E407AD3D26}"/>
              </a:ext>
            </a:extLst>
          </p:cNvPr>
          <p:cNvSpPr txBox="1"/>
          <p:nvPr/>
        </p:nvSpPr>
        <p:spPr>
          <a:xfrm>
            <a:off x="6100290" y="1231000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E00361C-E923-2C05-8147-6E85FFD1D830}"/>
              </a:ext>
            </a:extLst>
          </p:cNvPr>
          <p:cNvSpPr txBox="1"/>
          <p:nvPr/>
        </p:nvSpPr>
        <p:spPr>
          <a:xfrm>
            <a:off x="6096000" y="3213136"/>
            <a:ext cx="5950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 I/II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DE9DA71-77A5-C09C-E18F-26257B979B22}"/>
              </a:ext>
            </a:extLst>
          </p:cNvPr>
          <p:cNvSpPr txBox="1"/>
          <p:nvPr/>
        </p:nvSpPr>
        <p:spPr>
          <a:xfrm>
            <a:off x="5528072" y="5733824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A970FC8-0BE6-E5A7-07BB-1D4C6E022D42}"/>
              </a:ext>
            </a:extLst>
          </p:cNvPr>
          <p:cNvSpPr txBox="1"/>
          <p:nvPr/>
        </p:nvSpPr>
        <p:spPr>
          <a:xfrm>
            <a:off x="2472413" y="-79331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RPMI-8226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D1FF619-9977-E048-0049-B19D80BC1A84}"/>
              </a:ext>
            </a:extLst>
          </p:cNvPr>
          <p:cNvSpPr txBox="1"/>
          <p:nvPr/>
        </p:nvSpPr>
        <p:spPr>
          <a:xfrm>
            <a:off x="7982049" y="-97797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AMO-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CD79441-9C6D-F276-30E1-FEC4DF41A9CE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103" t="14705" r="7528" b="20302"/>
          <a:stretch>
            <a:fillRect/>
          </a:stretch>
        </p:blipFill>
        <p:spPr>
          <a:xfrm>
            <a:off x="6851616" y="2453132"/>
            <a:ext cx="2846895" cy="22406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06B24DF7-F897-7AB4-57EE-E6D6F6F1B01B}"/>
              </a:ext>
            </a:extLst>
          </p:cNvPr>
          <p:cNvSpPr/>
          <p:nvPr/>
        </p:nvSpPr>
        <p:spPr>
          <a:xfrm>
            <a:off x="8137595" y="2681533"/>
            <a:ext cx="912016" cy="482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47976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09CCB3B-CC10-22EF-28C3-A932B444C5DE}"/>
              </a:ext>
            </a:extLst>
          </p:cNvPr>
          <p:cNvSpPr txBox="1"/>
          <p:nvPr/>
        </p:nvSpPr>
        <p:spPr>
          <a:xfrm>
            <a:off x="0" y="0"/>
            <a:ext cx="1073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3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2F27D6C-5B06-2868-1797-0CEDAE1C97F9}"/>
              </a:ext>
            </a:extLst>
          </p:cNvPr>
          <p:cNvSpPr txBox="1"/>
          <p:nvPr/>
        </p:nvSpPr>
        <p:spPr>
          <a:xfrm>
            <a:off x="727329" y="1898311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45C744F-546A-61C7-542F-D98C9A878015}"/>
              </a:ext>
            </a:extLst>
          </p:cNvPr>
          <p:cNvSpPr txBox="1"/>
          <p:nvPr/>
        </p:nvSpPr>
        <p:spPr>
          <a:xfrm>
            <a:off x="607104" y="3652328"/>
            <a:ext cx="5950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 I/II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91F1F26-8F39-8EE3-7ECD-C3CD375435BD}"/>
              </a:ext>
            </a:extLst>
          </p:cNvPr>
          <p:cNvSpPr txBox="1"/>
          <p:nvPr/>
        </p:nvSpPr>
        <p:spPr>
          <a:xfrm>
            <a:off x="589471" y="5406345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EF79B73-5644-0B4D-4DA7-0E446DA75152}"/>
              </a:ext>
            </a:extLst>
          </p:cNvPr>
          <p:cNvSpPr txBox="1"/>
          <p:nvPr/>
        </p:nvSpPr>
        <p:spPr>
          <a:xfrm>
            <a:off x="1991929" y="184666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U266B1</a:t>
            </a:r>
            <a:r>
              <a:rPr lang="en-US" sz="1400" b="1" i="0" baseline="30000" dirty="0">
                <a:solidFill>
                  <a:srgbClr val="4A4A4A"/>
                </a:solidFill>
                <a:effectLst/>
                <a:latin typeface="brandon_grotesque_bold"/>
              </a:rPr>
              <a:t>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29354F-81FE-1C72-0FD2-78453C94F4F0}"/>
              </a:ext>
            </a:extLst>
          </p:cNvPr>
          <p:cNvSpPr txBox="1"/>
          <p:nvPr/>
        </p:nvSpPr>
        <p:spPr>
          <a:xfrm>
            <a:off x="9283383" y="119584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AMO-1</a:t>
            </a:r>
            <a:r>
              <a:rPr lang="en-US" sz="1400" b="1" i="0" baseline="30000" dirty="0">
                <a:solidFill>
                  <a:srgbClr val="4A4A4A"/>
                </a:solidFill>
                <a:effectLst/>
                <a:latin typeface="brandon_grotesque_bold"/>
              </a:rPr>
              <a:t>R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8BF80B74-9151-1891-AB70-81AED6C5CC1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303" t="23027" r="31007" b="24665"/>
          <a:stretch/>
        </p:blipFill>
        <p:spPr>
          <a:xfrm>
            <a:off x="8405622" y="2941686"/>
            <a:ext cx="2605374" cy="20758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1AC2B76-3428-E6EF-E00F-8A6A533DEB2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557" t="31152" r="19799" b="21823"/>
          <a:stretch/>
        </p:blipFill>
        <p:spPr>
          <a:xfrm>
            <a:off x="8405622" y="755123"/>
            <a:ext cx="2605374" cy="21073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83A7880-806E-3AAE-9BBD-DEFE0027847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215" t="19237" r="17098" b="37895"/>
          <a:stretch/>
        </p:blipFill>
        <p:spPr>
          <a:xfrm>
            <a:off x="8405622" y="5189526"/>
            <a:ext cx="2676906" cy="15488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86297A9-DE90-0347-0CEC-9331AB484D4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85" t="18588" r="24508" b="22576"/>
          <a:stretch/>
        </p:blipFill>
        <p:spPr>
          <a:xfrm>
            <a:off x="1529790" y="880152"/>
            <a:ext cx="2609789" cy="18572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FB63FE1-947D-F4A0-029C-D3059CE26B16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265" t="22214" r="14503" b="24332"/>
          <a:stretch/>
        </p:blipFill>
        <p:spPr>
          <a:xfrm>
            <a:off x="1529790" y="2864124"/>
            <a:ext cx="2605374" cy="18380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9815EB9-26B4-9EE6-F513-7DEB55F77511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566" t="27321" r="20279" b="32566"/>
          <a:stretch/>
        </p:blipFill>
        <p:spPr>
          <a:xfrm>
            <a:off x="1539033" y="4817369"/>
            <a:ext cx="2605374" cy="16627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529DC8D7-1586-7F06-E06C-FD1AFE2C153B}"/>
              </a:ext>
            </a:extLst>
          </p:cNvPr>
          <p:cNvSpPr txBox="1"/>
          <p:nvPr/>
        </p:nvSpPr>
        <p:spPr>
          <a:xfrm>
            <a:off x="7614718" y="1767506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E7A35B0-F05F-3DD0-E319-0573EC426D19}"/>
              </a:ext>
            </a:extLst>
          </p:cNvPr>
          <p:cNvSpPr txBox="1"/>
          <p:nvPr/>
        </p:nvSpPr>
        <p:spPr>
          <a:xfrm>
            <a:off x="7615692" y="3783133"/>
            <a:ext cx="5950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 I/II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9EB276D-2D22-CFB7-152B-D50B26FCFD35}"/>
              </a:ext>
            </a:extLst>
          </p:cNvPr>
          <p:cNvSpPr txBox="1"/>
          <p:nvPr/>
        </p:nvSpPr>
        <p:spPr>
          <a:xfrm>
            <a:off x="7614718" y="5788291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6217685E-315E-3066-9420-B57AE8E7CE28}"/>
              </a:ext>
            </a:extLst>
          </p:cNvPr>
          <p:cNvSpPr/>
          <p:nvPr/>
        </p:nvSpPr>
        <p:spPr>
          <a:xfrm>
            <a:off x="2340864" y="1170432"/>
            <a:ext cx="873674" cy="32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A408E6E1-D380-4646-9DBC-F0FDDB9081E3}"/>
              </a:ext>
            </a:extLst>
          </p:cNvPr>
          <p:cNvSpPr/>
          <p:nvPr/>
        </p:nvSpPr>
        <p:spPr>
          <a:xfrm>
            <a:off x="2185817" y="3332288"/>
            <a:ext cx="873674" cy="32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3CBD7230-F581-962A-EA91-D09FD274560E}"/>
              </a:ext>
            </a:extLst>
          </p:cNvPr>
          <p:cNvSpPr/>
          <p:nvPr/>
        </p:nvSpPr>
        <p:spPr>
          <a:xfrm>
            <a:off x="2295144" y="5524515"/>
            <a:ext cx="873674" cy="32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1ED9BE6-93FA-70B5-8E35-D9CB64168421}"/>
              </a:ext>
            </a:extLst>
          </p:cNvPr>
          <p:cNvSpPr/>
          <p:nvPr/>
        </p:nvSpPr>
        <p:spPr>
          <a:xfrm>
            <a:off x="9140952" y="1488747"/>
            <a:ext cx="873674" cy="32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7C486F6E-31D2-790C-A574-41CE0EC1862B}"/>
              </a:ext>
            </a:extLst>
          </p:cNvPr>
          <p:cNvSpPr/>
          <p:nvPr/>
        </p:nvSpPr>
        <p:spPr>
          <a:xfrm>
            <a:off x="9283383" y="3863127"/>
            <a:ext cx="873674" cy="32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03C10F70-0F1E-B4DF-88B4-BC62E5AC402D}"/>
              </a:ext>
            </a:extLst>
          </p:cNvPr>
          <p:cNvSpPr/>
          <p:nvPr/>
        </p:nvSpPr>
        <p:spPr>
          <a:xfrm>
            <a:off x="9950684" y="6190201"/>
            <a:ext cx="873674" cy="32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46679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4B46290-DED7-3C04-1EB7-1919557CA205}"/>
              </a:ext>
            </a:extLst>
          </p:cNvPr>
          <p:cNvSpPr txBox="1"/>
          <p:nvPr/>
        </p:nvSpPr>
        <p:spPr>
          <a:xfrm>
            <a:off x="0" y="0"/>
            <a:ext cx="1065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3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2246573-0CFE-0EF6-14A5-41A954CB99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570" t="26729" r="8806" b="24768"/>
          <a:stretch/>
        </p:blipFill>
        <p:spPr>
          <a:xfrm>
            <a:off x="1320775" y="999495"/>
            <a:ext cx="3368308" cy="16032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430E54E-A4B5-913E-2E33-5AD202E82D7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544" t="29397" r="8750" b="28595"/>
          <a:stretch/>
        </p:blipFill>
        <p:spPr>
          <a:xfrm>
            <a:off x="1312373" y="2719325"/>
            <a:ext cx="3358481" cy="14142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522B253-120C-9495-6BE5-3D0091D3FE4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868" t="31496" r="8698" b="31600"/>
          <a:stretch/>
        </p:blipFill>
        <p:spPr>
          <a:xfrm>
            <a:off x="1341242" y="4318546"/>
            <a:ext cx="3358481" cy="13010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8ED4854-F3E2-2202-1ED3-565854B46F7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535" t="36056" r="12068" b="32564"/>
          <a:stretch/>
        </p:blipFill>
        <p:spPr>
          <a:xfrm>
            <a:off x="7284290" y="1006010"/>
            <a:ext cx="4234387" cy="15005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28D4F75-95A8-CC7E-58FA-A0F3335E28CA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240" t="33277" r="26476" b="32501"/>
          <a:stretch/>
        </p:blipFill>
        <p:spPr>
          <a:xfrm>
            <a:off x="7827435" y="2855951"/>
            <a:ext cx="3358481" cy="15727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C:\Users\EL-Huda\OneDrive - Faculty of Pharmacy (Kafr Elshiekh University)\Lab work\Dr. Senthil lab\Autac -mcl1\wb\2st trial nsclcancer\gapdh.tif">
            <a:extLst>
              <a:ext uri="{FF2B5EF4-FFF2-40B4-BE49-F238E27FC236}">
                <a16:creationId xmlns:a16="http://schemas.microsoft.com/office/drawing/2014/main" id="{C0F0E900-540A-01C3-5BCD-D0174A6757E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398" t="12560" r="25061" b="41655"/>
          <a:stretch/>
        </p:blipFill>
        <p:spPr bwMode="auto">
          <a:xfrm>
            <a:off x="7937402" y="4595480"/>
            <a:ext cx="3248514" cy="204825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EB475880-0BD6-FB7E-284E-4DFC918D9BDC}"/>
              </a:ext>
            </a:extLst>
          </p:cNvPr>
          <p:cNvSpPr txBox="1"/>
          <p:nvPr/>
        </p:nvSpPr>
        <p:spPr>
          <a:xfrm>
            <a:off x="8917794" y="369332"/>
            <a:ext cx="13327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I-H1975</a:t>
            </a:r>
            <a:r>
              <a:rPr lang="en-US" sz="1400" b="1" baseline="30000" dirty="0"/>
              <a:t>R</a:t>
            </a:r>
            <a:endParaRPr lang="en-US" sz="14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3D25368-C912-54AB-4904-D78416413C45}"/>
              </a:ext>
            </a:extLst>
          </p:cNvPr>
          <p:cNvSpPr txBox="1"/>
          <p:nvPr/>
        </p:nvSpPr>
        <p:spPr>
          <a:xfrm>
            <a:off x="1941464" y="369332"/>
            <a:ext cx="18624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CI-H197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725B30C-A486-0F7E-3530-3CDCEBEE1F06}"/>
              </a:ext>
            </a:extLst>
          </p:cNvPr>
          <p:cNvSpPr txBox="1"/>
          <p:nvPr/>
        </p:nvSpPr>
        <p:spPr>
          <a:xfrm>
            <a:off x="507228" y="1670309"/>
            <a:ext cx="6811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5EB2347-306F-8E7A-1468-E703CBB114F5}"/>
              </a:ext>
            </a:extLst>
          </p:cNvPr>
          <p:cNvSpPr txBox="1"/>
          <p:nvPr/>
        </p:nvSpPr>
        <p:spPr>
          <a:xfrm>
            <a:off x="478428" y="3245026"/>
            <a:ext cx="8945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LC3 I/II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C287A6E-A745-5886-0074-33EB6CC4D75A}"/>
              </a:ext>
            </a:extLst>
          </p:cNvPr>
          <p:cNvSpPr txBox="1"/>
          <p:nvPr/>
        </p:nvSpPr>
        <p:spPr>
          <a:xfrm>
            <a:off x="532678" y="4838272"/>
            <a:ext cx="11494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82654A9-AB2F-B62C-9B62-8B86D295A867}"/>
              </a:ext>
            </a:extLst>
          </p:cNvPr>
          <p:cNvSpPr txBox="1"/>
          <p:nvPr/>
        </p:nvSpPr>
        <p:spPr>
          <a:xfrm>
            <a:off x="6559986" y="1625483"/>
            <a:ext cx="6811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DB428F4-212E-C376-CAA3-0F60D7B3F67F}"/>
              </a:ext>
            </a:extLst>
          </p:cNvPr>
          <p:cNvSpPr txBox="1"/>
          <p:nvPr/>
        </p:nvSpPr>
        <p:spPr>
          <a:xfrm>
            <a:off x="6900550" y="3506636"/>
            <a:ext cx="8945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LC3 I/II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A65F130-BFBD-B288-6922-CFA009904897}"/>
              </a:ext>
            </a:extLst>
          </p:cNvPr>
          <p:cNvSpPr txBox="1"/>
          <p:nvPr/>
        </p:nvSpPr>
        <p:spPr>
          <a:xfrm>
            <a:off x="7112315" y="5488803"/>
            <a:ext cx="11494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59FB87FB-D030-3511-52D6-20CF2BDCD658}"/>
              </a:ext>
            </a:extLst>
          </p:cNvPr>
          <p:cNvSpPr/>
          <p:nvPr/>
        </p:nvSpPr>
        <p:spPr>
          <a:xfrm>
            <a:off x="2991612" y="1641094"/>
            <a:ext cx="1315211" cy="32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86F59ED4-735F-ACD7-4C04-F7104F742C9D}"/>
              </a:ext>
            </a:extLst>
          </p:cNvPr>
          <p:cNvSpPr/>
          <p:nvPr/>
        </p:nvSpPr>
        <p:spPr>
          <a:xfrm>
            <a:off x="3066202" y="3244333"/>
            <a:ext cx="1315211" cy="32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45E09736-B0FD-0FB1-0265-745CFCC6A2DB}"/>
              </a:ext>
            </a:extLst>
          </p:cNvPr>
          <p:cNvSpPr/>
          <p:nvPr/>
        </p:nvSpPr>
        <p:spPr>
          <a:xfrm>
            <a:off x="3002777" y="4779842"/>
            <a:ext cx="1315211" cy="32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5E1A9E97-CA92-1EF7-7D87-636AAC821D78}"/>
              </a:ext>
            </a:extLst>
          </p:cNvPr>
          <p:cNvSpPr/>
          <p:nvPr/>
        </p:nvSpPr>
        <p:spPr>
          <a:xfrm>
            <a:off x="8743877" y="1510289"/>
            <a:ext cx="1315211" cy="32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E6BA4472-2955-ACAE-5B26-44442DE9E277}"/>
              </a:ext>
            </a:extLst>
          </p:cNvPr>
          <p:cNvSpPr/>
          <p:nvPr/>
        </p:nvSpPr>
        <p:spPr>
          <a:xfrm>
            <a:off x="8174736" y="3459132"/>
            <a:ext cx="1224122" cy="3904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9C99E4A7-513F-A0A5-58DC-271A46516A37}"/>
              </a:ext>
            </a:extLst>
          </p:cNvPr>
          <p:cNvSpPr/>
          <p:nvPr/>
        </p:nvSpPr>
        <p:spPr>
          <a:xfrm>
            <a:off x="8839925" y="4942724"/>
            <a:ext cx="1315211" cy="32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332029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4A26201-6F36-DD2E-36FA-E792C583213F}"/>
              </a:ext>
            </a:extLst>
          </p:cNvPr>
          <p:cNvSpPr txBox="1"/>
          <p:nvPr/>
        </p:nvSpPr>
        <p:spPr>
          <a:xfrm>
            <a:off x="0" y="0"/>
            <a:ext cx="1089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3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707E71E-0561-E9F6-B629-241F3280E05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436" t="23352" r="16100" b="26144"/>
          <a:stretch/>
        </p:blipFill>
        <p:spPr>
          <a:xfrm>
            <a:off x="1187134" y="747178"/>
            <a:ext cx="3770497" cy="23875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4B30D78-4751-7E15-35E4-C3D5AB2AED7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014" t="14937" r="13367" b="22188"/>
          <a:stretch/>
        </p:blipFill>
        <p:spPr>
          <a:xfrm>
            <a:off x="8180002" y="643133"/>
            <a:ext cx="2962656" cy="29900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F1A228D-34A8-8C98-A478-F6B0B95CCBF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789" t="24027" r="23021" b="23169"/>
          <a:stretch/>
        </p:blipFill>
        <p:spPr>
          <a:xfrm>
            <a:off x="2612568" y="3701959"/>
            <a:ext cx="3452952" cy="25968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097B3FEF-4864-783B-D99B-9A8A081A5B10}"/>
              </a:ext>
            </a:extLst>
          </p:cNvPr>
          <p:cNvSpPr txBox="1"/>
          <p:nvPr/>
        </p:nvSpPr>
        <p:spPr>
          <a:xfrm>
            <a:off x="4853322" y="-166941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U266B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768A9C1-CC5A-C9DC-A75A-383F58970B2B}"/>
              </a:ext>
            </a:extLst>
          </p:cNvPr>
          <p:cNvSpPr txBox="1"/>
          <p:nvPr/>
        </p:nvSpPr>
        <p:spPr>
          <a:xfrm>
            <a:off x="476891" y="1810136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5012517-2474-1086-69DF-1792A78C944B}"/>
              </a:ext>
            </a:extLst>
          </p:cNvPr>
          <p:cNvSpPr txBox="1"/>
          <p:nvPr/>
        </p:nvSpPr>
        <p:spPr>
          <a:xfrm>
            <a:off x="7418739" y="2007372"/>
            <a:ext cx="5950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 I/II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8396BC5-2794-92BC-8888-C7A395211964}"/>
              </a:ext>
            </a:extLst>
          </p:cNvPr>
          <p:cNvSpPr txBox="1"/>
          <p:nvPr/>
        </p:nvSpPr>
        <p:spPr>
          <a:xfrm>
            <a:off x="1624078" y="4869602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A2BDAD0-C5CB-3A2B-EADF-7DACCA1E7B22}"/>
              </a:ext>
            </a:extLst>
          </p:cNvPr>
          <p:cNvSpPr/>
          <p:nvPr/>
        </p:nvSpPr>
        <p:spPr>
          <a:xfrm>
            <a:off x="1921824" y="1726697"/>
            <a:ext cx="2285999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068A30F5-69A9-974D-A8CD-8A6DF5A851EF}"/>
              </a:ext>
            </a:extLst>
          </p:cNvPr>
          <p:cNvSpPr/>
          <p:nvPr/>
        </p:nvSpPr>
        <p:spPr>
          <a:xfrm>
            <a:off x="3072383" y="5367528"/>
            <a:ext cx="2285999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590AAE1-30DA-05A3-7E61-3AF6822E785A}"/>
              </a:ext>
            </a:extLst>
          </p:cNvPr>
          <p:cNvSpPr/>
          <p:nvPr/>
        </p:nvSpPr>
        <p:spPr>
          <a:xfrm>
            <a:off x="8586216" y="939688"/>
            <a:ext cx="1956816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22682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493CADB-EE4B-9DF8-228B-27F8A791C4C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491" t="7906" r="11420" b="30209"/>
          <a:stretch>
            <a:fillRect/>
          </a:stretch>
        </p:blipFill>
        <p:spPr>
          <a:xfrm>
            <a:off x="948416" y="3847959"/>
            <a:ext cx="3226043" cy="20826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B629703-7B78-86FE-BF10-6FA139959C3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310" t="30148" r="13177" b="8591"/>
          <a:stretch>
            <a:fillRect/>
          </a:stretch>
        </p:blipFill>
        <p:spPr>
          <a:xfrm>
            <a:off x="1082989" y="585638"/>
            <a:ext cx="2828041" cy="20782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A2F2770-DCD7-7429-B09B-95A15E5E14E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106" t="7705" r="18687" b="4630"/>
          <a:stretch>
            <a:fillRect/>
          </a:stretch>
        </p:blipFill>
        <p:spPr>
          <a:xfrm>
            <a:off x="5341096" y="3202682"/>
            <a:ext cx="2828041" cy="31673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8CEEE5A-1101-0A29-932B-DEE46A003A7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206" t="3701" r="12063" b="5956"/>
          <a:stretch>
            <a:fillRect/>
          </a:stretch>
        </p:blipFill>
        <p:spPr>
          <a:xfrm>
            <a:off x="8986980" y="184666"/>
            <a:ext cx="2649740" cy="27460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1C5793C-D844-AEE1-65A2-39F74415F1C8}"/>
              </a:ext>
            </a:extLst>
          </p:cNvPr>
          <p:cNvSpPr txBox="1"/>
          <p:nvPr/>
        </p:nvSpPr>
        <p:spPr>
          <a:xfrm>
            <a:off x="8234533" y="4827801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A22D374-5B7C-AD3D-8B01-4080152FEC0C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847" t="5068" r="9723" b="15601"/>
          <a:stretch>
            <a:fillRect/>
          </a:stretch>
        </p:blipFill>
        <p:spPr>
          <a:xfrm>
            <a:off x="8823264" y="3368012"/>
            <a:ext cx="3315856" cy="28367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2E724B1-183B-6D32-F80C-DDC4A1FDF729}"/>
              </a:ext>
            </a:extLst>
          </p:cNvPr>
          <p:cNvPicPr>
            <a:picLocks noChangeAspect="1"/>
          </p:cNvPicPr>
          <p:nvPr/>
        </p:nvPicPr>
        <p:blipFill>
          <a:blip r:embed="rId1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721" t="13095" r="6934" b="5415"/>
          <a:stretch>
            <a:fillRect/>
          </a:stretch>
        </p:blipFill>
        <p:spPr>
          <a:xfrm>
            <a:off x="4859851" y="137004"/>
            <a:ext cx="2472298" cy="28414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295D1E1-467A-60BC-E033-D0FD1CC0FE1A}"/>
              </a:ext>
            </a:extLst>
          </p:cNvPr>
          <p:cNvSpPr txBox="1"/>
          <p:nvPr/>
        </p:nvSpPr>
        <p:spPr>
          <a:xfrm>
            <a:off x="7687892" y="1280362"/>
            <a:ext cx="13869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caspase 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E6C571A-78CB-CC05-C47C-B192C93CAD9C}"/>
              </a:ext>
            </a:extLst>
          </p:cNvPr>
          <p:cNvSpPr txBox="1"/>
          <p:nvPr/>
        </p:nvSpPr>
        <p:spPr>
          <a:xfrm>
            <a:off x="4250733" y="4860498"/>
            <a:ext cx="10903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PAR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023BD89-F431-B7D0-8BEB-C9C075DF61B4}"/>
              </a:ext>
            </a:extLst>
          </p:cNvPr>
          <p:cNvSpPr txBox="1"/>
          <p:nvPr/>
        </p:nvSpPr>
        <p:spPr>
          <a:xfrm>
            <a:off x="4301868" y="1296102"/>
            <a:ext cx="4940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EF4A73F-5BD6-EF1E-A65A-39002A6ED602}"/>
              </a:ext>
            </a:extLst>
          </p:cNvPr>
          <p:cNvSpPr txBox="1"/>
          <p:nvPr/>
        </p:nvSpPr>
        <p:spPr>
          <a:xfrm>
            <a:off x="555280" y="1193429"/>
            <a:ext cx="5277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NRF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869F44E-8507-241A-6ED0-BFD5B7BF5FC9}"/>
              </a:ext>
            </a:extLst>
          </p:cNvPr>
          <p:cNvSpPr txBox="1"/>
          <p:nvPr/>
        </p:nvSpPr>
        <p:spPr>
          <a:xfrm>
            <a:off x="0" y="0"/>
            <a:ext cx="10829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4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9903C06-FD90-23A8-5ACA-D0E780441F1B}"/>
              </a:ext>
            </a:extLst>
          </p:cNvPr>
          <p:cNvSpPr txBox="1"/>
          <p:nvPr/>
        </p:nvSpPr>
        <p:spPr>
          <a:xfrm>
            <a:off x="208069" y="4545601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I/II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0D067BA-7688-AF68-10E4-5C7B9F6CB8FB}"/>
              </a:ext>
            </a:extLst>
          </p:cNvPr>
          <p:cNvSpPr/>
          <p:nvPr/>
        </p:nvSpPr>
        <p:spPr>
          <a:xfrm>
            <a:off x="2194332" y="982209"/>
            <a:ext cx="822246" cy="472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238A276D-10BF-30E9-9F27-FD9896C3476A}"/>
              </a:ext>
            </a:extLst>
          </p:cNvPr>
          <p:cNvSpPr/>
          <p:nvPr/>
        </p:nvSpPr>
        <p:spPr>
          <a:xfrm>
            <a:off x="1674763" y="4203576"/>
            <a:ext cx="822246" cy="472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1C33B9E9-178F-2D1E-8D5B-A6B04D33C69F}"/>
              </a:ext>
            </a:extLst>
          </p:cNvPr>
          <p:cNvSpPr/>
          <p:nvPr/>
        </p:nvSpPr>
        <p:spPr>
          <a:xfrm>
            <a:off x="6436871" y="5543753"/>
            <a:ext cx="822246" cy="472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D4785676-5001-5671-1483-71405E18DE17}"/>
              </a:ext>
            </a:extLst>
          </p:cNvPr>
          <p:cNvSpPr/>
          <p:nvPr/>
        </p:nvSpPr>
        <p:spPr>
          <a:xfrm>
            <a:off x="11161685" y="4722191"/>
            <a:ext cx="822246" cy="472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DCC0A48-059F-E45C-EC6E-DA6FB9D7D9B4}"/>
              </a:ext>
            </a:extLst>
          </p:cNvPr>
          <p:cNvSpPr/>
          <p:nvPr/>
        </p:nvSpPr>
        <p:spPr>
          <a:xfrm>
            <a:off x="10597648" y="1624763"/>
            <a:ext cx="822246" cy="472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FD1556E-93FC-2212-C7F7-A4398DBB09D7}"/>
              </a:ext>
            </a:extLst>
          </p:cNvPr>
          <p:cNvSpPr/>
          <p:nvPr/>
        </p:nvSpPr>
        <p:spPr>
          <a:xfrm>
            <a:off x="5565861" y="1500202"/>
            <a:ext cx="693537" cy="2491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5224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7EA8CB3-9B20-22E0-F967-69836D1F98A4}"/>
              </a:ext>
            </a:extLst>
          </p:cNvPr>
          <p:cNvSpPr txBox="1"/>
          <p:nvPr/>
        </p:nvSpPr>
        <p:spPr>
          <a:xfrm>
            <a:off x="0" y="0"/>
            <a:ext cx="10829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4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F20A107-7175-F064-0707-5750A235D68B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047" t="10456" r="18124" b="20811"/>
          <a:stretch>
            <a:fillRect/>
          </a:stretch>
        </p:blipFill>
        <p:spPr>
          <a:xfrm>
            <a:off x="1351902" y="3345897"/>
            <a:ext cx="3240554" cy="32025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8E7D514-FAF3-9E69-47B5-0D2F12DCA41F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928" t="5000" r="14009" b="13077"/>
          <a:stretch>
            <a:fillRect/>
          </a:stretch>
        </p:blipFill>
        <p:spPr>
          <a:xfrm>
            <a:off x="9605435" y="302997"/>
            <a:ext cx="2403835" cy="28296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CA30EF8-4D2D-C4A5-6CC0-EB0147063239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95" t="12291" r="10278" b="9733"/>
          <a:stretch>
            <a:fillRect/>
          </a:stretch>
        </p:blipFill>
        <p:spPr>
          <a:xfrm>
            <a:off x="5414439" y="3862692"/>
            <a:ext cx="3065585" cy="21689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ED60EA7-5D25-295A-00DA-58A40D67ECAB}"/>
              </a:ext>
            </a:extLst>
          </p:cNvPr>
          <p:cNvPicPr>
            <a:picLocks noChangeAspect="1"/>
          </p:cNvPicPr>
          <p:nvPr/>
        </p:nvPicPr>
        <p:blipFill>
          <a:blip r:embed="rId8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856" t="11677" r="16348" b="21223"/>
          <a:stretch>
            <a:fillRect/>
          </a:stretch>
        </p:blipFill>
        <p:spPr>
          <a:xfrm>
            <a:off x="1384647" y="682398"/>
            <a:ext cx="2668879" cy="24120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EA09BCA-5DFB-89B4-0454-B6D54D3DC4CC}"/>
              </a:ext>
            </a:extLst>
          </p:cNvPr>
          <p:cNvPicPr>
            <a:picLocks noChangeAspect="1"/>
          </p:cNvPicPr>
          <p:nvPr/>
        </p:nvPicPr>
        <p:blipFill>
          <a:blip r:embed="rId10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249" t="9599" r="22491" b="17553"/>
          <a:stretch>
            <a:fillRect/>
          </a:stretch>
        </p:blipFill>
        <p:spPr>
          <a:xfrm>
            <a:off x="5295583" y="406778"/>
            <a:ext cx="2966539" cy="31374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FD686F2-6105-776C-E7C0-3BD79C7F5EF7}"/>
              </a:ext>
            </a:extLst>
          </p:cNvPr>
          <p:cNvPicPr>
            <a:picLocks noChangeAspect="1"/>
          </p:cNvPicPr>
          <p:nvPr/>
        </p:nvPicPr>
        <p:blipFill>
          <a:blip r:embed="rId12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611" t="5997" r="8232" b="6591"/>
          <a:stretch>
            <a:fillRect/>
          </a:stretch>
        </p:blipFill>
        <p:spPr>
          <a:xfrm>
            <a:off x="9328646" y="3725314"/>
            <a:ext cx="2733415" cy="2585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4E7E7B7-7718-4A04-0639-7B817493919A}"/>
              </a:ext>
            </a:extLst>
          </p:cNvPr>
          <p:cNvSpPr txBox="1"/>
          <p:nvPr/>
        </p:nvSpPr>
        <p:spPr>
          <a:xfrm>
            <a:off x="8641249" y="4554774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2074563-9C5C-1A5A-3708-796CF748007F}"/>
              </a:ext>
            </a:extLst>
          </p:cNvPr>
          <p:cNvSpPr txBox="1"/>
          <p:nvPr/>
        </p:nvSpPr>
        <p:spPr>
          <a:xfrm>
            <a:off x="657854" y="1433875"/>
            <a:ext cx="5277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NRF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3A65B35-0AA1-7126-C823-62EFE17B6D6F}"/>
              </a:ext>
            </a:extLst>
          </p:cNvPr>
          <p:cNvSpPr txBox="1"/>
          <p:nvPr/>
        </p:nvSpPr>
        <p:spPr>
          <a:xfrm>
            <a:off x="4286974" y="1303070"/>
            <a:ext cx="10086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62/SQSTM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E9EDE7B-823B-983B-500F-9164AE514000}"/>
              </a:ext>
            </a:extLst>
          </p:cNvPr>
          <p:cNvSpPr txBox="1"/>
          <p:nvPr/>
        </p:nvSpPr>
        <p:spPr>
          <a:xfrm>
            <a:off x="8965249" y="1975525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TS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3DF1E45-2A99-CB3C-ED90-1F10ECFB92C4}"/>
              </a:ext>
            </a:extLst>
          </p:cNvPr>
          <p:cNvSpPr txBox="1"/>
          <p:nvPr/>
        </p:nvSpPr>
        <p:spPr>
          <a:xfrm>
            <a:off x="420172" y="5770077"/>
            <a:ext cx="9589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BARAPL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EA8FD2C-AE87-3604-6ED7-E6E1A52A0121}"/>
              </a:ext>
            </a:extLst>
          </p:cNvPr>
          <p:cNvSpPr txBox="1"/>
          <p:nvPr/>
        </p:nvSpPr>
        <p:spPr>
          <a:xfrm>
            <a:off x="4791278" y="4685579"/>
            <a:ext cx="6206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AMP1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7F5E0BE-6AD4-39B1-A517-44A36002E87B}"/>
              </a:ext>
            </a:extLst>
          </p:cNvPr>
          <p:cNvSpPr/>
          <p:nvPr/>
        </p:nvSpPr>
        <p:spPr>
          <a:xfrm>
            <a:off x="2200085" y="701252"/>
            <a:ext cx="693537" cy="2491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8C9249D-A824-8F2A-AAFD-7BE36DE40C91}"/>
              </a:ext>
            </a:extLst>
          </p:cNvPr>
          <p:cNvSpPr/>
          <p:nvPr/>
        </p:nvSpPr>
        <p:spPr>
          <a:xfrm>
            <a:off x="6401961" y="1197204"/>
            <a:ext cx="1008608" cy="3549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8767790-E20C-B5FA-792F-7C5C3CFC981C}"/>
              </a:ext>
            </a:extLst>
          </p:cNvPr>
          <p:cNvSpPr/>
          <p:nvPr/>
        </p:nvSpPr>
        <p:spPr>
          <a:xfrm>
            <a:off x="10847492" y="1975525"/>
            <a:ext cx="1008608" cy="3549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4C719A2-7146-DC8E-B845-70DA85499054}"/>
              </a:ext>
            </a:extLst>
          </p:cNvPr>
          <p:cNvSpPr/>
          <p:nvPr/>
        </p:nvSpPr>
        <p:spPr>
          <a:xfrm>
            <a:off x="10113773" y="3909827"/>
            <a:ext cx="1008608" cy="3549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D3957C63-F073-186D-6FC2-CDD536D0D5BA}"/>
              </a:ext>
            </a:extLst>
          </p:cNvPr>
          <p:cNvSpPr/>
          <p:nvPr/>
        </p:nvSpPr>
        <p:spPr>
          <a:xfrm>
            <a:off x="6096000" y="4741414"/>
            <a:ext cx="1008608" cy="3549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056D49D-99D7-CFB3-94FF-370EE293C36F}"/>
              </a:ext>
            </a:extLst>
          </p:cNvPr>
          <p:cNvSpPr/>
          <p:nvPr/>
        </p:nvSpPr>
        <p:spPr>
          <a:xfrm>
            <a:off x="1787660" y="5770077"/>
            <a:ext cx="1087107" cy="4055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430797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1BB91CF-DDD9-3B83-52F0-B34437F4B582}"/>
              </a:ext>
            </a:extLst>
          </p:cNvPr>
          <p:cNvSpPr txBox="1"/>
          <p:nvPr/>
        </p:nvSpPr>
        <p:spPr>
          <a:xfrm>
            <a:off x="34274" y="43473"/>
            <a:ext cx="10829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4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AB972C4-66AC-8986-B029-4E681970C323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450" t="7019" r="10968" b="4102"/>
          <a:stretch>
            <a:fillRect/>
          </a:stretch>
        </p:blipFill>
        <p:spPr>
          <a:xfrm>
            <a:off x="4510879" y="79494"/>
            <a:ext cx="3403076" cy="32817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1032A54-BBF7-A036-539C-2B1FB20A2942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603" t="10935" r="15131" b="14081"/>
          <a:stretch>
            <a:fillRect/>
          </a:stretch>
        </p:blipFill>
        <p:spPr>
          <a:xfrm>
            <a:off x="4913012" y="3767444"/>
            <a:ext cx="2365976" cy="28289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C4B32D6-2147-CF8A-43FC-A419478EC30E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712" t="4557" r="18217" b="13627"/>
          <a:stretch>
            <a:fillRect/>
          </a:stretch>
        </p:blipFill>
        <p:spPr>
          <a:xfrm>
            <a:off x="9181465" y="654932"/>
            <a:ext cx="2524598" cy="29086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A12B18D-0D3E-B8B4-AB77-AD551094F1E2}"/>
              </a:ext>
            </a:extLst>
          </p:cNvPr>
          <p:cNvPicPr>
            <a:picLocks noChangeAspect="1"/>
          </p:cNvPicPr>
          <p:nvPr/>
        </p:nvPicPr>
        <p:blipFill>
          <a:blip r:embed="rId8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575" t="4959" r="13907" b="1082"/>
          <a:stretch>
            <a:fillRect/>
          </a:stretch>
        </p:blipFill>
        <p:spPr>
          <a:xfrm>
            <a:off x="904229" y="1113271"/>
            <a:ext cx="2657232" cy="29122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4F08AC6-BAB7-F4A6-FC64-624D8D416BEB}"/>
              </a:ext>
            </a:extLst>
          </p:cNvPr>
          <p:cNvSpPr txBox="1"/>
          <p:nvPr/>
        </p:nvSpPr>
        <p:spPr>
          <a:xfrm>
            <a:off x="4198268" y="5811872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10265D3-21A3-FC0C-025A-781B92A83B6D}"/>
              </a:ext>
            </a:extLst>
          </p:cNvPr>
          <p:cNvSpPr txBox="1"/>
          <p:nvPr/>
        </p:nvSpPr>
        <p:spPr>
          <a:xfrm>
            <a:off x="272903" y="1626715"/>
            <a:ext cx="5277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NRF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7AF41F3-6FA8-340A-B518-3EC7AAE3E511}"/>
              </a:ext>
            </a:extLst>
          </p:cNvPr>
          <p:cNvSpPr txBox="1"/>
          <p:nvPr/>
        </p:nvSpPr>
        <p:spPr>
          <a:xfrm>
            <a:off x="3864118" y="1046128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I/II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E8FC3A3-E1C5-B91F-170F-47945E3E66F4}"/>
              </a:ext>
            </a:extLst>
          </p:cNvPr>
          <p:cNvSpPr txBox="1"/>
          <p:nvPr/>
        </p:nvSpPr>
        <p:spPr>
          <a:xfrm>
            <a:off x="8396475" y="1006170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I/II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E810855-0EE4-AE90-ED20-AA1AE08A0038}"/>
              </a:ext>
            </a:extLst>
          </p:cNvPr>
          <p:cNvSpPr txBox="1"/>
          <p:nvPr/>
        </p:nvSpPr>
        <p:spPr>
          <a:xfrm>
            <a:off x="3690191" y="1223860"/>
            <a:ext cx="10086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Low exposur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BEA1DB7-0878-9F4A-14E3-7B3A4FB7E72A}"/>
              </a:ext>
            </a:extLst>
          </p:cNvPr>
          <p:cNvSpPr txBox="1"/>
          <p:nvPr/>
        </p:nvSpPr>
        <p:spPr>
          <a:xfrm>
            <a:off x="8222548" y="1223860"/>
            <a:ext cx="9589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High exposure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936BEE5-02AA-C347-894E-EE388DF4DA41}"/>
              </a:ext>
            </a:extLst>
          </p:cNvPr>
          <p:cNvSpPr/>
          <p:nvPr/>
        </p:nvSpPr>
        <p:spPr>
          <a:xfrm>
            <a:off x="1385740" y="1454692"/>
            <a:ext cx="1720570" cy="4803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FC260F2-2163-A934-005A-968C1AA59EED}"/>
              </a:ext>
            </a:extLst>
          </p:cNvPr>
          <p:cNvSpPr/>
          <p:nvPr/>
        </p:nvSpPr>
        <p:spPr>
          <a:xfrm>
            <a:off x="5336162" y="1067577"/>
            <a:ext cx="1720570" cy="4803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5994402-0616-3B98-7685-3C4677379145}"/>
              </a:ext>
            </a:extLst>
          </p:cNvPr>
          <p:cNvSpPr/>
          <p:nvPr/>
        </p:nvSpPr>
        <p:spPr>
          <a:xfrm>
            <a:off x="9553830" y="1099115"/>
            <a:ext cx="1720570" cy="4803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95CCE03-0C83-9338-B028-EF0FE4607ED6}"/>
              </a:ext>
            </a:extLst>
          </p:cNvPr>
          <p:cNvSpPr/>
          <p:nvPr/>
        </p:nvSpPr>
        <p:spPr>
          <a:xfrm>
            <a:off x="5351630" y="5776268"/>
            <a:ext cx="1488739" cy="2972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35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4C27FEB-0F6A-C4CE-5BCD-231B2C6FD814}"/>
              </a:ext>
            </a:extLst>
          </p:cNvPr>
          <p:cNvSpPr txBox="1"/>
          <p:nvPr/>
        </p:nvSpPr>
        <p:spPr>
          <a:xfrm>
            <a:off x="0" y="0"/>
            <a:ext cx="2177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1C AUTAC 48h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2F30370-4901-EED9-8840-338C08C7EEF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948" t="26768" r="21650" b="41266"/>
          <a:stretch/>
        </p:blipFill>
        <p:spPr>
          <a:xfrm>
            <a:off x="1553187" y="2656625"/>
            <a:ext cx="3391339" cy="17440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EC667A8-6A4E-4FAD-F434-03F59CCBE13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797" t="37790" r="23167" b="31956"/>
          <a:stretch/>
        </p:blipFill>
        <p:spPr>
          <a:xfrm>
            <a:off x="8086623" y="4640816"/>
            <a:ext cx="3276033" cy="16056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6B52C03-0D15-6C54-7EC9-593D0EC144B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509" t="25687" r="18149" b="34517"/>
          <a:stretch/>
        </p:blipFill>
        <p:spPr>
          <a:xfrm>
            <a:off x="8086623" y="2379142"/>
            <a:ext cx="3276033" cy="20997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EC8052B-78CA-AB11-D932-3527A054EDD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453" t="34737" r="17295" b="34246"/>
          <a:stretch/>
        </p:blipFill>
        <p:spPr>
          <a:xfrm>
            <a:off x="1552103" y="885914"/>
            <a:ext cx="3392424" cy="16056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967630F-3E7A-FD8A-FC4C-11A579396252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753" t="33387" r="15239" b="35717"/>
          <a:stretch/>
        </p:blipFill>
        <p:spPr>
          <a:xfrm>
            <a:off x="8086623" y="666144"/>
            <a:ext cx="3276033" cy="15510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CC923E1-1757-5016-324D-874180EFB0B0}"/>
              </a:ext>
            </a:extLst>
          </p:cNvPr>
          <p:cNvSpPr txBox="1"/>
          <p:nvPr/>
        </p:nvSpPr>
        <p:spPr>
          <a:xfrm>
            <a:off x="829344" y="1557924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F9FEABA-8082-1B3D-D5D3-4A35EC7ABA87}"/>
              </a:ext>
            </a:extLst>
          </p:cNvPr>
          <p:cNvSpPr txBox="1"/>
          <p:nvPr/>
        </p:nvSpPr>
        <p:spPr>
          <a:xfrm>
            <a:off x="882564" y="3341760"/>
            <a:ext cx="4299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Bcl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07FEE91-664B-0421-CC9B-27C7EDB19DD8}"/>
              </a:ext>
            </a:extLst>
          </p:cNvPr>
          <p:cNvSpPr txBox="1"/>
          <p:nvPr/>
        </p:nvSpPr>
        <p:spPr>
          <a:xfrm>
            <a:off x="7299418" y="3167390"/>
            <a:ext cx="5950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 I/II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8C2DC15-42D6-1C2E-4CFF-0CBEA61CC1E2}"/>
              </a:ext>
            </a:extLst>
          </p:cNvPr>
          <p:cNvSpPr txBox="1"/>
          <p:nvPr/>
        </p:nvSpPr>
        <p:spPr>
          <a:xfrm>
            <a:off x="7346426" y="5333167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946B6C9-5D75-AA18-252D-FC2F657B6164}"/>
              </a:ext>
            </a:extLst>
          </p:cNvPr>
          <p:cNvSpPr txBox="1"/>
          <p:nvPr/>
        </p:nvSpPr>
        <p:spPr>
          <a:xfrm>
            <a:off x="7299418" y="1152759"/>
            <a:ext cx="4571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/>
              <a:t>Bclxl</a:t>
            </a:r>
            <a:endParaRPr lang="en-US" sz="1100" b="1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FBAF50E-3303-C7B6-04F7-B4ADC8C77F44}"/>
              </a:ext>
            </a:extLst>
          </p:cNvPr>
          <p:cNvSpPr/>
          <p:nvPr/>
        </p:nvSpPr>
        <p:spPr>
          <a:xfrm>
            <a:off x="2280613" y="1293859"/>
            <a:ext cx="1763537" cy="6564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C05BEF2-B209-B175-AF62-E31C35F6EC92}"/>
              </a:ext>
            </a:extLst>
          </p:cNvPr>
          <p:cNvSpPr/>
          <p:nvPr/>
        </p:nvSpPr>
        <p:spPr>
          <a:xfrm>
            <a:off x="2506165" y="3144320"/>
            <a:ext cx="1763537" cy="6564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0671212-C384-E658-0797-8F9C78FA742B}"/>
              </a:ext>
            </a:extLst>
          </p:cNvPr>
          <p:cNvSpPr/>
          <p:nvPr/>
        </p:nvSpPr>
        <p:spPr>
          <a:xfrm>
            <a:off x="8778403" y="1028124"/>
            <a:ext cx="1763537" cy="6564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299966A-FAB5-473D-4369-C849F05C749E}"/>
              </a:ext>
            </a:extLst>
          </p:cNvPr>
          <p:cNvSpPr/>
          <p:nvPr/>
        </p:nvSpPr>
        <p:spPr>
          <a:xfrm>
            <a:off x="8778402" y="3013515"/>
            <a:ext cx="1763537" cy="6564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11B28027-5D5C-06E0-51AE-97A195F3C12C}"/>
              </a:ext>
            </a:extLst>
          </p:cNvPr>
          <p:cNvSpPr/>
          <p:nvPr/>
        </p:nvSpPr>
        <p:spPr>
          <a:xfrm>
            <a:off x="8842870" y="5046394"/>
            <a:ext cx="1763537" cy="6564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00405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05C9A1D-B717-B5E0-7197-7556E3EF6C82}"/>
              </a:ext>
            </a:extLst>
          </p:cNvPr>
          <p:cNvSpPr txBox="1"/>
          <p:nvPr/>
        </p:nvSpPr>
        <p:spPr>
          <a:xfrm>
            <a:off x="0" y="0"/>
            <a:ext cx="10829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4F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736CF42-F14E-B38B-F9D4-E08FA0460E6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115" t="31475" r="18905" b="23199"/>
          <a:stretch/>
        </p:blipFill>
        <p:spPr>
          <a:xfrm>
            <a:off x="6956487" y="3536845"/>
            <a:ext cx="4153105" cy="2560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DEE30C6-D5D9-AB2A-5406-08CCF6998C0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418" t="14775" r="16826" b="31632"/>
          <a:stretch/>
        </p:blipFill>
        <p:spPr>
          <a:xfrm>
            <a:off x="6865799" y="369331"/>
            <a:ext cx="3767328" cy="26698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B40D718-1B03-BB7B-2985-D3F7C636CF7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387" t="10562" r="17165" b="30033"/>
          <a:stretch/>
        </p:blipFill>
        <p:spPr>
          <a:xfrm>
            <a:off x="1705928" y="3846871"/>
            <a:ext cx="3131248" cy="24329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456F845-8BF1-EE1D-7449-1675DBD2BAB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850" t="13325" r="14011" b="29124"/>
          <a:stretch/>
        </p:blipFill>
        <p:spPr>
          <a:xfrm>
            <a:off x="1451495" y="1096885"/>
            <a:ext cx="3385681" cy="22768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724CB409-D258-00B9-5F8C-BBBF7A290F1A}"/>
              </a:ext>
            </a:extLst>
          </p:cNvPr>
          <p:cNvSpPr txBox="1"/>
          <p:nvPr/>
        </p:nvSpPr>
        <p:spPr>
          <a:xfrm>
            <a:off x="2104335" y="230832"/>
            <a:ext cx="95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nd NRF1 </a:t>
            </a:r>
            <a:r>
              <a:rPr lang="en-US" sz="1200" b="1" baseline="30000" dirty="0"/>
              <a:t>K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386731B-D6C6-2E3A-F2ED-A7AE266DE1C4}"/>
              </a:ext>
            </a:extLst>
          </p:cNvPr>
          <p:cNvSpPr txBox="1"/>
          <p:nvPr/>
        </p:nvSpPr>
        <p:spPr>
          <a:xfrm>
            <a:off x="1558873" y="230832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NRF1 </a:t>
            </a:r>
            <a:r>
              <a:rPr lang="en-US" sz="1200" b="1" baseline="30000" dirty="0"/>
              <a:t>W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0A967D2-9687-FBE9-AE25-0FED88D013B3}"/>
              </a:ext>
            </a:extLst>
          </p:cNvPr>
          <p:cNvSpPr txBox="1"/>
          <p:nvPr/>
        </p:nvSpPr>
        <p:spPr>
          <a:xfrm>
            <a:off x="965395" y="5164578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B9BB3AD-FB9E-084F-7242-321C73562353}"/>
              </a:ext>
            </a:extLst>
          </p:cNvPr>
          <p:cNvSpPr txBox="1"/>
          <p:nvPr/>
        </p:nvSpPr>
        <p:spPr>
          <a:xfrm>
            <a:off x="6115236" y="1450359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191C5E0-FADA-C01F-88F7-BCD0FC37D0AF}"/>
              </a:ext>
            </a:extLst>
          </p:cNvPr>
          <p:cNvSpPr txBox="1"/>
          <p:nvPr/>
        </p:nvSpPr>
        <p:spPr>
          <a:xfrm>
            <a:off x="6096000" y="4690047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8236E8D-B3EA-D48A-B993-DBC9969A834C}"/>
              </a:ext>
            </a:extLst>
          </p:cNvPr>
          <p:cNvSpPr txBox="1"/>
          <p:nvPr/>
        </p:nvSpPr>
        <p:spPr>
          <a:xfrm>
            <a:off x="725586" y="2108360"/>
            <a:ext cx="4796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NRF1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9ADDC8D5-06E9-6ECF-0841-895F9EBBEE0F}"/>
              </a:ext>
            </a:extLst>
          </p:cNvPr>
          <p:cNvSpPr/>
          <p:nvPr/>
        </p:nvSpPr>
        <p:spPr>
          <a:xfrm>
            <a:off x="2227465" y="1842126"/>
            <a:ext cx="2078310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2A4AA94-2BE3-EF52-C44A-4ADF04619764}"/>
              </a:ext>
            </a:extLst>
          </p:cNvPr>
          <p:cNvSpPr/>
          <p:nvPr/>
        </p:nvSpPr>
        <p:spPr>
          <a:xfrm>
            <a:off x="2434729" y="4484307"/>
            <a:ext cx="2078310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AE1BA64-0DCA-FD0D-AA65-FE1B91E1ED05}"/>
              </a:ext>
            </a:extLst>
          </p:cNvPr>
          <p:cNvSpPr/>
          <p:nvPr/>
        </p:nvSpPr>
        <p:spPr>
          <a:xfrm>
            <a:off x="7387006" y="760835"/>
            <a:ext cx="2543377" cy="5417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4773F011-2C2F-502B-8DBC-9D81EB0DEB8D}"/>
              </a:ext>
            </a:extLst>
          </p:cNvPr>
          <p:cNvSpPr/>
          <p:nvPr/>
        </p:nvSpPr>
        <p:spPr>
          <a:xfrm>
            <a:off x="7694854" y="4600963"/>
            <a:ext cx="2543377" cy="5417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34338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21AC795-A604-8D99-EA67-D84239264619}"/>
              </a:ext>
            </a:extLst>
          </p:cNvPr>
          <p:cNvSpPr txBox="1"/>
          <p:nvPr/>
        </p:nvSpPr>
        <p:spPr>
          <a:xfrm>
            <a:off x="0" y="0"/>
            <a:ext cx="1091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4G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2025CBA-5611-AB56-40DA-35D7D0CA169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686" t="22970" r="20177" b="28072"/>
          <a:stretch/>
        </p:blipFill>
        <p:spPr>
          <a:xfrm>
            <a:off x="6829410" y="3415637"/>
            <a:ext cx="4271406" cy="28929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6D2462D-1101-AFCA-6985-90B560DED05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471" t="27211" r="18346" b="29215"/>
          <a:stretch/>
        </p:blipFill>
        <p:spPr>
          <a:xfrm>
            <a:off x="1223446" y="3066175"/>
            <a:ext cx="4434840" cy="28098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641184A-077F-6930-DF93-3BD8E6B4D1DE}"/>
              </a:ext>
            </a:extLst>
          </p:cNvPr>
          <p:cNvSpPr txBox="1"/>
          <p:nvPr/>
        </p:nvSpPr>
        <p:spPr>
          <a:xfrm>
            <a:off x="2203463" y="400336"/>
            <a:ext cx="947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nd ATG5 </a:t>
            </a:r>
            <a:r>
              <a:rPr lang="en-US" sz="1200" b="1" baseline="30000" dirty="0"/>
              <a:t>K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0499484-EFFD-B34A-ECC8-D33AB7B03FDA}"/>
              </a:ext>
            </a:extLst>
          </p:cNvPr>
          <p:cNvSpPr txBox="1"/>
          <p:nvPr/>
        </p:nvSpPr>
        <p:spPr>
          <a:xfrm>
            <a:off x="1609883" y="400336"/>
            <a:ext cx="6941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TG5 </a:t>
            </a:r>
            <a:r>
              <a:rPr lang="en-US" sz="1200" b="1" baseline="30000" dirty="0"/>
              <a:t>W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5257765-5E72-2F9C-FB31-689752696A70}"/>
              </a:ext>
            </a:extLst>
          </p:cNvPr>
          <p:cNvSpPr txBox="1"/>
          <p:nvPr/>
        </p:nvSpPr>
        <p:spPr>
          <a:xfrm>
            <a:off x="5808100" y="1592306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3ED1FD7-4AC2-13BE-0F4B-B0F62E544857}"/>
              </a:ext>
            </a:extLst>
          </p:cNvPr>
          <p:cNvSpPr txBox="1"/>
          <p:nvPr/>
        </p:nvSpPr>
        <p:spPr>
          <a:xfrm>
            <a:off x="467277" y="1592306"/>
            <a:ext cx="4892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ATG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BD2CD61-5334-22A0-10F6-29CAC68F9111}"/>
              </a:ext>
            </a:extLst>
          </p:cNvPr>
          <p:cNvSpPr txBox="1"/>
          <p:nvPr/>
        </p:nvSpPr>
        <p:spPr>
          <a:xfrm>
            <a:off x="536685" y="4330304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9D249D5-A030-3CFC-B0C9-EDD141779B8B}"/>
              </a:ext>
            </a:extLst>
          </p:cNvPr>
          <p:cNvSpPr txBox="1"/>
          <p:nvPr/>
        </p:nvSpPr>
        <p:spPr>
          <a:xfrm>
            <a:off x="6185577" y="4750169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pic>
        <p:nvPicPr>
          <p:cNvPr id="24" name="Picture 23" descr="A close-up of a test&#10;&#10;Description automatically generated">
            <a:extLst>
              <a:ext uri="{FF2B5EF4-FFF2-40B4-BE49-F238E27FC236}">
                <a16:creationId xmlns:a16="http://schemas.microsoft.com/office/drawing/2014/main" id="{E617D4F4-A8CD-4530-6901-6BC95F7767DC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694" t="27090" r="15012" b="28811"/>
          <a:stretch/>
        </p:blipFill>
        <p:spPr>
          <a:xfrm>
            <a:off x="6491911" y="490860"/>
            <a:ext cx="4700208" cy="24568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 descr="A black lines on a white background&#10;&#10;Description automatically generated">
            <a:extLst>
              <a:ext uri="{FF2B5EF4-FFF2-40B4-BE49-F238E27FC236}">
                <a16:creationId xmlns:a16="http://schemas.microsoft.com/office/drawing/2014/main" id="{CECC798E-1E43-52AE-9AE3-01F7D7E6C8AD}"/>
              </a:ext>
            </a:extLst>
          </p:cNvPr>
          <p:cNvPicPr>
            <a:picLocks noChangeAspect="1"/>
          </p:cNvPicPr>
          <p:nvPr/>
        </p:nvPicPr>
        <p:blipFill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019" t="32953" r="14533" b="39563"/>
          <a:stretch/>
        </p:blipFill>
        <p:spPr>
          <a:xfrm>
            <a:off x="1193000" y="978961"/>
            <a:ext cx="4153705" cy="17345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Rectangle 26">
            <a:extLst>
              <a:ext uri="{FF2B5EF4-FFF2-40B4-BE49-F238E27FC236}">
                <a16:creationId xmlns:a16="http://schemas.microsoft.com/office/drawing/2014/main" id="{315E3B3F-7281-BD94-40A2-8D98476FF7AE}"/>
              </a:ext>
            </a:extLst>
          </p:cNvPr>
          <p:cNvSpPr/>
          <p:nvPr/>
        </p:nvSpPr>
        <p:spPr>
          <a:xfrm>
            <a:off x="1638026" y="3429000"/>
            <a:ext cx="3199149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204479F8-1705-C0A6-C6B1-E2C184A8369F}"/>
              </a:ext>
            </a:extLst>
          </p:cNvPr>
          <p:cNvSpPr/>
          <p:nvPr/>
        </p:nvSpPr>
        <p:spPr>
          <a:xfrm>
            <a:off x="7434071" y="4172740"/>
            <a:ext cx="2834641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4BA6FB39-4CEF-6CE6-C760-C28F96D79A68}"/>
              </a:ext>
            </a:extLst>
          </p:cNvPr>
          <p:cNvSpPr/>
          <p:nvPr/>
        </p:nvSpPr>
        <p:spPr>
          <a:xfrm>
            <a:off x="6770813" y="773221"/>
            <a:ext cx="2598739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346E6814-3A9E-DEC3-F5A7-5B80D1209145}"/>
              </a:ext>
            </a:extLst>
          </p:cNvPr>
          <p:cNvSpPr/>
          <p:nvPr/>
        </p:nvSpPr>
        <p:spPr>
          <a:xfrm>
            <a:off x="1417909" y="1489364"/>
            <a:ext cx="2395140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9213238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10BE27C-7456-C3FF-2775-6951EB23F2AD}"/>
              </a:ext>
            </a:extLst>
          </p:cNvPr>
          <p:cNvSpPr txBox="1"/>
          <p:nvPr/>
        </p:nvSpPr>
        <p:spPr>
          <a:xfrm>
            <a:off x="0" y="0"/>
            <a:ext cx="1089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4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C27C048-308A-BEEF-218A-30A1F361F522}"/>
              </a:ext>
            </a:extLst>
          </p:cNvPr>
          <p:cNvSpPr txBox="1"/>
          <p:nvPr/>
        </p:nvSpPr>
        <p:spPr>
          <a:xfrm>
            <a:off x="2104335" y="230832"/>
            <a:ext cx="858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nd p62 </a:t>
            </a:r>
            <a:r>
              <a:rPr lang="en-US" sz="1200" b="1" baseline="30000" dirty="0"/>
              <a:t>KO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D2ACBB9-3EA0-7F36-A505-14553E474708}"/>
              </a:ext>
            </a:extLst>
          </p:cNvPr>
          <p:cNvSpPr txBox="1"/>
          <p:nvPr/>
        </p:nvSpPr>
        <p:spPr>
          <a:xfrm>
            <a:off x="1558873" y="230832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62 </a:t>
            </a:r>
            <a:r>
              <a:rPr lang="en-US" sz="1200" b="1" baseline="30000" dirty="0"/>
              <a:t>WT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B42DA5A-C373-05CE-FF2C-1FF7449FF5A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212" t="27858" r="23766" b="36128"/>
          <a:stretch>
            <a:fillRect/>
          </a:stretch>
        </p:blipFill>
        <p:spPr>
          <a:xfrm>
            <a:off x="1065356" y="4038218"/>
            <a:ext cx="4628560" cy="247256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CC31267-D359-C874-4529-B2BFFFBB4AF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556" t="5232" r="23489" b="10025"/>
          <a:stretch>
            <a:fillRect/>
          </a:stretch>
        </p:blipFill>
        <p:spPr>
          <a:xfrm>
            <a:off x="6297501" y="2979274"/>
            <a:ext cx="2559631" cy="353150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0EF304F-FD5C-F057-D713-E6E198E4CD3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443" t="1857" r="21379" b="25088"/>
          <a:stretch>
            <a:fillRect/>
          </a:stretch>
        </p:blipFill>
        <p:spPr>
          <a:xfrm>
            <a:off x="9029025" y="184666"/>
            <a:ext cx="2959890" cy="325587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CB1AE54E-4F4C-4B0E-DACD-AC3F036F74A6}"/>
              </a:ext>
            </a:extLst>
          </p:cNvPr>
          <p:cNvSpPr txBox="1"/>
          <p:nvPr/>
        </p:nvSpPr>
        <p:spPr>
          <a:xfrm>
            <a:off x="433081" y="5274499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BAE2BC9-FD55-7D46-2133-C08E4FC3C86A}"/>
              </a:ext>
            </a:extLst>
          </p:cNvPr>
          <p:cNvSpPr txBox="1"/>
          <p:nvPr/>
        </p:nvSpPr>
        <p:spPr>
          <a:xfrm>
            <a:off x="8344546" y="507831"/>
            <a:ext cx="5453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I/II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0E43A21-FF51-C176-92A1-9A5E8BBB0952}"/>
              </a:ext>
            </a:extLst>
          </p:cNvPr>
          <p:cNvSpPr txBox="1"/>
          <p:nvPr/>
        </p:nvSpPr>
        <p:spPr>
          <a:xfrm>
            <a:off x="5616519" y="3302042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pic>
        <p:nvPicPr>
          <p:cNvPr id="14" name="Picture 13" descr="A close-up of a white background&#10;&#10;AI-generated content may be incorrect.">
            <a:extLst>
              <a:ext uri="{FF2B5EF4-FFF2-40B4-BE49-F238E27FC236}">
                <a16:creationId xmlns:a16="http://schemas.microsoft.com/office/drawing/2014/main" id="{24D0DE96-D461-D4E4-BD42-4D9B72054B83}"/>
              </a:ext>
            </a:extLst>
          </p:cNvPr>
          <p:cNvPicPr>
            <a:picLocks noChangeAspect="1"/>
          </p:cNvPicPr>
          <p:nvPr/>
        </p:nvPicPr>
        <p:blipFill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589" t="31176" r="27456" b="18480"/>
          <a:stretch>
            <a:fillRect/>
          </a:stretch>
        </p:blipFill>
        <p:spPr>
          <a:xfrm>
            <a:off x="1364739" y="922556"/>
            <a:ext cx="2878433" cy="27582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08D94FA9-D84F-1351-DFFB-B8D1AAE3AE91}"/>
              </a:ext>
            </a:extLst>
          </p:cNvPr>
          <p:cNvSpPr txBox="1"/>
          <p:nvPr/>
        </p:nvSpPr>
        <p:spPr>
          <a:xfrm>
            <a:off x="843222" y="2444147"/>
            <a:ext cx="3946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p62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F61B1B1-27FF-7F87-3DF4-D5A819869DFD}"/>
              </a:ext>
            </a:extLst>
          </p:cNvPr>
          <p:cNvSpPr/>
          <p:nvPr/>
        </p:nvSpPr>
        <p:spPr>
          <a:xfrm>
            <a:off x="2234152" y="2444147"/>
            <a:ext cx="1348033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219526AC-7448-7E49-E9BE-EBAC4F0363F0}"/>
              </a:ext>
            </a:extLst>
          </p:cNvPr>
          <p:cNvSpPr/>
          <p:nvPr/>
        </p:nvSpPr>
        <p:spPr>
          <a:xfrm>
            <a:off x="1652258" y="5116935"/>
            <a:ext cx="1477442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5F60140-ED07-8237-431D-0F23D4270710}"/>
              </a:ext>
            </a:extLst>
          </p:cNvPr>
          <p:cNvSpPr/>
          <p:nvPr/>
        </p:nvSpPr>
        <p:spPr>
          <a:xfrm>
            <a:off x="6495068" y="3302042"/>
            <a:ext cx="1054806" cy="2539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FD0806E8-F3EB-5E2C-9320-7D7A2D962592}"/>
              </a:ext>
            </a:extLst>
          </p:cNvPr>
          <p:cNvSpPr/>
          <p:nvPr/>
        </p:nvSpPr>
        <p:spPr>
          <a:xfrm>
            <a:off x="9436231" y="380873"/>
            <a:ext cx="1072739" cy="4486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95776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C488B83-55F9-A028-B074-3A992A0F3D54}"/>
              </a:ext>
            </a:extLst>
          </p:cNvPr>
          <p:cNvSpPr txBox="1"/>
          <p:nvPr/>
        </p:nvSpPr>
        <p:spPr>
          <a:xfrm>
            <a:off x="0" y="0"/>
            <a:ext cx="1073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5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1A8A18B-1BE9-16A7-DA01-7E662E8040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721" t="31410" r="11128" b="36547"/>
          <a:stretch/>
        </p:blipFill>
        <p:spPr>
          <a:xfrm>
            <a:off x="1259281" y="1271030"/>
            <a:ext cx="4868951" cy="17550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C77D371-F684-49E1-2977-0BB4F8A83FCD}"/>
              </a:ext>
            </a:extLst>
          </p:cNvPr>
          <p:cNvSpPr txBox="1"/>
          <p:nvPr/>
        </p:nvSpPr>
        <p:spPr>
          <a:xfrm>
            <a:off x="2796492" y="184666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U266B1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9777258-E357-DB24-FBFD-40C37E40EF40}"/>
              </a:ext>
            </a:extLst>
          </p:cNvPr>
          <p:cNvSpPr/>
          <p:nvPr/>
        </p:nvSpPr>
        <p:spPr>
          <a:xfrm>
            <a:off x="1406217" y="1942834"/>
            <a:ext cx="1390275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26A664D-AD35-B561-7829-16E3F3652F8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156" t="31993" r="14763" b="45850"/>
          <a:stretch/>
        </p:blipFill>
        <p:spPr>
          <a:xfrm>
            <a:off x="1170433" y="3831883"/>
            <a:ext cx="4835424" cy="13714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CBF69C24-9E4E-5ED7-02F4-FA447B31C6F2}"/>
              </a:ext>
            </a:extLst>
          </p:cNvPr>
          <p:cNvSpPr/>
          <p:nvPr/>
        </p:nvSpPr>
        <p:spPr>
          <a:xfrm>
            <a:off x="1275997" y="4278701"/>
            <a:ext cx="1421483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98539A3-EF23-3BBF-AABF-C13BD60ABD22}"/>
              </a:ext>
            </a:extLst>
          </p:cNvPr>
          <p:cNvSpPr txBox="1"/>
          <p:nvPr/>
        </p:nvSpPr>
        <p:spPr>
          <a:xfrm>
            <a:off x="-12288" y="2092704"/>
            <a:ext cx="12554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Caspase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ECAA1BA-C9B2-1E3A-14FE-59434925717C}"/>
              </a:ext>
            </a:extLst>
          </p:cNvPr>
          <p:cNvSpPr txBox="1"/>
          <p:nvPr/>
        </p:nvSpPr>
        <p:spPr>
          <a:xfrm>
            <a:off x="309114" y="4484441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CA4CFDF-10D3-C740-EEA4-A1142598C95C}"/>
              </a:ext>
            </a:extLst>
          </p:cNvPr>
          <p:cNvSpPr txBox="1"/>
          <p:nvPr/>
        </p:nvSpPr>
        <p:spPr>
          <a:xfrm>
            <a:off x="9319071" y="161540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MM.1S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E459793-1701-5092-B146-D4941ADB083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240" t="15814" r="21054" b="43563"/>
          <a:stretch/>
        </p:blipFill>
        <p:spPr>
          <a:xfrm>
            <a:off x="8237933" y="773442"/>
            <a:ext cx="2783634" cy="19119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FD5E21C-1B06-FA96-C24C-D06B7B538ED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230" t="25507" r="11738" b="28887"/>
          <a:stretch/>
        </p:blipFill>
        <p:spPr>
          <a:xfrm>
            <a:off x="7735821" y="2867434"/>
            <a:ext cx="3776471" cy="21784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C6CE57F8-5578-9199-63DF-F4EE2FF914D3}"/>
              </a:ext>
            </a:extLst>
          </p:cNvPr>
          <p:cNvSpPr/>
          <p:nvPr/>
        </p:nvSpPr>
        <p:spPr>
          <a:xfrm>
            <a:off x="7912607" y="3750935"/>
            <a:ext cx="1120092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15B5DCF-9DDB-5E12-1CDA-F5A6CF1BD4A7}"/>
              </a:ext>
            </a:extLst>
          </p:cNvPr>
          <p:cNvSpPr/>
          <p:nvPr/>
        </p:nvSpPr>
        <p:spPr>
          <a:xfrm>
            <a:off x="8810437" y="1242586"/>
            <a:ext cx="1120092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C3D1ADB-1B75-F12E-A689-C0B2E0FA9B78}"/>
              </a:ext>
            </a:extLst>
          </p:cNvPr>
          <p:cNvSpPr txBox="1"/>
          <p:nvPr/>
        </p:nvSpPr>
        <p:spPr>
          <a:xfrm>
            <a:off x="6888384" y="1598613"/>
            <a:ext cx="12554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Caspase 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7019F6D-7104-6F68-EC30-A7D236AB73A1}"/>
              </a:ext>
            </a:extLst>
          </p:cNvPr>
          <p:cNvSpPr txBox="1"/>
          <p:nvPr/>
        </p:nvSpPr>
        <p:spPr>
          <a:xfrm>
            <a:off x="6939319" y="3907475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325087271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6A48508-0713-F73B-7C12-8BB6D79D6BC3}"/>
              </a:ext>
            </a:extLst>
          </p:cNvPr>
          <p:cNvSpPr txBox="1"/>
          <p:nvPr/>
        </p:nvSpPr>
        <p:spPr>
          <a:xfrm>
            <a:off x="0" y="0"/>
            <a:ext cx="1073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5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E63524A-3A91-CBD4-841D-E55ADC4BF49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502" t="16671" r="15514" b="34778"/>
          <a:stretch/>
        </p:blipFill>
        <p:spPr>
          <a:xfrm>
            <a:off x="1527048" y="962487"/>
            <a:ext cx="3127607" cy="30099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77D6C10-26E5-6A6F-CBF8-AECF80195A1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650" t="9925" r="24678" b="37654"/>
          <a:stretch/>
        </p:blipFill>
        <p:spPr>
          <a:xfrm>
            <a:off x="1527048" y="4256440"/>
            <a:ext cx="3127607" cy="24278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2394BCF-9615-045B-FFFB-FD3E7AAB256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610" t="25321" r="14894" b="30818"/>
          <a:stretch/>
        </p:blipFill>
        <p:spPr>
          <a:xfrm>
            <a:off x="6909848" y="756853"/>
            <a:ext cx="4128940" cy="21790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7F08A6B-1C82-0324-1FD0-56E2FA87E24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357" t="23485" r="13894" b="32043"/>
          <a:stretch/>
        </p:blipFill>
        <p:spPr>
          <a:xfrm>
            <a:off x="6774731" y="3429000"/>
            <a:ext cx="4405460" cy="22470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41A24850-E636-F3B0-4477-7CB5797E54D4}"/>
              </a:ext>
            </a:extLst>
          </p:cNvPr>
          <p:cNvSpPr/>
          <p:nvPr/>
        </p:nvSpPr>
        <p:spPr>
          <a:xfrm>
            <a:off x="1810512" y="1640650"/>
            <a:ext cx="1106603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19D8D81-F2C8-2061-854D-915DFD9DC39A}"/>
              </a:ext>
            </a:extLst>
          </p:cNvPr>
          <p:cNvSpPr/>
          <p:nvPr/>
        </p:nvSpPr>
        <p:spPr>
          <a:xfrm>
            <a:off x="7227144" y="4436575"/>
            <a:ext cx="1106603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E81ADEF-143F-954E-5ED2-9580C032DA18}"/>
              </a:ext>
            </a:extLst>
          </p:cNvPr>
          <p:cNvSpPr/>
          <p:nvPr/>
        </p:nvSpPr>
        <p:spPr>
          <a:xfrm>
            <a:off x="6910300" y="1701538"/>
            <a:ext cx="1106603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D9311DD4-F6BF-7C95-1878-FD0C089A81CC}"/>
              </a:ext>
            </a:extLst>
          </p:cNvPr>
          <p:cNvSpPr/>
          <p:nvPr/>
        </p:nvSpPr>
        <p:spPr>
          <a:xfrm>
            <a:off x="1931920" y="5011610"/>
            <a:ext cx="1106603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AE0F244-1536-3C42-B74B-D4678C26CB9E}"/>
              </a:ext>
            </a:extLst>
          </p:cNvPr>
          <p:cNvSpPr txBox="1"/>
          <p:nvPr/>
        </p:nvSpPr>
        <p:spPr>
          <a:xfrm>
            <a:off x="2363813" y="85406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RPMI-822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8D400A5-311D-AF85-4280-551DE5F63E0C}"/>
              </a:ext>
            </a:extLst>
          </p:cNvPr>
          <p:cNvSpPr txBox="1"/>
          <p:nvPr/>
        </p:nvSpPr>
        <p:spPr>
          <a:xfrm>
            <a:off x="8440537" y="85406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AMO-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A51413-C294-517F-3158-421D25E27DAF}"/>
              </a:ext>
            </a:extLst>
          </p:cNvPr>
          <p:cNvSpPr txBox="1"/>
          <p:nvPr/>
        </p:nvSpPr>
        <p:spPr>
          <a:xfrm>
            <a:off x="205274" y="2375462"/>
            <a:ext cx="12554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Caspase 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3C29736-116D-FA97-8A4B-2CB88F0754FF}"/>
              </a:ext>
            </a:extLst>
          </p:cNvPr>
          <p:cNvSpPr txBox="1"/>
          <p:nvPr/>
        </p:nvSpPr>
        <p:spPr>
          <a:xfrm>
            <a:off x="565548" y="5414424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6EA7873-17FC-6AA9-359B-EEA444AEFB98}"/>
              </a:ext>
            </a:extLst>
          </p:cNvPr>
          <p:cNvSpPr txBox="1"/>
          <p:nvPr/>
        </p:nvSpPr>
        <p:spPr>
          <a:xfrm>
            <a:off x="6015812" y="4401136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BD2D961-B18C-A303-AA35-242DBD43F67A}"/>
              </a:ext>
            </a:extLst>
          </p:cNvPr>
          <p:cNvSpPr txBox="1"/>
          <p:nvPr/>
        </p:nvSpPr>
        <p:spPr>
          <a:xfrm>
            <a:off x="5537861" y="1790520"/>
            <a:ext cx="12554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Caspase 3</a:t>
            </a:r>
          </a:p>
        </p:txBody>
      </p:sp>
    </p:spTree>
    <p:extLst>
      <p:ext uri="{BB962C8B-B14F-4D97-AF65-F5344CB8AC3E}">
        <p14:creationId xmlns:p14="http://schemas.microsoft.com/office/powerpoint/2010/main" val="233717764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01228B4-C8C9-7520-65B0-7C53DDCE484B}"/>
              </a:ext>
            </a:extLst>
          </p:cNvPr>
          <p:cNvSpPr txBox="1"/>
          <p:nvPr/>
        </p:nvSpPr>
        <p:spPr>
          <a:xfrm>
            <a:off x="0" y="0"/>
            <a:ext cx="1073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5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C51CF9A-6EDF-409F-58FB-B8CE8FD3ABC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523" t="12107" r="10124" b="35172"/>
          <a:stretch/>
        </p:blipFill>
        <p:spPr>
          <a:xfrm>
            <a:off x="7032397" y="976647"/>
            <a:ext cx="3308808" cy="25792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2D56532-BDC6-3BA0-8FB7-0BE33A00E66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465" t="11713" r="11581" b="34568"/>
          <a:stretch/>
        </p:blipFill>
        <p:spPr>
          <a:xfrm>
            <a:off x="7184381" y="3926319"/>
            <a:ext cx="3308808" cy="25667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59C24DC-CBFF-C07C-C4A8-91F7A0AD9A9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224" t="15072" r="23912" b="40236"/>
          <a:stretch/>
        </p:blipFill>
        <p:spPr>
          <a:xfrm>
            <a:off x="1585538" y="1192200"/>
            <a:ext cx="3137100" cy="25905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CA40DBB-2618-756F-878C-C6EE83CD5C0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277" t="25034" r="18411" b="28542"/>
          <a:stretch/>
        </p:blipFill>
        <p:spPr>
          <a:xfrm>
            <a:off x="1511845" y="3899011"/>
            <a:ext cx="3660963" cy="27583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C72A31C-6204-145A-F383-ED7975AEE6FD}"/>
              </a:ext>
            </a:extLst>
          </p:cNvPr>
          <p:cNvSpPr txBox="1"/>
          <p:nvPr/>
        </p:nvSpPr>
        <p:spPr>
          <a:xfrm>
            <a:off x="2620307" y="357321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U266B1</a:t>
            </a:r>
            <a:r>
              <a:rPr lang="en-US" sz="1400" b="1" i="0" baseline="30000" dirty="0">
                <a:solidFill>
                  <a:srgbClr val="4A4A4A"/>
                </a:solidFill>
                <a:effectLst/>
                <a:latin typeface="brandon_grotesque_bold"/>
              </a:rPr>
              <a:t>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38F5E52-6855-01F4-856C-1906C24E166F}"/>
              </a:ext>
            </a:extLst>
          </p:cNvPr>
          <p:cNvSpPr txBox="1"/>
          <p:nvPr/>
        </p:nvSpPr>
        <p:spPr>
          <a:xfrm>
            <a:off x="8504133" y="261366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AMO-1</a:t>
            </a:r>
            <a:r>
              <a:rPr lang="en-US" sz="1400" b="1" i="0" baseline="30000" dirty="0">
                <a:solidFill>
                  <a:srgbClr val="4A4A4A"/>
                </a:solidFill>
                <a:effectLst/>
                <a:latin typeface="brandon_grotesque_bold"/>
              </a:rPr>
              <a:t>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E073970-8740-1A99-4BE3-E1796E1E1D95}"/>
              </a:ext>
            </a:extLst>
          </p:cNvPr>
          <p:cNvSpPr txBox="1"/>
          <p:nvPr/>
        </p:nvSpPr>
        <p:spPr>
          <a:xfrm>
            <a:off x="175746" y="2225864"/>
            <a:ext cx="12554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Caspase 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0B96DA5-D02F-F254-9FAD-D302E77E35F0}"/>
              </a:ext>
            </a:extLst>
          </p:cNvPr>
          <p:cNvSpPr txBox="1"/>
          <p:nvPr/>
        </p:nvSpPr>
        <p:spPr>
          <a:xfrm>
            <a:off x="460703" y="5147388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26F778B-08D5-8104-29D1-36DC7AE6D349}"/>
              </a:ext>
            </a:extLst>
          </p:cNvPr>
          <p:cNvSpPr txBox="1"/>
          <p:nvPr/>
        </p:nvSpPr>
        <p:spPr>
          <a:xfrm>
            <a:off x="5776925" y="2115451"/>
            <a:ext cx="12554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Caspase 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748BD44-BFBB-3077-46CD-2C40A2B73CDF}"/>
              </a:ext>
            </a:extLst>
          </p:cNvPr>
          <p:cNvSpPr txBox="1"/>
          <p:nvPr/>
        </p:nvSpPr>
        <p:spPr>
          <a:xfrm>
            <a:off x="6404661" y="5016583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CDB0114E-8ECA-4CF1-E997-42E82CF6C223}"/>
              </a:ext>
            </a:extLst>
          </p:cNvPr>
          <p:cNvSpPr/>
          <p:nvPr/>
        </p:nvSpPr>
        <p:spPr>
          <a:xfrm>
            <a:off x="8964890" y="2487474"/>
            <a:ext cx="867267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EF6C34BB-789E-75F7-BAC6-F539341C287B}"/>
              </a:ext>
            </a:extLst>
          </p:cNvPr>
          <p:cNvSpPr/>
          <p:nvPr/>
        </p:nvSpPr>
        <p:spPr>
          <a:xfrm>
            <a:off x="9075622" y="5590463"/>
            <a:ext cx="867267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16267FC9-E31C-E9B0-BAF7-F53A7A5CD48E}"/>
              </a:ext>
            </a:extLst>
          </p:cNvPr>
          <p:cNvSpPr/>
          <p:nvPr/>
        </p:nvSpPr>
        <p:spPr>
          <a:xfrm>
            <a:off x="2696067" y="5072453"/>
            <a:ext cx="1089320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4FEB851C-4824-D59E-B58C-E3BE61797D2D}"/>
              </a:ext>
            </a:extLst>
          </p:cNvPr>
          <p:cNvSpPr/>
          <p:nvPr/>
        </p:nvSpPr>
        <p:spPr>
          <a:xfrm>
            <a:off x="2468117" y="1712502"/>
            <a:ext cx="1089320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359163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04AB4DD-EB69-42BE-F958-7F1417F6CDB1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869" t="6423" r="17029" b="11316"/>
          <a:stretch>
            <a:fillRect/>
          </a:stretch>
        </p:blipFill>
        <p:spPr>
          <a:xfrm>
            <a:off x="1177382" y="441838"/>
            <a:ext cx="2756649" cy="26238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CB4A406-9977-863B-6490-768D6A3DE040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bg1">
                <a:lumMod val="8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940" t="10403" r="10866" b="14893"/>
          <a:stretch>
            <a:fillRect/>
          </a:stretch>
        </p:blipFill>
        <p:spPr>
          <a:xfrm>
            <a:off x="8632521" y="2948376"/>
            <a:ext cx="3380133" cy="29586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2BAAF0E-FC90-289D-A51B-386432259E3E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695" t="7508" r="13858" b="9480"/>
          <a:stretch>
            <a:fillRect/>
          </a:stretch>
        </p:blipFill>
        <p:spPr>
          <a:xfrm>
            <a:off x="1252973" y="3309152"/>
            <a:ext cx="2894029" cy="26238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83FCF6C-4516-76B9-5A4C-7A68CAA21DE1}"/>
              </a:ext>
            </a:extLst>
          </p:cNvPr>
          <p:cNvPicPr>
            <a:picLocks noChangeAspect="1"/>
          </p:cNvPicPr>
          <p:nvPr/>
        </p:nvPicPr>
        <p:blipFill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425" t="8058" r="13022" b="6816"/>
          <a:stretch>
            <a:fillRect/>
          </a:stretch>
        </p:blipFill>
        <p:spPr>
          <a:xfrm>
            <a:off x="4769538" y="230632"/>
            <a:ext cx="2309993" cy="23246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97DB034-4E67-5B5C-D235-EB11C2382A1C}"/>
              </a:ext>
            </a:extLst>
          </p:cNvPr>
          <p:cNvPicPr>
            <a:picLocks noChangeAspect="1"/>
          </p:cNvPicPr>
          <p:nvPr/>
        </p:nvPicPr>
        <p:blipFill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272" t="22582" r="17144" b="4365"/>
          <a:stretch>
            <a:fillRect/>
          </a:stretch>
        </p:blipFill>
        <p:spPr>
          <a:xfrm>
            <a:off x="4769538" y="4076449"/>
            <a:ext cx="2689155" cy="245861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02487AA-4C25-1298-486A-C5EC6608F6D0}"/>
              </a:ext>
            </a:extLst>
          </p:cNvPr>
          <p:cNvSpPr txBox="1"/>
          <p:nvPr/>
        </p:nvSpPr>
        <p:spPr>
          <a:xfrm>
            <a:off x="630437" y="1254435"/>
            <a:ext cx="5229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cl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78DAE42-7AAC-40ED-B008-2FA45E9AEE9F}"/>
              </a:ext>
            </a:extLst>
          </p:cNvPr>
          <p:cNvSpPr txBox="1"/>
          <p:nvPr/>
        </p:nvSpPr>
        <p:spPr>
          <a:xfrm>
            <a:off x="7929187" y="4738531"/>
            <a:ext cx="703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PD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CA5AED4-246A-6DC0-E2DC-16B383C3EDB8}"/>
              </a:ext>
            </a:extLst>
          </p:cNvPr>
          <p:cNvSpPr txBox="1"/>
          <p:nvPr/>
        </p:nvSpPr>
        <p:spPr>
          <a:xfrm>
            <a:off x="4169759" y="1392935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cl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357C8E9-EB20-18FD-1304-11849DF18526}"/>
              </a:ext>
            </a:extLst>
          </p:cNvPr>
          <p:cNvSpPr txBox="1"/>
          <p:nvPr/>
        </p:nvSpPr>
        <p:spPr>
          <a:xfrm>
            <a:off x="630437" y="4600032"/>
            <a:ext cx="5469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/>
              <a:t>BclXl</a:t>
            </a:r>
            <a:endParaRPr lang="en-US" sz="12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2403F88-9D6F-1445-E683-C158ACDB01CD}"/>
              </a:ext>
            </a:extLst>
          </p:cNvPr>
          <p:cNvSpPr txBox="1"/>
          <p:nvPr/>
        </p:nvSpPr>
        <p:spPr>
          <a:xfrm>
            <a:off x="3578609" y="6085252"/>
            <a:ext cx="1073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62/SQSTM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9B59920-C555-C3D2-5891-9B0D609AD33B}"/>
              </a:ext>
            </a:extLst>
          </p:cNvPr>
          <p:cNvSpPr txBox="1"/>
          <p:nvPr/>
        </p:nvSpPr>
        <p:spPr>
          <a:xfrm>
            <a:off x="15194" y="45966"/>
            <a:ext cx="1065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6C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E5C1FB4-68DE-AE7B-2F25-911858A12579}"/>
              </a:ext>
            </a:extLst>
          </p:cNvPr>
          <p:cNvSpPr/>
          <p:nvPr/>
        </p:nvSpPr>
        <p:spPr>
          <a:xfrm>
            <a:off x="1610666" y="1254435"/>
            <a:ext cx="2112921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E601FF9F-ED45-EE7B-2762-9CE7D88785E3}"/>
              </a:ext>
            </a:extLst>
          </p:cNvPr>
          <p:cNvSpPr/>
          <p:nvPr/>
        </p:nvSpPr>
        <p:spPr>
          <a:xfrm>
            <a:off x="1715932" y="4394292"/>
            <a:ext cx="2112921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2E995230-4038-77E4-AEB8-6E65AB3E892C}"/>
              </a:ext>
            </a:extLst>
          </p:cNvPr>
          <p:cNvSpPr/>
          <p:nvPr/>
        </p:nvSpPr>
        <p:spPr>
          <a:xfrm>
            <a:off x="4911604" y="1325694"/>
            <a:ext cx="2017097" cy="340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A5382E8C-4305-0FD6-E41D-3D249C357736}"/>
              </a:ext>
            </a:extLst>
          </p:cNvPr>
          <p:cNvSpPr/>
          <p:nvPr/>
        </p:nvSpPr>
        <p:spPr>
          <a:xfrm>
            <a:off x="5034866" y="6085252"/>
            <a:ext cx="2158498" cy="340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26BE0D76-D1A8-50ED-F248-4AFCC169607F}"/>
              </a:ext>
            </a:extLst>
          </p:cNvPr>
          <p:cNvSpPr/>
          <p:nvPr/>
        </p:nvSpPr>
        <p:spPr>
          <a:xfrm>
            <a:off x="8974318" y="4600032"/>
            <a:ext cx="2587245" cy="340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530694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BED4E30B-220C-8505-C740-023FFF2369B4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162" t="8295" r="11571" b="12857"/>
          <a:stretch>
            <a:fillRect/>
          </a:stretch>
        </p:blipFill>
        <p:spPr>
          <a:xfrm>
            <a:off x="2133252" y="598132"/>
            <a:ext cx="2957223" cy="26918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25F625C-5AC1-6028-0985-AB6868891C0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8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650" t="11353" r="13755" b="16996"/>
          <a:stretch>
            <a:fillRect/>
          </a:stretch>
        </p:blipFill>
        <p:spPr>
          <a:xfrm>
            <a:off x="5952248" y="2580271"/>
            <a:ext cx="3525624" cy="29844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E326994-E632-DE54-B49D-FCE9F6B65464}"/>
              </a:ext>
            </a:extLst>
          </p:cNvPr>
          <p:cNvSpPr txBox="1"/>
          <p:nvPr/>
        </p:nvSpPr>
        <p:spPr>
          <a:xfrm>
            <a:off x="1351615" y="2580271"/>
            <a:ext cx="6444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C3I/II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AF85C9C-A101-3950-834F-7E7C9A2FD69C}"/>
              </a:ext>
            </a:extLst>
          </p:cNvPr>
          <p:cNvSpPr txBox="1"/>
          <p:nvPr/>
        </p:nvSpPr>
        <p:spPr>
          <a:xfrm>
            <a:off x="5012162" y="4179990"/>
            <a:ext cx="703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PDH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BD543E-02BF-94E3-504B-AEE2374F261B}"/>
              </a:ext>
            </a:extLst>
          </p:cNvPr>
          <p:cNvSpPr txBox="1"/>
          <p:nvPr/>
        </p:nvSpPr>
        <p:spPr>
          <a:xfrm>
            <a:off x="150795" y="115422"/>
            <a:ext cx="1065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6C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D5AC4B4-1225-CB77-6F95-F1F55707F730}"/>
              </a:ext>
            </a:extLst>
          </p:cNvPr>
          <p:cNvSpPr/>
          <p:nvPr/>
        </p:nvSpPr>
        <p:spPr>
          <a:xfrm>
            <a:off x="6334812" y="3874416"/>
            <a:ext cx="2847607" cy="5825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56D6053-6821-D464-7900-5B7A6C7120D3}"/>
              </a:ext>
            </a:extLst>
          </p:cNvPr>
          <p:cNvSpPr/>
          <p:nvPr/>
        </p:nvSpPr>
        <p:spPr>
          <a:xfrm>
            <a:off x="2353757" y="2361495"/>
            <a:ext cx="2320077" cy="5825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500814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4" descr="C:\Users\EL-Huda\OneDrive - Faculty of Pharmacy (Kafr Elshiekh University)\Lab work\Dr. Senthil lab\Autac -mcl1\wb\2st trial nsclcancer\caspase314.tif">
            <a:extLst>
              <a:ext uri="{FF2B5EF4-FFF2-40B4-BE49-F238E27FC236}">
                <a16:creationId xmlns:a16="http://schemas.microsoft.com/office/drawing/2014/main" id="{15F6D678-7762-D447-E74D-8AFA19E6E89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700" t="19743" r="17706" b="25730"/>
          <a:stretch/>
        </p:blipFill>
        <p:spPr bwMode="auto">
          <a:xfrm>
            <a:off x="2190954" y="1239129"/>
            <a:ext cx="2883381" cy="211661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379C730-6F35-EC4D-9691-0AF63F442856}"/>
              </a:ext>
            </a:extLst>
          </p:cNvPr>
          <p:cNvSpPr txBox="1"/>
          <p:nvPr/>
        </p:nvSpPr>
        <p:spPr>
          <a:xfrm>
            <a:off x="0" y="0"/>
            <a:ext cx="1073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8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83E33D4-0420-7E17-2D8E-7AA05BA7B868}"/>
              </a:ext>
            </a:extLst>
          </p:cNvPr>
          <p:cNvSpPr txBox="1"/>
          <p:nvPr/>
        </p:nvSpPr>
        <p:spPr>
          <a:xfrm>
            <a:off x="8952550" y="407411"/>
            <a:ext cx="8643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NCI-H1975</a:t>
            </a:r>
            <a:r>
              <a:rPr lang="en-US" sz="1100" b="1" baseline="30000" dirty="0"/>
              <a:t>R</a:t>
            </a:r>
            <a:endParaRPr lang="en-US" sz="11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B32083A-968C-2CFF-FF98-529443BC30E3}"/>
              </a:ext>
            </a:extLst>
          </p:cNvPr>
          <p:cNvSpPr txBox="1"/>
          <p:nvPr/>
        </p:nvSpPr>
        <p:spPr>
          <a:xfrm>
            <a:off x="3028596" y="407411"/>
            <a:ext cx="8114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NCI-H197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7E4EE20-2E14-8812-1133-1AEA053B9A06}"/>
              </a:ext>
            </a:extLst>
          </p:cNvPr>
          <p:cNvSpPr txBox="1"/>
          <p:nvPr/>
        </p:nvSpPr>
        <p:spPr>
          <a:xfrm>
            <a:off x="372618" y="4724324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5C19D096-05C3-0500-496D-73C1B2F1433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737" t="27966" r="9904" b="27888"/>
          <a:stretch/>
        </p:blipFill>
        <p:spPr>
          <a:xfrm>
            <a:off x="1255024" y="4002564"/>
            <a:ext cx="4279392" cy="18836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B7EFDD0-66F2-0FF7-0A05-903B5FE4E53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608" t="18349" r="15440" b="26580"/>
          <a:stretch/>
        </p:blipFill>
        <p:spPr>
          <a:xfrm>
            <a:off x="7428874" y="1165868"/>
            <a:ext cx="3549473" cy="22631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10" descr="C:\Users\EL-Huda\OneDrive - Faculty of Pharmacy (Kafr Elshiekh University)\Lab work\Dr. Senthil lab\Autac -mcl1\wb\2st trial nsclcancer\gapdh.tif">
            <a:extLst>
              <a:ext uri="{FF2B5EF4-FFF2-40B4-BE49-F238E27FC236}">
                <a16:creationId xmlns:a16="http://schemas.microsoft.com/office/drawing/2014/main" id="{0F5B3348-2CDB-BE00-83E4-4426EDB4041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409" t="5839" r="16002" b="26658"/>
          <a:stretch/>
        </p:blipFill>
        <p:spPr bwMode="auto">
          <a:xfrm>
            <a:off x="7428874" y="3582721"/>
            <a:ext cx="3803904" cy="272751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C1CF0573-9381-347A-ACD1-86A4A7C430C8}"/>
              </a:ext>
            </a:extLst>
          </p:cNvPr>
          <p:cNvSpPr txBox="1"/>
          <p:nvPr/>
        </p:nvSpPr>
        <p:spPr>
          <a:xfrm>
            <a:off x="357550" y="2344820"/>
            <a:ext cx="12554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Caspase 3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2A91ECDB-07C8-584C-E6D3-3FA2301FD98B}"/>
              </a:ext>
            </a:extLst>
          </p:cNvPr>
          <p:cNvSpPr/>
          <p:nvPr/>
        </p:nvSpPr>
        <p:spPr>
          <a:xfrm>
            <a:off x="2986482" y="1707763"/>
            <a:ext cx="1417018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4DD15906-36EB-38FF-FA4F-ABB0B942E860}"/>
              </a:ext>
            </a:extLst>
          </p:cNvPr>
          <p:cNvSpPr/>
          <p:nvPr/>
        </p:nvSpPr>
        <p:spPr>
          <a:xfrm>
            <a:off x="3509914" y="4724324"/>
            <a:ext cx="1541986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9F72BB41-55C5-1653-7D8D-6AD79396442C}"/>
              </a:ext>
            </a:extLst>
          </p:cNvPr>
          <p:cNvSpPr/>
          <p:nvPr/>
        </p:nvSpPr>
        <p:spPr>
          <a:xfrm>
            <a:off x="8641158" y="4129424"/>
            <a:ext cx="1124634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E846D2C-319B-AF92-0B39-11592C9B9243}"/>
              </a:ext>
            </a:extLst>
          </p:cNvPr>
          <p:cNvSpPr/>
          <p:nvPr/>
        </p:nvSpPr>
        <p:spPr>
          <a:xfrm>
            <a:off x="9254572" y="1885954"/>
            <a:ext cx="1072052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F88A0F4-E554-5D97-570F-179E376D79FE}"/>
              </a:ext>
            </a:extLst>
          </p:cNvPr>
          <p:cNvSpPr txBox="1"/>
          <p:nvPr/>
        </p:nvSpPr>
        <p:spPr>
          <a:xfrm>
            <a:off x="6657586" y="4733133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68C01A7-25C9-045D-1BA5-1E122D1A47F7}"/>
              </a:ext>
            </a:extLst>
          </p:cNvPr>
          <p:cNvSpPr txBox="1"/>
          <p:nvPr/>
        </p:nvSpPr>
        <p:spPr>
          <a:xfrm>
            <a:off x="5991028" y="2214015"/>
            <a:ext cx="12554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Caspase 3</a:t>
            </a:r>
          </a:p>
        </p:txBody>
      </p:sp>
    </p:spTree>
    <p:extLst>
      <p:ext uri="{BB962C8B-B14F-4D97-AF65-F5344CB8AC3E}">
        <p14:creationId xmlns:p14="http://schemas.microsoft.com/office/powerpoint/2010/main" val="10582413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7AEE205-5CD2-5B50-433A-3C2D74C63446}"/>
              </a:ext>
            </a:extLst>
          </p:cNvPr>
          <p:cNvSpPr txBox="1"/>
          <p:nvPr/>
        </p:nvSpPr>
        <p:spPr>
          <a:xfrm>
            <a:off x="0" y="0"/>
            <a:ext cx="232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1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8534707-20DF-9A1E-B667-8CE25ADD32A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380" t="17361" r="19216" b="11970"/>
          <a:stretch>
            <a:fillRect/>
          </a:stretch>
        </p:blipFill>
        <p:spPr>
          <a:xfrm>
            <a:off x="7569724" y="426356"/>
            <a:ext cx="3949830" cy="45060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C37583E-25EF-033D-EA81-F7CC8F31DCA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247" t="22984" r="25163" b="7700"/>
          <a:stretch>
            <a:fillRect/>
          </a:stretch>
        </p:blipFill>
        <p:spPr>
          <a:xfrm>
            <a:off x="1866508" y="740097"/>
            <a:ext cx="3560488" cy="43863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D333D89-F86E-A8AC-E7F9-30D02AE38117}"/>
              </a:ext>
            </a:extLst>
          </p:cNvPr>
          <p:cNvSpPr txBox="1"/>
          <p:nvPr/>
        </p:nvSpPr>
        <p:spPr>
          <a:xfrm>
            <a:off x="1163876" y="2679363"/>
            <a:ext cx="5453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I/II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ECC15F-6B6A-FCD7-041F-F12DE8563696}"/>
              </a:ext>
            </a:extLst>
          </p:cNvPr>
          <p:cNvSpPr txBox="1"/>
          <p:nvPr/>
        </p:nvSpPr>
        <p:spPr>
          <a:xfrm>
            <a:off x="6830994" y="4166539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F0BB3DD-2AD2-BC7B-672F-6FC3911023B7}"/>
              </a:ext>
            </a:extLst>
          </p:cNvPr>
          <p:cNvSpPr/>
          <p:nvPr/>
        </p:nvSpPr>
        <p:spPr>
          <a:xfrm>
            <a:off x="3101418" y="2594413"/>
            <a:ext cx="1423868" cy="4787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9F87CFE-B610-272C-1834-A62EDAEE771B}"/>
              </a:ext>
            </a:extLst>
          </p:cNvPr>
          <p:cNvSpPr/>
          <p:nvPr/>
        </p:nvSpPr>
        <p:spPr>
          <a:xfrm>
            <a:off x="8683657" y="3978111"/>
            <a:ext cx="1423868" cy="4067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60487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C1E4B79-8F31-D4A2-4719-42BA6894AE01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780" t="37276" r="11228" b="3563"/>
          <a:stretch>
            <a:fillRect/>
          </a:stretch>
        </p:blipFill>
        <p:spPr>
          <a:xfrm>
            <a:off x="7134095" y="1847194"/>
            <a:ext cx="4543720" cy="29918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157680A-AF87-FBC9-AAB4-44DCCE0C69DB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448" t="38294" r="7194" b="305"/>
          <a:stretch>
            <a:fillRect/>
          </a:stretch>
        </p:blipFill>
        <p:spPr>
          <a:xfrm>
            <a:off x="1847654" y="2003145"/>
            <a:ext cx="4119514" cy="25977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9DC026A-EAF5-FFF6-483E-FBD06F136558}"/>
              </a:ext>
            </a:extLst>
          </p:cNvPr>
          <p:cNvSpPr txBox="1"/>
          <p:nvPr/>
        </p:nvSpPr>
        <p:spPr>
          <a:xfrm>
            <a:off x="0" y="0"/>
            <a:ext cx="1089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1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7905D77-5CD6-7EB7-FEC7-915E27B30B0B}"/>
              </a:ext>
            </a:extLst>
          </p:cNvPr>
          <p:cNvSpPr txBox="1"/>
          <p:nvPr/>
        </p:nvSpPr>
        <p:spPr>
          <a:xfrm>
            <a:off x="6481352" y="3302586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GAPDH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569F1B0-091B-AEFF-98C2-94AB142C914B}"/>
              </a:ext>
            </a:extLst>
          </p:cNvPr>
          <p:cNvSpPr txBox="1"/>
          <p:nvPr/>
        </p:nvSpPr>
        <p:spPr>
          <a:xfrm>
            <a:off x="1274641" y="3204632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Mcl1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5B249CB-6F88-D16F-A1FE-AA9EE00933D8}"/>
              </a:ext>
            </a:extLst>
          </p:cNvPr>
          <p:cNvSpPr/>
          <p:nvPr/>
        </p:nvSpPr>
        <p:spPr>
          <a:xfrm>
            <a:off x="3907411" y="2909676"/>
            <a:ext cx="1589037" cy="5314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7244EAB-028D-0ECC-6C6D-89A55AEA9611}"/>
              </a:ext>
            </a:extLst>
          </p:cNvPr>
          <p:cNvSpPr/>
          <p:nvPr/>
        </p:nvSpPr>
        <p:spPr>
          <a:xfrm>
            <a:off x="7649773" y="3204631"/>
            <a:ext cx="1589037" cy="5314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23115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E4EAAAB-6F2E-D697-6109-34FE0EC64699}"/>
              </a:ext>
            </a:extLst>
          </p:cNvPr>
          <p:cNvSpPr txBox="1"/>
          <p:nvPr/>
        </p:nvSpPr>
        <p:spPr>
          <a:xfrm>
            <a:off x="0" y="0"/>
            <a:ext cx="2337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2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0744CC5-0AC3-9B63-4DA5-5F8DA11D7EC3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898" t="6487" r="12522" b="21717"/>
          <a:stretch>
            <a:fillRect/>
          </a:stretch>
        </p:blipFill>
        <p:spPr>
          <a:xfrm>
            <a:off x="5817180" y="4051784"/>
            <a:ext cx="2611617" cy="21554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50F15F1-F7E3-723C-7FDD-AC1D77072400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146" t="6734" r="11882" b="701"/>
          <a:stretch>
            <a:fillRect/>
          </a:stretch>
        </p:blipFill>
        <p:spPr>
          <a:xfrm>
            <a:off x="3488832" y="4000017"/>
            <a:ext cx="2217599" cy="2412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756F771-DB07-785C-7098-D7EB8EA4A773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849" t="16469" r="10531" b="12167"/>
          <a:stretch>
            <a:fillRect/>
          </a:stretch>
        </p:blipFill>
        <p:spPr>
          <a:xfrm>
            <a:off x="6708191" y="737691"/>
            <a:ext cx="2719847" cy="24276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78E5705-9747-76EF-2D5E-4D1853284B7A}"/>
              </a:ext>
            </a:extLst>
          </p:cNvPr>
          <p:cNvPicPr>
            <a:picLocks noChangeAspect="1"/>
          </p:cNvPicPr>
          <p:nvPr/>
        </p:nvPicPr>
        <p:blipFill>
          <a:blip r:embed="rId8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320" t="5236" r="9917" b="-1756"/>
          <a:stretch>
            <a:fillRect/>
          </a:stretch>
        </p:blipFill>
        <p:spPr>
          <a:xfrm>
            <a:off x="9665434" y="584488"/>
            <a:ext cx="2391337" cy="26466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A8FA2C9-BAF2-089D-2F65-4ECBC44B2863}"/>
              </a:ext>
            </a:extLst>
          </p:cNvPr>
          <p:cNvPicPr>
            <a:picLocks noChangeAspect="1"/>
          </p:cNvPicPr>
          <p:nvPr/>
        </p:nvPicPr>
        <p:blipFill>
          <a:blip r:embed="rId10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258" t="16431" r="17637" b="10273"/>
          <a:stretch>
            <a:fillRect/>
          </a:stretch>
        </p:blipFill>
        <p:spPr>
          <a:xfrm>
            <a:off x="3748486" y="723748"/>
            <a:ext cx="2841007" cy="27052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D82DBE9-2C4F-6FB3-5566-949C61938F51}"/>
              </a:ext>
            </a:extLst>
          </p:cNvPr>
          <p:cNvPicPr>
            <a:picLocks noChangeAspect="1"/>
          </p:cNvPicPr>
          <p:nvPr/>
        </p:nvPicPr>
        <p:blipFill>
          <a:blip r:embed="rId12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534" t="20900" r="11460" b="6374"/>
          <a:stretch>
            <a:fillRect/>
          </a:stretch>
        </p:blipFill>
        <p:spPr>
          <a:xfrm>
            <a:off x="319047" y="839808"/>
            <a:ext cx="2992036" cy="2628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83BEC4B-4F4B-1EB1-D179-7D0A2EADE844}"/>
              </a:ext>
            </a:extLst>
          </p:cNvPr>
          <p:cNvPicPr>
            <a:picLocks noChangeAspect="1"/>
          </p:cNvPicPr>
          <p:nvPr/>
        </p:nvPicPr>
        <p:blipFill>
          <a:blip r:embed="rId14">
            <a:duotone>
              <a:prstClr val="black"/>
              <a:schemeClr val="tx1">
                <a:lumMod val="75000"/>
                <a:lumOff val="2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748" t="11365" r="10921" b="21096"/>
          <a:stretch>
            <a:fillRect/>
          </a:stretch>
        </p:blipFill>
        <p:spPr>
          <a:xfrm>
            <a:off x="8665731" y="4051784"/>
            <a:ext cx="3193188" cy="218545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306F6E86-DD88-D03A-266A-D129DD0AA5CA}"/>
              </a:ext>
            </a:extLst>
          </p:cNvPr>
          <p:cNvSpPr txBox="1"/>
          <p:nvPr/>
        </p:nvSpPr>
        <p:spPr>
          <a:xfrm>
            <a:off x="1462671" y="506313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599CCFC-DBD5-9F2B-7B74-9C153C4EEC3F}"/>
              </a:ext>
            </a:extLst>
          </p:cNvPr>
          <p:cNvSpPr txBox="1"/>
          <p:nvPr/>
        </p:nvSpPr>
        <p:spPr>
          <a:xfrm>
            <a:off x="9861862" y="3790174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7286B46-E0D6-12DA-5B77-432369B0F39C}"/>
              </a:ext>
            </a:extLst>
          </p:cNvPr>
          <p:cNvSpPr txBox="1"/>
          <p:nvPr/>
        </p:nvSpPr>
        <p:spPr>
          <a:xfrm>
            <a:off x="4323164" y="420242"/>
            <a:ext cx="5741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TO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ED5F401-D808-C717-6276-1A24A87E25F5}"/>
              </a:ext>
            </a:extLst>
          </p:cNvPr>
          <p:cNvSpPr txBox="1"/>
          <p:nvPr/>
        </p:nvSpPr>
        <p:spPr>
          <a:xfrm>
            <a:off x="7779236" y="446030"/>
            <a:ext cx="4187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5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771FA1A-5825-0F31-B41B-28FE2855A3E2}"/>
              </a:ext>
            </a:extLst>
          </p:cNvPr>
          <p:cNvSpPr txBox="1"/>
          <p:nvPr/>
        </p:nvSpPr>
        <p:spPr>
          <a:xfrm>
            <a:off x="10583623" y="252088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HSP7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B60C067-8AAF-8F26-A77A-8E8B7B1EBD7A}"/>
              </a:ext>
            </a:extLst>
          </p:cNvPr>
          <p:cNvSpPr txBox="1"/>
          <p:nvPr/>
        </p:nvSpPr>
        <p:spPr>
          <a:xfrm>
            <a:off x="4355567" y="3694267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HSP6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9E5DA15-46F0-6FF8-9FE4-10864C4381BA}"/>
              </a:ext>
            </a:extLst>
          </p:cNvPr>
          <p:cNvSpPr txBox="1"/>
          <p:nvPr/>
        </p:nvSpPr>
        <p:spPr>
          <a:xfrm>
            <a:off x="7003034" y="3760123"/>
            <a:ext cx="4427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ERK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A0A32453-F24D-3155-7DEC-52FA132D44A9}"/>
              </a:ext>
            </a:extLst>
          </p:cNvPr>
          <p:cNvPicPr>
            <a:picLocks noChangeAspect="1"/>
          </p:cNvPicPr>
          <p:nvPr/>
        </p:nvPicPr>
        <p:blipFill>
          <a:blip r:embed="rId1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876" t="10475" r="6633" b="14262"/>
          <a:stretch>
            <a:fillRect/>
          </a:stretch>
        </p:blipFill>
        <p:spPr>
          <a:xfrm>
            <a:off x="529532" y="4239761"/>
            <a:ext cx="2781551" cy="21728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295F8C06-1C8D-DDD9-4884-10AECD21386C}"/>
              </a:ext>
            </a:extLst>
          </p:cNvPr>
          <p:cNvSpPr txBox="1"/>
          <p:nvPr/>
        </p:nvSpPr>
        <p:spPr>
          <a:xfrm>
            <a:off x="1421398" y="3955877"/>
            <a:ext cx="5180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ULK1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AAE9866-A7D0-6B1C-6CEA-CD0F3081A9E0}"/>
              </a:ext>
            </a:extLst>
          </p:cNvPr>
          <p:cNvSpPr/>
          <p:nvPr/>
        </p:nvSpPr>
        <p:spPr>
          <a:xfrm>
            <a:off x="513613" y="1060200"/>
            <a:ext cx="447921" cy="4787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2BE228E0-0035-8FB1-593A-D2FCFB7CB63A}"/>
              </a:ext>
            </a:extLst>
          </p:cNvPr>
          <p:cNvSpPr/>
          <p:nvPr/>
        </p:nvSpPr>
        <p:spPr>
          <a:xfrm>
            <a:off x="2192229" y="4969530"/>
            <a:ext cx="447921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136A3989-115E-63A4-0C8C-C4AC8EA7BA42}"/>
              </a:ext>
            </a:extLst>
          </p:cNvPr>
          <p:cNvSpPr/>
          <p:nvPr/>
        </p:nvSpPr>
        <p:spPr>
          <a:xfrm>
            <a:off x="3889609" y="6032205"/>
            <a:ext cx="447921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EB462A36-2421-2D12-1EDF-E9172A3FC1F9}"/>
              </a:ext>
            </a:extLst>
          </p:cNvPr>
          <p:cNvSpPr/>
          <p:nvPr/>
        </p:nvSpPr>
        <p:spPr>
          <a:xfrm>
            <a:off x="6096000" y="4140505"/>
            <a:ext cx="447921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284FECF8-5009-1A99-2A56-3E6078E4255E}"/>
              </a:ext>
            </a:extLst>
          </p:cNvPr>
          <p:cNvSpPr/>
          <p:nvPr/>
        </p:nvSpPr>
        <p:spPr>
          <a:xfrm>
            <a:off x="10613623" y="4547027"/>
            <a:ext cx="447921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C42154E-7F1A-F7A6-664F-4DE4C439D85E}"/>
              </a:ext>
            </a:extLst>
          </p:cNvPr>
          <p:cNvSpPr/>
          <p:nvPr/>
        </p:nvSpPr>
        <p:spPr>
          <a:xfrm>
            <a:off x="11191482" y="2826239"/>
            <a:ext cx="447921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A2171631-1052-7957-FF9A-64E7A7D90966}"/>
              </a:ext>
            </a:extLst>
          </p:cNvPr>
          <p:cNvSpPr/>
          <p:nvPr/>
        </p:nvSpPr>
        <p:spPr>
          <a:xfrm>
            <a:off x="8634750" y="949603"/>
            <a:ext cx="447921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3C804381-ACC6-95B9-E611-73E6BC3E5D13}"/>
              </a:ext>
            </a:extLst>
          </p:cNvPr>
          <p:cNvSpPr/>
          <p:nvPr/>
        </p:nvSpPr>
        <p:spPr>
          <a:xfrm>
            <a:off x="5692236" y="1124583"/>
            <a:ext cx="447921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402324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9C2CEC9-0CED-4D1C-B60E-F57B6E4F800B}"/>
              </a:ext>
            </a:extLst>
          </p:cNvPr>
          <p:cNvSpPr txBox="1"/>
          <p:nvPr/>
        </p:nvSpPr>
        <p:spPr>
          <a:xfrm>
            <a:off x="0" y="0"/>
            <a:ext cx="2337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3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D3A0D30-68ED-C4F6-E0DC-5453BAC5B9DC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436" t="10935" r="16047" b="10599"/>
          <a:stretch>
            <a:fillRect/>
          </a:stretch>
        </p:blipFill>
        <p:spPr>
          <a:xfrm>
            <a:off x="2024323" y="443159"/>
            <a:ext cx="3301775" cy="30219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8D37B77-097E-193D-3A03-6DD351D3B359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875" t="5017" r="7441" b="13896"/>
          <a:stretch>
            <a:fillRect/>
          </a:stretch>
        </p:blipFill>
        <p:spPr>
          <a:xfrm>
            <a:off x="6645897" y="724579"/>
            <a:ext cx="3044858" cy="26207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FD8F87F-8121-51B3-DF31-D960C10CCEFC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429" t="6030" r="14634" b="5715"/>
          <a:stretch>
            <a:fillRect/>
          </a:stretch>
        </p:blipFill>
        <p:spPr>
          <a:xfrm>
            <a:off x="4524867" y="3512691"/>
            <a:ext cx="3301776" cy="32460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8407516-3989-D5BF-1F07-469F471F4E59}"/>
              </a:ext>
            </a:extLst>
          </p:cNvPr>
          <p:cNvSpPr txBox="1"/>
          <p:nvPr/>
        </p:nvSpPr>
        <p:spPr>
          <a:xfrm>
            <a:off x="3675210" y="4349689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D239E51-727F-BC67-0275-1045D8413A95}"/>
              </a:ext>
            </a:extLst>
          </p:cNvPr>
          <p:cNvSpPr txBox="1"/>
          <p:nvPr/>
        </p:nvSpPr>
        <p:spPr>
          <a:xfrm>
            <a:off x="5952299" y="843616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I/II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B9072FA-2305-462F-A73E-99E3731A8869}"/>
              </a:ext>
            </a:extLst>
          </p:cNvPr>
          <p:cNvSpPr txBox="1"/>
          <p:nvPr/>
        </p:nvSpPr>
        <p:spPr>
          <a:xfrm>
            <a:off x="1530277" y="2034944"/>
            <a:ext cx="4940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4C4EC87B-DCCF-A619-E189-38FE45AB0247}"/>
              </a:ext>
            </a:extLst>
          </p:cNvPr>
          <p:cNvSpPr/>
          <p:nvPr/>
        </p:nvSpPr>
        <p:spPr>
          <a:xfrm>
            <a:off x="2176640" y="1859964"/>
            <a:ext cx="683457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7B60D4E-9B17-FD00-EFA7-B20C7B702EE8}"/>
              </a:ext>
            </a:extLst>
          </p:cNvPr>
          <p:cNvSpPr/>
          <p:nvPr/>
        </p:nvSpPr>
        <p:spPr>
          <a:xfrm>
            <a:off x="8041684" y="724579"/>
            <a:ext cx="683457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1F7F3D8-E46D-62DE-210A-5627545146E0}"/>
              </a:ext>
            </a:extLst>
          </p:cNvPr>
          <p:cNvSpPr/>
          <p:nvPr/>
        </p:nvSpPr>
        <p:spPr>
          <a:xfrm>
            <a:off x="4772154" y="4261339"/>
            <a:ext cx="683457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051958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80CD9D2-65B5-7240-EDA7-549A7C79B1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E991B86-F5F8-1BF5-F4AB-C445757D6670}"/>
              </a:ext>
            </a:extLst>
          </p:cNvPr>
          <p:cNvSpPr txBox="1"/>
          <p:nvPr/>
        </p:nvSpPr>
        <p:spPr>
          <a:xfrm>
            <a:off x="0" y="0"/>
            <a:ext cx="2337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3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9FA164E-8A28-3F80-4036-856B3E158A7D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017" t="1282" r="12476" b="5622"/>
          <a:stretch>
            <a:fillRect/>
          </a:stretch>
        </p:blipFill>
        <p:spPr>
          <a:xfrm>
            <a:off x="4701727" y="2260741"/>
            <a:ext cx="3202314" cy="31320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7187A08-3376-E42F-9BD6-F3B6155F739E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652" t="7009" r="15119" b="2450"/>
          <a:stretch>
            <a:fillRect/>
          </a:stretch>
        </p:blipFill>
        <p:spPr>
          <a:xfrm>
            <a:off x="1209396" y="803675"/>
            <a:ext cx="3198067" cy="33445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C26056E-4A5F-E55C-E051-23B07916E9D6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311" t="9898" r="11868" b="3683"/>
          <a:stretch>
            <a:fillRect/>
          </a:stretch>
        </p:blipFill>
        <p:spPr>
          <a:xfrm>
            <a:off x="8198306" y="140852"/>
            <a:ext cx="3619892" cy="335687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67C72E9-7AD6-56D5-E631-0F780AB74452}"/>
              </a:ext>
            </a:extLst>
          </p:cNvPr>
          <p:cNvSpPr txBox="1"/>
          <p:nvPr/>
        </p:nvSpPr>
        <p:spPr>
          <a:xfrm>
            <a:off x="10022564" y="3565139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I/II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51A9D61-C95B-B908-85FA-75D34C6E8B83}"/>
              </a:ext>
            </a:extLst>
          </p:cNvPr>
          <p:cNvSpPr txBox="1"/>
          <p:nvPr/>
        </p:nvSpPr>
        <p:spPr>
          <a:xfrm>
            <a:off x="5972505" y="1819291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35EB04E-9258-783C-2686-FA3BDB11FA55}"/>
              </a:ext>
            </a:extLst>
          </p:cNvPr>
          <p:cNvSpPr txBox="1"/>
          <p:nvPr/>
        </p:nvSpPr>
        <p:spPr>
          <a:xfrm>
            <a:off x="444105" y="3565139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I/II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55A86A9-423E-9FE4-BF79-9A1633453B7D}"/>
              </a:ext>
            </a:extLst>
          </p:cNvPr>
          <p:cNvSpPr/>
          <p:nvPr/>
        </p:nvSpPr>
        <p:spPr>
          <a:xfrm>
            <a:off x="2469824" y="3322751"/>
            <a:ext cx="946456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17ED522-2EAF-5472-9ECE-B23FD0E16707}"/>
              </a:ext>
            </a:extLst>
          </p:cNvPr>
          <p:cNvSpPr/>
          <p:nvPr/>
        </p:nvSpPr>
        <p:spPr>
          <a:xfrm>
            <a:off x="9687173" y="2702153"/>
            <a:ext cx="946456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B00D035-83F1-DFA7-9AC6-33CEEE5E77AC}"/>
              </a:ext>
            </a:extLst>
          </p:cNvPr>
          <p:cNvSpPr/>
          <p:nvPr/>
        </p:nvSpPr>
        <p:spPr>
          <a:xfrm>
            <a:off x="6511912" y="4240293"/>
            <a:ext cx="946456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9025427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BEF1AF-81D9-5A45-E519-18A155E1270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194AD6C-1B69-D45D-E9CB-0353A4A68913}"/>
              </a:ext>
            </a:extLst>
          </p:cNvPr>
          <p:cNvSpPr txBox="1"/>
          <p:nvPr/>
        </p:nvSpPr>
        <p:spPr>
          <a:xfrm>
            <a:off x="0" y="0"/>
            <a:ext cx="2337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3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8320307-16E2-05DD-99AF-BEC69FAEC698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299" t="6541" r="12137" b="-482"/>
          <a:stretch>
            <a:fillRect/>
          </a:stretch>
        </p:blipFill>
        <p:spPr>
          <a:xfrm>
            <a:off x="4477432" y="556028"/>
            <a:ext cx="3008524" cy="32945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BC55C5A-F1B1-29B4-C108-84B86B4D642D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769" t="3375" r="10889" b="2967"/>
          <a:stretch>
            <a:fillRect/>
          </a:stretch>
        </p:blipFill>
        <p:spPr>
          <a:xfrm>
            <a:off x="1073509" y="3958414"/>
            <a:ext cx="2457853" cy="27292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BD545A8-1DFA-A62D-7D88-0A01A5D4017A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627" t="7223" r="15517" b="218"/>
          <a:stretch>
            <a:fillRect/>
          </a:stretch>
        </p:blipFill>
        <p:spPr>
          <a:xfrm>
            <a:off x="967642" y="885522"/>
            <a:ext cx="2582944" cy="293674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6997919-AB68-461B-3607-337D7EF5C6F0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793" t="-840" r="8279" b="1046"/>
          <a:stretch>
            <a:fillRect/>
          </a:stretch>
        </p:blipFill>
        <p:spPr>
          <a:xfrm>
            <a:off x="8427915" y="295401"/>
            <a:ext cx="2796443" cy="27795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4879C39-ED72-81FD-8228-28679CFC37AB}"/>
              </a:ext>
            </a:extLst>
          </p:cNvPr>
          <p:cNvPicPr>
            <a:picLocks noChangeAspect="1"/>
          </p:cNvPicPr>
          <p:nvPr/>
        </p:nvPicPr>
        <p:blipFill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7" t="3338" r="8245" b="14016"/>
          <a:stretch>
            <a:fillRect/>
          </a:stretch>
        </p:blipFill>
        <p:spPr>
          <a:xfrm>
            <a:off x="4777937" y="4033528"/>
            <a:ext cx="2923764" cy="25789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FE149D4-CB86-8ADA-E785-E273965CAA21}"/>
              </a:ext>
            </a:extLst>
          </p:cNvPr>
          <p:cNvPicPr>
            <a:picLocks noChangeAspect="1"/>
          </p:cNvPicPr>
          <p:nvPr/>
        </p:nvPicPr>
        <p:blipFill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785" t="5607" r="8717" b="2643"/>
          <a:stretch>
            <a:fillRect/>
          </a:stretch>
        </p:blipFill>
        <p:spPr>
          <a:xfrm>
            <a:off x="8526594" y="3429000"/>
            <a:ext cx="3008524" cy="30126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91ECE12-8A18-3A05-4C2F-BBC7D6623F69}"/>
              </a:ext>
            </a:extLst>
          </p:cNvPr>
          <p:cNvSpPr txBox="1"/>
          <p:nvPr/>
        </p:nvSpPr>
        <p:spPr>
          <a:xfrm>
            <a:off x="4240027" y="6040362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D2AD958-1BBA-DBBC-98E1-A70DCF803B04}"/>
              </a:ext>
            </a:extLst>
          </p:cNvPr>
          <p:cNvSpPr txBox="1"/>
          <p:nvPr/>
        </p:nvSpPr>
        <p:spPr>
          <a:xfrm>
            <a:off x="7844217" y="5323014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43E244F-151C-5623-6D1D-A9F993D328DA}"/>
              </a:ext>
            </a:extLst>
          </p:cNvPr>
          <p:cNvSpPr txBox="1"/>
          <p:nvPr/>
        </p:nvSpPr>
        <p:spPr>
          <a:xfrm>
            <a:off x="464578" y="6057515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S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D12A9B2-8260-D1E3-0D88-6F35CEE7CCE6}"/>
              </a:ext>
            </a:extLst>
          </p:cNvPr>
          <p:cNvSpPr txBox="1"/>
          <p:nvPr/>
        </p:nvSpPr>
        <p:spPr>
          <a:xfrm>
            <a:off x="7936390" y="1815963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T-S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6FC23EB-3A42-BB69-5D1D-410F000C1E0F}"/>
              </a:ext>
            </a:extLst>
          </p:cNvPr>
          <p:cNvSpPr txBox="1"/>
          <p:nvPr/>
        </p:nvSpPr>
        <p:spPr>
          <a:xfrm>
            <a:off x="366794" y="1991904"/>
            <a:ext cx="5741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TO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5500DEE-57A5-1D1B-2A2C-554389B768F0}"/>
              </a:ext>
            </a:extLst>
          </p:cNvPr>
          <p:cNvSpPr txBox="1"/>
          <p:nvPr/>
        </p:nvSpPr>
        <p:spPr>
          <a:xfrm>
            <a:off x="3757360" y="1554353"/>
            <a:ext cx="7056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mTOR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557FB062-685F-4731-235F-D8DBDA5757E9}"/>
              </a:ext>
            </a:extLst>
          </p:cNvPr>
          <p:cNvSpPr/>
          <p:nvPr/>
        </p:nvSpPr>
        <p:spPr>
          <a:xfrm>
            <a:off x="1487425" y="1903554"/>
            <a:ext cx="624179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C0D706A-C9C6-77A7-7DD8-6215A740E5FC}"/>
              </a:ext>
            </a:extLst>
          </p:cNvPr>
          <p:cNvSpPr/>
          <p:nvPr/>
        </p:nvSpPr>
        <p:spPr>
          <a:xfrm>
            <a:off x="6296380" y="1447149"/>
            <a:ext cx="624179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3A99DF73-8293-9C77-CF37-EF889D36B51B}"/>
              </a:ext>
            </a:extLst>
          </p:cNvPr>
          <p:cNvSpPr/>
          <p:nvPr/>
        </p:nvSpPr>
        <p:spPr>
          <a:xfrm>
            <a:off x="10241456" y="1646790"/>
            <a:ext cx="624179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8520F47-C34F-E1C9-2E68-1A01EFD36949}"/>
              </a:ext>
            </a:extLst>
          </p:cNvPr>
          <p:cNvSpPr/>
          <p:nvPr/>
        </p:nvSpPr>
        <p:spPr>
          <a:xfrm>
            <a:off x="1549942" y="5964729"/>
            <a:ext cx="624179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6FB0A757-5290-2E76-8BEF-E694B0FBA2CB}"/>
              </a:ext>
            </a:extLst>
          </p:cNvPr>
          <p:cNvSpPr/>
          <p:nvPr/>
        </p:nvSpPr>
        <p:spPr>
          <a:xfrm>
            <a:off x="1702342" y="6117129"/>
            <a:ext cx="624179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0A2B76D4-6381-F3CB-87C2-EEC446F09268}"/>
              </a:ext>
            </a:extLst>
          </p:cNvPr>
          <p:cNvSpPr/>
          <p:nvPr/>
        </p:nvSpPr>
        <p:spPr>
          <a:xfrm>
            <a:off x="5227640" y="5882535"/>
            <a:ext cx="624179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E874323-2EAC-AEE0-84E1-C646A445A179}"/>
              </a:ext>
            </a:extLst>
          </p:cNvPr>
          <p:cNvSpPr/>
          <p:nvPr/>
        </p:nvSpPr>
        <p:spPr>
          <a:xfrm>
            <a:off x="10450418" y="5453819"/>
            <a:ext cx="624179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3127191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202177B-6D48-1FD7-4DED-AE65617F5A2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07E76F5-2E2F-F466-3838-11B715D439F9}"/>
              </a:ext>
            </a:extLst>
          </p:cNvPr>
          <p:cNvSpPr txBox="1"/>
          <p:nvPr/>
        </p:nvSpPr>
        <p:spPr>
          <a:xfrm>
            <a:off x="0" y="0"/>
            <a:ext cx="23437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3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035B927-0087-4D5B-FFCA-B80D828C0087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649" t="5394" r="11480" b="7949"/>
          <a:stretch>
            <a:fillRect/>
          </a:stretch>
        </p:blipFill>
        <p:spPr>
          <a:xfrm>
            <a:off x="5523886" y="3524005"/>
            <a:ext cx="3176833" cy="29902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CC6265C-DD44-A4DF-E0AB-BDCE97930BDB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195" t="4529" r="11441" b="9933"/>
          <a:stretch>
            <a:fillRect/>
          </a:stretch>
        </p:blipFill>
        <p:spPr>
          <a:xfrm>
            <a:off x="1376314" y="621763"/>
            <a:ext cx="3289954" cy="29994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A54DE07-13AA-E60A-A904-58689897723D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882" t="7612" r="9708" b="10781"/>
          <a:stretch>
            <a:fillRect/>
          </a:stretch>
        </p:blipFill>
        <p:spPr>
          <a:xfrm>
            <a:off x="6533505" y="0"/>
            <a:ext cx="3630541" cy="32796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85FA515-3304-8CD3-7C35-15965127F559}"/>
              </a:ext>
            </a:extLst>
          </p:cNvPr>
          <p:cNvSpPr txBox="1"/>
          <p:nvPr/>
        </p:nvSpPr>
        <p:spPr>
          <a:xfrm>
            <a:off x="4764698" y="5449993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41AB2CD-18D1-E634-29E5-CEF98B77CD63}"/>
              </a:ext>
            </a:extLst>
          </p:cNvPr>
          <p:cNvSpPr txBox="1"/>
          <p:nvPr/>
        </p:nvSpPr>
        <p:spPr>
          <a:xfrm>
            <a:off x="5808100" y="2866677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7F9D825-BCFB-56C4-178E-62DE8B7B3E41}"/>
              </a:ext>
            </a:extLst>
          </p:cNvPr>
          <p:cNvSpPr txBox="1"/>
          <p:nvPr/>
        </p:nvSpPr>
        <p:spPr>
          <a:xfrm>
            <a:off x="717877" y="3270089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D00CECAF-408E-955B-ADDC-A6B4BD00ADBA}"/>
              </a:ext>
            </a:extLst>
          </p:cNvPr>
          <p:cNvSpPr/>
          <p:nvPr/>
        </p:nvSpPr>
        <p:spPr>
          <a:xfrm>
            <a:off x="1866507" y="3120593"/>
            <a:ext cx="789365" cy="349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E97C5B4-7D22-CE85-5E5C-35D4A2E8CDD7}"/>
              </a:ext>
            </a:extLst>
          </p:cNvPr>
          <p:cNvSpPr/>
          <p:nvPr/>
        </p:nvSpPr>
        <p:spPr>
          <a:xfrm>
            <a:off x="6845594" y="2714920"/>
            <a:ext cx="1015879" cy="4323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D3FEAF2-E787-CA3D-30AA-C53AEF983AAA}"/>
              </a:ext>
            </a:extLst>
          </p:cNvPr>
          <p:cNvSpPr/>
          <p:nvPr/>
        </p:nvSpPr>
        <p:spPr>
          <a:xfrm>
            <a:off x="6383899" y="5429840"/>
            <a:ext cx="838123" cy="3487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7231905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EFDA26-3F80-E27E-944B-8DF83103DD7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8B5CC43-60DF-DBAA-CAE9-9BCD477EFD44}"/>
              </a:ext>
            </a:extLst>
          </p:cNvPr>
          <p:cNvSpPr txBox="1"/>
          <p:nvPr/>
        </p:nvSpPr>
        <p:spPr>
          <a:xfrm>
            <a:off x="0" y="0"/>
            <a:ext cx="2310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3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2BE3B3B-E841-C046-3F23-50985BAAF959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590" t="6160" r="19871" b="11360"/>
          <a:stretch>
            <a:fillRect/>
          </a:stretch>
        </p:blipFill>
        <p:spPr>
          <a:xfrm>
            <a:off x="7381191" y="742508"/>
            <a:ext cx="3638744" cy="43363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0D01CD6-72AD-5CCB-57B3-11E3C6C42827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799" t="12898" r="11300" b="15623"/>
          <a:stretch>
            <a:fillRect/>
          </a:stretch>
        </p:blipFill>
        <p:spPr>
          <a:xfrm>
            <a:off x="1846055" y="1534087"/>
            <a:ext cx="3638745" cy="27531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EBABE0F-D062-7417-F615-32BCB2541D03}"/>
              </a:ext>
            </a:extLst>
          </p:cNvPr>
          <p:cNvSpPr txBox="1"/>
          <p:nvPr/>
        </p:nvSpPr>
        <p:spPr>
          <a:xfrm>
            <a:off x="6640503" y="3633973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FB1A788-5E2C-D708-42C8-8A9B7DBF9FC3}"/>
              </a:ext>
            </a:extLst>
          </p:cNvPr>
          <p:cNvSpPr txBox="1"/>
          <p:nvPr/>
        </p:nvSpPr>
        <p:spPr>
          <a:xfrm>
            <a:off x="1155060" y="2910673"/>
            <a:ext cx="5453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I/II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5182486-2C7D-0355-65FB-8567012F9917}"/>
              </a:ext>
            </a:extLst>
          </p:cNvPr>
          <p:cNvSpPr/>
          <p:nvPr/>
        </p:nvSpPr>
        <p:spPr>
          <a:xfrm>
            <a:off x="2990030" y="2821431"/>
            <a:ext cx="1015879" cy="4323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ABF8690-81D3-9584-5D73-3356D631F90D}"/>
              </a:ext>
            </a:extLst>
          </p:cNvPr>
          <p:cNvSpPr/>
          <p:nvPr/>
        </p:nvSpPr>
        <p:spPr>
          <a:xfrm>
            <a:off x="8391242" y="3490380"/>
            <a:ext cx="1157630" cy="4323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5307987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B0C65ED-8B05-0565-4B1B-565D43B65DB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AA8CEE7-EAF8-3F3D-22E8-229C5B427BF7}"/>
              </a:ext>
            </a:extLst>
          </p:cNvPr>
          <p:cNvSpPr txBox="1"/>
          <p:nvPr/>
        </p:nvSpPr>
        <p:spPr>
          <a:xfrm>
            <a:off x="0" y="0"/>
            <a:ext cx="2310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3F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55E0101-BE48-F7DD-C761-641516AB1972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730" t="8986" r="11005" b="2398"/>
          <a:stretch>
            <a:fillRect/>
          </a:stretch>
        </p:blipFill>
        <p:spPr>
          <a:xfrm>
            <a:off x="1287006" y="1072657"/>
            <a:ext cx="2567232" cy="25912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1DC6829-ADD5-76C6-ACF6-92924424289E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640" t="17083" r="12514" b="7075"/>
          <a:stretch>
            <a:fillRect/>
          </a:stretch>
        </p:blipFill>
        <p:spPr>
          <a:xfrm>
            <a:off x="1219679" y="3987538"/>
            <a:ext cx="2472825" cy="21774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5657BF8-DEE4-E050-5A3D-1CBD749E3DE4}"/>
              </a:ext>
            </a:extLst>
          </p:cNvPr>
          <p:cNvSpPr txBox="1"/>
          <p:nvPr/>
        </p:nvSpPr>
        <p:spPr>
          <a:xfrm>
            <a:off x="394453" y="4232787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E4A1C9F-B34B-EADD-5D2E-8E3DCCEBC8E6}"/>
              </a:ext>
            </a:extLst>
          </p:cNvPr>
          <p:cNvSpPr txBox="1"/>
          <p:nvPr/>
        </p:nvSpPr>
        <p:spPr>
          <a:xfrm>
            <a:off x="759297" y="1541778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8C5D71D-305E-5035-8072-B77B41C9A126}"/>
              </a:ext>
            </a:extLst>
          </p:cNvPr>
          <p:cNvSpPr txBox="1"/>
          <p:nvPr/>
        </p:nvSpPr>
        <p:spPr>
          <a:xfrm>
            <a:off x="5455313" y="226974"/>
            <a:ext cx="5453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I/I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F089FD8-84AC-DEF0-38FB-D8F1D24EA135}"/>
              </a:ext>
            </a:extLst>
          </p:cNvPr>
          <p:cNvSpPr txBox="1"/>
          <p:nvPr/>
        </p:nvSpPr>
        <p:spPr>
          <a:xfrm>
            <a:off x="5573497" y="6466094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3AE773D-9DCF-F8BF-CCD3-5B209C745DA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329" t="3682" r="16658" b="1334"/>
          <a:stretch>
            <a:fillRect/>
          </a:stretch>
        </p:blipFill>
        <p:spPr>
          <a:xfrm>
            <a:off x="6357611" y="3663882"/>
            <a:ext cx="2472825" cy="30561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AF6CA4B-988C-6B73-B84D-3E8005A8A19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358" t="10204" r="18593" b="1274"/>
          <a:stretch>
            <a:fillRect/>
          </a:stretch>
        </p:blipFill>
        <p:spPr>
          <a:xfrm>
            <a:off x="6096000" y="34352"/>
            <a:ext cx="2935670" cy="35424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CCED8EAB-3DCF-ED06-D541-5168F5F5670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613" t="2324" r="18763" b="431"/>
          <a:stretch>
            <a:fillRect/>
          </a:stretch>
        </p:blipFill>
        <p:spPr>
          <a:xfrm>
            <a:off x="9222361" y="17808"/>
            <a:ext cx="2854771" cy="374971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E00AA5B1-F5DE-E489-5A45-2CD8DAFF09FB}"/>
              </a:ext>
            </a:extLst>
          </p:cNvPr>
          <p:cNvSpPr/>
          <p:nvPr/>
        </p:nvSpPr>
        <p:spPr>
          <a:xfrm>
            <a:off x="2456091" y="1398879"/>
            <a:ext cx="617047" cy="4323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AB35AA89-E830-CD43-6DB3-A2EEA1928E5E}"/>
              </a:ext>
            </a:extLst>
          </p:cNvPr>
          <p:cNvSpPr/>
          <p:nvPr/>
        </p:nvSpPr>
        <p:spPr>
          <a:xfrm>
            <a:off x="1645939" y="4143545"/>
            <a:ext cx="617047" cy="4323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F7C1C37-6F3C-2328-2B4C-7DA6B3869491}"/>
              </a:ext>
            </a:extLst>
          </p:cNvPr>
          <p:cNvSpPr/>
          <p:nvPr/>
        </p:nvSpPr>
        <p:spPr>
          <a:xfrm>
            <a:off x="6558875" y="76894"/>
            <a:ext cx="1802700" cy="4323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52F288CD-B5D5-16E9-E00A-84D5566487A7}"/>
              </a:ext>
            </a:extLst>
          </p:cNvPr>
          <p:cNvSpPr/>
          <p:nvPr/>
        </p:nvSpPr>
        <p:spPr>
          <a:xfrm>
            <a:off x="9603785" y="353932"/>
            <a:ext cx="1802700" cy="4323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2498CEC-2810-FFFB-0CAA-118141D53710}"/>
              </a:ext>
            </a:extLst>
          </p:cNvPr>
          <p:cNvSpPr/>
          <p:nvPr/>
        </p:nvSpPr>
        <p:spPr>
          <a:xfrm>
            <a:off x="6662485" y="6429130"/>
            <a:ext cx="1802700" cy="2908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4644223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A91F96A-634D-1F54-578D-F54221AB22C2}"/>
              </a:ext>
            </a:extLst>
          </p:cNvPr>
          <p:cNvSpPr txBox="1"/>
          <p:nvPr/>
        </p:nvSpPr>
        <p:spPr>
          <a:xfrm>
            <a:off x="94268" y="75414"/>
            <a:ext cx="23453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3G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029A892-EFBA-C037-9FC3-C8FF2EFDA1B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820" t="25189" r="21567" b="32260"/>
          <a:stretch>
            <a:fillRect/>
          </a:stretch>
        </p:blipFill>
        <p:spPr>
          <a:xfrm>
            <a:off x="1600700" y="1861962"/>
            <a:ext cx="3789575" cy="25923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44B37BD-AC35-DE4E-656E-9E703455960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452" t="9773" r="22708" b="3236"/>
          <a:stretch>
            <a:fillRect/>
          </a:stretch>
        </p:blipFill>
        <p:spPr>
          <a:xfrm>
            <a:off x="7129650" y="155712"/>
            <a:ext cx="4270343" cy="60614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8BC4443-EF54-E589-97B4-DF2A83A0C9B3}"/>
              </a:ext>
            </a:extLst>
          </p:cNvPr>
          <p:cNvSpPr txBox="1"/>
          <p:nvPr/>
        </p:nvSpPr>
        <p:spPr>
          <a:xfrm>
            <a:off x="6391638" y="3564574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E9FAE14-EF83-D17C-D0E0-E31E0493A75A}"/>
              </a:ext>
            </a:extLst>
          </p:cNvPr>
          <p:cNvSpPr txBox="1"/>
          <p:nvPr/>
        </p:nvSpPr>
        <p:spPr>
          <a:xfrm>
            <a:off x="792007" y="3031190"/>
            <a:ext cx="5453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I/II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42627B8-B90A-D92A-D700-3CEF961D5A75}"/>
              </a:ext>
            </a:extLst>
          </p:cNvPr>
          <p:cNvSpPr/>
          <p:nvPr/>
        </p:nvSpPr>
        <p:spPr>
          <a:xfrm>
            <a:off x="2714920" y="3085848"/>
            <a:ext cx="1785672" cy="4787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6AECA0E-CD23-95DF-481E-42B2C66442DD}"/>
              </a:ext>
            </a:extLst>
          </p:cNvPr>
          <p:cNvSpPr/>
          <p:nvPr/>
        </p:nvSpPr>
        <p:spPr>
          <a:xfrm>
            <a:off x="8371984" y="3429000"/>
            <a:ext cx="2063487" cy="4787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5477353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E17470B-5C04-021B-7E53-E4A8649819E6}"/>
              </a:ext>
            </a:extLst>
          </p:cNvPr>
          <p:cNvSpPr txBox="1"/>
          <p:nvPr/>
        </p:nvSpPr>
        <p:spPr>
          <a:xfrm>
            <a:off x="94268" y="75414"/>
            <a:ext cx="23453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3H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646106B-352A-9AC1-6300-41DA3D56E43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9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657" t="23717" r="19634" b="41248"/>
          <a:stretch>
            <a:fillRect/>
          </a:stretch>
        </p:blipFill>
        <p:spPr>
          <a:xfrm>
            <a:off x="5273026" y="818985"/>
            <a:ext cx="5293895" cy="25017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5880883-3EF0-871E-CBD7-FFD73CC38BB2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bg1">
                <a:lumMod val="8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852" t="16836" r="20298" b="14114"/>
          <a:stretch>
            <a:fillRect/>
          </a:stretch>
        </p:blipFill>
        <p:spPr>
          <a:xfrm>
            <a:off x="5592278" y="3429000"/>
            <a:ext cx="3339967" cy="33720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0D6D58B-DAB3-E0B2-C27F-966EC21F9EDE}"/>
              </a:ext>
            </a:extLst>
          </p:cNvPr>
          <p:cNvSpPr txBox="1"/>
          <p:nvPr/>
        </p:nvSpPr>
        <p:spPr>
          <a:xfrm>
            <a:off x="4677991" y="5265538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5B8C768-D837-833A-0AA9-486A8E47117C}"/>
              </a:ext>
            </a:extLst>
          </p:cNvPr>
          <p:cNvSpPr txBox="1"/>
          <p:nvPr/>
        </p:nvSpPr>
        <p:spPr>
          <a:xfrm>
            <a:off x="10592223" y="2126150"/>
            <a:ext cx="73609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p-Beclin1 </a:t>
            </a:r>
          </a:p>
          <a:p>
            <a:pPr algn="ctr"/>
            <a:r>
              <a:rPr lang="en-US" sz="1050" b="1" dirty="0"/>
              <a:t>(Ser15)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02F35AC-E7F6-1D74-A774-B728478C66C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6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27" t="2279" r="28576" b="22482"/>
          <a:stretch>
            <a:fillRect/>
          </a:stretch>
        </p:blipFill>
        <p:spPr>
          <a:xfrm rot="16200000" flipV="1">
            <a:off x="1087131" y="663916"/>
            <a:ext cx="3029827" cy="333996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ED4C7A1-B7B0-D102-A61B-4C27B0BA1453}"/>
              </a:ext>
            </a:extLst>
          </p:cNvPr>
          <p:cNvSpPr txBox="1"/>
          <p:nvPr/>
        </p:nvSpPr>
        <p:spPr>
          <a:xfrm>
            <a:off x="335077" y="2541648"/>
            <a:ext cx="62228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Beclin1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574286C-F8B4-BD85-C44E-2EC0218393FD}"/>
              </a:ext>
            </a:extLst>
          </p:cNvPr>
          <p:cNvSpPr/>
          <p:nvPr/>
        </p:nvSpPr>
        <p:spPr>
          <a:xfrm>
            <a:off x="2714920" y="2189880"/>
            <a:ext cx="740549" cy="4787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275004B-1CC1-E387-9CF8-5704C11C41CC}"/>
              </a:ext>
            </a:extLst>
          </p:cNvPr>
          <p:cNvSpPr/>
          <p:nvPr/>
        </p:nvSpPr>
        <p:spPr>
          <a:xfrm>
            <a:off x="9076623" y="2165242"/>
            <a:ext cx="1020278" cy="4787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E36453C-9E04-AD07-FDDC-48E8AE4D7039}"/>
              </a:ext>
            </a:extLst>
          </p:cNvPr>
          <p:cNvSpPr/>
          <p:nvPr/>
        </p:nvSpPr>
        <p:spPr>
          <a:xfrm>
            <a:off x="7409834" y="5265538"/>
            <a:ext cx="839017" cy="4342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1402879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5C95A5A-8038-4DB2-AD54-D00B4B1CFEB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822" t="15737" r="15931" b="5252"/>
          <a:stretch/>
        </p:blipFill>
        <p:spPr>
          <a:xfrm>
            <a:off x="1470374" y="1310764"/>
            <a:ext cx="2921703" cy="27406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FDCDA01-C806-41D8-BC10-2F78B0721190}"/>
              </a:ext>
            </a:extLst>
          </p:cNvPr>
          <p:cNvSpPr txBox="1"/>
          <p:nvPr/>
        </p:nvSpPr>
        <p:spPr>
          <a:xfrm>
            <a:off x="2701035" y="805066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7BC4D56-A473-4EC9-A0D9-4AFA3E9D623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504" t="10083" r="17117" b="10086"/>
          <a:stretch/>
        </p:blipFill>
        <p:spPr>
          <a:xfrm>
            <a:off x="6958518" y="805066"/>
            <a:ext cx="3441627" cy="34491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3E85082-06CE-4D9C-9B3A-9CE56674F746}"/>
              </a:ext>
            </a:extLst>
          </p:cNvPr>
          <p:cNvSpPr txBox="1"/>
          <p:nvPr/>
        </p:nvSpPr>
        <p:spPr>
          <a:xfrm>
            <a:off x="5664556" y="2379898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1672747-2632-4FB5-8F46-3E7AB3232237}"/>
              </a:ext>
            </a:extLst>
          </p:cNvPr>
          <p:cNvSpPr/>
          <p:nvPr/>
        </p:nvSpPr>
        <p:spPr>
          <a:xfrm>
            <a:off x="2445780" y="3025606"/>
            <a:ext cx="1158858" cy="4033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79C0579-6456-431B-98EB-C7B5A4B4E2A6}"/>
              </a:ext>
            </a:extLst>
          </p:cNvPr>
          <p:cNvSpPr/>
          <p:nvPr/>
        </p:nvSpPr>
        <p:spPr>
          <a:xfrm>
            <a:off x="7943273" y="2373745"/>
            <a:ext cx="1660383" cy="5201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E5FD534-AB9D-6D22-0248-A161D1FD7C3C}"/>
              </a:ext>
            </a:extLst>
          </p:cNvPr>
          <p:cNvSpPr txBox="1"/>
          <p:nvPr/>
        </p:nvSpPr>
        <p:spPr>
          <a:xfrm>
            <a:off x="94268" y="75414"/>
            <a:ext cx="2337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4A</a:t>
            </a:r>
          </a:p>
        </p:txBody>
      </p:sp>
    </p:spTree>
    <p:extLst>
      <p:ext uri="{BB962C8B-B14F-4D97-AF65-F5344CB8AC3E}">
        <p14:creationId xmlns:p14="http://schemas.microsoft.com/office/powerpoint/2010/main" val="22713895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49B9469-4E77-18A4-6569-32A819E9FA9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073" t="15607" r="7868" b="40097"/>
          <a:stretch/>
        </p:blipFill>
        <p:spPr>
          <a:xfrm>
            <a:off x="1952244" y="968092"/>
            <a:ext cx="3342132" cy="16196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B27AE4E-6D8C-200F-678F-811603F6679E}"/>
              </a:ext>
            </a:extLst>
          </p:cNvPr>
          <p:cNvSpPr txBox="1"/>
          <p:nvPr/>
        </p:nvSpPr>
        <p:spPr>
          <a:xfrm>
            <a:off x="0" y="0"/>
            <a:ext cx="1055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1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BD81E17-937F-B93A-CD6D-E24A227365D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828" t="19548" r="15653" b="41952"/>
          <a:stretch/>
        </p:blipFill>
        <p:spPr>
          <a:xfrm>
            <a:off x="8392801" y="2961472"/>
            <a:ext cx="3342132" cy="17351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007AED5-0273-35F7-521E-AC5385C1E51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704" t="16219" r="7772" b="30362"/>
          <a:stretch/>
        </p:blipFill>
        <p:spPr>
          <a:xfrm>
            <a:off x="8373260" y="398633"/>
            <a:ext cx="3342132" cy="201957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67A5A2A-2268-4D5A-5C84-05DF619EB6F7}"/>
              </a:ext>
            </a:extLst>
          </p:cNvPr>
          <p:cNvSpPr txBox="1"/>
          <p:nvPr/>
        </p:nvSpPr>
        <p:spPr>
          <a:xfrm>
            <a:off x="1215129" y="1777921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B0CA48B-3A81-D4E7-0647-34324F83E32F}"/>
              </a:ext>
            </a:extLst>
          </p:cNvPr>
          <p:cNvSpPr txBox="1"/>
          <p:nvPr/>
        </p:nvSpPr>
        <p:spPr>
          <a:xfrm>
            <a:off x="7603940" y="968092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777493C-367F-1F42-3AAB-54A57E6D7884}"/>
              </a:ext>
            </a:extLst>
          </p:cNvPr>
          <p:cNvSpPr txBox="1"/>
          <p:nvPr/>
        </p:nvSpPr>
        <p:spPr>
          <a:xfrm>
            <a:off x="7584704" y="3766820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pic>
        <p:nvPicPr>
          <p:cNvPr id="12" name="Picture 2" descr="C:\Users\EL-Huda\OneDrive - Faculty of Pharmacy (Kafr Elshiekh University)\Lab work\Dr. Senthil lab\Autac -mcl1\wb\autophagy inhbition\lc3bb.tif">
            <a:extLst>
              <a:ext uri="{FF2B5EF4-FFF2-40B4-BE49-F238E27FC236}">
                <a16:creationId xmlns:a16="http://schemas.microsoft.com/office/drawing/2014/main" id="{281529BE-B66B-1F06-66E9-CEA1A685E0D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310" t="13985" r="12545" b="27681"/>
          <a:stretch/>
        </p:blipFill>
        <p:spPr bwMode="auto">
          <a:xfrm>
            <a:off x="1982024" y="2961472"/>
            <a:ext cx="3342132" cy="252167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56EBA12-A431-20D8-78C4-A972E176B8A4}"/>
              </a:ext>
            </a:extLst>
          </p:cNvPr>
          <p:cNvSpPr txBox="1"/>
          <p:nvPr/>
        </p:nvSpPr>
        <p:spPr>
          <a:xfrm>
            <a:off x="1215129" y="3806952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B29A49C-D3CB-30F9-2CC3-95C3051E223D}"/>
              </a:ext>
            </a:extLst>
          </p:cNvPr>
          <p:cNvSpPr txBox="1"/>
          <p:nvPr/>
        </p:nvSpPr>
        <p:spPr>
          <a:xfrm>
            <a:off x="852619" y="4083812"/>
            <a:ext cx="1069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ow exposur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77BFFC0-C505-3543-78BA-03B0D7790EBC}"/>
              </a:ext>
            </a:extLst>
          </p:cNvPr>
          <p:cNvSpPr txBox="1"/>
          <p:nvPr/>
        </p:nvSpPr>
        <p:spPr>
          <a:xfrm>
            <a:off x="7228715" y="1500922"/>
            <a:ext cx="10990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High exposure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9467240-5F3B-1CF7-9E06-DA5C056C723C}"/>
              </a:ext>
            </a:extLst>
          </p:cNvPr>
          <p:cNvSpPr/>
          <p:nvPr/>
        </p:nvSpPr>
        <p:spPr>
          <a:xfrm>
            <a:off x="2824359" y="1515794"/>
            <a:ext cx="1570982" cy="5242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7606636-920B-40A8-D39B-C5871ABFC115}"/>
              </a:ext>
            </a:extLst>
          </p:cNvPr>
          <p:cNvSpPr/>
          <p:nvPr/>
        </p:nvSpPr>
        <p:spPr>
          <a:xfrm>
            <a:off x="2695804" y="4326880"/>
            <a:ext cx="1570982" cy="5242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195B0F9-6401-6968-0A9B-BFD0CD8B629C}"/>
              </a:ext>
            </a:extLst>
          </p:cNvPr>
          <p:cNvSpPr/>
          <p:nvPr/>
        </p:nvSpPr>
        <p:spPr>
          <a:xfrm>
            <a:off x="9120988" y="1455202"/>
            <a:ext cx="1570982" cy="5242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A44212F-671F-4160-3F82-322BDDB40640}"/>
              </a:ext>
            </a:extLst>
          </p:cNvPr>
          <p:cNvSpPr/>
          <p:nvPr/>
        </p:nvSpPr>
        <p:spPr>
          <a:xfrm>
            <a:off x="9120988" y="3369524"/>
            <a:ext cx="1570982" cy="5242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83559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F76B107-46E2-5CE4-D8A8-D969DBEFBBD6}"/>
              </a:ext>
            </a:extLst>
          </p:cNvPr>
          <p:cNvSpPr txBox="1"/>
          <p:nvPr/>
        </p:nvSpPr>
        <p:spPr>
          <a:xfrm>
            <a:off x="0" y="0"/>
            <a:ext cx="232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4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E42B490-B2AF-E303-E2BE-FA602BD85CB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964" t="41260" r="21158" b="37540"/>
          <a:stretch/>
        </p:blipFill>
        <p:spPr>
          <a:xfrm>
            <a:off x="1085123" y="3265228"/>
            <a:ext cx="4521683" cy="16836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87A1708-743F-5FEA-69E9-8FB2C436DE9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485" t="28182" r="5673" b="27640"/>
          <a:stretch/>
        </p:blipFill>
        <p:spPr>
          <a:xfrm>
            <a:off x="6601968" y="724245"/>
            <a:ext cx="5010470" cy="22294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AB728BF-49BA-2305-81FB-4B7D4B4DA4B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766" t="19909" r="12313" b="27062"/>
          <a:stretch/>
        </p:blipFill>
        <p:spPr>
          <a:xfrm>
            <a:off x="7306474" y="3434971"/>
            <a:ext cx="4386582" cy="27267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D5C1ADA-19B7-61EA-07B6-EBF88E8FA85A}"/>
              </a:ext>
            </a:extLst>
          </p:cNvPr>
          <p:cNvSpPr txBox="1"/>
          <p:nvPr/>
        </p:nvSpPr>
        <p:spPr>
          <a:xfrm>
            <a:off x="433222" y="3980097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D4F82C6-8C62-3FEA-F86C-63787794A582}"/>
              </a:ext>
            </a:extLst>
          </p:cNvPr>
          <p:cNvSpPr txBox="1"/>
          <p:nvPr/>
        </p:nvSpPr>
        <p:spPr>
          <a:xfrm>
            <a:off x="5799971" y="1585056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8622444-D677-18AE-4596-ED3766826EA8}"/>
              </a:ext>
            </a:extLst>
          </p:cNvPr>
          <p:cNvSpPr txBox="1"/>
          <p:nvPr/>
        </p:nvSpPr>
        <p:spPr>
          <a:xfrm>
            <a:off x="6345729" y="4535036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A4CBDAAE-6667-ECA8-6C0F-6937DB6EB5B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078" t="39642" r="13441" b="34487"/>
          <a:stretch/>
        </p:blipFill>
        <p:spPr>
          <a:xfrm>
            <a:off x="1039351" y="1250328"/>
            <a:ext cx="4534422" cy="14654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0CE4DA6-8BDD-8C8F-91CE-BEF801634076}"/>
              </a:ext>
            </a:extLst>
          </p:cNvPr>
          <p:cNvSpPr txBox="1"/>
          <p:nvPr/>
        </p:nvSpPr>
        <p:spPr>
          <a:xfrm>
            <a:off x="498944" y="1552788"/>
            <a:ext cx="39466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p62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B17BFDB-0693-D8C7-8255-7A87B282CA90}"/>
              </a:ext>
            </a:extLst>
          </p:cNvPr>
          <p:cNvSpPr/>
          <p:nvPr/>
        </p:nvSpPr>
        <p:spPr>
          <a:xfrm>
            <a:off x="1525666" y="3822533"/>
            <a:ext cx="1308974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AFA9A43-D52B-C787-89DB-ECF73EE7CAEC}"/>
              </a:ext>
            </a:extLst>
          </p:cNvPr>
          <p:cNvSpPr/>
          <p:nvPr/>
        </p:nvSpPr>
        <p:spPr>
          <a:xfrm>
            <a:off x="3890914" y="1722444"/>
            <a:ext cx="1308974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74BCFFA-D8DC-A5BF-6391-28C0CF8F77E7}"/>
              </a:ext>
            </a:extLst>
          </p:cNvPr>
          <p:cNvSpPr/>
          <p:nvPr/>
        </p:nvSpPr>
        <p:spPr>
          <a:xfrm>
            <a:off x="7475362" y="1600964"/>
            <a:ext cx="1308974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E47CEB2-1FA6-E863-1146-F3D74CF2E372}"/>
              </a:ext>
            </a:extLst>
          </p:cNvPr>
          <p:cNvSpPr/>
          <p:nvPr/>
        </p:nvSpPr>
        <p:spPr>
          <a:xfrm>
            <a:off x="9852767" y="3937891"/>
            <a:ext cx="1308974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127B8E7-8A9F-39D7-D44D-7E47DBAC7D66}"/>
              </a:ext>
            </a:extLst>
          </p:cNvPr>
          <p:cNvSpPr txBox="1"/>
          <p:nvPr/>
        </p:nvSpPr>
        <p:spPr>
          <a:xfrm>
            <a:off x="5672399" y="-65082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U266B1</a:t>
            </a:r>
            <a:endParaRPr lang="en-US" sz="1400" b="1" i="0" baseline="30000" dirty="0">
              <a:solidFill>
                <a:srgbClr val="4A4A4A"/>
              </a:solidFill>
              <a:effectLst/>
              <a:latin typeface="brandon_grotesque_bold"/>
            </a:endParaRPr>
          </a:p>
        </p:txBody>
      </p:sp>
    </p:spTree>
    <p:extLst>
      <p:ext uri="{BB962C8B-B14F-4D97-AF65-F5344CB8AC3E}">
        <p14:creationId xmlns:p14="http://schemas.microsoft.com/office/powerpoint/2010/main" val="2521586895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F6D7D40-EE01-524C-FBE1-1B7CE8AD5C4F}"/>
              </a:ext>
            </a:extLst>
          </p:cNvPr>
          <p:cNvSpPr txBox="1"/>
          <p:nvPr/>
        </p:nvSpPr>
        <p:spPr>
          <a:xfrm>
            <a:off x="0" y="0"/>
            <a:ext cx="232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5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63CB945-F6D8-0DCD-50B7-364B74689AA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182" t="17326" r="24865" b="23885"/>
          <a:stretch>
            <a:fillRect/>
          </a:stretch>
        </p:blipFill>
        <p:spPr>
          <a:xfrm>
            <a:off x="1624112" y="1418402"/>
            <a:ext cx="2479249" cy="27386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A1702C7-9C64-4490-7529-4888AC82B3E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590" t="30238" r="26384" b="23088"/>
          <a:stretch>
            <a:fillRect/>
          </a:stretch>
        </p:blipFill>
        <p:spPr>
          <a:xfrm>
            <a:off x="1541540" y="4420627"/>
            <a:ext cx="2479249" cy="203794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959F281-D3A7-53A0-4AC0-817440CA128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371" t="28260" r="14218" b="26519"/>
          <a:stretch>
            <a:fillRect/>
          </a:stretch>
        </p:blipFill>
        <p:spPr>
          <a:xfrm>
            <a:off x="7772800" y="1193037"/>
            <a:ext cx="3652486" cy="21081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FC12EC1-9976-2C44-22AB-9A891917029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52" t="29746" r="8096" b="31752"/>
          <a:stretch>
            <a:fillRect/>
          </a:stretch>
        </p:blipFill>
        <p:spPr>
          <a:xfrm>
            <a:off x="7412937" y="4042505"/>
            <a:ext cx="4372211" cy="19098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419D9B6-6E5C-9319-C967-2CDE4631A70E}"/>
              </a:ext>
            </a:extLst>
          </p:cNvPr>
          <p:cNvSpPr txBox="1"/>
          <p:nvPr/>
        </p:nvSpPr>
        <p:spPr>
          <a:xfrm>
            <a:off x="996198" y="2492943"/>
            <a:ext cx="5453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I/II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FECCE6A-6850-CE79-812D-644C1B083658}"/>
              </a:ext>
            </a:extLst>
          </p:cNvPr>
          <p:cNvSpPr txBox="1"/>
          <p:nvPr/>
        </p:nvSpPr>
        <p:spPr>
          <a:xfrm>
            <a:off x="866358" y="4870470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86C1B5C-4A57-B784-E60F-9748534209AE}"/>
              </a:ext>
            </a:extLst>
          </p:cNvPr>
          <p:cNvSpPr txBox="1"/>
          <p:nvPr/>
        </p:nvSpPr>
        <p:spPr>
          <a:xfrm>
            <a:off x="2485530" y="693541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MM.1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2B37434-F904-1CC8-1FC9-6A92EE00E64A}"/>
              </a:ext>
            </a:extLst>
          </p:cNvPr>
          <p:cNvSpPr txBox="1"/>
          <p:nvPr/>
        </p:nvSpPr>
        <p:spPr>
          <a:xfrm>
            <a:off x="8881156" y="443793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RPMI-822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B24ED95-3F1D-1900-F8BF-3A0C62056C1D}"/>
              </a:ext>
            </a:extLst>
          </p:cNvPr>
          <p:cNvSpPr txBox="1"/>
          <p:nvPr/>
        </p:nvSpPr>
        <p:spPr>
          <a:xfrm>
            <a:off x="7140266" y="2120170"/>
            <a:ext cx="54534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I/II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A22456E-7EBD-7143-E211-9E326911859F}"/>
              </a:ext>
            </a:extLst>
          </p:cNvPr>
          <p:cNvSpPr txBox="1"/>
          <p:nvPr/>
        </p:nvSpPr>
        <p:spPr>
          <a:xfrm>
            <a:off x="6561719" y="4870470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4ED4294B-9E8A-1AB6-D31B-9A70022C8206}"/>
              </a:ext>
            </a:extLst>
          </p:cNvPr>
          <p:cNvSpPr/>
          <p:nvPr/>
        </p:nvSpPr>
        <p:spPr>
          <a:xfrm>
            <a:off x="2457249" y="2455325"/>
            <a:ext cx="1067562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C379602-2517-D7B4-F041-FFE6425C5F1B}"/>
              </a:ext>
            </a:extLst>
          </p:cNvPr>
          <p:cNvSpPr/>
          <p:nvPr/>
        </p:nvSpPr>
        <p:spPr>
          <a:xfrm>
            <a:off x="1793972" y="4664730"/>
            <a:ext cx="1067562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3849AD8-1D1F-CD8A-A461-609D0AE1CA8D}"/>
              </a:ext>
            </a:extLst>
          </p:cNvPr>
          <p:cNvSpPr/>
          <p:nvPr/>
        </p:nvSpPr>
        <p:spPr>
          <a:xfrm>
            <a:off x="9634195" y="4763898"/>
            <a:ext cx="1168759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AB76FEA2-AB2C-6D8E-925A-5360C945C87C}"/>
              </a:ext>
            </a:extLst>
          </p:cNvPr>
          <p:cNvSpPr/>
          <p:nvPr/>
        </p:nvSpPr>
        <p:spPr>
          <a:xfrm>
            <a:off x="9634195" y="1835648"/>
            <a:ext cx="1168759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6456833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1AF3732-197F-30FF-54BD-ABF9B4B6C684}"/>
              </a:ext>
            </a:extLst>
          </p:cNvPr>
          <p:cNvSpPr txBox="1"/>
          <p:nvPr/>
        </p:nvSpPr>
        <p:spPr>
          <a:xfrm>
            <a:off x="0" y="0"/>
            <a:ext cx="2319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5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D37CDB-D8B9-A35D-04A3-9677E06F0250}"/>
              </a:ext>
            </a:extLst>
          </p:cNvPr>
          <p:cNvSpPr txBox="1"/>
          <p:nvPr/>
        </p:nvSpPr>
        <p:spPr>
          <a:xfrm>
            <a:off x="6843617" y="1520686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DB4E253-5037-2213-354A-400D29693D76}"/>
              </a:ext>
            </a:extLst>
          </p:cNvPr>
          <p:cNvSpPr txBox="1"/>
          <p:nvPr/>
        </p:nvSpPr>
        <p:spPr>
          <a:xfrm>
            <a:off x="6843617" y="5742720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C061C79-1F81-5A8D-CCA6-6965422AB270}"/>
              </a:ext>
            </a:extLst>
          </p:cNvPr>
          <p:cNvSpPr txBox="1"/>
          <p:nvPr/>
        </p:nvSpPr>
        <p:spPr>
          <a:xfrm>
            <a:off x="6862853" y="3631703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CA432B8-7B8F-63AF-2A3C-8E6E3B4A837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545" t="24770" r="20292" b="31382"/>
          <a:stretch/>
        </p:blipFill>
        <p:spPr>
          <a:xfrm>
            <a:off x="7642649" y="4789262"/>
            <a:ext cx="3282696" cy="19069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5101402-E4F2-4B16-CA99-0E1E30EA9D5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252" t="25172" r="19514" b="16320"/>
          <a:stretch/>
        </p:blipFill>
        <p:spPr>
          <a:xfrm>
            <a:off x="7671816" y="993432"/>
            <a:ext cx="2551176" cy="18999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7CBE039-FEAD-9037-7D10-CF7ED84EB1E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143" t="25168" r="15379" b="25370"/>
          <a:stretch/>
        </p:blipFill>
        <p:spPr>
          <a:xfrm>
            <a:off x="7671816" y="3043880"/>
            <a:ext cx="2724912" cy="16834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831356A7-1FF7-E01D-9138-32EAE1AB943D}"/>
              </a:ext>
            </a:extLst>
          </p:cNvPr>
          <p:cNvSpPr txBox="1"/>
          <p:nvPr/>
        </p:nvSpPr>
        <p:spPr>
          <a:xfrm>
            <a:off x="8216435" y="184666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U266B1</a:t>
            </a:r>
            <a:r>
              <a:rPr lang="en-US" sz="1400" b="1" i="0" baseline="30000" dirty="0">
                <a:solidFill>
                  <a:srgbClr val="4A4A4A"/>
                </a:solidFill>
                <a:effectLst/>
                <a:latin typeface="brandon_grotesque_bold"/>
              </a:rPr>
              <a:t>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AA50C8B-170F-83E2-2058-9EE7E2AE107D}"/>
              </a:ext>
            </a:extLst>
          </p:cNvPr>
          <p:cNvSpPr txBox="1"/>
          <p:nvPr/>
        </p:nvSpPr>
        <p:spPr>
          <a:xfrm>
            <a:off x="2327753" y="400336"/>
            <a:ext cx="1067562" cy="49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3600"/>
              </a:lnSpc>
              <a:spcAft>
                <a:spcPts val="750"/>
              </a:spcAft>
            </a:pPr>
            <a:r>
              <a:rPr lang="en-US" sz="1400" b="1" i="0" dirty="0">
                <a:solidFill>
                  <a:srgbClr val="4A4A4A"/>
                </a:solidFill>
                <a:effectLst/>
                <a:latin typeface="brandon_grotesque_bold"/>
              </a:rPr>
              <a:t>U266B1</a:t>
            </a:r>
            <a:endParaRPr lang="en-US" sz="1400" b="1" i="0" baseline="30000" dirty="0">
              <a:solidFill>
                <a:srgbClr val="4A4A4A"/>
              </a:solidFill>
              <a:effectLst/>
              <a:latin typeface="brandon_grotesque_bold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E93A8B5-B328-25B2-724B-E44F8655D8E7}"/>
              </a:ext>
            </a:extLst>
          </p:cNvPr>
          <p:cNvSpPr txBox="1"/>
          <p:nvPr/>
        </p:nvSpPr>
        <p:spPr>
          <a:xfrm>
            <a:off x="10390422" y="1794811"/>
            <a:ext cx="1069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ow exposur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44473F4-6044-6985-8DAA-F77B30840E5C}"/>
              </a:ext>
            </a:extLst>
          </p:cNvPr>
          <p:cNvSpPr txBox="1"/>
          <p:nvPr/>
        </p:nvSpPr>
        <p:spPr>
          <a:xfrm>
            <a:off x="10571396" y="3747119"/>
            <a:ext cx="10990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High exposure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5AECD33-28FA-BC7D-5C8D-E963E890E93D}"/>
              </a:ext>
            </a:extLst>
          </p:cNvPr>
          <p:cNvSpPr/>
          <p:nvPr/>
        </p:nvSpPr>
        <p:spPr>
          <a:xfrm>
            <a:off x="8311895" y="1866070"/>
            <a:ext cx="1213513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2D48750D-8FBA-60ED-9FA2-48BBD7E321AE}"/>
              </a:ext>
            </a:extLst>
          </p:cNvPr>
          <p:cNvSpPr/>
          <p:nvPr/>
        </p:nvSpPr>
        <p:spPr>
          <a:xfrm>
            <a:off x="8284462" y="3967686"/>
            <a:ext cx="1213513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7EDF4265-EF1D-F56D-CF12-BED27C1F654C}"/>
              </a:ext>
            </a:extLst>
          </p:cNvPr>
          <p:cNvSpPr/>
          <p:nvPr/>
        </p:nvSpPr>
        <p:spPr>
          <a:xfrm>
            <a:off x="8427515" y="5306352"/>
            <a:ext cx="1612597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B6E04B61-21CB-4AA7-8EAE-EB6F500BF7C4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518" t="31435" r="8459" b="27982"/>
          <a:stretch/>
        </p:blipFill>
        <p:spPr>
          <a:xfrm>
            <a:off x="1396522" y="4956293"/>
            <a:ext cx="3563398" cy="18267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DBDD6E4-67DD-420E-9457-C319D0D0853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575" t="50866" r="15612" b="22227"/>
          <a:stretch/>
        </p:blipFill>
        <p:spPr>
          <a:xfrm>
            <a:off x="1064526" y="3255388"/>
            <a:ext cx="4445841" cy="15374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B34C76C1-895C-4E8C-B731-D60A5939053C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043" t="45805" r="10268" b="18431"/>
          <a:stretch/>
        </p:blipFill>
        <p:spPr>
          <a:xfrm>
            <a:off x="1098624" y="1247699"/>
            <a:ext cx="4434657" cy="19250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37B4555B-CE6F-4F2A-900F-1D1784E9A7AB}"/>
              </a:ext>
            </a:extLst>
          </p:cNvPr>
          <p:cNvSpPr/>
          <p:nvPr/>
        </p:nvSpPr>
        <p:spPr>
          <a:xfrm>
            <a:off x="1291992" y="2065331"/>
            <a:ext cx="1612573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EC7D7DF7-8D51-4963-85A6-1D78882A51AD}"/>
              </a:ext>
            </a:extLst>
          </p:cNvPr>
          <p:cNvSpPr/>
          <p:nvPr/>
        </p:nvSpPr>
        <p:spPr>
          <a:xfrm>
            <a:off x="1291992" y="3885618"/>
            <a:ext cx="1776984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E091EA22-BBDB-4FBA-89EF-CAA9AA28BB93}"/>
              </a:ext>
            </a:extLst>
          </p:cNvPr>
          <p:cNvSpPr/>
          <p:nvPr/>
        </p:nvSpPr>
        <p:spPr>
          <a:xfrm>
            <a:off x="1901592" y="5306352"/>
            <a:ext cx="1298808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5117507-8B9D-4E9D-9E94-6A08B6B0934C}"/>
              </a:ext>
            </a:extLst>
          </p:cNvPr>
          <p:cNvSpPr txBox="1"/>
          <p:nvPr/>
        </p:nvSpPr>
        <p:spPr>
          <a:xfrm>
            <a:off x="343291" y="1866070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03B52A1-ED38-4FDE-A6FD-B890148E7D17}"/>
              </a:ext>
            </a:extLst>
          </p:cNvPr>
          <p:cNvSpPr txBox="1"/>
          <p:nvPr/>
        </p:nvSpPr>
        <p:spPr>
          <a:xfrm>
            <a:off x="699488" y="5830650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FC8FC33-32A8-4D57-AE53-ED1D49126DD7}"/>
              </a:ext>
            </a:extLst>
          </p:cNvPr>
          <p:cNvSpPr txBox="1"/>
          <p:nvPr/>
        </p:nvSpPr>
        <p:spPr>
          <a:xfrm>
            <a:off x="362527" y="3977087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04039F-E401-4A43-A24A-C8549F883437}"/>
              </a:ext>
            </a:extLst>
          </p:cNvPr>
          <p:cNvSpPr txBox="1"/>
          <p:nvPr/>
        </p:nvSpPr>
        <p:spPr>
          <a:xfrm>
            <a:off x="5653526" y="2268005"/>
            <a:ext cx="1069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ow exposur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785BC1B-A95B-446F-863F-6E2F421E3DFA}"/>
              </a:ext>
            </a:extLst>
          </p:cNvPr>
          <p:cNvSpPr txBox="1"/>
          <p:nvPr/>
        </p:nvSpPr>
        <p:spPr>
          <a:xfrm>
            <a:off x="5573503" y="3838587"/>
            <a:ext cx="10990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High exposure</a:t>
            </a:r>
          </a:p>
        </p:txBody>
      </p:sp>
    </p:spTree>
    <p:extLst>
      <p:ext uri="{BB962C8B-B14F-4D97-AF65-F5344CB8AC3E}">
        <p14:creationId xmlns:p14="http://schemas.microsoft.com/office/powerpoint/2010/main" val="286445929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147C4FB-1948-E83F-BEFB-60639EDDFEDD}"/>
              </a:ext>
            </a:extLst>
          </p:cNvPr>
          <p:cNvSpPr txBox="1"/>
          <p:nvPr/>
        </p:nvSpPr>
        <p:spPr>
          <a:xfrm>
            <a:off x="0" y="0"/>
            <a:ext cx="232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6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74434B9-09C5-75FD-658E-5CB33D61A48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229" t="28457" r="30394" b="6424"/>
          <a:stretch>
            <a:fillRect/>
          </a:stretch>
        </p:blipFill>
        <p:spPr>
          <a:xfrm>
            <a:off x="9758877" y="623606"/>
            <a:ext cx="2103811" cy="31003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7C122E6-AC36-AA6D-2A89-53EB63133B9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534" t="7721" r="21888" b="8654"/>
          <a:stretch>
            <a:fillRect/>
          </a:stretch>
        </p:blipFill>
        <p:spPr>
          <a:xfrm>
            <a:off x="355035" y="1838114"/>
            <a:ext cx="2753438" cy="33246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EC3796C-9480-DB56-8B8B-A4F1436A694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381" t="3251" r="25283" b="-297"/>
          <a:stretch>
            <a:fillRect/>
          </a:stretch>
        </p:blipFill>
        <p:spPr>
          <a:xfrm>
            <a:off x="3678508" y="2720375"/>
            <a:ext cx="2067595" cy="40084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DB51E41-6D93-49E8-A217-FD0275B85DB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816" t="8359" r="23981" b="890"/>
          <a:stretch>
            <a:fillRect/>
          </a:stretch>
        </p:blipFill>
        <p:spPr>
          <a:xfrm>
            <a:off x="7244336" y="2943849"/>
            <a:ext cx="2327753" cy="37849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99AA5A3-2F1C-1DEF-B338-DD4E7ABA972D}"/>
              </a:ext>
            </a:extLst>
          </p:cNvPr>
          <p:cNvSpPr txBox="1"/>
          <p:nvPr/>
        </p:nvSpPr>
        <p:spPr>
          <a:xfrm>
            <a:off x="1020081" y="736663"/>
            <a:ext cx="8322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U266B1 an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7A72247-5125-B737-A566-187737FA0335}"/>
              </a:ext>
            </a:extLst>
          </p:cNvPr>
          <p:cNvSpPr txBox="1"/>
          <p:nvPr/>
        </p:nvSpPr>
        <p:spPr>
          <a:xfrm>
            <a:off x="1731849" y="734391"/>
            <a:ext cx="651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U266B1</a:t>
            </a:r>
            <a:r>
              <a:rPr lang="en-US" sz="1000" b="1" baseline="30000" dirty="0"/>
              <a:t>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668B0F0-8115-B8DD-0DA0-45D4C3F486C1}"/>
              </a:ext>
            </a:extLst>
          </p:cNvPr>
          <p:cNvSpPr txBox="1"/>
          <p:nvPr/>
        </p:nvSpPr>
        <p:spPr>
          <a:xfrm>
            <a:off x="7623069" y="115606"/>
            <a:ext cx="9989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U266B1 </a:t>
            </a:r>
            <a:r>
              <a:rPr lang="en-US" sz="1000" b="1" baseline="30000" dirty="0"/>
              <a:t>WT </a:t>
            </a:r>
            <a:r>
              <a:rPr lang="en-US" sz="1000" b="1" dirty="0"/>
              <a:t> and</a:t>
            </a:r>
            <a:endParaRPr lang="en-US" sz="1000" b="1" baseline="30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ED1CFEE-EEB5-4FA8-CD2C-39B610F6EDED}"/>
              </a:ext>
            </a:extLst>
          </p:cNvPr>
          <p:cNvSpPr txBox="1"/>
          <p:nvPr/>
        </p:nvSpPr>
        <p:spPr>
          <a:xfrm rot="28209">
            <a:off x="8551726" y="119359"/>
            <a:ext cx="9156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U266B1</a:t>
            </a:r>
            <a:r>
              <a:rPr lang="en-US" sz="1000" b="1" baseline="30000" dirty="0"/>
              <a:t> Mcl1 O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BE43BEE-E231-914B-9F96-DAE1A2DF6A91}"/>
              </a:ext>
            </a:extLst>
          </p:cNvPr>
          <p:cNvSpPr txBox="1"/>
          <p:nvPr/>
        </p:nvSpPr>
        <p:spPr>
          <a:xfrm>
            <a:off x="1651317" y="1422404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F406756-EBDD-DFE4-90C8-8DC507693B0D}"/>
              </a:ext>
            </a:extLst>
          </p:cNvPr>
          <p:cNvSpPr txBox="1"/>
          <p:nvPr/>
        </p:nvSpPr>
        <p:spPr>
          <a:xfrm>
            <a:off x="4414787" y="2397094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776D54C-7F8E-187B-A4A2-D3A42A721548}"/>
              </a:ext>
            </a:extLst>
          </p:cNvPr>
          <p:cNvSpPr txBox="1"/>
          <p:nvPr/>
        </p:nvSpPr>
        <p:spPr>
          <a:xfrm>
            <a:off x="7994862" y="2646157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GAPD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964B9F9-F558-B006-CF4A-658CB0FE4D06}"/>
              </a:ext>
            </a:extLst>
          </p:cNvPr>
          <p:cNvSpPr txBox="1"/>
          <p:nvPr/>
        </p:nvSpPr>
        <p:spPr>
          <a:xfrm>
            <a:off x="10580591" y="242469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55C33A3C-705E-8992-4515-2A3AEBBC61A2}"/>
              </a:ext>
            </a:extLst>
          </p:cNvPr>
          <p:cNvSpPr/>
          <p:nvPr/>
        </p:nvSpPr>
        <p:spPr>
          <a:xfrm>
            <a:off x="1178351" y="3618953"/>
            <a:ext cx="501247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C8625916-4463-119E-054E-A71B18BF6873}"/>
              </a:ext>
            </a:extLst>
          </p:cNvPr>
          <p:cNvSpPr/>
          <p:nvPr/>
        </p:nvSpPr>
        <p:spPr>
          <a:xfrm>
            <a:off x="4045671" y="5807543"/>
            <a:ext cx="501247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D0561CC5-1F12-5B93-34C8-3D61D7959F85}"/>
              </a:ext>
            </a:extLst>
          </p:cNvPr>
          <p:cNvSpPr/>
          <p:nvPr/>
        </p:nvSpPr>
        <p:spPr>
          <a:xfrm>
            <a:off x="8408212" y="5875102"/>
            <a:ext cx="501247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FE3036D-8556-2371-0510-6D663844CF0D}"/>
              </a:ext>
            </a:extLst>
          </p:cNvPr>
          <p:cNvSpPr/>
          <p:nvPr/>
        </p:nvSpPr>
        <p:spPr>
          <a:xfrm>
            <a:off x="10746224" y="1754511"/>
            <a:ext cx="501247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1762361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D6F0867-B448-1E0B-FA2C-F3FA888183D4}"/>
              </a:ext>
            </a:extLst>
          </p:cNvPr>
          <p:cNvSpPr txBox="1"/>
          <p:nvPr/>
        </p:nvSpPr>
        <p:spPr>
          <a:xfrm>
            <a:off x="0" y="0"/>
            <a:ext cx="2327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6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B1DECA9-7A71-CE47-909C-D11923C64079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889" t="1754" r="13778" b="12598"/>
          <a:stretch>
            <a:fillRect/>
          </a:stretch>
        </p:blipFill>
        <p:spPr>
          <a:xfrm>
            <a:off x="4728138" y="3701091"/>
            <a:ext cx="3058493" cy="28651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44E61D6-B0A6-5A12-35EA-BEA7946BD8F5}"/>
              </a:ext>
            </a:extLst>
          </p:cNvPr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355" t="8512" r="16461" b="33293"/>
          <a:stretch>
            <a:fillRect/>
          </a:stretch>
        </p:blipFill>
        <p:spPr>
          <a:xfrm>
            <a:off x="1442301" y="829022"/>
            <a:ext cx="3285837" cy="23379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AB0A232-4C4C-13D3-F52D-A778BE9006A7}"/>
              </a:ext>
            </a:extLst>
          </p:cNvPr>
          <p:cNvPicPr>
            <a:picLocks noChangeAspect="1"/>
          </p:cNvPicPr>
          <p:nvPr/>
        </p:nvPicPr>
        <p:blipFill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906" t="4553" r="10843" b="10248"/>
          <a:stretch>
            <a:fillRect/>
          </a:stretch>
        </p:blipFill>
        <p:spPr>
          <a:xfrm>
            <a:off x="1130148" y="3394665"/>
            <a:ext cx="3309503" cy="32560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B39E9DE-6A58-F900-4849-E69474C117B6}"/>
              </a:ext>
            </a:extLst>
          </p:cNvPr>
          <p:cNvPicPr>
            <a:picLocks noChangeAspect="1"/>
          </p:cNvPicPr>
          <p:nvPr/>
        </p:nvPicPr>
        <p:blipFill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336" t="6030" r="12785" b="12422"/>
          <a:stretch>
            <a:fillRect/>
          </a:stretch>
        </p:blipFill>
        <p:spPr>
          <a:xfrm>
            <a:off x="8220173" y="3556356"/>
            <a:ext cx="3535052" cy="33003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4D724B0-6727-A008-EC54-6FF3274937DF}"/>
              </a:ext>
            </a:extLst>
          </p:cNvPr>
          <p:cNvPicPr>
            <a:picLocks noChangeAspect="1"/>
          </p:cNvPicPr>
          <p:nvPr/>
        </p:nvPicPr>
        <p:blipFill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011" t="3935" r="11030" b="10157"/>
          <a:stretch>
            <a:fillRect/>
          </a:stretch>
        </p:blipFill>
        <p:spPr>
          <a:xfrm>
            <a:off x="6560598" y="184666"/>
            <a:ext cx="2810094" cy="28375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E7E4C5A-7311-8CF5-DE3C-D968FF44D640}"/>
              </a:ext>
            </a:extLst>
          </p:cNvPr>
          <p:cNvSpPr txBox="1"/>
          <p:nvPr/>
        </p:nvSpPr>
        <p:spPr>
          <a:xfrm>
            <a:off x="916853" y="1010055"/>
            <a:ext cx="4940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cl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8749843-9714-4ACF-56CD-5D2D92B7DBBA}"/>
              </a:ext>
            </a:extLst>
          </p:cNvPr>
          <p:cNvSpPr txBox="1"/>
          <p:nvPr/>
        </p:nvSpPr>
        <p:spPr>
          <a:xfrm>
            <a:off x="9657320" y="3263860"/>
            <a:ext cx="6607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4A8502-EE0D-FC9C-95F4-CFC7C988526F}"/>
              </a:ext>
            </a:extLst>
          </p:cNvPr>
          <p:cNvSpPr txBox="1"/>
          <p:nvPr/>
        </p:nvSpPr>
        <p:spPr>
          <a:xfrm>
            <a:off x="5949533" y="2493768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LC3I/II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BE620C5-13A1-E3D1-5D54-7D51D389EE17}"/>
              </a:ext>
            </a:extLst>
          </p:cNvPr>
          <p:cNvSpPr txBox="1"/>
          <p:nvPr/>
        </p:nvSpPr>
        <p:spPr>
          <a:xfrm>
            <a:off x="168626" y="4035388"/>
            <a:ext cx="10903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PAR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E6854F8-03E3-06D2-98CC-2BE5A5C45FD4}"/>
              </a:ext>
            </a:extLst>
          </p:cNvPr>
          <p:cNvSpPr txBox="1"/>
          <p:nvPr/>
        </p:nvSpPr>
        <p:spPr>
          <a:xfrm>
            <a:off x="5658855" y="3425551"/>
            <a:ext cx="13421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Cleaved Caspase 3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5492949-599B-C5C1-50A8-0936EC3A4221}"/>
              </a:ext>
            </a:extLst>
          </p:cNvPr>
          <p:cNvSpPr/>
          <p:nvPr/>
        </p:nvSpPr>
        <p:spPr>
          <a:xfrm>
            <a:off x="1826506" y="935120"/>
            <a:ext cx="1142937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B839AFCF-EEEC-A8A5-048D-9DFAD3C2E38E}"/>
              </a:ext>
            </a:extLst>
          </p:cNvPr>
          <p:cNvSpPr/>
          <p:nvPr/>
        </p:nvSpPr>
        <p:spPr>
          <a:xfrm>
            <a:off x="1410899" y="4035388"/>
            <a:ext cx="1142937" cy="4114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AF079F3-E4D6-FCA3-F23E-DBC4E2690752}"/>
              </a:ext>
            </a:extLst>
          </p:cNvPr>
          <p:cNvSpPr/>
          <p:nvPr/>
        </p:nvSpPr>
        <p:spPr>
          <a:xfrm>
            <a:off x="6329912" y="4722829"/>
            <a:ext cx="1142937" cy="4837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AD5FFD1-9A10-75DD-AE8B-AF90B5BA752F}"/>
              </a:ext>
            </a:extLst>
          </p:cNvPr>
          <p:cNvSpPr/>
          <p:nvPr/>
        </p:nvSpPr>
        <p:spPr>
          <a:xfrm>
            <a:off x="8799223" y="4059570"/>
            <a:ext cx="1142937" cy="4837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5F25C19-78E6-832E-B9CE-E68BC6BF8A9B}"/>
              </a:ext>
            </a:extLst>
          </p:cNvPr>
          <p:cNvSpPr/>
          <p:nvPr/>
        </p:nvSpPr>
        <p:spPr>
          <a:xfrm>
            <a:off x="6639057" y="2382719"/>
            <a:ext cx="1072070" cy="4837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34835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CD59358-3DA0-C022-B564-BDEE80F2AC9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073" t="13759" r="8688" b="30484"/>
          <a:stretch/>
        </p:blipFill>
        <p:spPr>
          <a:xfrm>
            <a:off x="7050024" y="704088"/>
            <a:ext cx="3465745" cy="21157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09C7B31-7811-1EC7-4339-8B0ABF21EDD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024" t="36213" r="15671" b="27998"/>
          <a:stretch/>
        </p:blipFill>
        <p:spPr>
          <a:xfrm>
            <a:off x="1402775" y="855049"/>
            <a:ext cx="3465576" cy="19638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155C63C-ECC5-14F4-206E-3479D2AF0CF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065" t="27479" r="13805" b="28947"/>
          <a:stretch/>
        </p:blipFill>
        <p:spPr>
          <a:xfrm>
            <a:off x="1402775" y="3581925"/>
            <a:ext cx="3452588" cy="19246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69A8BFB-1FA9-4AAA-BD3C-D1E875D8821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918" t="31808" r="22206" b="24027"/>
          <a:stretch/>
        </p:blipFill>
        <p:spPr>
          <a:xfrm>
            <a:off x="7050025" y="3279204"/>
            <a:ext cx="3465577" cy="22370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18A6F2A-F690-D357-77BC-5F4115902CFD}"/>
              </a:ext>
            </a:extLst>
          </p:cNvPr>
          <p:cNvSpPr txBox="1"/>
          <p:nvPr/>
        </p:nvSpPr>
        <p:spPr>
          <a:xfrm>
            <a:off x="6251079" y="1710031"/>
            <a:ext cx="5757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LC3 I/II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E74D9E7-ED01-64F9-5FAD-369E5EE61B0C}"/>
              </a:ext>
            </a:extLst>
          </p:cNvPr>
          <p:cNvSpPr txBox="1"/>
          <p:nvPr/>
        </p:nvSpPr>
        <p:spPr>
          <a:xfrm>
            <a:off x="740801" y="1583073"/>
            <a:ext cx="4892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ATG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3A9AACB-8E4B-7E50-F031-4286BB4526E2}"/>
              </a:ext>
            </a:extLst>
          </p:cNvPr>
          <p:cNvSpPr txBox="1"/>
          <p:nvPr/>
        </p:nvSpPr>
        <p:spPr>
          <a:xfrm>
            <a:off x="690940" y="4414853"/>
            <a:ext cx="4603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l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7BFF2C-F591-5854-5848-AB356B931E96}"/>
              </a:ext>
            </a:extLst>
          </p:cNvPr>
          <p:cNvSpPr txBox="1"/>
          <p:nvPr/>
        </p:nvSpPr>
        <p:spPr>
          <a:xfrm>
            <a:off x="6232644" y="4159630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9DC5FFC-0D0C-657E-1042-ED9100B646B9}"/>
              </a:ext>
            </a:extLst>
          </p:cNvPr>
          <p:cNvSpPr txBox="1"/>
          <p:nvPr/>
        </p:nvSpPr>
        <p:spPr>
          <a:xfrm>
            <a:off x="0" y="0"/>
            <a:ext cx="1049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1F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707CF8DF-A97E-FAD8-2E4C-1A2E132EF6A0}"/>
              </a:ext>
            </a:extLst>
          </p:cNvPr>
          <p:cNvSpPr/>
          <p:nvPr/>
        </p:nvSpPr>
        <p:spPr>
          <a:xfrm>
            <a:off x="2998095" y="2139695"/>
            <a:ext cx="1107561" cy="348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DA5D26F-853C-86B2-C599-2A84D86D676C}"/>
              </a:ext>
            </a:extLst>
          </p:cNvPr>
          <p:cNvSpPr/>
          <p:nvPr/>
        </p:nvSpPr>
        <p:spPr>
          <a:xfrm>
            <a:off x="2921895" y="4916423"/>
            <a:ext cx="1107561" cy="348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5F6BFD1-0F87-3D22-ADD6-1B2231223CE2}"/>
              </a:ext>
            </a:extLst>
          </p:cNvPr>
          <p:cNvSpPr/>
          <p:nvPr/>
        </p:nvSpPr>
        <p:spPr>
          <a:xfrm>
            <a:off x="7730048" y="1845178"/>
            <a:ext cx="959115" cy="348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E0CD10F-026A-11FA-1568-975F2EC9EB38}"/>
              </a:ext>
            </a:extLst>
          </p:cNvPr>
          <p:cNvSpPr/>
          <p:nvPr/>
        </p:nvSpPr>
        <p:spPr>
          <a:xfrm>
            <a:off x="8782813" y="4742170"/>
            <a:ext cx="1305681" cy="348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0835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0E917E-48DF-86D5-3310-496858CDBE09}"/>
              </a:ext>
            </a:extLst>
          </p:cNvPr>
          <p:cNvSpPr txBox="1"/>
          <p:nvPr/>
        </p:nvSpPr>
        <p:spPr>
          <a:xfrm>
            <a:off x="71793" y="0"/>
            <a:ext cx="1089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1H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64CB8DB-D9BE-6C5B-981F-7FB78BF99FE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815" t="20601" r="30963" b="13539"/>
          <a:stretch>
            <a:fillRect/>
          </a:stretch>
        </p:blipFill>
        <p:spPr>
          <a:xfrm>
            <a:off x="8348472" y="184666"/>
            <a:ext cx="3093307" cy="39867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B1DADE9-1ABF-C6DC-2663-FE2D9DD8A97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234" t="53625" r="27184" b="11789"/>
          <a:stretch>
            <a:fillRect/>
          </a:stretch>
        </p:blipFill>
        <p:spPr>
          <a:xfrm>
            <a:off x="4793469" y="4031595"/>
            <a:ext cx="3465576" cy="25612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7E34C47-9566-1E6D-7E19-914B291BBDD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805" t="16915" r="28975" b="27312"/>
          <a:stretch>
            <a:fillRect/>
          </a:stretch>
        </p:blipFill>
        <p:spPr>
          <a:xfrm>
            <a:off x="1204616" y="529444"/>
            <a:ext cx="3282696" cy="35021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AD5E65B-FEC6-5CA5-4FD7-78A8983BCE5B}"/>
              </a:ext>
            </a:extLst>
          </p:cNvPr>
          <p:cNvSpPr txBox="1"/>
          <p:nvPr/>
        </p:nvSpPr>
        <p:spPr>
          <a:xfrm>
            <a:off x="119403" y="2018909"/>
            <a:ext cx="9957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PAR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601F916-F4D4-3499-2D00-2F142B79D6BD}"/>
              </a:ext>
            </a:extLst>
          </p:cNvPr>
          <p:cNvSpPr txBox="1"/>
          <p:nvPr/>
        </p:nvSpPr>
        <p:spPr>
          <a:xfrm>
            <a:off x="6914145" y="1916448"/>
            <a:ext cx="12554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</a:t>
            </a:r>
            <a:r>
              <a:rPr lang="en-US" sz="1100" b="1" dirty="0" err="1"/>
              <a:t>Caspase</a:t>
            </a:r>
            <a:r>
              <a:rPr lang="en-US" sz="1100" b="1" dirty="0"/>
              <a:t> 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74069AA-D106-739F-5C49-4FDF0C04B98E}"/>
              </a:ext>
            </a:extLst>
          </p:cNvPr>
          <p:cNvSpPr txBox="1"/>
          <p:nvPr/>
        </p:nvSpPr>
        <p:spPr>
          <a:xfrm>
            <a:off x="4032100" y="5609748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528578D-7409-F581-47BA-2B47A7FC345E}"/>
              </a:ext>
            </a:extLst>
          </p:cNvPr>
          <p:cNvSpPr/>
          <p:nvPr/>
        </p:nvSpPr>
        <p:spPr>
          <a:xfrm>
            <a:off x="2352438" y="1361398"/>
            <a:ext cx="1158858" cy="4033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1D3107B-3D2D-065D-5C5B-0D554A61173E}"/>
              </a:ext>
            </a:extLst>
          </p:cNvPr>
          <p:cNvSpPr/>
          <p:nvPr/>
        </p:nvSpPr>
        <p:spPr>
          <a:xfrm>
            <a:off x="5806440" y="5871358"/>
            <a:ext cx="1299246" cy="5181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3209AF1-F25B-9294-6FCB-B1A4D36B2260}"/>
              </a:ext>
            </a:extLst>
          </p:cNvPr>
          <p:cNvSpPr/>
          <p:nvPr/>
        </p:nvSpPr>
        <p:spPr>
          <a:xfrm>
            <a:off x="9442704" y="1828800"/>
            <a:ext cx="1299246" cy="8674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1376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51DE470-3F4E-0C56-A278-9B3A6AAB7A70}"/>
              </a:ext>
            </a:extLst>
          </p:cNvPr>
          <p:cNvSpPr txBox="1"/>
          <p:nvPr/>
        </p:nvSpPr>
        <p:spPr>
          <a:xfrm>
            <a:off x="134296" y="75415"/>
            <a:ext cx="10204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1J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8CD21A5-39F6-C787-2A84-65BE076822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565" t="10776" r="18550" b="20796"/>
          <a:stretch>
            <a:fillRect/>
          </a:stretch>
        </p:blipFill>
        <p:spPr>
          <a:xfrm>
            <a:off x="2106000" y="1545336"/>
            <a:ext cx="4116057" cy="41879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941F184-F14A-3B70-4B37-B45318B055F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827" t="7103" r="20626" b="4238"/>
          <a:stretch>
            <a:fillRect/>
          </a:stretch>
        </p:blipFill>
        <p:spPr>
          <a:xfrm>
            <a:off x="8153159" y="1545336"/>
            <a:ext cx="3213827" cy="418795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524F6C9-D57B-CB7D-906D-CED7FEFC81A5}"/>
              </a:ext>
            </a:extLst>
          </p:cNvPr>
          <p:cNvSpPr txBox="1"/>
          <p:nvPr/>
        </p:nvSpPr>
        <p:spPr>
          <a:xfrm>
            <a:off x="644532" y="2175849"/>
            <a:ext cx="12554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leaved </a:t>
            </a:r>
            <a:r>
              <a:rPr lang="en-US" sz="1100" b="1" dirty="0" err="1"/>
              <a:t>Caspase</a:t>
            </a:r>
            <a:r>
              <a:rPr lang="en-US" sz="1100" b="1" dirty="0"/>
              <a:t> 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B9E40AF-125A-5AE0-2468-13F6DC266A18}"/>
              </a:ext>
            </a:extLst>
          </p:cNvPr>
          <p:cNvSpPr txBox="1"/>
          <p:nvPr/>
        </p:nvSpPr>
        <p:spPr>
          <a:xfrm>
            <a:off x="7407800" y="3805631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GAPDH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20C5C51-90C6-9FD8-0647-DD5DE27B6BD0}"/>
              </a:ext>
            </a:extLst>
          </p:cNvPr>
          <p:cNvSpPr/>
          <p:nvPr/>
        </p:nvSpPr>
        <p:spPr>
          <a:xfrm>
            <a:off x="3181482" y="2306654"/>
            <a:ext cx="1814723" cy="5181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D26EF3CB-F781-B8C9-FD5F-FCBC809A7B9D}"/>
              </a:ext>
            </a:extLst>
          </p:cNvPr>
          <p:cNvSpPr/>
          <p:nvPr/>
        </p:nvSpPr>
        <p:spPr>
          <a:xfrm>
            <a:off x="8688307" y="3546551"/>
            <a:ext cx="1814723" cy="5181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6032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F1222D8B-372B-A82F-4F8D-EFDE1DA0713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159" t="18438" r="8507" b="30330"/>
          <a:stretch>
            <a:fillRect/>
          </a:stretch>
        </p:blipFill>
        <p:spPr>
          <a:xfrm>
            <a:off x="8540570" y="4624638"/>
            <a:ext cx="3541697" cy="19846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34F1EC3-1931-B4D8-1621-F314FAC5AFC2}"/>
              </a:ext>
            </a:extLst>
          </p:cNvPr>
          <p:cNvSpPr txBox="1"/>
          <p:nvPr/>
        </p:nvSpPr>
        <p:spPr>
          <a:xfrm>
            <a:off x="71793" y="0"/>
            <a:ext cx="1089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1K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5C10614-D134-7398-EF37-A088FB53F17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922" t="13007" r="6985" b="24632"/>
          <a:stretch>
            <a:fillRect/>
          </a:stretch>
        </p:blipFill>
        <p:spPr>
          <a:xfrm>
            <a:off x="4225435" y="4655059"/>
            <a:ext cx="3041525" cy="19542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B4AE9F9-B7E0-1E08-04A1-B83665CB9341}"/>
              </a:ext>
            </a:extLst>
          </p:cNvPr>
          <p:cNvSpPr txBox="1"/>
          <p:nvPr/>
        </p:nvSpPr>
        <p:spPr>
          <a:xfrm>
            <a:off x="7714511" y="5359490"/>
            <a:ext cx="6928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IB: Mcl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395F5A1-E78C-1D35-4A59-A4299D4D76E6}"/>
              </a:ext>
            </a:extLst>
          </p:cNvPr>
          <p:cNvSpPr txBox="1"/>
          <p:nvPr/>
        </p:nvSpPr>
        <p:spPr>
          <a:xfrm>
            <a:off x="3422991" y="5514828"/>
            <a:ext cx="6928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IB: Mcl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E4FE86F-A1EE-52E1-1B3E-E99A5FFB3C36}"/>
              </a:ext>
            </a:extLst>
          </p:cNvPr>
          <p:cNvSpPr txBox="1"/>
          <p:nvPr/>
        </p:nvSpPr>
        <p:spPr>
          <a:xfrm>
            <a:off x="521268" y="1373149"/>
            <a:ext cx="8915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IB: Beclin1 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E568E85-FA71-7BE4-F553-F1988EE1B28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rgbClr val="E9E9E3">
                <a:tint val="45000"/>
                <a:satMod val="40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073" t="9263" r="17395" b="23396"/>
          <a:stretch>
            <a:fillRect/>
          </a:stretch>
        </p:blipFill>
        <p:spPr>
          <a:xfrm>
            <a:off x="6550062" y="765499"/>
            <a:ext cx="2799758" cy="22610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C8A2C7A-60D2-7499-4B3F-EB3DBB1E879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357" t="16361" r="11377" b="24152"/>
          <a:stretch>
            <a:fillRect/>
          </a:stretch>
        </p:blipFill>
        <p:spPr>
          <a:xfrm>
            <a:off x="1442303" y="2370147"/>
            <a:ext cx="2903454" cy="19938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31711474-0C45-E615-18CC-29F1CEBC0C1A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119" t="24893" r="13652" b="25763"/>
          <a:stretch>
            <a:fillRect/>
          </a:stretch>
        </p:blipFill>
        <p:spPr>
          <a:xfrm>
            <a:off x="1442303" y="701589"/>
            <a:ext cx="2799758" cy="15741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B5B68B4-5328-2DE2-2402-C17B29118EA2}"/>
              </a:ext>
            </a:extLst>
          </p:cNvPr>
          <p:cNvSpPr txBox="1"/>
          <p:nvPr/>
        </p:nvSpPr>
        <p:spPr>
          <a:xfrm>
            <a:off x="5658471" y="1578539"/>
            <a:ext cx="8915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IB: Beclin1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547C473-86E0-E96D-E7CA-D6319F924B4A}"/>
              </a:ext>
            </a:extLst>
          </p:cNvPr>
          <p:cNvSpPr txBox="1"/>
          <p:nvPr/>
        </p:nvSpPr>
        <p:spPr>
          <a:xfrm>
            <a:off x="5576084" y="1750175"/>
            <a:ext cx="9589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High exposur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0713F33-3D88-65EC-F46B-64463D63A2EC}"/>
              </a:ext>
            </a:extLst>
          </p:cNvPr>
          <p:cNvSpPr txBox="1"/>
          <p:nvPr/>
        </p:nvSpPr>
        <p:spPr>
          <a:xfrm>
            <a:off x="7581653" y="5514828"/>
            <a:ext cx="9589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High exposur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056A1DA-6B41-9802-FC1B-993948EA9E1C}"/>
              </a:ext>
            </a:extLst>
          </p:cNvPr>
          <p:cNvSpPr txBox="1"/>
          <p:nvPr/>
        </p:nvSpPr>
        <p:spPr>
          <a:xfrm>
            <a:off x="491823" y="1634759"/>
            <a:ext cx="10086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Low exposur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08BC473-1D93-BB92-16CC-A0F26052CE8A}"/>
              </a:ext>
            </a:extLst>
          </p:cNvPr>
          <p:cNvSpPr txBox="1"/>
          <p:nvPr/>
        </p:nvSpPr>
        <p:spPr>
          <a:xfrm>
            <a:off x="3313365" y="5632166"/>
            <a:ext cx="10086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Low exposur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F57B460-6DEA-C531-65DD-13EEE4685EE1}"/>
              </a:ext>
            </a:extLst>
          </p:cNvPr>
          <p:cNvSpPr txBox="1"/>
          <p:nvPr/>
        </p:nvSpPr>
        <p:spPr>
          <a:xfrm>
            <a:off x="463139" y="2936558"/>
            <a:ext cx="8915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IB: Beclin1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E71773F-907B-99AA-3962-09A874AE5034}"/>
              </a:ext>
            </a:extLst>
          </p:cNvPr>
          <p:cNvSpPr txBox="1"/>
          <p:nvPr/>
        </p:nvSpPr>
        <p:spPr>
          <a:xfrm>
            <a:off x="433694" y="3198168"/>
            <a:ext cx="10086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Low exposure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7D4EA3CC-8470-A04A-8D2E-6979514BFF8C}"/>
              </a:ext>
            </a:extLst>
          </p:cNvPr>
          <p:cNvSpPr/>
          <p:nvPr/>
        </p:nvSpPr>
        <p:spPr>
          <a:xfrm>
            <a:off x="1608269" y="995002"/>
            <a:ext cx="1116078" cy="5181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1E5696D0-F3D7-97E6-1965-7B7ABE46B1FD}"/>
              </a:ext>
            </a:extLst>
          </p:cNvPr>
          <p:cNvSpPr/>
          <p:nvPr/>
        </p:nvSpPr>
        <p:spPr>
          <a:xfrm>
            <a:off x="1529876" y="3011600"/>
            <a:ext cx="1116078" cy="5181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DA5B47D4-C01E-10E1-67FE-27B11B0E9C0D}"/>
              </a:ext>
            </a:extLst>
          </p:cNvPr>
          <p:cNvSpPr/>
          <p:nvPr/>
        </p:nvSpPr>
        <p:spPr>
          <a:xfrm>
            <a:off x="6853286" y="1319458"/>
            <a:ext cx="1015737" cy="9563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34C9BAAD-1188-9598-3EA0-087B8BDA5352}"/>
              </a:ext>
            </a:extLst>
          </p:cNvPr>
          <p:cNvSpPr/>
          <p:nvPr/>
        </p:nvSpPr>
        <p:spPr>
          <a:xfrm>
            <a:off x="5794998" y="5399061"/>
            <a:ext cx="1015737" cy="3465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EDD6F2E-BB95-CEC6-E3AC-CC06E174267D}"/>
              </a:ext>
            </a:extLst>
          </p:cNvPr>
          <p:cNvSpPr/>
          <p:nvPr/>
        </p:nvSpPr>
        <p:spPr>
          <a:xfrm>
            <a:off x="10566532" y="5250730"/>
            <a:ext cx="1015737" cy="69758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7280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E9CE927-C36F-1CA7-36F3-0E72F7FCC265}"/>
              </a:ext>
            </a:extLst>
          </p:cNvPr>
          <p:cNvSpPr txBox="1"/>
          <p:nvPr/>
        </p:nvSpPr>
        <p:spPr>
          <a:xfrm>
            <a:off x="0" y="0"/>
            <a:ext cx="1065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890A84E-607F-D31F-7DF2-B4FB3124DF8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710" t="11308" r="12472" b="17381"/>
          <a:stretch>
            <a:fillRect/>
          </a:stretch>
        </p:blipFill>
        <p:spPr>
          <a:xfrm>
            <a:off x="1237217" y="420945"/>
            <a:ext cx="2308830" cy="23378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76F661C-37CD-5016-4014-6A53736E61C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849" t="9932" r="15762" b="13259"/>
          <a:stretch>
            <a:fillRect/>
          </a:stretch>
        </p:blipFill>
        <p:spPr>
          <a:xfrm>
            <a:off x="4722940" y="425129"/>
            <a:ext cx="2384870" cy="23336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FE460BA-B0A4-69C4-F582-5498D8B40395}"/>
              </a:ext>
            </a:extLst>
          </p:cNvPr>
          <p:cNvSpPr txBox="1"/>
          <p:nvPr/>
        </p:nvSpPr>
        <p:spPr>
          <a:xfrm>
            <a:off x="368441" y="1180624"/>
            <a:ext cx="6222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IB: K63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E7DF765-510B-8BE2-041B-D56B4ACD5B0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492" t="29027" r="14328" b="22652"/>
          <a:stretch>
            <a:fillRect/>
          </a:stretch>
        </p:blipFill>
        <p:spPr>
          <a:xfrm>
            <a:off x="8284703" y="681795"/>
            <a:ext cx="3186261" cy="16873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0587543-ACE9-650E-C266-5A27FD88FDB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589" t="11134" r="12640" b="24943"/>
          <a:stretch>
            <a:fillRect/>
          </a:stretch>
        </p:blipFill>
        <p:spPr>
          <a:xfrm>
            <a:off x="8808472" y="2623197"/>
            <a:ext cx="3110846" cy="23766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5CD1878-C5E1-D64F-9BDE-27548B8545F7}"/>
              </a:ext>
            </a:extLst>
          </p:cNvPr>
          <p:cNvSpPr txBox="1"/>
          <p:nvPr/>
        </p:nvSpPr>
        <p:spPr>
          <a:xfrm>
            <a:off x="7491703" y="1296040"/>
            <a:ext cx="6928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IB: Mcl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F6BD2D1-DC9C-87D2-D050-E854953EE54D}"/>
              </a:ext>
            </a:extLst>
          </p:cNvPr>
          <p:cNvSpPr txBox="1"/>
          <p:nvPr/>
        </p:nvSpPr>
        <p:spPr>
          <a:xfrm>
            <a:off x="96630" y="3811499"/>
            <a:ext cx="12073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IB: p62/SQSTM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E197FB-B5CE-2ABA-A70C-FF1D4C318A2B}"/>
              </a:ext>
            </a:extLst>
          </p:cNvPr>
          <p:cNvSpPr txBox="1"/>
          <p:nvPr/>
        </p:nvSpPr>
        <p:spPr>
          <a:xfrm>
            <a:off x="228608" y="1326818"/>
            <a:ext cx="10086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Low exposur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790BB83-AFA9-8B64-390A-E6ED495D7BF2}"/>
              </a:ext>
            </a:extLst>
          </p:cNvPr>
          <p:cNvSpPr txBox="1"/>
          <p:nvPr/>
        </p:nvSpPr>
        <p:spPr>
          <a:xfrm>
            <a:off x="272682" y="3982848"/>
            <a:ext cx="10086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Low exposur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58B9C70-DB90-5E31-2320-6CA8693DD48C}"/>
              </a:ext>
            </a:extLst>
          </p:cNvPr>
          <p:cNvSpPr txBox="1"/>
          <p:nvPr/>
        </p:nvSpPr>
        <p:spPr>
          <a:xfrm>
            <a:off x="7388672" y="1451831"/>
            <a:ext cx="10086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Low exposur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AF75855-FE54-1EC4-A112-7A970A28ECDA}"/>
              </a:ext>
            </a:extLst>
          </p:cNvPr>
          <p:cNvSpPr txBox="1"/>
          <p:nvPr/>
        </p:nvSpPr>
        <p:spPr>
          <a:xfrm>
            <a:off x="3764023" y="1525451"/>
            <a:ext cx="9589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High exposur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C92E3D3-B49E-24E1-971C-50D79A309041}"/>
              </a:ext>
            </a:extLst>
          </p:cNvPr>
          <p:cNvSpPr txBox="1"/>
          <p:nvPr/>
        </p:nvSpPr>
        <p:spPr>
          <a:xfrm>
            <a:off x="4175233" y="4323519"/>
            <a:ext cx="9589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High exposur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F1887F5-2B59-2F28-1ACC-C97D8B45F24C}"/>
              </a:ext>
            </a:extLst>
          </p:cNvPr>
          <p:cNvSpPr txBox="1"/>
          <p:nvPr/>
        </p:nvSpPr>
        <p:spPr>
          <a:xfrm>
            <a:off x="7953555" y="3606751"/>
            <a:ext cx="9589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High exposur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E42B576-B72A-97A2-A0D4-F02D3E247FE9}"/>
              </a:ext>
            </a:extLst>
          </p:cNvPr>
          <p:cNvSpPr txBox="1"/>
          <p:nvPr/>
        </p:nvSpPr>
        <p:spPr>
          <a:xfrm>
            <a:off x="3894615" y="1296040"/>
            <a:ext cx="6222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IB: K6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4B180A6-1FB3-26A6-0DB9-188A3F3CBA26}"/>
              </a:ext>
            </a:extLst>
          </p:cNvPr>
          <p:cNvSpPr txBox="1"/>
          <p:nvPr/>
        </p:nvSpPr>
        <p:spPr>
          <a:xfrm>
            <a:off x="3996769" y="4145407"/>
            <a:ext cx="12073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IB: p62/SQSTM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974F6D6-E59F-4ECE-D215-8988971C3AFC}"/>
              </a:ext>
            </a:extLst>
          </p:cNvPr>
          <p:cNvSpPr txBox="1"/>
          <p:nvPr/>
        </p:nvSpPr>
        <p:spPr>
          <a:xfrm>
            <a:off x="8086604" y="3429000"/>
            <a:ext cx="6928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IB: Mcl1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8C43B7C7-BD3D-12B2-064A-CCC459634A7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duotone>
              <a:prstClr val="black"/>
              <a:schemeClr val="bg1">
                <a:lumMod val="7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150" t="12583" r="6857" b="8191"/>
          <a:stretch>
            <a:fillRect/>
          </a:stretch>
        </p:blipFill>
        <p:spPr>
          <a:xfrm>
            <a:off x="1252247" y="3173536"/>
            <a:ext cx="2726286" cy="22837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E80B042B-6F1C-42C6-AD61-70ADCBD116DD}"/>
              </a:ext>
            </a:extLst>
          </p:cNvPr>
          <p:cNvPicPr>
            <a:picLocks noChangeAspect="1"/>
          </p:cNvPicPr>
          <p:nvPr/>
        </p:nvPicPr>
        <p:blipFill>
          <a:blip r:embed="rId12">
            <a:duotone>
              <a:prstClr val="black"/>
              <a:schemeClr val="bg1">
                <a:lumMod val="8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272" t="12263" r="7885" b="7531"/>
          <a:stretch>
            <a:fillRect/>
          </a:stretch>
        </p:blipFill>
        <p:spPr>
          <a:xfrm>
            <a:off x="5163200" y="3331606"/>
            <a:ext cx="2670080" cy="20745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8B866568-6BCB-00F2-BF20-28C57E9DB604}"/>
              </a:ext>
            </a:extLst>
          </p:cNvPr>
          <p:cNvSpPr/>
          <p:nvPr/>
        </p:nvSpPr>
        <p:spPr>
          <a:xfrm>
            <a:off x="1725104" y="2105037"/>
            <a:ext cx="798301" cy="5181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4E4AF0C3-42C4-0A1A-EFFE-8C64B5532720}"/>
              </a:ext>
            </a:extLst>
          </p:cNvPr>
          <p:cNvSpPr/>
          <p:nvPr/>
        </p:nvSpPr>
        <p:spPr>
          <a:xfrm>
            <a:off x="2965722" y="4740721"/>
            <a:ext cx="798301" cy="5181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208DD37F-5EAF-D5C6-7BD8-AB89D89DD780}"/>
              </a:ext>
            </a:extLst>
          </p:cNvPr>
          <p:cNvSpPr/>
          <p:nvPr/>
        </p:nvSpPr>
        <p:spPr>
          <a:xfrm>
            <a:off x="5279010" y="2017336"/>
            <a:ext cx="937553" cy="5821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49A6398C-AD42-37CE-4134-4C3DDD375DDB}"/>
              </a:ext>
            </a:extLst>
          </p:cNvPr>
          <p:cNvSpPr/>
          <p:nvPr/>
        </p:nvSpPr>
        <p:spPr>
          <a:xfrm>
            <a:off x="6911420" y="4740721"/>
            <a:ext cx="780854" cy="5337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326E91C8-735D-76AA-1771-683969C72C45}"/>
              </a:ext>
            </a:extLst>
          </p:cNvPr>
          <p:cNvSpPr/>
          <p:nvPr/>
        </p:nvSpPr>
        <p:spPr>
          <a:xfrm>
            <a:off x="10613134" y="3559805"/>
            <a:ext cx="916660" cy="5337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5CE1ED30-4A91-6408-DDCB-B5522575E436}"/>
              </a:ext>
            </a:extLst>
          </p:cNvPr>
          <p:cNvSpPr/>
          <p:nvPr/>
        </p:nvSpPr>
        <p:spPr>
          <a:xfrm>
            <a:off x="10267369" y="888397"/>
            <a:ext cx="916660" cy="5337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309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569</Words>
  <Application>Microsoft Office PowerPoint</Application>
  <PresentationFormat>Widescreen</PresentationFormat>
  <Paragraphs>286</Paragraphs>
  <Slides>4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4</vt:i4>
      </vt:variant>
    </vt:vector>
  </HeadingPairs>
  <TitlesOfParts>
    <vt:vector size="48" baseType="lpstr">
      <vt:lpstr>Aptos</vt:lpstr>
      <vt:lpstr>Arial</vt:lpstr>
      <vt:lpstr>brandon_grotesque_bold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Ahmed Elshazly</dc:creator>
  <cp:lastModifiedBy>Dr Ahmed Elshazly</cp:lastModifiedBy>
  <cp:revision>2</cp:revision>
  <dcterms:created xsi:type="dcterms:W3CDTF">2024-09-06T15:27:05Z</dcterms:created>
  <dcterms:modified xsi:type="dcterms:W3CDTF">2026-03-01T12:38:57Z</dcterms:modified>
</cp:coreProperties>
</file>